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sldIdLst>
    <p:sldId id="257" r:id="rId5"/>
  </p:sldIdLst>
  <p:sldSz cx="12192000" cy="76803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7AAFD95F-772F-C3DB-AAA0-73AA0720A791}" name="Mendoza Valderrey, Alberto" initials="MVA" userId="S::alberto.mendozavalderrey@providence.org::3ca0a5ef-cfc6-4d76-a1eb-aa1d46514f4a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F8CD0453-8ED0-46A4-8521-4FFE3B7B613F}" v="1" dt="2024-02-27T03:15:02.01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10" d="100"/>
          <a:sy n="110" d="100"/>
        </p:scale>
        <p:origin x="59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12" Type="http://schemas.microsoft.com/office/2018/10/relationships/authors" Target="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endoza Valderrey, Alberto" userId="3ca0a5ef-cfc6-4d76-a1eb-aa1d46514f4a" providerId="ADAL" clId="{1DBBE095-44EE-4C77-9AAA-5893DB6FDA75}"/>
    <pc:docChg chg="undo custSel delSld modSld">
      <pc:chgData name="Mendoza Valderrey, Alberto" userId="3ca0a5ef-cfc6-4d76-a1eb-aa1d46514f4a" providerId="ADAL" clId="{1DBBE095-44EE-4C77-9AAA-5893DB6FDA75}" dt="2024-02-01T19:06:57.186" v="35"/>
      <pc:docMkLst>
        <pc:docMk/>
      </pc:docMkLst>
      <pc:sldChg chg="del">
        <pc:chgData name="Mendoza Valderrey, Alberto" userId="3ca0a5ef-cfc6-4d76-a1eb-aa1d46514f4a" providerId="ADAL" clId="{1DBBE095-44EE-4C77-9AAA-5893DB6FDA75}" dt="2024-02-01T01:08:09.311" v="0" actId="47"/>
        <pc:sldMkLst>
          <pc:docMk/>
          <pc:sldMk cId="1652852917" sldId="256"/>
        </pc:sldMkLst>
      </pc:sldChg>
      <pc:sldChg chg="addSp modSp mod delCm">
        <pc:chgData name="Mendoza Valderrey, Alberto" userId="3ca0a5ef-cfc6-4d76-a1eb-aa1d46514f4a" providerId="ADAL" clId="{1DBBE095-44EE-4C77-9AAA-5893DB6FDA75}" dt="2024-02-01T19:06:57.186" v="35"/>
        <pc:sldMkLst>
          <pc:docMk/>
          <pc:sldMk cId="2030739124" sldId="257"/>
        </pc:sldMkLst>
        <pc:picChg chg="add mod modCrop">
          <ac:chgData name="Mendoza Valderrey, Alberto" userId="3ca0a5ef-cfc6-4d76-a1eb-aa1d46514f4a" providerId="ADAL" clId="{1DBBE095-44EE-4C77-9AAA-5893DB6FDA75}" dt="2024-02-01T19:06:47.717" v="34" actId="732"/>
          <ac:picMkLst>
            <pc:docMk/>
            <pc:sldMk cId="2030739124" sldId="257"/>
            <ac:picMk id="47" creationId="{230EB767-C7BA-EBD4-5090-55C2F927F1B0}"/>
          </ac:picMkLst>
        </pc:picChg>
        <pc:extLst>
          <p:ext xmlns:p="http://schemas.openxmlformats.org/presentationml/2006/main" uri="{D6D511B9-2390-475A-947B-AFAB55BFBCF1}">
            <pc226:cmChg xmlns:pc226="http://schemas.microsoft.com/office/powerpoint/2022/06/main/command" chg="del">
              <pc226:chgData name="Mendoza Valderrey, Alberto" userId="3ca0a5ef-cfc6-4d76-a1eb-aa1d46514f4a" providerId="ADAL" clId="{1DBBE095-44EE-4C77-9AAA-5893DB6FDA75}" dt="2024-02-01T19:06:57.186" v="35"/>
              <pc2:cmMkLst xmlns:pc2="http://schemas.microsoft.com/office/powerpoint/2019/9/main/command">
                <pc:docMk/>
                <pc:sldMk cId="2030739124" sldId="257"/>
                <pc2:cmMk id="{2BB4051F-D674-4C9D-9B43-C15D19DD60D4}"/>
              </pc2:cmMkLst>
            </pc226:cmChg>
          </p:ext>
        </pc:extLst>
      </pc:sldChg>
    </pc:docChg>
  </pc:docChgLst>
  <pc:docChgLst>
    <pc:chgData name="Mendoza Valderrey, Alberto" userId="3ca0a5ef-cfc6-4d76-a1eb-aa1d46514f4a" providerId="ADAL" clId="{4F8E51F9-E0E7-4E38-A829-33EDC4CC36D3}"/>
    <pc:docChg chg="undo custSel addSld delSld modSld">
      <pc:chgData name="Mendoza Valderrey, Alberto" userId="3ca0a5ef-cfc6-4d76-a1eb-aa1d46514f4a" providerId="ADAL" clId="{4F8E51F9-E0E7-4E38-A829-33EDC4CC36D3}" dt="2024-02-01T01:04:23.256" v="3340" actId="1036"/>
      <pc:docMkLst>
        <pc:docMk/>
      </pc:docMkLst>
      <pc:sldChg chg="addSp delSp modSp mod">
        <pc:chgData name="Mendoza Valderrey, Alberto" userId="3ca0a5ef-cfc6-4d76-a1eb-aa1d46514f4a" providerId="ADAL" clId="{4F8E51F9-E0E7-4E38-A829-33EDC4CC36D3}" dt="2024-02-01T01:04:23.256" v="3340" actId="1036"/>
        <pc:sldMkLst>
          <pc:docMk/>
          <pc:sldMk cId="1652852917" sldId="256"/>
        </pc:sldMkLst>
        <pc:spChg chg="mod">
          <ac:chgData name="Mendoza Valderrey, Alberto" userId="3ca0a5ef-cfc6-4d76-a1eb-aa1d46514f4a" providerId="ADAL" clId="{4F8E51F9-E0E7-4E38-A829-33EDC4CC36D3}" dt="2024-01-31T19:40:37.316" v="404" actId="1035"/>
          <ac:spMkLst>
            <pc:docMk/>
            <pc:sldMk cId="1652852917" sldId="256"/>
            <ac:spMk id="4" creationId="{F7FE4A56-827B-699D-647E-9FE77269094D}"/>
          </ac:spMkLst>
        </pc:spChg>
        <pc:spChg chg="mod">
          <ac:chgData name="Mendoza Valderrey, Alberto" userId="3ca0a5ef-cfc6-4d76-a1eb-aa1d46514f4a" providerId="ADAL" clId="{4F8E51F9-E0E7-4E38-A829-33EDC4CC36D3}" dt="2024-01-31T19:43:06.446" v="593" actId="1036"/>
          <ac:spMkLst>
            <pc:docMk/>
            <pc:sldMk cId="1652852917" sldId="256"/>
            <ac:spMk id="6" creationId="{8113FA29-54B4-9AE5-135B-F5D51FD367B5}"/>
          </ac:spMkLst>
        </pc:spChg>
        <pc:spChg chg="mod">
          <ac:chgData name="Mendoza Valderrey, Alberto" userId="3ca0a5ef-cfc6-4d76-a1eb-aa1d46514f4a" providerId="ADAL" clId="{4F8E51F9-E0E7-4E38-A829-33EDC4CC36D3}" dt="2024-02-01T01:03:21.074" v="3301" actId="1036"/>
          <ac:spMkLst>
            <pc:docMk/>
            <pc:sldMk cId="1652852917" sldId="256"/>
            <ac:spMk id="8" creationId="{0697C01E-0CB8-CB9C-E55F-0B425F4D80A8}"/>
          </ac:spMkLst>
        </pc:spChg>
        <pc:spChg chg="mod">
          <ac:chgData name="Mendoza Valderrey, Alberto" userId="3ca0a5ef-cfc6-4d76-a1eb-aa1d46514f4a" providerId="ADAL" clId="{4F8E51F9-E0E7-4E38-A829-33EDC4CC36D3}" dt="2024-01-31T19:43:06.446" v="593" actId="1036"/>
          <ac:spMkLst>
            <pc:docMk/>
            <pc:sldMk cId="1652852917" sldId="256"/>
            <ac:spMk id="11" creationId="{B3DEBB82-A92C-A3EF-51B4-598FE1CBA1FE}"/>
          </ac:spMkLst>
        </pc:spChg>
        <pc:spChg chg="mod">
          <ac:chgData name="Mendoza Valderrey, Alberto" userId="3ca0a5ef-cfc6-4d76-a1eb-aa1d46514f4a" providerId="ADAL" clId="{4F8E51F9-E0E7-4E38-A829-33EDC4CC36D3}" dt="2024-01-31T19:43:06.446" v="593" actId="1036"/>
          <ac:spMkLst>
            <pc:docMk/>
            <pc:sldMk cId="1652852917" sldId="256"/>
            <ac:spMk id="12" creationId="{84338C17-ABCC-EFAA-F227-607B882FD349}"/>
          </ac:spMkLst>
        </pc:spChg>
        <pc:spChg chg="mod">
          <ac:chgData name="Mendoza Valderrey, Alberto" userId="3ca0a5ef-cfc6-4d76-a1eb-aa1d46514f4a" providerId="ADAL" clId="{4F8E51F9-E0E7-4E38-A829-33EDC4CC36D3}" dt="2024-01-31T19:43:06.446" v="593" actId="1036"/>
          <ac:spMkLst>
            <pc:docMk/>
            <pc:sldMk cId="1652852917" sldId="256"/>
            <ac:spMk id="13" creationId="{8D528BAD-7CAF-0D67-11C3-D80C3179B100}"/>
          </ac:spMkLst>
        </pc:spChg>
        <pc:spChg chg="mod">
          <ac:chgData name="Mendoza Valderrey, Alberto" userId="3ca0a5ef-cfc6-4d76-a1eb-aa1d46514f4a" providerId="ADAL" clId="{4F8E51F9-E0E7-4E38-A829-33EDC4CC36D3}" dt="2024-01-31T19:43:06.446" v="593" actId="1036"/>
          <ac:spMkLst>
            <pc:docMk/>
            <pc:sldMk cId="1652852917" sldId="256"/>
            <ac:spMk id="14" creationId="{C0D4F112-4E93-36E1-9CBC-D5C395C50E3B}"/>
          </ac:spMkLst>
        </pc:spChg>
        <pc:spChg chg="mod">
          <ac:chgData name="Mendoza Valderrey, Alberto" userId="3ca0a5ef-cfc6-4d76-a1eb-aa1d46514f4a" providerId="ADAL" clId="{4F8E51F9-E0E7-4E38-A829-33EDC4CC36D3}" dt="2024-01-31T19:43:06.446" v="593" actId="1036"/>
          <ac:spMkLst>
            <pc:docMk/>
            <pc:sldMk cId="1652852917" sldId="256"/>
            <ac:spMk id="15" creationId="{5336C22A-171C-4B5C-5D15-A9F829B9C805}"/>
          </ac:spMkLst>
        </pc:spChg>
        <pc:spChg chg="mod">
          <ac:chgData name="Mendoza Valderrey, Alberto" userId="3ca0a5ef-cfc6-4d76-a1eb-aa1d46514f4a" providerId="ADAL" clId="{4F8E51F9-E0E7-4E38-A829-33EDC4CC36D3}" dt="2024-01-31T19:43:06.446" v="593" actId="1036"/>
          <ac:spMkLst>
            <pc:docMk/>
            <pc:sldMk cId="1652852917" sldId="256"/>
            <ac:spMk id="16" creationId="{6E6A7C5E-AFC9-E3AD-A448-8A573D16A9FE}"/>
          </ac:spMkLst>
        </pc:spChg>
        <pc:spChg chg="mod">
          <ac:chgData name="Mendoza Valderrey, Alberto" userId="3ca0a5ef-cfc6-4d76-a1eb-aa1d46514f4a" providerId="ADAL" clId="{4F8E51F9-E0E7-4E38-A829-33EDC4CC36D3}" dt="2024-01-31T19:43:06.446" v="593" actId="1036"/>
          <ac:spMkLst>
            <pc:docMk/>
            <pc:sldMk cId="1652852917" sldId="256"/>
            <ac:spMk id="17" creationId="{38038143-A4EA-2235-E696-490E0516D40E}"/>
          </ac:spMkLst>
        </pc:spChg>
        <pc:spChg chg="mod">
          <ac:chgData name="Mendoza Valderrey, Alberto" userId="3ca0a5ef-cfc6-4d76-a1eb-aa1d46514f4a" providerId="ADAL" clId="{4F8E51F9-E0E7-4E38-A829-33EDC4CC36D3}" dt="2024-01-31T19:43:06.446" v="593" actId="1036"/>
          <ac:spMkLst>
            <pc:docMk/>
            <pc:sldMk cId="1652852917" sldId="256"/>
            <ac:spMk id="18" creationId="{A921C152-753B-86AF-D4FC-D39C0D504CF5}"/>
          </ac:spMkLst>
        </pc:spChg>
        <pc:spChg chg="mod">
          <ac:chgData name="Mendoza Valderrey, Alberto" userId="3ca0a5ef-cfc6-4d76-a1eb-aa1d46514f4a" providerId="ADAL" clId="{4F8E51F9-E0E7-4E38-A829-33EDC4CC36D3}" dt="2024-01-31T19:43:06.446" v="593" actId="1036"/>
          <ac:spMkLst>
            <pc:docMk/>
            <pc:sldMk cId="1652852917" sldId="256"/>
            <ac:spMk id="19" creationId="{B4CA9ADD-F75C-E627-436A-1513C6B08996}"/>
          </ac:spMkLst>
        </pc:spChg>
        <pc:spChg chg="mod">
          <ac:chgData name="Mendoza Valderrey, Alberto" userId="3ca0a5ef-cfc6-4d76-a1eb-aa1d46514f4a" providerId="ADAL" clId="{4F8E51F9-E0E7-4E38-A829-33EDC4CC36D3}" dt="2024-01-31T19:43:06.446" v="593" actId="1036"/>
          <ac:spMkLst>
            <pc:docMk/>
            <pc:sldMk cId="1652852917" sldId="256"/>
            <ac:spMk id="20" creationId="{D33AD1E8-F97A-FF38-A915-F605B8EE6091}"/>
          </ac:spMkLst>
        </pc:spChg>
        <pc:spChg chg="mod">
          <ac:chgData name="Mendoza Valderrey, Alberto" userId="3ca0a5ef-cfc6-4d76-a1eb-aa1d46514f4a" providerId="ADAL" clId="{4F8E51F9-E0E7-4E38-A829-33EDC4CC36D3}" dt="2024-01-31T19:43:06.446" v="593" actId="1036"/>
          <ac:spMkLst>
            <pc:docMk/>
            <pc:sldMk cId="1652852917" sldId="256"/>
            <ac:spMk id="21" creationId="{CA00F5EB-3404-B024-FC81-53BAAFF84A2E}"/>
          </ac:spMkLst>
        </pc:spChg>
        <pc:spChg chg="mod">
          <ac:chgData name="Mendoza Valderrey, Alberto" userId="3ca0a5ef-cfc6-4d76-a1eb-aa1d46514f4a" providerId="ADAL" clId="{4F8E51F9-E0E7-4E38-A829-33EDC4CC36D3}" dt="2024-01-31T19:43:06.446" v="593" actId="1036"/>
          <ac:spMkLst>
            <pc:docMk/>
            <pc:sldMk cId="1652852917" sldId="256"/>
            <ac:spMk id="22" creationId="{7B796F5E-F72F-89A8-2FE0-C27EB2F6E09D}"/>
          </ac:spMkLst>
        </pc:spChg>
        <pc:spChg chg="mod">
          <ac:chgData name="Mendoza Valderrey, Alberto" userId="3ca0a5ef-cfc6-4d76-a1eb-aa1d46514f4a" providerId="ADAL" clId="{4F8E51F9-E0E7-4E38-A829-33EDC4CC36D3}" dt="2024-02-01T00:49:48.133" v="1960" actId="1035"/>
          <ac:spMkLst>
            <pc:docMk/>
            <pc:sldMk cId="1652852917" sldId="256"/>
            <ac:spMk id="24" creationId="{6098EF30-42CA-18E8-E384-FEA13CD9514E}"/>
          </ac:spMkLst>
        </pc:spChg>
        <pc:spChg chg="mod">
          <ac:chgData name="Mendoza Valderrey, Alberto" userId="3ca0a5ef-cfc6-4d76-a1eb-aa1d46514f4a" providerId="ADAL" clId="{4F8E51F9-E0E7-4E38-A829-33EDC4CC36D3}" dt="2024-01-31T19:40:37.316" v="404" actId="1035"/>
          <ac:spMkLst>
            <pc:docMk/>
            <pc:sldMk cId="1652852917" sldId="256"/>
            <ac:spMk id="25" creationId="{925A10A4-741C-E089-3760-95752FFB088A}"/>
          </ac:spMkLst>
        </pc:spChg>
        <pc:spChg chg="mod">
          <ac:chgData name="Mendoza Valderrey, Alberto" userId="3ca0a5ef-cfc6-4d76-a1eb-aa1d46514f4a" providerId="ADAL" clId="{4F8E51F9-E0E7-4E38-A829-33EDC4CC36D3}" dt="2024-01-31T19:40:37.316" v="404" actId="1035"/>
          <ac:spMkLst>
            <pc:docMk/>
            <pc:sldMk cId="1652852917" sldId="256"/>
            <ac:spMk id="26" creationId="{D5FB9FAE-5BD1-06C5-ACB0-467E881E544E}"/>
          </ac:spMkLst>
        </pc:spChg>
        <pc:spChg chg="mod">
          <ac:chgData name="Mendoza Valderrey, Alberto" userId="3ca0a5ef-cfc6-4d76-a1eb-aa1d46514f4a" providerId="ADAL" clId="{4F8E51F9-E0E7-4E38-A829-33EDC4CC36D3}" dt="2024-01-31T19:40:37.316" v="404" actId="1035"/>
          <ac:spMkLst>
            <pc:docMk/>
            <pc:sldMk cId="1652852917" sldId="256"/>
            <ac:spMk id="27" creationId="{27C4CD06-6E2C-C02F-864B-4E7FA3F2F8FA}"/>
          </ac:spMkLst>
        </pc:spChg>
        <pc:spChg chg="mod">
          <ac:chgData name="Mendoza Valderrey, Alberto" userId="3ca0a5ef-cfc6-4d76-a1eb-aa1d46514f4a" providerId="ADAL" clId="{4F8E51F9-E0E7-4E38-A829-33EDC4CC36D3}" dt="2024-01-31T19:40:37.316" v="404" actId="1035"/>
          <ac:spMkLst>
            <pc:docMk/>
            <pc:sldMk cId="1652852917" sldId="256"/>
            <ac:spMk id="28" creationId="{245B352C-1E3F-20D8-E9C2-B2E82206BFD6}"/>
          </ac:spMkLst>
        </pc:spChg>
        <pc:spChg chg="mod">
          <ac:chgData name="Mendoza Valderrey, Alberto" userId="3ca0a5ef-cfc6-4d76-a1eb-aa1d46514f4a" providerId="ADAL" clId="{4F8E51F9-E0E7-4E38-A829-33EDC4CC36D3}" dt="2024-01-31T19:40:37.316" v="404" actId="1035"/>
          <ac:spMkLst>
            <pc:docMk/>
            <pc:sldMk cId="1652852917" sldId="256"/>
            <ac:spMk id="29" creationId="{19369B87-9690-FB63-BB52-980C55990941}"/>
          </ac:spMkLst>
        </pc:spChg>
        <pc:spChg chg="mod">
          <ac:chgData name="Mendoza Valderrey, Alberto" userId="3ca0a5ef-cfc6-4d76-a1eb-aa1d46514f4a" providerId="ADAL" clId="{4F8E51F9-E0E7-4E38-A829-33EDC4CC36D3}" dt="2024-01-31T19:40:37.316" v="404" actId="1035"/>
          <ac:spMkLst>
            <pc:docMk/>
            <pc:sldMk cId="1652852917" sldId="256"/>
            <ac:spMk id="30" creationId="{5EC2C184-A8D0-1E1C-841C-E4F83E98E9B6}"/>
          </ac:spMkLst>
        </pc:spChg>
        <pc:spChg chg="mod">
          <ac:chgData name="Mendoza Valderrey, Alberto" userId="3ca0a5ef-cfc6-4d76-a1eb-aa1d46514f4a" providerId="ADAL" clId="{4F8E51F9-E0E7-4E38-A829-33EDC4CC36D3}" dt="2024-02-01T00:45:14.773" v="1640" actId="1076"/>
          <ac:spMkLst>
            <pc:docMk/>
            <pc:sldMk cId="1652852917" sldId="256"/>
            <ac:spMk id="31" creationId="{6F342284-778A-F690-4D5D-353242982D85}"/>
          </ac:spMkLst>
        </pc:spChg>
        <pc:spChg chg="mod">
          <ac:chgData name="Mendoza Valderrey, Alberto" userId="3ca0a5ef-cfc6-4d76-a1eb-aa1d46514f4a" providerId="ADAL" clId="{4F8E51F9-E0E7-4E38-A829-33EDC4CC36D3}" dt="2024-02-01T01:02:44.256" v="3283" actId="1036"/>
          <ac:spMkLst>
            <pc:docMk/>
            <pc:sldMk cId="1652852917" sldId="256"/>
            <ac:spMk id="35" creationId="{C0E4A550-8CA2-9549-14C4-8A06D013673D}"/>
          </ac:spMkLst>
        </pc:spChg>
        <pc:spChg chg="mod">
          <ac:chgData name="Mendoza Valderrey, Alberto" userId="3ca0a5ef-cfc6-4d76-a1eb-aa1d46514f4a" providerId="ADAL" clId="{4F8E51F9-E0E7-4E38-A829-33EDC4CC36D3}" dt="2024-01-31T19:43:06.446" v="593" actId="1036"/>
          <ac:spMkLst>
            <pc:docMk/>
            <pc:sldMk cId="1652852917" sldId="256"/>
            <ac:spMk id="37" creationId="{8F8F31C8-03CE-F654-C781-B5B8D1404D3E}"/>
          </ac:spMkLst>
        </pc:spChg>
        <pc:spChg chg="mod">
          <ac:chgData name="Mendoza Valderrey, Alberto" userId="3ca0a5ef-cfc6-4d76-a1eb-aa1d46514f4a" providerId="ADAL" clId="{4F8E51F9-E0E7-4E38-A829-33EDC4CC36D3}" dt="2024-01-31T19:43:06.446" v="593" actId="1036"/>
          <ac:spMkLst>
            <pc:docMk/>
            <pc:sldMk cId="1652852917" sldId="256"/>
            <ac:spMk id="38" creationId="{79E0D2A7-65AD-E4AC-7933-01A042716293}"/>
          </ac:spMkLst>
        </pc:spChg>
        <pc:spChg chg="add mod">
          <ac:chgData name="Mendoza Valderrey, Alberto" userId="3ca0a5ef-cfc6-4d76-a1eb-aa1d46514f4a" providerId="ADAL" clId="{4F8E51F9-E0E7-4E38-A829-33EDC4CC36D3}" dt="2024-02-01T00:52:06.486" v="2281" actId="14100"/>
          <ac:spMkLst>
            <pc:docMk/>
            <pc:sldMk cId="1652852917" sldId="256"/>
            <ac:spMk id="40" creationId="{5FF8FB36-FC44-E519-C818-B150E3F2D891}"/>
          </ac:spMkLst>
        </pc:spChg>
        <pc:spChg chg="mod">
          <ac:chgData name="Mendoza Valderrey, Alberto" userId="3ca0a5ef-cfc6-4d76-a1eb-aa1d46514f4a" providerId="ADAL" clId="{4F8E51F9-E0E7-4E38-A829-33EDC4CC36D3}" dt="2024-01-31T19:43:11.805" v="601" actId="1036"/>
          <ac:spMkLst>
            <pc:docMk/>
            <pc:sldMk cId="1652852917" sldId="256"/>
            <ac:spMk id="42" creationId="{D1347603-35D1-38BD-70B9-D108063ACD47}"/>
          </ac:spMkLst>
        </pc:spChg>
        <pc:spChg chg="mod">
          <ac:chgData name="Mendoza Valderrey, Alberto" userId="3ca0a5ef-cfc6-4d76-a1eb-aa1d46514f4a" providerId="ADAL" clId="{4F8E51F9-E0E7-4E38-A829-33EDC4CC36D3}" dt="2024-01-31T19:43:11.805" v="601" actId="1036"/>
          <ac:spMkLst>
            <pc:docMk/>
            <pc:sldMk cId="1652852917" sldId="256"/>
            <ac:spMk id="43" creationId="{849CCA14-EF76-A2D5-ADFC-BB4A7351D73D}"/>
          </ac:spMkLst>
        </pc:spChg>
        <pc:spChg chg="mod">
          <ac:chgData name="Mendoza Valderrey, Alberto" userId="3ca0a5ef-cfc6-4d76-a1eb-aa1d46514f4a" providerId="ADAL" clId="{4F8E51F9-E0E7-4E38-A829-33EDC4CC36D3}" dt="2024-01-31T19:43:11.805" v="601" actId="1036"/>
          <ac:spMkLst>
            <pc:docMk/>
            <pc:sldMk cId="1652852917" sldId="256"/>
            <ac:spMk id="44" creationId="{9AC273EB-4243-B7CE-DCE5-E2315DFECA82}"/>
          </ac:spMkLst>
        </pc:spChg>
        <pc:spChg chg="mod">
          <ac:chgData name="Mendoza Valderrey, Alberto" userId="3ca0a5ef-cfc6-4d76-a1eb-aa1d46514f4a" providerId="ADAL" clId="{4F8E51F9-E0E7-4E38-A829-33EDC4CC36D3}" dt="2024-01-31T19:43:11.805" v="601" actId="1036"/>
          <ac:spMkLst>
            <pc:docMk/>
            <pc:sldMk cId="1652852917" sldId="256"/>
            <ac:spMk id="45" creationId="{1280E8CD-4BE5-11B3-E323-44C4415AD5A8}"/>
          </ac:spMkLst>
        </pc:spChg>
        <pc:spChg chg="mod">
          <ac:chgData name="Mendoza Valderrey, Alberto" userId="3ca0a5ef-cfc6-4d76-a1eb-aa1d46514f4a" providerId="ADAL" clId="{4F8E51F9-E0E7-4E38-A829-33EDC4CC36D3}" dt="2024-01-31T19:43:11.805" v="601" actId="1036"/>
          <ac:spMkLst>
            <pc:docMk/>
            <pc:sldMk cId="1652852917" sldId="256"/>
            <ac:spMk id="46" creationId="{97203481-DEDB-86AD-4CBF-D9D7CD993AF4}"/>
          </ac:spMkLst>
        </pc:spChg>
        <pc:spChg chg="mod">
          <ac:chgData name="Mendoza Valderrey, Alberto" userId="3ca0a5ef-cfc6-4d76-a1eb-aa1d46514f4a" providerId="ADAL" clId="{4F8E51F9-E0E7-4E38-A829-33EDC4CC36D3}" dt="2024-01-31T19:43:11.805" v="601" actId="1036"/>
          <ac:spMkLst>
            <pc:docMk/>
            <pc:sldMk cId="1652852917" sldId="256"/>
            <ac:spMk id="47" creationId="{54AA1A9F-E949-7A81-5D80-84A7E349ABFC}"/>
          </ac:spMkLst>
        </pc:spChg>
        <pc:spChg chg="mod">
          <ac:chgData name="Mendoza Valderrey, Alberto" userId="3ca0a5ef-cfc6-4d76-a1eb-aa1d46514f4a" providerId="ADAL" clId="{4F8E51F9-E0E7-4E38-A829-33EDC4CC36D3}" dt="2024-02-01T01:03:59.569" v="3328" actId="1036"/>
          <ac:spMkLst>
            <pc:docMk/>
            <pc:sldMk cId="1652852917" sldId="256"/>
            <ac:spMk id="48" creationId="{52E99609-C44D-763C-F339-BE7579E475DE}"/>
          </ac:spMkLst>
        </pc:spChg>
        <pc:spChg chg="mod">
          <ac:chgData name="Mendoza Valderrey, Alberto" userId="3ca0a5ef-cfc6-4d76-a1eb-aa1d46514f4a" providerId="ADAL" clId="{4F8E51F9-E0E7-4E38-A829-33EDC4CC36D3}" dt="2024-01-31T19:43:11.805" v="601" actId="1036"/>
          <ac:spMkLst>
            <pc:docMk/>
            <pc:sldMk cId="1652852917" sldId="256"/>
            <ac:spMk id="51" creationId="{B2D9B45F-1686-8D82-0ABF-481A1B9FC923}"/>
          </ac:spMkLst>
        </pc:spChg>
        <pc:spChg chg="mod">
          <ac:chgData name="Mendoza Valderrey, Alberto" userId="3ca0a5ef-cfc6-4d76-a1eb-aa1d46514f4a" providerId="ADAL" clId="{4F8E51F9-E0E7-4E38-A829-33EDC4CC36D3}" dt="2024-02-01T00:59:16.735" v="2914" actId="1035"/>
          <ac:spMkLst>
            <pc:docMk/>
            <pc:sldMk cId="1652852917" sldId="256"/>
            <ac:spMk id="53" creationId="{67C21F2B-26A5-415F-D97E-8FE3F8424CE4}"/>
          </ac:spMkLst>
        </pc:spChg>
        <pc:spChg chg="mod">
          <ac:chgData name="Mendoza Valderrey, Alberto" userId="3ca0a5ef-cfc6-4d76-a1eb-aa1d46514f4a" providerId="ADAL" clId="{4F8E51F9-E0E7-4E38-A829-33EDC4CC36D3}" dt="2024-01-31T19:40:29.966" v="386" actId="1037"/>
          <ac:spMkLst>
            <pc:docMk/>
            <pc:sldMk cId="1652852917" sldId="256"/>
            <ac:spMk id="54" creationId="{7C9666FB-A579-6471-92D9-140CC9953295}"/>
          </ac:spMkLst>
        </pc:spChg>
        <pc:spChg chg="mod">
          <ac:chgData name="Mendoza Valderrey, Alberto" userId="3ca0a5ef-cfc6-4d76-a1eb-aa1d46514f4a" providerId="ADAL" clId="{4F8E51F9-E0E7-4E38-A829-33EDC4CC36D3}" dt="2024-01-31T19:40:29.966" v="386" actId="1037"/>
          <ac:spMkLst>
            <pc:docMk/>
            <pc:sldMk cId="1652852917" sldId="256"/>
            <ac:spMk id="55" creationId="{32038E89-01EC-16D0-4F5D-F5D25545B9EA}"/>
          </ac:spMkLst>
        </pc:spChg>
        <pc:spChg chg="mod">
          <ac:chgData name="Mendoza Valderrey, Alberto" userId="3ca0a5ef-cfc6-4d76-a1eb-aa1d46514f4a" providerId="ADAL" clId="{4F8E51F9-E0E7-4E38-A829-33EDC4CC36D3}" dt="2024-01-31T19:40:29.966" v="386" actId="1037"/>
          <ac:spMkLst>
            <pc:docMk/>
            <pc:sldMk cId="1652852917" sldId="256"/>
            <ac:spMk id="56" creationId="{FCBE7A43-3D16-CC79-041A-B4006DA642C0}"/>
          </ac:spMkLst>
        </pc:spChg>
        <pc:spChg chg="mod">
          <ac:chgData name="Mendoza Valderrey, Alberto" userId="3ca0a5ef-cfc6-4d76-a1eb-aa1d46514f4a" providerId="ADAL" clId="{4F8E51F9-E0E7-4E38-A829-33EDC4CC36D3}" dt="2024-01-31T19:40:29.966" v="386" actId="1037"/>
          <ac:spMkLst>
            <pc:docMk/>
            <pc:sldMk cId="1652852917" sldId="256"/>
            <ac:spMk id="57" creationId="{C8CDA92C-DA46-0A48-4E44-A88288F7424B}"/>
          </ac:spMkLst>
        </pc:spChg>
        <pc:spChg chg="mod">
          <ac:chgData name="Mendoza Valderrey, Alberto" userId="3ca0a5ef-cfc6-4d76-a1eb-aa1d46514f4a" providerId="ADAL" clId="{4F8E51F9-E0E7-4E38-A829-33EDC4CC36D3}" dt="2024-01-31T19:40:29.966" v="386" actId="1037"/>
          <ac:spMkLst>
            <pc:docMk/>
            <pc:sldMk cId="1652852917" sldId="256"/>
            <ac:spMk id="58" creationId="{5B4BEEAC-22A7-C2D7-0F91-228BD12CAF6E}"/>
          </ac:spMkLst>
        </pc:spChg>
        <pc:spChg chg="mod">
          <ac:chgData name="Mendoza Valderrey, Alberto" userId="3ca0a5ef-cfc6-4d76-a1eb-aa1d46514f4a" providerId="ADAL" clId="{4F8E51F9-E0E7-4E38-A829-33EDC4CC36D3}" dt="2024-01-31T19:40:29.966" v="386" actId="1037"/>
          <ac:spMkLst>
            <pc:docMk/>
            <pc:sldMk cId="1652852917" sldId="256"/>
            <ac:spMk id="59" creationId="{CD250BC1-09E0-F675-9E1D-8E01921C719B}"/>
          </ac:spMkLst>
        </pc:spChg>
        <pc:spChg chg="mod">
          <ac:chgData name="Mendoza Valderrey, Alberto" userId="3ca0a5ef-cfc6-4d76-a1eb-aa1d46514f4a" providerId="ADAL" clId="{4F8E51F9-E0E7-4E38-A829-33EDC4CC36D3}" dt="2024-01-31T19:40:29.966" v="386" actId="1037"/>
          <ac:spMkLst>
            <pc:docMk/>
            <pc:sldMk cId="1652852917" sldId="256"/>
            <ac:spMk id="60" creationId="{9910B533-A008-FA50-AB58-EFDF1D13652A}"/>
          </ac:spMkLst>
        </pc:spChg>
        <pc:spChg chg="mod">
          <ac:chgData name="Mendoza Valderrey, Alberto" userId="3ca0a5ef-cfc6-4d76-a1eb-aa1d46514f4a" providerId="ADAL" clId="{4F8E51F9-E0E7-4E38-A829-33EDC4CC36D3}" dt="2024-02-01T01:02:05.781" v="3145" actId="1036"/>
          <ac:spMkLst>
            <pc:docMk/>
            <pc:sldMk cId="1652852917" sldId="256"/>
            <ac:spMk id="64" creationId="{44280590-F7EC-0D82-914D-1DD20324A966}"/>
          </ac:spMkLst>
        </pc:spChg>
        <pc:spChg chg="mod">
          <ac:chgData name="Mendoza Valderrey, Alberto" userId="3ca0a5ef-cfc6-4d76-a1eb-aa1d46514f4a" providerId="ADAL" clId="{4F8E51F9-E0E7-4E38-A829-33EDC4CC36D3}" dt="2024-02-01T00:45:10.927" v="1639" actId="1076"/>
          <ac:spMkLst>
            <pc:docMk/>
            <pc:sldMk cId="1652852917" sldId="256"/>
            <ac:spMk id="66" creationId="{7F13430E-3190-5D32-6FAE-DA2307455F2B}"/>
          </ac:spMkLst>
        </pc:spChg>
        <pc:spChg chg="mod">
          <ac:chgData name="Mendoza Valderrey, Alberto" userId="3ca0a5ef-cfc6-4d76-a1eb-aa1d46514f4a" providerId="ADAL" clId="{4F8E51F9-E0E7-4E38-A829-33EDC4CC36D3}" dt="2024-01-31T19:40:29.966" v="386" actId="1037"/>
          <ac:spMkLst>
            <pc:docMk/>
            <pc:sldMk cId="1652852917" sldId="256"/>
            <ac:spMk id="67" creationId="{CA80CBF0-AD59-D834-7F2B-A485047DBC68}"/>
          </ac:spMkLst>
        </pc:spChg>
        <pc:spChg chg="mod">
          <ac:chgData name="Mendoza Valderrey, Alberto" userId="3ca0a5ef-cfc6-4d76-a1eb-aa1d46514f4a" providerId="ADAL" clId="{4F8E51F9-E0E7-4E38-A829-33EDC4CC36D3}" dt="2024-01-31T19:43:11.805" v="601" actId="1036"/>
          <ac:spMkLst>
            <pc:docMk/>
            <pc:sldMk cId="1652852917" sldId="256"/>
            <ac:spMk id="68" creationId="{BB66211D-DE05-ACA4-8B94-5EC8EFA8AC52}"/>
          </ac:spMkLst>
        </pc:spChg>
        <pc:spChg chg="mod">
          <ac:chgData name="Mendoza Valderrey, Alberto" userId="3ca0a5ef-cfc6-4d76-a1eb-aa1d46514f4a" providerId="ADAL" clId="{4F8E51F9-E0E7-4E38-A829-33EDC4CC36D3}" dt="2024-02-01T00:44:03.781" v="1549" actId="1036"/>
          <ac:spMkLst>
            <pc:docMk/>
            <pc:sldMk cId="1652852917" sldId="256"/>
            <ac:spMk id="69" creationId="{8F7D5F62-AA52-0087-38AC-326C2D335539}"/>
          </ac:spMkLst>
        </pc:spChg>
        <pc:spChg chg="mod">
          <ac:chgData name="Mendoza Valderrey, Alberto" userId="3ca0a5ef-cfc6-4d76-a1eb-aa1d46514f4a" providerId="ADAL" clId="{4F8E51F9-E0E7-4E38-A829-33EDC4CC36D3}" dt="2024-02-01T00:44:03.781" v="1549" actId="1036"/>
          <ac:spMkLst>
            <pc:docMk/>
            <pc:sldMk cId="1652852917" sldId="256"/>
            <ac:spMk id="70" creationId="{EAF2BDAB-6978-DAA6-EB47-946085A6A8F3}"/>
          </ac:spMkLst>
        </pc:spChg>
        <pc:spChg chg="mod">
          <ac:chgData name="Mendoza Valderrey, Alberto" userId="3ca0a5ef-cfc6-4d76-a1eb-aa1d46514f4a" providerId="ADAL" clId="{4F8E51F9-E0E7-4E38-A829-33EDC4CC36D3}" dt="2024-02-01T00:44:03.781" v="1549" actId="1036"/>
          <ac:spMkLst>
            <pc:docMk/>
            <pc:sldMk cId="1652852917" sldId="256"/>
            <ac:spMk id="71" creationId="{8F3C8732-EC74-CE3C-2E1B-9E12F69C4099}"/>
          </ac:spMkLst>
        </pc:spChg>
        <pc:spChg chg="mod">
          <ac:chgData name="Mendoza Valderrey, Alberto" userId="3ca0a5ef-cfc6-4d76-a1eb-aa1d46514f4a" providerId="ADAL" clId="{4F8E51F9-E0E7-4E38-A829-33EDC4CC36D3}" dt="2024-02-01T00:44:03.781" v="1549" actId="1036"/>
          <ac:spMkLst>
            <pc:docMk/>
            <pc:sldMk cId="1652852917" sldId="256"/>
            <ac:spMk id="72" creationId="{92891E6A-35C1-9601-D980-253E50BD29F3}"/>
          </ac:spMkLst>
        </pc:spChg>
        <pc:spChg chg="mod">
          <ac:chgData name="Mendoza Valderrey, Alberto" userId="3ca0a5ef-cfc6-4d76-a1eb-aa1d46514f4a" providerId="ADAL" clId="{4F8E51F9-E0E7-4E38-A829-33EDC4CC36D3}" dt="2024-02-01T00:44:03.781" v="1549" actId="1036"/>
          <ac:spMkLst>
            <pc:docMk/>
            <pc:sldMk cId="1652852917" sldId="256"/>
            <ac:spMk id="73" creationId="{BB23D4D7-2E6A-B2B8-A741-D31F129F3249}"/>
          </ac:spMkLst>
        </pc:spChg>
        <pc:spChg chg="mod">
          <ac:chgData name="Mendoza Valderrey, Alberto" userId="3ca0a5ef-cfc6-4d76-a1eb-aa1d46514f4a" providerId="ADAL" clId="{4F8E51F9-E0E7-4E38-A829-33EDC4CC36D3}" dt="2024-02-01T00:44:03.781" v="1549" actId="1036"/>
          <ac:spMkLst>
            <pc:docMk/>
            <pc:sldMk cId="1652852917" sldId="256"/>
            <ac:spMk id="74" creationId="{F02E32B5-C36A-843B-A481-286F22D046DB}"/>
          </ac:spMkLst>
        </pc:spChg>
        <pc:spChg chg="mod">
          <ac:chgData name="Mendoza Valderrey, Alberto" userId="3ca0a5ef-cfc6-4d76-a1eb-aa1d46514f4a" providerId="ADAL" clId="{4F8E51F9-E0E7-4E38-A829-33EDC4CC36D3}" dt="2024-01-31T19:43:11.805" v="601" actId="1036"/>
          <ac:spMkLst>
            <pc:docMk/>
            <pc:sldMk cId="1652852917" sldId="256"/>
            <ac:spMk id="75" creationId="{91C09D38-54C6-5B61-2835-86922E52041C}"/>
          </ac:spMkLst>
        </pc:spChg>
        <pc:spChg chg="mod">
          <ac:chgData name="Mendoza Valderrey, Alberto" userId="3ca0a5ef-cfc6-4d76-a1eb-aa1d46514f4a" providerId="ADAL" clId="{4F8E51F9-E0E7-4E38-A829-33EDC4CC36D3}" dt="2024-02-01T00:53:59.207" v="2593" actId="1035"/>
          <ac:spMkLst>
            <pc:docMk/>
            <pc:sldMk cId="1652852917" sldId="256"/>
            <ac:spMk id="77" creationId="{2C0177ED-D2E3-0350-6096-FEE2A570546C}"/>
          </ac:spMkLst>
        </pc:spChg>
        <pc:spChg chg="mod">
          <ac:chgData name="Mendoza Valderrey, Alberto" userId="3ca0a5ef-cfc6-4d76-a1eb-aa1d46514f4a" providerId="ADAL" clId="{4F8E51F9-E0E7-4E38-A829-33EDC4CC36D3}" dt="2024-01-31T19:40:50.733" v="423" actId="1036"/>
          <ac:spMkLst>
            <pc:docMk/>
            <pc:sldMk cId="1652852917" sldId="256"/>
            <ac:spMk id="78" creationId="{83BAEACA-51E3-BBAB-D4BD-960EE5863611}"/>
          </ac:spMkLst>
        </pc:spChg>
        <pc:spChg chg="mod">
          <ac:chgData name="Mendoza Valderrey, Alberto" userId="3ca0a5ef-cfc6-4d76-a1eb-aa1d46514f4a" providerId="ADAL" clId="{4F8E51F9-E0E7-4E38-A829-33EDC4CC36D3}" dt="2024-01-31T19:40:50.733" v="423" actId="1036"/>
          <ac:spMkLst>
            <pc:docMk/>
            <pc:sldMk cId="1652852917" sldId="256"/>
            <ac:spMk id="79" creationId="{A8A5F15D-06D3-A5CF-3453-FBC5D5616435}"/>
          </ac:spMkLst>
        </pc:spChg>
        <pc:spChg chg="mod">
          <ac:chgData name="Mendoza Valderrey, Alberto" userId="3ca0a5ef-cfc6-4d76-a1eb-aa1d46514f4a" providerId="ADAL" clId="{4F8E51F9-E0E7-4E38-A829-33EDC4CC36D3}" dt="2024-01-31T19:40:50.733" v="423" actId="1036"/>
          <ac:spMkLst>
            <pc:docMk/>
            <pc:sldMk cId="1652852917" sldId="256"/>
            <ac:spMk id="80" creationId="{44BA89D6-9E5E-3D0C-4C4F-2483798A757C}"/>
          </ac:spMkLst>
        </pc:spChg>
        <pc:spChg chg="mod">
          <ac:chgData name="Mendoza Valderrey, Alberto" userId="3ca0a5ef-cfc6-4d76-a1eb-aa1d46514f4a" providerId="ADAL" clId="{4F8E51F9-E0E7-4E38-A829-33EDC4CC36D3}" dt="2024-01-31T19:40:50.733" v="423" actId="1036"/>
          <ac:spMkLst>
            <pc:docMk/>
            <pc:sldMk cId="1652852917" sldId="256"/>
            <ac:spMk id="81" creationId="{32DC9442-D117-DC37-50B2-35F97C3926C3}"/>
          </ac:spMkLst>
        </pc:spChg>
        <pc:spChg chg="mod">
          <ac:chgData name="Mendoza Valderrey, Alberto" userId="3ca0a5ef-cfc6-4d76-a1eb-aa1d46514f4a" providerId="ADAL" clId="{4F8E51F9-E0E7-4E38-A829-33EDC4CC36D3}" dt="2024-01-31T19:40:50.733" v="423" actId="1036"/>
          <ac:spMkLst>
            <pc:docMk/>
            <pc:sldMk cId="1652852917" sldId="256"/>
            <ac:spMk id="82" creationId="{5EE530AF-4508-A59A-2E66-1BD90DB0FA73}"/>
          </ac:spMkLst>
        </pc:spChg>
        <pc:spChg chg="mod">
          <ac:chgData name="Mendoza Valderrey, Alberto" userId="3ca0a5ef-cfc6-4d76-a1eb-aa1d46514f4a" providerId="ADAL" clId="{4F8E51F9-E0E7-4E38-A829-33EDC4CC36D3}" dt="2024-01-31T19:40:50.733" v="423" actId="1036"/>
          <ac:spMkLst>
            <pc:docMk/>
            <pc:sldMk cId="1652852917" sldId="256"/>
            <ac:spMk id="83" creationId="{52BC0855-0236-9213-EFDD-ADA2BFA0369A}"/>
          </ac:spMkLst>
        </pc:spChg>
        <pc:spChg chg="mod">
          <ac:chgData name="Mendoza Valderrey, Alberto" userId="3ca0a5ef-cfc6-4d76-a1eb-aa1d46514f4a" providerId="ADAL" clId="{4F8E51F9-E0E7-4E38-A829-33EDC4CC36D3}" dt="2024-01-31T19:40:50.733" v="423" actId="1036"/>
          <ac:spMkLst>
            <pc:docMk/>
            <pc:sldMk cId="1652852917" sldId="256"/>
            <ac:spMk id="84" creationId="{711B6472-60EE-D251-CD79-4C2B78CACDAD}"/>
          </ac:spMkLst>
        </pc:spChg>
        <pc:spChg chg="mod">
          <ac:chgData name="Mendoza Valderrey, Alberto" userId="3ca0a5ef-cfc6-4d76-a1eb-aa1d46514f4a" providerId="ADAL" clId="{4F8E51F9-E0E7-4E38-A829-33EDC4CC36D3}" dt="2024-02-01T00:52:56.157" v="2354" actId="14100"/>
          <ac:spMkLst>
            <pc:docMk/>
            <pc:sldMk cId="1652852917" sldId="256"/>
            <ac:spMk id="85" creationId="{2DF19A4C-FC1D-A553-E11D-C167A9EE5CD8}"/>
          </ac:spMkLst>
        </pc:spChg>
        <pc:spChg chg="mod">
          <ac:chgData name="Mendoza Valderrey, Alberto" userId="3ca0a5ef-cfc6-4d76-a1eb-aa1d46514f4a" providerId="ADAL" clId="{4F8E51F9-E0E7-4E38-A829-33EDC4CC36D3}" dt="2024-02-01T01:01:58.236" v="3140" actId="1036"/>
          <ac:spMkLst>
            <pc:docMk/>
            <pc:sldMk cId="1652852917" sldId="256"/>
            <ac:spMk id="89" creationId="{226E2D30-C79E-2C5E-15A7-9D355395239D}"/>
          </ac:spMkLst>
        </pc:spChg>
        <pc:spChg chg="mod">
          <ac:chgData name="Mendoza Valderrey, Alberto" userId="3ca0a5ef-cfc6-4d76-a1eb-aa1d46514f4a" providerId="ADAL" clId="{4F8E51F9-E0E7-4E38-A829-33EDC4CC36D3}" dt="2024-02-01T01:04:23.256" v="3340" actId="1036"/>
          <ac:spMkLst>
            <pc:docMk/>
            <pc:sldMk cId="1652852917" sldId="256"/>
            <ac:spMk id="92" creationId="{EEC9F0DD-27F6-53A1-7597-2D17280AF4C3}"/>
          </ac:spMkLst>
        </pc:spChg>
        <pc:spChg chg="mod">
          <ac:chgData name="Mendoza Valderrey, Alberto" userId="3ca0a5ef-cfc6-4d76-a1eb-aa1d46514f4a" providerId="ADAL" clId="{4F8E51F9-E0E7-4E38-A829-33EDC4CC36D3}" dt="2024-01-31T19:43:21.103" v="608" actId="1035"/>
          <ac:spMkLst>
            <pc:docMk/>
            <pc:sldMk cId="1652852917" sldId="256"/>
            <ac:spMk id="95" creationId="{4047D12E-9111-6C23-89C4-5F4521F2AD7F}"/>
          </ac:spMkLst>
        </pc:spChg>
        <pc:spChg chg="mod">
          <ac:chgData name="Mendoza Valderrey, Alberto" userId="3ca0a5ef-cfc6-4d76-a1eb-aa1d46514f4a" providerId="ADAL" clId="{4F8E51F9-E0E7-4E38-A829-33EDC4CC36D3}" dt="2024-01-31T19:43:21.103" v="608" actId="1035"/>
          <ac:spMkLst>
            <pc:docMk/>
            <pc:sldMk cId="1652852917" sldId="256"/>
            <ac:spMk id="96" creationId="{43222342-5B33-BEEE-D137-A26E51769218}"/>
          </ac:spMkLst>
        </pc:spChg>
        <pc:spChg chg="mod">
          <ac:chgData name="Mendoza Valderrey, Alberto" userId="3ca0a5ef-cfc6-4d76-a1eb-aa1d46514f4a" providerId="ADAL" clId="{4F8E51F9-E0E7-4E38-A829-33EDC4CC36D3}" dt="2024-01-31T19:43:21.103" v="608" actId="1035"/>
          <ac:spMkLst>
            <pc:docMk/>
            <pc:sldMk cId="1652852917" sldId="256"/>
            <ac:spMk id="97" creationId="{A97B8EE9-5F51-1ADD-9043-38CFC8EF64FD}"/>
          </ac:spMkLst>
        </pc:spChg>
        <pc:spChg chg="mod">
          <ac:chgData name="Mendoza Valderrey, Alberto" userId="3ca0a5ef-cfc6-4d76-a1eb-aa1d46514f4a" providerId="ADAL" clId="{4F8E51F9-E0E7-4E38-A829-33EDC4CC36D3}" dt="2024-01-31T19:43:21.103" v="608" actId="1035"/>
          <ac:spMkLst>
            <pc:docMk/>
            <pc:sldMk cId="1652852917" sldId="256"/>
            <ac:spMk id="98" creationId="{30FF2F09-02C6-5FCC-77F2-95CA1735AEA7}"/>
          </ac:spMkLst>
        </pc:spChg>
        <pc:spChg chg="mod">
          <ac:chgData name="Mendoza Valderrey, Alberto" userId="3ca0a5ef-cfc6-4d76-a1eb-aa1d46514f4a" providerId="ADAL" clId="{4F8E51F9-E0E7-4E38-A829-33EDC4CC36D3}" dt="2024-01-31T19:43:21.103" v="608" actId="1035"/>
          <ac:spMkLst>
            <pc:docMk/>
            <pc:sldMk cId="1652852917" sldId="256"/>
            <ac:spMk id="99" creationId="{AF6420B6-4836-F1E5-F10E-071BE2FD3777}"/>
          </ac:spMkLst>
        </pc:spChg>
        <pc:spChg chg="mod">
          <ac:chgData name="Mendoza Valderrey, Alberto" userId="3ca0a5ef-cfc6-4d76-a1eb-aa1d46514f4a" providerId="ADAL" clId="{4F8E51F9-E0E7-4E38-A829-33EDC4CC36D3}" dt="2024-01-31T19:43:21.103" v="608" actId="1035"/>
          <ac:spMkLst>
            <pc:docMk/>
            <pc:sldMk cId="1652852917" sldId="256"/>
            <ac:spMk id="100" creationId="{F5538F71-BC23-8EFE-548A-CDBBDB7449D9}"/>
          </ac:spMkLst>
        </pc:spChg>
        <pc:spChg chg="mod">
          <ac:chgData name="Mendoza Valderrey, Alberto" userId="3ca0a5ef-cfc6-4d76-a1eb-aa1d46514f4a" providerId="ADAL" clId="{4F8E51F9-E0E7-4E38-A829-33EDC4CC36D3}" dt="2024-01-31T19:43:21.103" v="608" actId="1035"/>
          <ac:spMkLst>
            <pc:docMk/>
            <pc:sldMk cId="1652852917" sldId="256"/>
            <ac:spMk id="101" creationId="{618758D5-3658-7F70-3D7C-DE836C6EF4D5}"/>
          </ac:spMkLst>
        </pc:spChg>
        <pc:spChg chg="mod">
          <ac:chgData name="Mendoza Valderrey, Alberto" userId="3ca0a5ef-cfc6-4d76-a1eb-aa1d46514f4a" providerId="ADAL" clId="{4F8E51F9-E0E7-4E38-A829-33EDC4CC36D3}" dt="2024-01-31T19:43:21.103" v="608" actId="1035"/>
          <ac:spMkLst>
            <pc:docMk/>
            <pc:sldMk cId="1652852917" sldId="256"/>
            <ac:spMk id="102" creationId="{B64B7A49-4BC4-A1CB-30BE-E8B6B3871FD4}"/>
          </ac:spMkLst>
        </pc:spChg>
        <pc:spChg chg="mod">
          <ac:chgData name="Mendoza Valderrey, Alberto" userId="3ca0a5ef-cfc6-4d76-a1eb-aa1d46514f4a" providerId="ADAL" clId="{4F8E51F9-E0E7-4E38-A829-33EDC4CC36D3}" dt="2024-02-01T00:43:55.929" v="1544" actId="1036"/>
          <ac:spMkLst>
            <pc:docMk/>
            <pc:sldMk cId="1652852917" sldId="256"/>
            <ac:spMk id="103" creationId="{07FA942B-926B-E910-A089-D8FD8ED839A7}"/>
          </ac:spMkLst>
        </pc:spChg>
        <pc:spChg chg="mod">
          <ac:chgData name="Mendoza Valderrey, Alberto" userId="3ca0a5ef-cfc6-4d76-a1eb-aa1d46514f4a" providerId="ADAL" clId="{4F8E51F9-E0E7-4E38-A829-33EDC4CC36D3}" dt="2024-02-01T00:43:55.929" v="1544" actId="1036"/>
          <ac:spMkLst>
            <pc:docMk/>
            <pc:sldMk cId="1652852917" sldId="256"/>
            <ac:spMk id="104" creationId="{353E69BE-D856-8785-2801-33B89041F25C}"/>
          </ac:spMkLst>
        </pc:spChg>
        <pc:spChg chg="mod">
          <ac:chgData name="Mendoza Valderrey, Alberto" userId="3ca0a5ef-cfc6-4d76-a1eb-aa1d46514f4a" providerId="ADAL" clId="{4F8E51F9-E0E7-4E38-A829-33EDC4CC36D3}" dt="2024-02-01T00:43:55.929" v="1544" actId="1036"/>
          <ac:spMkLst>
            <pc:docMk/>
            <pc:sldMk cId="1652852917" sldId="256"/>
            <ac:spMk id="105" creationId="{F100F3FA-0889-C912-98A7-FDF1EC73FACE}"/>
          </ac:spMkLst>
        </pc:spChg>
        <pc:spChg chg="mod">
          <ac:chgData name="Mendoza Valderrey, Alberto" userId="3ca0a5ef-cfc6-4d76-a1eb-aa1d46514f4a" providerId="ADAL" clId="{4F8E51F9-E0E7-4E38-A829-33EDC4CC36D3}" dt="2024-02-01T00:43:55.929" v="1544" actId="1036"/>
          <ac:spMkLst>
            <pc:docMk/>
            <pc:sldMk cId="1652852917" sldId="256"/>
            <ac:spMk id="106" creationId="{DB2E2F42-0F95-8702-8E1B-09BD019126F0}"/>
          </ac:spMkLst>
        </pc:spChg>
        <pc:spChg chg="mod">
          <ac:chgData name="Mendoza Valderrey, Alberto" userId="3ca0a5ef-cfc6-4d76-a1eb-aa1d46514f4a" providerId="ADAL" clId="{4F8E51F9-E0E7-4E38-A829-33EDC4CC36D3}" dt="2024-02-01T00:43:55.929" v="1544" actId="1036"/>
          <ac:spMkLst>
            <pc:docMk/>
            <pc:sldMk cId="1652852917" sldId="256"/>
            <ac:spMk id="107" creationId="{74116D1D-3A7B-5E69-6A84-382326E83867}"/>
          </ac:spMkLst>
        </pc:spChg>
        <pc:spChg chg="mod">
          <ac:chgData name="Mendoza Valderrey, Alberto" userId="3ca0a5ef-cfc6-4d76-a1eb-aa1d46514f4a" providerId="ADAL" clId="{4F8E51F9-E0E7-4E38-A829-33EDC4CC36D3}" dt="2024-02-01T00:43:55.929" v="1544" actId="1036"/>
          <ac:spMkLst>
            <pc:docMk/>
            <pc:sldMk cId="1652852917" sldId="256"/>
            <ac:spMk id="108" creationId="{24238419-D72A-1314-C551-30A3CCA78D90}"/>
          </ac:spMkLst>
        </pc:spChg>
        <pc:spChg chg="mod">
          <ac:chgData name="Mendoza Valderrey, Alberto" userId="3ca0a5ef-cfc6-4d76-a1eb-aa1d46514f4a" providerId="ADAL" clId="{4F8E51F9-E0E7-4E38-A829-33EDC4CC36D3}" dt="2024-01-31T19:43:21.103" v="608" actId="1035"/>
          <ac:spMkLst>
            <pc:docMk/>
            <pc:sldMk cId="1652852917" sldId="256"/>
            <ac:spMk id="109" creationId="{FD022E5B-C154-2B26-7C51-CB0202C5633E}"/>
          </ac:spMkLst>
        </pc:spChg>
        <pc:spChg chg="add mod">
          <ac:chgData name="Mendoza Valderrey, Alberto" userId="3ca0a5ef-cfc6-4d76-a1eb-aa1d46514f4a" providerId="ADAL" clId="{4F8E51F9-E0E7-4E38-A829-33EDC4CC36D3}" dt="2024-02-01T00:46:37.411" v="1770" actId="1038"/>
          <ac:spMkLst>
            <pc:docMk/>
            <pc:sldMk cId="1652852917" sldId="256"/>
            <ac:spMk id="110" creationId="{A5FE755C-0DCC-4A08-4E9A-7685F693F727}"/>
          </ac:spMkLst>
        </pc:spChg>
        <pc:spChg chg="add mod">
          <ac:chgData name="Mendoza Valderrey, Alberto" userId="3ca0a5ef-cfc6-4d76-a1eb-aa1d46514f4a" providerId="ADAL" clId="{4F8E51F9-E0E7-4E38-A829-33EDC4CC36D3}" dt="2024-02-01T00:46:37.411" v="1770" actId="1038"/>
          <ac:spMkLst>
            <pc:docMk/>
            <pc:sldMk cId="1652852917" sldId="256"/>
            <ac:spMk id="111" creationId="{8FC58753-37C9-73A4-1A75-758BA237BBC5}"/>
          </ac:spMkLst>
        </pc:spChg>
        <pc:spChg chg="add mod">
          <ac:chgData name="Mendoza Valderrey, Alberto" userId="3ca0a5ef-cfc6-4d76-a1eb-aa1d46514f4a" providerId="ADAL" clId="{4F8E51F9-E0E7-4E38-A829-33EDC4CC36D3}" dt="2024-02-01T00:46:37.411" v="1770" actId="1038"/>
          <ac:spMkLst>
            <pc:docMk/>
            <pc:sldMk cId="1652852917" sldId="256"/>
            <ac:spMk id="112" creationId="{B2429D19-F622-7842-7F21-37BDC2B300DB}"/>
          </ac:spMkLst>
        </pc:spChg>
        <pc:spChg chg="add mod">
          <ac:chgData name="Mendoza Valderrey, Alberto" userId="3ca0a5ef-cfc6-4d76-a1eb-aa1d46514f4a" providerId="ADAL" clId="{4F8E51F9-E0E7-4E38-A829-33EDC4CC36D3}" dt="2024-02-01T00:46:37.411" v="1770" actId="1038"/>
          <ac:spMkLst>
            <pc:docMk/>
            <pc:sldMk cId="1652852917" sldId="256"/>
            <ac:spMk id="113" creationId="{F87E72A3-0F01-3CBE-804C-A007CF75C332}"/>
          </ac:spMkLst>
        </pc:spChg>
        <pc:spChg chg="add mod">
          <ac:chgData name="Mendoza Valderrey, Alberto" userId="3ca0a5ef-cfc6-4d76-a1eb-aa1d46514f4a" providerId="ADAL" clId="{4F8E51F9-E0E7-4E38-A829-33EDC4CC36D3}" dt="2024-02-01T00:46:37.411" v="1770" actId="1038"/>
          <ac:spMkLst>
            <pc:docMk/>
            <pc:sldMk cId="1652852917" sldId="256"/>
            <ac:spMk id="114" creationId="{E454748D-0221-0F33-BBBC-57CD727F33B9}"/>
          </ac:spMkLst>
        </pc:spChg>
        <pc:spChg chg="add mod">
          <ac:chgData name="Mendoza Valderrey, Alberto" userId="3ca0a5ef-cfc6-4d76-a1eb-aa1d46514f4a" providerId="ADAL" clId="{4F8E51F9-E0E7-4E38-A829-33EDC4CC36D3}" dt="2024-02-01T00:46:37.411" v="1770" actId="1038"/>
          <ac:spMkLst>
            <pc:docMk/>
            <pc:sldMk cId="1652852917" sldId="256"/>
            <ac:spMk id="115" creationId="{C52DB22A-D42C-9F4E-C0B4-74785EA13280}"/>
          </ac:spMkLst>
        </pc:spChg>
        <pc:spChg chg="add mod">
          <ac:chgData name="Mendoza Valderrey, Alberto" userId="3ca0a5ef-cfc6-4d76-a1eb-aa1d46514f4a" providerId="ADAL" clId="{4F8E51F9-E0E7-4E38-A829-33EDC4CC36D3}" dt="2024-02-01T00:49:13.690" v="1921" actId="1038"/>
          <ac:spMkLst>
            <pc:docMk/>
            <pc:sldMk cId="1652852917" sldId="256"/>
            <ac:spMk id="116" creationId="{28E256A9-CAFE-3C87-FE9B-5515DB8580B1}"/>
          </ac:spMkLst>
        </pc:spChg>
        <pc:spChg chg="add mod">
          <ac:chgData name="Mendoza Valderrey, Alberto" userId="3ca0a5ef-cfc6-4d76-a1eb-aa1d46514f4a" providerId="ADAL" clId="{4F8E51F9-E0E7-4E38-A829-33EDC4CC36D3}" dt="2024-02-01T00:50:54.699" v="2074" actId="1038"/>
          <ac:spMkLst>
            <pc:docMk/>
            <pc:sldMk cId="1652852917" sldId="256"/>
            <ac:spMk id="117" creationId="{3C426841-3532-71FA-9C2A-902EEB630DDA}"/>
          </ac:spMkLst>
        </pc:spChg>
        <pc:spChg chg="add mod">
          <ac:chgData name="Mendoza Valderrey, Alberto" userId="3ca0a5ef-cfc6-4d76-a1eb-aa1d46514f4a" providerId="ADAL" clId="{4F8E51F9-E0E7-4E38-A829-33EDC4CC36D3}" dt="2024-02-01T00:50:54.699" v="2074" actId="1038"/>
          <ac:spMkLst>
            <pc:docMk/>
            <pc:sldMk cId="1652852917" sldId="256"/>
            <ac:spMk id="118" creationId="{63849269-B090-624D-F085-1083FA6A6DA2}"/>
          </ac:spMkLst>
        </pc:spChg>
        <pc:spChg chg="add mod">
          <ac:chgData name="Mendoza Valderrey, Alberto" userId="3ca0a5ef-cfc6-4d76-a1eb-aa1d46514f4a" providerId="ADAL" clId="{4F8E51F9-E0E7-4E38-A829-33EDC4CC36D3}" dt="2024-02-01T00:50:54.699" v="2074" actId="1038"/>
          <ac:spMkLst>
            <pc:docMk/>
            <pc:sldMk cId="1652852917" sldId="256"/>
            <ac:spMk id="119" creationId="{1B340F51-5391-50F0-82A4-A8E76E38FFA3}"/>
          </ac:spMkLst>
        </pc:spChg>
        <pc:spChg chg="add mod">
          <ac:chgData name="Mendoza Valderrey, Alberto" userId="3ca0a5ef-cfc6-4d76-a1eb-aa1d46514f4a" providerId="ADAL" clId="{4F8E51F9-E0E7-4E38-A829-33EDC4CC36D3}" dt="2024-02-01T00:50:54.699" v="2074" actId="1038"/>
          <ac:spMkLst>
            <pc:docMk/>
            <pc:sldMk cId="1652852917" sldId="256"/>
            <ac:spMk id="120" creationId="{32BBE64A-9322-848D-BE22-27561BDD9B75}"/>
          </ac:spMkLst>
        </pc:spChg>
        <pc:spChg chg="add mod">
          <ac:chgData name="Mendoza Valderrey, Alberto" userId="3ca0a5ef-cfc6-4d76-a1eb-aa1d46514f4a" providerId="ADAL" clId="{4F8E51F9-E0E7-4E38-A829-33EDC4CC36D3}" dt="2024-02-01T00:50:54.699" v="2074" actId="1038"/>
          <ac:spMkLst>
            <pc:docMk/>
            <pc:sldMk cId="1652852917" sldId="256"/>
            <ac:spMk id="121" creationId="{FADB1E28-DE57-6EB5-1610-64A7351217AE}"/>
          </ac:spMkLst>
        </pc:spChg>
        <pc:spChg chg="add mod">
          <ac:chgData name="Mendoza Valderrey, Alberto" userId="3ca0a5ef-cfc6-4d76-a1eb-aa1d46514f4a" providerId="ADAL" clId="{4F8E51F9-E0E7-4E38-A829-33EDC4CC36D3}" dt="2024-02-01T00:50:54.699" v="2074" actId="1038"/>
          <ac:spMkLst>
            <pc:docMk/>
            <pc:sldMk cId="1652852917" sldId="256"/>
            <ac:spMk id="122" creationId="{F7136016-23DE-3B8E-F4F7-EB9E72193DE9}"/>
          </ac:spMkLst>
        </pc:spChg>
        <pc:spChg chg="add mod">
          <ac:chgData name="Mendoza Valderrey, Alberto" userId="3ca0a5ef-cfc6-4d76-a1eb-aa1d46514f4a" providerId="ADAL" clId="{4F8E51F9-E0E7-4E38-A829-33EDC4CC36D3}" dt="2024-02-01T00:50:54.699" v="2074" actId="1038"/>
          <ac:spMkLst>
            <pc:docMk/>
            <pc:sldMk cId="1652852917" sldId="256"/>
            <ac:spMk id="123" creationId="{245D786E-8A73-B50F-A2B0-4DBAD3438D54}"/>
          </ac:spMkLst>
        </pc:spChg>
        <pc:spChg chg="add mod">
          <ac:chgData name="Mendoza Valderrey, Alberto" userId="3ca0a5ef-cfc6-4d76-a1eb-aa1d46514f4a" providerId="ADAL" clId="{4F8E51F9-E0E7-4E38-A829-33EDC4CC36D3}" dt="2024-02-01T00:51:34.045" v="2162" actId="1076"/>
          <ac:spMkLst>
            <pc:docMk/>
            <pc:sldMk cId="1652852917" sldId="256"/>
            <ac:spMk id="124" creationId="{22ABA75F-3B95-5C07-28CB-7D5ABDC33FB0}"/>
          </ac:spMkLst>
        </pc:spChg>
        <pc:spChg chg="add mod">
          <ac:chgData name="Mendoza Valderrey, Alberto" userId="3ca0a5ef-cfc6-4d76-a1eb-aa1d46514f4a" providerId="ADAL" clId="{4F8E51F9-E0E7-4E38-A829-33EDC4CC36D3}" dt="2024-02-01T00:59:16.735" v="2914" actId="1035"/>
          <ac:spMkLst>
            <pc:docMk/>
            <pc:sldMk cId="1652852917" sldId="256"/>
            <ac:spMk id="125" creationId="{EB04A003-866F-9CBA-BF5E-F8EC429698E4}"/>
          </ac:spMkLst>
        </pc:spChg>
        <pc:spChg chg="add mod">
          <ac:chgData name="Mendoza Valderrey, Alberto" userId="3ca0a5ef-cfc6-4d76-a1eb-aa1d46514f4a" providerId="ADAL" clId="{4F8E51F9-E0E7-4E38-A829-33EDC4CC36D3}" dt="2024-02-01T00:52:50.149" v="2353" actId="1076"/>
          <ac:spMkLst>
            <pc:docMk/>
            <pc:sldMk cId="1652852917" sldId="256"/>
            <ac:spMk id="126" creationId="{0E4456AB-943F-DA1B-8D00-65EFE9C0A6D9}"/>
          </ac:spMkLst>
        </pc:spChg>
        <pc:spChg chg="add mod">
          <ac:chgData name="Mendoza Valderrey, Alberto" userId="3ca0a5ef-cfc6-4d76-a1eb-aa1d46514f4a" providerId="ADAL" clId="{4F8E51F9-E0E7-4E38-A829-33EDC4CC36D3}" dt="2024-02-01T00:53:31.204" v="2566" actId="1037"/>
          <ac:spMkLst>
            <pc:docMk/>
            <pc:sldMk cId="1652852917" sldId="256"/>
            <ac:spMk id="127" creationId="{0423E2E0-00DC-BE64-3B73-68AAE99D03EB}"/>
          </ac:spMkLst>
        </pc:spChg>
        <pc:spChg chg="add mod">
          <ac:chgData name="Mendoza Valderrey, Alberto" userId="3ca0a5ef-cfc6-4d76-a1eb-aa1d46514f4a" providerId="ADAL" clId="{4F8E51F9-E0E7-4E38-A829-33EDC4CC36D3}" dt="2024-02-01T00:53:31.204" v="2566" actId="1037"/>
          <ac:spMkLst>
            <pc:docMk/>
            <pc:sldMk cId="1652852917" sldId="256"/>
            <ac:spMk id="128" creationId="{3BC53C34-A752-5AD2-2CFD-D2C9E6DEC190}"/>
          </ac:spMkLst>
        </pc:spChg>
        <pc:spChg chg="add mod">
          <ac:chgData name="Mendoza Valderrey, Alberto" userId="3ca0a5ef-cfc6-4d76-a1eb-aa1d46514f4a" providerId="ADAL" clId="{4F8E51F9-E0E7-4E38-A829-33EDC4CC36D3}" dt="2024-02-01T00:53:31.204" v="2566" actId="1037"/>
          <ac:spMkLst>
            <pc:docMk/>
            <pc:sldMk cId="1652852917" sldId="256"/>
            <ac:spMk id="129" creationId="{2D34B1A9-F1FE-2326-2FDD-628ABC1AF5B3}"/>
          </ac:spMkLst>
        </pc:spChg>
        <pc:spChg chg="add mod">
          <ac:chgData name="Mendoza Valderrey, Alberto" userId="3ca0a5ef-cfc6-4d76-a1eb-aa1d46514f4a" providerId="ADAL" clId="{4F8E51F9-E0E7-4E38-A829-33EDC4CC36D3}" dt="2024-02-01T00:53:31.204" v="2566" actId="1037"/>
          <ac:spMkLst>
            <pc:docMk/>
            <pc:sldMk cId="1652852917" sldId="256"/>
            <ac:spMk id="130" creationId="{BF459D8F-BAC1-8DF7-DD37-872FEE63F01D}"/>
          </ac:spMkLst>
        </pc:spChg>
        <pc:spChg chg="add mod">
          <ac:chgData name="Mendoza Valderrey, Alberto" userId="3ca0a5ef-cfc6-4d76-a1eb-aa1d46514f4a" providerId="ADAL" clId="{4F8E51F9-E0E7-4E38-A829-33EDC4CC36D3}" dt="2024-02-01T00:53:31.204" v="2566" actId="1037"/>
          <ac:spMkLst>
            <pc:docMk/>
            <pc:sldMk cId="1652852917" sldId="256"/>
            <ac:spMk id="131" creationId="{46DEEB54-6EDB-3D60-C723-7032B2CC7C50}"/>
          </ac:spMkLst>
        </pc:spChg>
        <pc:spChg chg="add mod">
          <ac:chgData name="Mendoza Valderrey, Alberto" userId="3ca0a5ef-cfc6-4d76-a1eb-aa1d46514f4a" providerId="ADAL" clId="{4F8E51F9-E0E7-4E38-A829-33EDC4CC36D3}" dt="2024-02-01T00:53:31.204" v="2566" actId="1037"/>
          <ac:spMkLst>
            <pc:docMk/>
            <pc:sldMk cId="1652852917" sldId="256"/>
            <ac:spMk id="132" creationId="{3894A5DF-6CE8-DC1B-55B1-60A3E25850BB}"/>
          </ac:spMkLst>
        </pc:spChg>
        <pc:spChg chg="add mod">
          <ac:chgData name="Mendoza Valderrey, Alberto" userId="3ca0a5ef-cfc6-4d76-a1eb-aa1d46514f4a" providerId="ADAL" clId="{4F8E51F9-E0E7-4E38-A829-33EDC4CC36D3}" dt="2024-02-01T00:54:23.038" v="2718" actId="14100"/>
          <ac:spMkLst>
            <pc:docMk/>
            <pc:sldMk cId="1652852917" sldId="256"/>
            <ac:spMk id="133" creationId="{899D7126-03F7-CA90-985B-BBB08ADF3C7C}"/>
          </ac:spMkLst>
        </pc:spChg>
        <pc:spChg chg="mod">
          <ac:chgData name="Mendoza Valderrey, Alberto" userId="3ca0a5ef-cfc6-4d76-a1eb-aa1d46514f4a" providerId="ADAL" clId="{4F8E51F9-E0E7-4E38-A829-33EDC4CC36D3}" dt="2024-02-01T00:56:16.132" v="2719"/>
          <ac:spMkLst>
            <pc:docMk/>
            <pc:sldMk cId="1652852917" sldId="256"/>
            <ac:spMk id="137" creationId="{5CDCA2BF-2925-0FA6-88B0-3C520AE0AF42}"/>
          </ac:spMkLst>
        </pc:spChg>
        <pc:spChg chg="mod">
          <ac:chgData name="Mendoza Valderrey, Alberto" userId="3ca0a5ef-cfc6-4d76-a1eb-aa1d46514f4a" providerId="ADAL" clId="{4F8E51F9-E0E7-4E38-A829-33EDC4CC36D3}" dt="2024-02-01T00:58:29.162" v="2813" actId="20577"/>
          <ac:spMkLst>
            <pc:docMk/>
            <pc:sldMk cId="1652852917" sldId="256"/>
            <ac:spMk id="142" creationId="{CA0623A0-8385-F3D5-57A6-71CE5BEBB256}"/>
          </ac:spMkLst>
        </pc:spChg>
        <pc:spChg chg="mod">
          <ac:chgData name="Mendoza Valderrey, Alberto" userId="3ca0a5ef-cfc6-4d76-a1eb-aa1d46514f4a" providerId="ADAL" clId="{4F8E51F9-E0E7-4E38-A829-33EDC4CC36D3}" dt="2024-02-01T00:58:20.925" v="2808" actId="20577"/>
          <ac:spMkLst>
            <pc:docMk/>
            <pc:sldMk cId="1652852917" sldId="256"/>
            <ac:spMk id="147" creationId="{57FA6B49-1C6E-6A4D-E9B1-8670E1CCA3DE}"/>
          </ac:spMkLst>
        </pc:spChg>
        <pc:spChg chg="mod">
          <ac:chgData name="Mendoza Valderrey, Alberto" userId="3ca0a5ef-cfc6-4d76-a1eb-aa1d46514f4a" providerId="ADAL" clId="{4F8E51F9-E0E7-4E38-A829-33EDC4CC36D3}" dt="2024-02-01T00:58:13.036" v="2803" actId="20577"/>
          <ac:spMkLst>
            <pc:docMk/>
            <pc:sldMk cId="1652852917" sldId="256"/>
            <ac:spMk id="152" creationId="{A23FC26A-033B-BDEA-993F-EF939674AE4E}"/>
          </ac:spMkLst>
        </pc:spChg>
        <pc:spChg chg="mod">
          <ac:chgData name="Mendoza Valderrey, Alberto" userId="3ca0a5ef-cfc6-4d76-a1eb-aa1d46514f4a" providerId="ADAL" clId="{4F8E51F9-E0E7-4E38-A829-33EDC4CC36D3}" dt="2024-02-01T00:59:33.376" v="2919" actId="20577"/>
          <ac:spMkLst>
            <pc:docMk/>
            <pc:sldMk cId="1652852917" sldId="256"/>
            <ac:spMk id="157" creationId="{551F5416-4AFE-CB2F-A657-0CCAA760D851}"/>
          </ac:spMkLst>
        </pc:spChg>
        <pc:spChg chg="mod">
          <ac:chgData name="Mendoza Valderrey, Alberto" userId="3ca0a5ef-cfc6-4d76-a1eb-aa1d46514f4a" providerId="ADAL" clId="{4F8E51F9-E0E7-4E38-A829-33EDC4CC36D3}" dt="2024-02-01T00:59:49.984" v="2924" actId="20577"/>
          <ac:spMkLst>
            <pc:docMk/>
            <pc:sldMk cId="1652852917" sldId="256"/>
            <ac:spMk id="162" creationId="{2FB70F50-B952-AEAE-F672-BB8F9ABB5400}"/>
          </ac:spMkLst>
        </pc:spChg>
        <pc:spChg chg="mod">
          <ac:chgData name="Mendoza Valderrey, Alberto" userId="3ca0a5ef-cfc6-4d76-a1eb-aa1d46514f4a" providerId="ADAL" clId="{4F8E51F9-E0E7-4E38-A829-33EDC4CC36D3}" dt="2024-02-01T00:59:55.689" v="2929" actId="20577"/>
          <ac:spMkLst>
            <pc:docMk/>
            <pc:sldMk cId="1652852917" sldId="256"/>
            <ac:spMk id="167" creationId="{6B91F3DB-3AC4-7B8F-FED6-A000706BAD08}"/>
          </ac:spMkLst>
        </pc:spChg>
        <pc:spChg chg="mod">
          <ac:chgData name="Mendoza Valderrey, Alberto" userId="3ca0a5ef-cfc6-4d76-a1eb-aa1d46514f4a" providerId="ADAL" clId="{4F8E51F9-E0E7-4E38-A829-33EDC4CC36D3}" dt="2024-02-01T01:00:19.034" v="2930"/>
          <ac:spMkLst>
            <pc:docMk/>
            <pc:sldMk cId="1652852917" sldId="256"/>
            <ac:spMk id="173" creationId="{944D71FC-2060-2BC4-8ACC-DFAEEE3AFB0A}"/>
          </ac:spMkLst>
        </pc:spChg>
        <pc:spChg chg="mod">
          <ac:chgData name="Mendoza Valderrey, Alberto" userId="3ca0a5ef-cfc6-4d76-a1eb-aa1d46514f4a" providerId="ADAL" clId="{4F8E51F9-E0E7-4E38-A829-33EDC4CC36D3}" dt="2024-02-01T01:00:19.034" v="2930"/>
          <ac:spMkLst>
            <pc:docMk/>
            <pc:sldMk cId="1652852917" sldId="256"/>
            <ac:spMk id="178" creationId="{EE8429AD-DF86-0AC7-A5A1-544873CBBD2B}"/>
          </ac:spMkLst>
        </pc:spChg>
        <pc:spChg chg="mod">
          <ac:chgData name="Mendoza Valderrey, Alberto" userId="3ca0a5ef-cfc6-4d76-a1eb-aa1d46514f4a" providerId="ADAL" clId="{4F8E51F9-E0E7-4E38-A829-33EDC4CC36D3}" dt="2024-02-01T01:00:19.034" v="2930"/>
          <ac:spMkLst>
            <pc:docMk/>
            <pc:sldMk cId="1652852917" sldId="256"/>
            <ac:spMk id="183" creationId="{727348AB-5E87-4BE7-3DE3-209C289CC165}"/>
          </ac:spMkLst>
        </pc:spChg>
        <pc:spChg chg="mod">
          <ac:chgData name="Mendoza Valderrey, Alberto" userId="3ca0a5ef-cfc6-4d76-a1eb-aa1d46514f4a" providerId="ADAL" clId="{4F8E51F9-E0E7-4E38-A829-33EDC4CC36D3}" dt="2024-02-01T01:01:17.789" v="3103" actId="20577"/>
          <ac:spMkLst>
            <pc:docMk/>
            <pc:sldMk cId="1652852917" sldId="256"/>
            <ac:spMk id="188" creationId="{EE86F4D6-C8F2-5A6D-9102-B9C88857EF45}"/>
          </ac:spMkLst>
        </pc:spChg>
        <pc:spChg chg="mod">
          <ac:chgData name="Mendoza Valderrey, Alberto" userId="3ca0a5ef-cfc6-4d76-a1eb-aa1d46514f4a" providerId="ADAL" clId="{4F8E51F9-E0E7-4E38-A829-33EDC4CC36D3}" dt="2024-02-01T01:01:13.006" v="3098" actId="20577"/>
          <ac:spMkLst>
            <pc:docMk/>
            <pc:sldMk cId="1652852917" sldId="256"/>
            <ac:spMk id="193" creationId="{07D95DF8-6167-4009-D415-2338E648A61B}"/>
          </ac:spMkLst>
        </pc:spChg>
        <pc:spChg chg="mod">
          <ac:chgData name="Mendoza Valderrey, Alberto" userId="3ca0a5ef-cfc6-4d76-a1eb-aa1d46514f4a" providerId="ADAL" clId="{4F8E51F9-E0E7-4E38-A829-33EDC4CC36D3}" dt="2024-02-01T01:01:08.584" v="3093" actId="20577"/>
          <ac:spMkLst>
            <pc:docMk/>
            <pc:sldMk cId="1652852917" sldId="256"/>
            <ac:spMk id="198" creationId="{E6AB1C3E-8924-9323-4084-C3AA7F2D44E7}"/>
          </ac:spMkLst>
        </pc:spChg>
        <pc:grpChg chg="mod">
          <ac:chgData name="Mendoza Valderrey, Alberto" userId="3ca0a5ef-cfc6-4d76-a1eb-aa1d46514f4a" providerId="ADAL" clId="{4F8E51F9-E0E7-4E38-A829-33EDC4CC36D3}" dt="2024-01-31T19:43:06.446" v="593" actId="1036"/>
          <ac:grpSpMkLst>
            <pc:docMk/>
            <pc:sldMk cId="1652852917" sldId="256"/>
            <ac:grpSpMk id="7" creationId="{E05EC9A2-2B42-71C9-BA72-1D0997B1172C}"/>
          </ac:grpSpMkLst>
        </pc:grpChg>
        <pc:grpChg chg="mod">
          <ac:chgData name="Mendoza Valderrey, Alberto" userId="3ca0a5ef-cfc6-4d76-a1eb-aa1d46514f4a" providerId="ADAL" clId="{4F8E51F9-E0E7-4E38-A829-33EDC4CC36D3}" dt="2024-02-01T01:02:41.111" v="3275" actId="1038"/>
          <ac:grpSpMkLst>
            <pc:docMk/>
            <pc:sldMk cId="1652852917" sldId="256"/>
            <ac:grpSpMk id="32" creationId="{6BCAB29C-F29F-823A-62BF-0CD59CBF7997}"/>
          </ac:grpSpMkLst>
        </pc:grpChg>
        <pc:grpChg chg="mod">
          <ac:chgData name="Mendoza Valderrey, Alberto" userId="3ca0a5ef-cfc6-4d76-a1eb-aa1d46514f4a" providerId="ADAL" clId="{4F8E51F9-E0E7-4E38-A829-33EDC4CC36D3}" dt="2024-02-01T01:01:50.115" v="3134" actId="1036"/>
          <ac:grpSpMkLst>
            <pc:docMk/>
            <pc:sldMk cId="1652852917" sldId="256"/>
            <ac:grpSpMk id="61" creationId="{0DD6CF78-2C29-9B48-135B-181959E65D89}"/>
          </ac:grpSpMkLst>
        </pc:grpChg>
        <pc:grpChg chg="mod">
          <ac:chgData name="Mendoza Valderrey, Alberto" userId="3ca0a5ef-cfc6-4d76-a1eb-aa1d46514f4a" providerId="ADAL" clId="{4F8E51F9-E0E7-4E38-A829-33EDC4CC36D3}" dt="2024-02-01T01:01:41.404" v="3110" actId="1035"/>
          <ac:grpSpMkLst>
            <pc:docMk/>
            <pc:sldMk cId="1652852917" sldId="256"/>
            <ac:grpSpMk id="86" creationId="{655CA869-85E8-C450-B8E0-6C84644980DF}"/>
          </ac:grpSpMkLst>
        </pc:grpChg>
        <pc:grpChg chg="add del mod">
          <ac:chgData name="Mendoza Valderrey, Alberto" userId="3ca0a5ef-cfc6-4d76-a1eb-aa1d46514f4a" providerId="ADAL" clId="{4F8E51F9-E0E7-4E38-A829-33EDC4CC36D3}" dt="2024-02-01T00:56:21.512" v="2722"/>
          <ac:grpSpMkLst>
            <pc:docMk/>
            <pc:sldMk cId="1652852917" sldId="256"/>
            <ac:grpSpMk id="134" creationId="{00C16FA6-04B4-5A3C-CC33-063AF8F8A35E}"/>
          </ac:grpSpMkLst>
        </pc:grpChg>
        <pc:grpChg chg="add mod">
          <ac:chgData name="Mendoza Valderrey, Alberto" userId="3ca0a5ef-cfc6-4d76-a1eb-aa1d46514f4a" providerId="ADAL" clId="{4F8E51F9-E0E7-4E38-A829-33EDC4CC36D3}" dt="2024-02-01T00:57:23.129" v="2742" actId="1035"/>
          <ac:grpSpMkLst>
            <pc:docMk/>
            <pc:sldMk cId="1652852917" sldId="256"/>
            <ac:grpSpMk id="139" creationId="{4BA0F636-6CFC-3552-4CEB-036411A62CD1}"/>
          </ac:grpSpMkLst>
        </pc:grpChg>
        <pc:grpChg chg="add mod">
          <ac:chgData name="Mendoza Valderrey, Alberto" userId="3ca0a5ef-cfc6-4d76-a1eb-aa1d46514f4a" providerId="ADAL" clId="{4F8E51F9-E0E7-4E38-A829-33EDC4CC36D3}" dt="2024-02-01T00:58:37.679" v="2827" actId="1035"/>
          <ac:grpSpMkLst>
            <pc:docMk/>
            <pc:sldMk cId="1652852917" sldId="256"/>
            <ac:grpSpMk id="144" creationId="{F96FA203-9FB2-B3F2-337E-AFD876982F13}"/>
          </ac:grpSpMkLst>
        </pc:grpChg>
        <pc:grpChg chg="add mod">
          <ac:chgData name="Mendoza Valderrey, Alberto" userId="3ca0a5ef-cfc6-4d76-a1eb-aa1d46514f4a" providerId="ADAL" clId="{4F8E51F9-E0E7-4E38-A829-33EDC4CC36D3}" dt="2024-02-01T00:57:30.463" v="2757" actId="1035"/>
          <ac:grpSpMkLst>
            <pc:docMk/>
            <pc:sldMk cId="1652852917" sldId="256"/>
            <ac:grpSpMk id="149" creationId="{9A225F7F-CDFC-5A99-13C9-8ABB166A0A6B}"/>
          </ac:grpSpMkLst>
        </pc:grpChg>
        <pc:grpChg chg="add mod">
          <ac:chgData name="Mendoza Valderrey, Alberto" userId="3ca0a5ef-cfc6-4d76-a1eb-aa1d46514f4a" providerId="ADAL" clId="{4F8E51F9-E0E7-4E38-A829-33EDC4CC36D3}" dt="2024-02-01T00:59:04.067" v="2905" actId="1036"/>
          <ac:grpSpMkLst>
            <pc:docMk/>
            <pc:sldMk cId="1652852917" sldId="256"/>
            <ac:grpSpMk id="154" creationId="{F2A425CA-BAC6-A31C-40CF-3BDB9E5DC983}"/>
          </ac:grpSpMkLst>
        </pc:grpChg>
        <pc:grpChg chg="add mod">
          <ac:chgData name="Mendoza Valderrey, Alberto" userId="3ca0a5ef-cfc6-4d76-a1eb-aa1d46514f4a" providerId="ADAL" clId="{4F8E51F9-E0E7-4E38-A829-33EDC4CC36D3}" dt="2024-02-01T00:59:04.067" v="2905" actId="1036"/>
          <ac:grpSpMkLst>
            <pc:docMk/>
            <pc:sldMk cId="1652852917" sldId="256"/>
            <ac:grpSpMk id="159" creationId="{471624AF-EF57-729C-3589-50B5D77CE4F4}"/>
          </ac:grpSpMkLst>
        </pc:grpChg>
        <pc:grpChg chg="add mod">
          <ac:chgData name="Mendoza Valderrey, Alberto" userId="3ca0a5ef-cfc6-4d76-a1eb-aa1d46514f4a" providerId="ADAL" clId="{4F8E51F9-E0E7-4E38-A829-33EDC4CC36D3}" dt="2024-02-01T00:59:04.067" v="2905" actId="1036"/>
          <ac:grpSpMkLst>
            <pc:docMk/>
            <pc:sldMk cId="1652852917" sldId="256"/>
            <ac:grpSpMk id="164" creationId="{3B568FAD-CB87-689B-5B56-CA7F4339D59B}"/>
          </ac:grpSpMkLst>
        </pc:grpChg>
        <pc:grpChg chg="add del mod">
          <ac:chgData name="Mendoza Valderrey, Alberto" userId="3ca0a5ef-cfc6-4d76-a1eb-aa1d46514f4a" providerId="ADAL" clId="{4F8E51F9-E0E7-4E38-A829-33EDC4CC36D3}" dt="2024-02-01T01:00:21.093" v="2931"/>
          <ac:grpSpMkLst>
            <pc:docMk/>
            <pc:sldMk cId="1652852917" sldId="256"/>
            <ac:grpSpMk id="170" creationId="{32111ADF-8166-C5FC-8574-A8EEA28BEC63}"/>
          </ac:grpSpMkLst>
        </pc:grpChg>
        <pc:grpChg chg="add del mod">
          <ac:chgData name="Mendoza Valderrey, Alberto" userId="3ca0a5ef-cfc6-4d76-a1eb-aa1d46514f4a" providerId="ADAL" clId="{4F8E51F9-E0E7-4E38-A829-33EDC4CC36D3}" dt="2024-02-01T01:00:21.093" v="2931"/>
          <ac:grpSpMkLst>
            <pc:docMk/>
            <pc:sldMk cId="1652852917" sldId="256"/>
            <ac:grpSpMk id="175" creationId="{734ACF9D-6FF8-6CBC-D9F7-7894AB5FCCCA}"/>
          </ac:grpSpMkLst>
        </pc:grpChg>
        <pc:grpChg chg="add del mod">
          <ac:chgData name="Mendoza Valderrey, Alberto" userId="3ca0a5ef-cfc6-4d76-a1eb-aa1d46514f4a" providerId="ADAL" clId="{4F8E51F9-E0E7-4E38-A829-33EDC4CC36D3}" dt="2024-02-01T01:00:21.093" v="2931"/>
          <ac:grpSpMkLst>
            <pc:docMk/>
            <pc:sldMk cId="1652852917" sldId="256"/>
            <ac:grpSpMk id="180" creationId="{7EE5344F-291F-61C8-7C71-9D99B44F38A3}"/>
          </ac:grpSpMkLst>
        </pc:grpChg>
        <pc:grpChg chg="add mod">
          <ac:chgData name="Mendoza Valderrey, Alberto" userId="3ca0a5ef-cfc6-4d76-a1eb-aa1d46514f4a" providerId="ADAL" clId="{4F8E51F9-E0E7-4E38-A829-33EDC4CC36D3}" dt="2024-02-01T01:01:01.661" v="3088" actId="1035"/>
          <ac:grpSpMkLst>
            <pc:docMk/>
            <pc:sldMk cId="1652852917" sldId="256"/>
            <ac:grpSpMk id="185" creationId="{3A1BF420-5263-1036-5134-2CC18B38C732}"/>
          </ac:grpSpMkLst>
        </pc:grpChg>
        <pc:grpChg chg="add mod">
          <ac:chgData name="Mendoza Valderrey, Alberto" userId="3ca0a5ef-cfc6-4d76-a1eb-aa1d46514f4a" providerId="ADAL" clId="{4F8E51F9-E0E7-4E38-A829-33EDC4CC36D3}" dt="2024-02-01T01:01:01.661" v="3088" actId="1035"/>
          <ac:grpSpMkLst>
            <pc:docMk/>
            <pc:sldMk cId="1652852917" sldId="256"/>
            <ac:grpSpMk id="190" creationId="{D24E710B-FA31-42EF-423B-427E4E089274}"/>
          </ac:grpSpMkLst>
        </pc:grpChg>
        <pc:grpChg chg="add mod">
          <ac:chgData name="Mendoza Valderrey, Alberto" userId="3ca0a5ef-cfc6-4d76-a1eb-aa1d46514f4a" providerId="ADAL" clId="{4F8E51F9-E0E7-4E38-A829-33EDC4CC36D3}" dt="2024-02-01T01:01:01.661" v="3088" actId="1035"/>
          <ac:grpSpMkLst>
            <pc:docMk/>
            <pc:sldMk cId="1652852917" sldId="256"/>
            <ac:grpSpMk id="195" creationId="{32BAA8C6-3560-6A2D-B4F7-90AFFA9D1894}"/>
          </ac:grpSpMkLst>
        </pc:grpChg>
        <pc:picChg chg="add mod modCrop">
          <ac:chgData name="Mendoza Valderrey, Alberto" userId="3ca0a5ef-cfc6-4d76-a1eb-aa1d46514f4a" providerId="ADAL" clId="{4F8E51F9-E0E7-4E38-A829-33EDC4CC36D3}" dt="2024-02-01T01:01:30.627" v="3106" actId="2085"/>
          <ac:picMkLst>
            <pc:docMk/>
            <pc:sldMk cId="1652852917" sldId="256"/>
            <ac:picMk id="2" creationId="{0513F2E9-1E7F-5CA1-D084-18049EB7A9A7}"/>
          </ac:picMkLst>
        </pc:picChg>
        <pc:picChg chg="add mod modCrop">
          <ac:chgData name="Mendoza Valderrey, Alberto" userId="3ca0a5ef-cfc6-4d76-a1eb-aa1d46514f4a" providerId="ADAL" clId="{4F8E51F9-E0E7-4E38-A829-33EDC4CC36D3}" dt="2024-02-01T01:01:27.411" v="3104" actId="2085"/>
          <ac:picMkLst>
            <pc:docMk/>
            <pc:sldMk cId="1652852917" sldId="256"/>
            <ac:picMk id="3" creationId="{3E23A3DE-0302-51A0-B5DA-7137844EC082}"/>
          </ac:picMkLst>
        </pc:picChg>
        <pc:picChg chg="mod">
          <ac:chgData name="Mendoza Valderrey, Alberto" userId="3ca0a5ef-cfc6-4d76-a1eb-aa1d46514f4a" providerId="ADAL" clId="{4F8E51F9-E0E7-4E38-A829-33EDC4CC36D3}" dt="2024-01-31T19:43:06.446" v="593" actId="1036"/>
          <ac:picMkLst>
            <pc:docMk/>
            <pc:sldMk cId="1652852917" sldId="256"/>
            <ac:picMk id="5" creationId="{8B145BCA-AE18-5133-6282-08511FC202D2}"/>
          </ac:picMkLst>
        </pc:picChg>
        <pc:picChg chg="mod">
          <ac:chgData name="Mendoza Valderrey, Alberto" userId="3ca0a5ef-cfc6-4d76-a1eb-aa1d46514f4a" providerId="ADAL" clId="{4F8E51F9-E0E7-4E38-A829-33EDC4CC36D3}" dt="2024-02-01T00:56:19.064" v="2721" actId="1076"/>
          <ac:picMkLst>
            <pc:docMk/>
            <pc:sldMk cId="1652852917" sldId="256"/>
            <ac:picMk id="23" creationId="{9B5ABF52-3CB8-4DBD-1780-A5D933412A31}"/>
          </ac:picMkLst>
        </pc:picChg>
        <pc:picChg chg="add mod modCrop">
          <ac:chgData name="Mendoza Valderrey, Alberto" userId="3ca0a5ef-cfc6-4d76-a1eb-aa1d46514f4a" providerId="ADAL" clId="{4F8E51F9-E0E7-4E38-A829-33EDC4CC36D3}" dt="2024-02-01T01:01:28.956" v="3105" actId="2085"/>
          <ac:picMkLst>
            <pc:docMk/>
            <pc:sldMk cId="1652852917" sldId="256"/>
            <ac:picMk id="39" creationId="{CCC6D441-1674-7A27-CDD1-9E7B784723CE}"/>
          </ac:picMkLst>
        </pc:picChg>
        <pc:picChg chg="mod">
          <ac:chgData name="Mendoza Valderrey, Alberto" userId="3ca0a5ef-cfc6-4d76-a1eb-aa1d46514f4a" providerId="ADAL" clId="{4F8E51F9-E0E7-4E38-A829-33EDC4CC36D3}" dt="2024-01-31T19:43:11.805" v="601" actId="1036"/>
          <ac:picMkLst>
            <pc:docMk/>
            <pc:sldMk cId="1652852917" sldId="256"/>
            <ac:picMk id="41" creationId="{114FF8DD-AD8F-CF7C-DE3F-E08DFC992624}"/>
          </ac:picMkLst>
        </pc:picChg>
        <pc:picChg chg="mod">
          <ac:chgData name="Mendoza Valderrey, Alberto" userId="3ca0a5ef-cfc6-4d76-a1eb-aa1d46514f4a" providerId="ADAL" clId="{4F8E51F9-E0E7-4E38-A829-33EDC4CC36D3}" dt="2024-01-31T19:40:29.966" v="386" actId="1037"/>
          <ac:picMkLst>
            <pc:docMk/>
            <pc:sldMk cId="1652852917" sldId="256"/>
            <ac:picMk id="52" creationId="{FEA76DBD-1CB5-E229-6EC1-7E413DD3F5E0}"/>
          </ac:picMkLst>
        </pc:picChg>
        <pc:picChg chg="mod">
          <ac:chgData name="Mendoza Valderrey, Alberto" userId="3ca0a5ef-cfc6-4d76-a1eb-aa1d46514f4a" providerId="ADAL" clId="{4F8E51F9-E0E7-4E38-A829-33EDC4CC36D3}" dt="2024-01-31T19:40:50.733" v="423" actId="1036"/>
          <ac:picMkLst>
            <pc:docMk/>
            <pc:sldMk cId="1652852917" sldId="256"/>
            <ac:picMk id="76" creationId="{8CE53928-3F9E-3EB8-5FB5-C84D04AC05D5}"/>
          </ac:picMkLst>
        </pc:picChg>
        <pc:picChg chg="mod">
          <ac:chgData name="Mendoza Valderrey, Alberto" userId="3ca0a5ef-cfc6-4d76-a1eb-aa1d46514f4a" providerId="ADAL" clId="{4F8E51F9-E0E7-4E38-A829-33EDC4CC36D3}" dt="2024-01-31T19:43:21.103" v="608" actId="1035"/>
          <ac:picMkLst>
            <pc:docMk/>
            <pc:sldMk cId="1652852917" sldId="256"/>
            <ac:picMk id="91" creationId="{3A34B4F1-C1EC-DC51-F88D-981EE7CFB14B}"/>
          </ac:picMkLst>
        </pc:picChg>
        <pc:picChg chg="add del mod">
          <ac:chgData name="Mendoza Valderrey, Alberto" userId="3ca0a5ef-cfc6-4d76-a1eb-aa1d46514f4a" providerId="ADAL" clId="{4F8E51F9-E0E7-4E38-A829-33EDC4CC36D3}" dt="2024-02-01T01:00:21.093" v="2931"/>
          <ac:picMkLst>
            <pc:docMk/>
            <pc:sldMk cId="1652852917" sldId="256"/>
            <ac:picMk id="169" creationId="{65489BEB-0F28-75E0-D90E-416DFF20B121}"/>
          </ac:picMkLst>
        </pc:picChg>
        <pc:cxnChg chg="mod">
          <ac:chgData name="Mendoza Valderrey, Alberto" userId="3ca0a5ef-cfc6-4d76-a1eb-aa1d46514f4a" providerId="ADAL" clId="{4F8E51F9-E0E7-4E38-A829-33EDC4CC36D3}" dt="2024-02-01T01:03:21.074" v="3301" actId="1036"/>
          <ac:cxnSpMkLst>
            <pc:docMk/>
            <pc:sldMk cId="1652852917" sldId="256"/>
            <ac:cxnSpMk id="9" creationId="{B42FDA5E-A7D9-3628-07D2-4B575AD45955}"/>
          </ac:cxnSpMkLst>
        </pc:cxnChg>
        <pc:cxnChg chg="mod">
          <ac:chgData name="Mendoza Valderrey, Alberto" userId="3ca0a5ef-cfc6-4d76-a1eb-aa1d46514f4a" providerId="ADAL" clId="{4F8E51F9-E0E7-4E38-A829-33EDC4CC36D3}" dt="2024-02-01T01:03:21.074" v="3301" actId="1036"/>
          <ac:cxnSpMkLst>
            <pc:docMk/>
            <pc:sldMk cId="1652852917" sldId="256"/>
            <ac:cxnSpMk id="10" creationId="{E91557CA-E2B8-27DA-56C7-B6D87F57B40E}"/>
          </ac:cxnSpMkLst>
        </pc:cxnChg>
        <pc:cxnChg chg="mod">
          <ac:chgData name="Mendoza Valderrey, Alberto" userId="3ca0a5ef-cfc6-4d76-a1eb-aa1d46514f4a" providerId="ADAL" clId="{4F8E51F9-E0E7-4E38-A829-33EDC4CC36D3}" dt="2024-02-01T01:03:59.569" v="3328" actId="1036"/>
          <ac:cxnSpMkLst>
            <pc:docMk/>
            <pc:sldMk cId="1652852917" sldId="256"/>
            <ac:cxnSpMk id="49" creationId="{201C8F08-5455-7CCD-9DAC-70B5A972EB78}"/>
          </ac:cxnSpMkLst>
        </pc:cxnChg>
        <pc:cxnChg chg="mod">
          <ac:chgData name="Mendoza Valderrey, Alberto" userId="3ca0a5ef-cfc6-4d76-a1eb-aa1d46514f4a" providerId="ADAL" clId="{4F8E51F9-E0E7-4E38-A829-33EDC4CC36D3}" dt="2024-02-01T01:03:59.569" v="3328" actId="1036"/>
          <ac:cxnSpMkLst>
            <pc:docMk/>
            <pc:sldMk cId="1652852917" sldId="256"/>
            <ac:cxnSpMk id="50" creationId="{172FC20E-3AC1-94AD-B912-6C7B41AA8257}"/>
          </ac:cxnSpMkLst>
        </pc:cxnChg>
        <pc:cxnChg chg="mod">
          <ac:chgData name="Mendoza Valderrey, Alberto" userId="3ca0a5ef-cfc6-4d76-a1eb-aa1d46514f4a" providerId="ADAL" clId="{4F8E51F9-E0E7-4E38-A829-33EDC4CC36D3}" dt="2024-02-01T01:04:23.256" v="3340" actId="1036"/>
          <ac:cxnSpMkLst>
            <pc:docMk/>
            <pc:sldMk cId="1652852917" sldId="256"/>
            <ac:cxnSpMk id="93" creationId="{DB375F48-B7F3-481D-EFD1-C6DF37B7285C}"/>
          </ac:cxnSpMkLst>
        </pc:cxnChg>
        <pc:cxnChg chg="mod">
          <ac:chgData name="Mendoza Valderrey, Alberto" userId="3ca0a5ef-cfc6-4d76-a1eb-aa1d46514f4a" providerId="ADAL" clId="{4F8E51F9-E0E7-4E38-A829-33EDC4CC36D3}" dt="2024-02-01T01:04:23.256" v="3340" actId="1036"/>
          <ac:cxnSpMkLst>
            <pc:docMk/>
            <pc:sldMk cId="1652852917" sldId="256"/>
            <ac:cxnSpMk id="94" creationId="{BDFAA0D9-125F-6F6E-52B1-F897C4D8B96F}"/>
          </ac:cxnSpMkLst>
        </pc:cxnChg>
        <pc:cxnChg chg="mod">
          <ac:chgData name="Mendoza Valderrey, Alberto" userId="3ca0a5ef-cfc6-4d76-a1eb-aa1d46514f4a" providerId="ADAL" clId="{4F8E51F9-E0E7-4E38-A829-33EDC4CC36D3}" dt="2024-02-01T00:56:16.132" v="2719"/>
          <ac:cxnSpMkLst>
            <pc:docMk/>
            <pc:sldMk cId="1652852917" sldId="256"/>
            <ac:cxnSpMk id="135" creationId="{940A341B-E9B1-E06F-99BB-780997B0E9A8}"/>
          </ac:cxnSpMkLst>
        </pc:cxnChg>
        <pc:cxnChg chg="mod">
          <ac:chgData name="Mendoza Valderrey, Alberto" userId="3ca0a5ef-cfc6-4d76-a1eb-aa1d46514f4a" providerId="ADAL" clId="{4F8E51F9-E0E7-4E38-A829-33EDC4CC36D3}" dt="2024-02-01T00:56:16.132" v="2719"/>
          <ac:cxnSpMkLst>
            <pc:docMk/>
            <pc:sldMk cId="1652852917" sldId="256"/>
            <ac:cxnSpMk id="136" creationId="{F47DB69B-32FE-48D7-0D35-89FF0C8BF7EF}"/>
          </ac:cxnSpMkLst>
        </pc:cxnChg>
        <pc:cxnChg chg="mod">
          <ac:chgData name="Mendoza Valderrey, Alberto" userId="3ca0a5ef-cfc6-4d76-a1eb-aa1d46514f4a" providerId="ADAL" clId="{4F8E51F9-E0E7-4E38-A829-33EDC4CC36D3}" dt="2024-02-01T00:56:16.132" v="2719"/>
          <ac:cxnSpMkLst>
            <pc:docMk/>
            <pc:sldMk cId="1652852917" sldId="256"/>
            <ac:cxnSpMk id="138" creationId="{23EA596F-05A6-C44F-11A0-067AA2231B5F}"/>
          </ac:cxnSpMkLst>
        </pc:cxnChg>
        <pc:cxnChg chg="mod">
          <ac:chgData name="Mendoza Valderrey, Alberto" userId="3ca0a5ef-cfc6-4d76-a1eb-aa1d46514f4a" providerId="ADAL" clId="{4F8E51F9-E0E7-4E38-A829-33EDC4CC36D3}" dt="2024-02-01T00:56:32.051" v="2723"/>
          <ac:cxnSpMkLst>
            <pc:docMk/>
            <pc:sldMk cId="1652852917" sldId="256"/>
            <ac:cxnSpMk id="140" creationId="{C7B339BD-CDE9-2BCD-0840-4D7F8BC31B2E}"/>
          </ac:cxnSpMkLst>
        </pc:cxnChg>
        <pc:cxnChg chg="mod">
          <ac:chgData name="Mendoza Valderrey, Alberto" userId="3ca0a5ef-cfc6-4d76-a1eb-aa1d46514f4a" providerId="ADAL" clId="{4F8E51F9-E0E7-4E38-A829-33EDC4CC36D3}" dt="2024-02-01T00:56:32.051" v="2723"/>
          <ac:cxnSpMkLst>
            <pc:docMk/>
            <pc:sldMk cId="1652852917" sldId="256"/>
            <ac:cxnSpMk id="141" creationId="{E0AC6F3B-FCA6-66D8-AF40-BAD139410C6B}"/>
          </ac:cxnSpMkLst>
        </pc:cxnChg>
        <pc:cxnChg chg="mod">
          <ac:chgData name="Mendoza Valderrey, Alberto" userId="3ca0a5ef-cfc6-4d76-a1eb-aa1d46514f4a" providerId="ADAL" clId="{4F8E51F9-E0E7-4E38-A829-33EDC4CC36D3}" dt="2024-02-01T00:56:32.051" v="2723"/>
          <ac:cxnSpMkLst>
            <pc:docMk/>
            <pc:sldMk cId="1652852917" sldId="256"/>
            <ac:cxnSpMk id="143" creationId="{990BE57F-ED32-BD11-2135-C8730023E2DD}"/>
          </ac:cxnSpMkLst>
        </pc:cxnChg>
        <pc:cxnChg chg="mod">
          <ac:chgData name="Mendoza Valderrey, Alberto" userId="3ca0a5ef-cfc6-4d76-a1eb-aa1d46514f4a" providerId="ADAL" clId="{4F8E51F9-E0E7-4E38-A829-33EDC4CC36D3}" dt="2024-02-01T00:56:55.239" v="2730"/>
          <ac:cxnSpMkLst>
            <pc:docMk/>
            <pc:sldMk cId="1652852917" sldId="256"/>
            <ac:cxnSpMk id="145" creationId="{F3A9CDCE-4B86-EE33-09F7-509486F54866}"/>
          </ac:cxnSpMkLst>
        </pc:cxnChg>
        <pc:cxnChg chg="mod">
          <ac:chgData name="Mendoza Valderrey, Alberto" userId="3ca0a5ef-cfc6-4d76-a1eb-aa1d46514f4a" providerId="ADAL" clId="{4F8E51F9-E0E7-4E38-A829-33EDC4CC36D3}" dt="2024-02-01T00:56:55.239" v="2730"/>
          <ac:cxnSpMkLst>
            <pc:docMk/>
            <pc:sldMk cId="1652852917" sldId="256"/>
            <ac:cxnSpMk id="146" creationId="{1E17A6A9-F8DB-FB58-4510-0B8BDB9A3CDF}"/>
          </ac:cxnSpMkLst>
        </pc:cxnChg>
        <pc:cxnChg chg="mod">
          <ac:chgData name="Mendoza Valderrey, Alberto" userId="3ca0a5ef-cfc6-4d76-a1eb-aa1d46514f4a" providerId="ADAL" clId="{4F8E51F9-E0E7-4E38-A829-33EDC4CC36D3}" dt="2024-02-01T00:56:55.239" v="2730"/>
          <ac:cxnSpMkLst>
            <pc:docMk/>
            <pc:sldMk cId="1652852917" sldId="256"/>
            <ac:cxnSpMk id="148" creationId="{1A3A42C7-36F2-6F4B-2233-2A815B446025}"/>
          </ac:cxnSpMkLst>
        </pc:cxnChg>
        <pc:cxnChg chg="mod">
          <ac:chgData name="Mendoza Valderrey, Alberto" userId="3ca0a5ef-cfc6-4d76-a1eb-aa1d46514f4a" providerId="ADAL" clId="{4F8E51F9-E0E7-4E38-A829-33EDC4CC36D3}" dt="2024-02-01T00:57:09.348" v="2733"/>
          <ac:cxnSpMkLst>
            <pc:docMk/>
            <pc:sldMk cId="1652852917" sldId="256"/>
            <ac:cxnSpMk id="150" creationId="{8B6FA76A-8F12-CCA4-B91D-0FDCA04B1647}"/>
          </ac:cxnSpMkLst>
        </pc:cxnChg>
        <pc:cxnChg chg="mod">
          <ac:chgData name="Mendoza Valderrey, Alberto" userId="3ca0a5ef-cfc6-4d76-a1eb-aa1d46514f4a" providerId="ADAL" clId="{4F8E51F9-E0E7-4E38-A829-33EDC4CC36D3}" dt="2024-02-01T00:57:09.348" v="2733"/>
          <ac:cxnSpMkLst>
            <pc:docMk/>
            <pc:sldMk cId="1652852917" sldId="256"/>
            <ac:cxnSpMk id="151" creationId="{DB6100D5-DEB3-2DCC-351B-F4AE9CD90904}"/>
          </ac:cxnSpMkLst>
        </pc:cxnChg>
        <pc:cxnChg chg="mod">
          <ac:chgData name="Mendoza Valderrey, Alberto" userId="3ca0a5ef-cfc6-4d76-a1eb-aa1d46514f4a" providerId="ADAL" clId="{4F8E51F9-E0E7-4E38-A829-33EDC4CC36D3}" dt="2024-02-01T00:57:09.348" v="2733"/>
          <ac:cxnSpMkLst>
            <pc:docMk/>
            <pc:sldMk cId="1652852917" sldId="256"/>
            <ac:cxnSpMk id="153" creationId="{D2C41EA2-B2A7-7BD6-385C-5A75039C46FC}"/>
          </ac:cxnSpMkLst>
        </pc:cxnChg>
        <pc:cxnChg chg="mod">
          <ac:chgData name="Mendoza Valderrey, Alberto" userId="3ca0a5ef-cfc6-4d76-a1eb-aa1d46514f4a" providerId="ADAL" clId="{4F8E51F9-E0E7-4E38-A829-33EDC4CC36D3}" dt="2024-02-01T00:58:48.949" v="2828"/>
          <ac:cxnSpMkLst>
            <pc:docMk/>
            <pc:sldMk cId="1652852917" sldId="256"/>
            <ac:cxnSpMk id="155" creationId="{4292F934-93D8-9237-0600-457BD6956767}"/>
          </ac:cxnSpMkLst>
        </pc:cxnChg>
        <pc:cxnChg chg="mod">
          <ac:chgData name="Mendoza Valderrey, Alberto" userId="3ca0a5ef-cfc6-4d76-a1eb-aa1d46514f4a" providerId="ADAL" clId="{4F8E51F9-E0E7-4E38-A829-33EDC4CC36D3}" dt="2024-02-01T00:58:48.949" v="2828"/>
          <ac:cxnSpMkLst>
            <pc:docMk/>
            <pc:sldMk cId="1652852917" sldId="256"/>
            <ac:cxnSpMk id="156" creationId="{C1FC8711-A296-9FBC-5C32-3891DB8E5D0A}"/>
          </ac:cxnSpMkLst>
        </pc:cxnChg>
        <pc:cxnChg chg="mod">
          <ac:chgData name="Mendoza Valderrey, Alberto" userId="3ca0a5ef-cfc6-4d76-a1eb-aa1d46514f4a" providerId="ADAL" clId="{4F8E51F9-E0E7-4E38-A829-33EDC4CC36D3}" dt="2024-02-01T00:58:48.949" v="2828"/>
          <ac:cxnSpMkLst>
            <pc:docMk/>
            <pc:sldMk cId="1652852917" sldId="256"/>
            <ac:cxnSpMk id="158" creationId="{802A9F2C-CCF6-9A67-156D-1639F3D67D72}"/>
          </ac:cxnSpMkLst>
        </pc:cxnChg>
        <pc:cxnChg chg="mod">
          <ac:chgData name="Mendoza Valderrey, Alberto" userId="3ca0a5ef-cfc6-4d76-a1eb-aa1d46514f4a" providerId="ADAL" clId="{4F8E51F9-E0E7-4E38-A829-33EDC4CC36D3}" dt="2024-02-01T00:58:48.949" v="2828"/>
          <ac:cxnSpMkLst>
            <pc:docMk/>
            <pc:sldMk cId="1652852917" sldId="256"/>
            <ac:cxnSpMk id="160" creationId="{2659FA2E-A6A4-E2D4-9E9D-4BF1AB1529BD}"/>
          </ac:cxnSpMkLst>
        </pc:cxnChg>
        <pc:cxnChg chg="mod">
          <ac:chgData name="Mendoza Valderrey, Alberto" userId="3ca0a5ef-cfc6-4d76-a1eb-aa1d46514f4a" providerId="ADAL" clId="{4F8E51F9-E0E7-4E38-A829-33EDC4CC36D3}" dt="2024-02-01T00:58:48.949" v="2828"/>
          <ac:cxnSpMkLst>
            <pc:docMk/>
            <pc:sldMk cId="1652852917" sldId="256"/>
            <ac:cxnSpMk id="161" creationId="{7FCA83A8-245C-A5FB-830F-E60FB0390988}"/>
          </ac:cxnSpMkLst>
        </pc:cxnChg>
        <pc:cxnChg chg="mod">
          <ac:chgData name="Mendoza Valderrey, Alberto" userId="3ca0a5ef-cfc6-4d76-a1eb-aa1d46514f4a" providerId="ADAL" clId="{4F8E51F9-E0E7-4E38-A829-33EDC4CC36D3}" dt="2024-02-01T00:58:48.949" v="2828"/>
          <ac:cxnSpMkLst>
            <pc:docMk/>
            <pc:sldMk cId="1652852917" sldId="256"/>
            <ac:cxnSpMk id="163" creationId="{6458D8D4-EAA0-F2AC-99CB-8D84EB556F09}"/>
          </ac:cxnSpMkLst>
        </pc:cxnChg>
        <pc:cxnChg chg="mod">
          <ac:chgData name="Mendoza Valderrey, Alberto" userId="3ca0a5ef-cfc6-4d76-a1eb-aa1d46514f4a" providerId="ADAL" clId="{4F8E51F9-E0E7-4E38-A829-33EDC4CC36D3}" dt="2024-02-01T00:58:48.949" v="2828"/>
          <ac:cxnSpMkLst>
            <pc:docMk/>
            <pc:sldMk cId="1652852917" sldId="256"/>
            <ac:cxnSpMk id="165" creationId="{EC4EE07D-4A9F-31BB-B858-562DB8E4B671}"/>
          </ac:cxnSpMkLst>
        </pc:cxnChg>
        <pc:cxnChg chg="mod">
          <ac:chgData name="Mendoza Valderrey, Alberto" userId="3ca0a5ef-cfc6-4d76-a1eb-aa1d46514f4a" providerId="ADAL" clId="{4F8E51F9-E0E7-4E38-A829-33EDC4CC36D3}" dt="2024-02-01T00:58:48.949" v="2828"/>
          <ac:cxnSpMkLst>
            <pc:docMk/>
            <pc:sldMk cId="1652852917" sldId="256"/>
            <ac:cxnSpMk id="166" creationId="{94AD0231-7FCC-7553-731C-F97AAA4E852B}"/>
          </ac:cxnSpMkLst>
        </pc:cxnChg>
        <pc:cxnChg chg="mod">
          <ac:chgData name="Mendoza Valderrey, Alberto" userId="3ca0a5ef-cfc6-4d76-a1eb-aa1d46514f4a" providerId="ADAL" clId="{4F8E51F9-E0E7-4E38-A829-33EDC4CC36D3}" dt="2024-02-01T00:58:48.949" v="2828"/>
          <ac:cxnSpMkLst>
            <pc:docMk/>
            <pc:sldMk cId="1652852917" sldId="256"/>
            <ac:cxnSpMk id="168" creationId="{E077A079-8756-31B7-5952-B7E0A94E637A}"/>
          </ac:cxnSpMkLst>
        </pc:cxnChg>
        <pc:cxnChg chg="mod">
          <ac:chgData name="Mendoza Valderrey, Alberto" userId="3ca0a5ef-cfc6-4d76-a1eb-aa1d46514f4a" providerId="ADAL" clId="{4F8E51F9-E0E7-4E38-A829-33EDC4CC36D3}" dt="2024-02-01T01:00:19.034" v="2930"/>
          <ac:cxnSpMkLst>
            <pc:docMk/>
            <pc:sldMk cId="1652852917" sldId="256"/>
            <ac:cxnSpMk id="171" creationId="{02955B4D-7642-61AB-0569-D02AC156E939}"/>
          </ac:cxnSpMkLst>
        </pc:cxnChg>
        <pc:cxnChg chg="mod">
          <ac:chgData name="Mendoza Valderrey, Alberto" userId="3ca0a5ef-cfc6-4d76-a1eb-aa1d46514f4a" providerId="ADAL" clId="{4F8E51F9-E0E7-4E38-A829-33EDC4CC36D3}" dt="2024-02-01T01:00:19.034" v="2930"/>
          <ac:cxnSpMkLst>
            <pc:docMk/>
            <pc:sldMk cId="1652852917" sldId="256"/>
            <ac:cxnSpMk id="172" creationId="{606A12BC-63D4-7D4C-AE86-9F48C7857744}"/>
          </ac:cxnSpMkLst>
        </pc:cxnChg>
        <pc:cxnChg chg="mod">
          <ac:chgData name="Mendoza Valderrey, Alberto" userId="3ca0a5ef-cfc6-4d76-a1eb-aa1d46514f4a" providerId="ADAL" clId="{4F8E51F9-E0E7-4E38-A829-33EDC4CC36D3}" dt="2024-02-01T01:00:19.034" v="2930"/>
          <ac:cxnSpMkLst>
            <pc:docMk/>
            <pc:sldMk cId="1652852917" sldId="256"/>
            <ac:cxnSpMk id="174" creationId="{B82DE630-449B-05B9-0A09-A36D8FC1D6D8}"/>
          </ac:cxnSpMkLst>
        </pc:cxnChg>
        <pc:cxnChg chg="mod">
          <ac:chgData name="Mendoza Valderrey, Alberto" userId="3ca0a5ef-cfc6-4d76-a1eb-aa1d46514f4a" providerId="ADAL" clId="{4F8E51F9-E0E7-4E38-A829-33EDC4CC36D3}" dt="2024-02-01T01:00:19.034" v="2930"/>
          <ac:cxnSpMkLst>
            <pc:docMk/>
            <pc:sldMk cId="1652852917" sldId="256"/>
            <ac:cxnSpMk id="176" creationId="{AFFD5A4F-F999-3625-D808-EBDB843A3E50}"/>
          </ac:cxnSpMkLst>
        </pc:cxnChg>
        <pc:cxnChg chg="mod">
          <ac:chgData name="Mendoza Valderrey, Alberto" userId="3ca0a5ef-cfc6-4d76-a1eb-aa1d46514f4a" providerId="ADAL" clId="{4F8E51F9-E0E7-4E38-A829-33EDC4CC36D3}" dt="2024-02-01T01:00:19.034" v="2930"/>
          <ac:cxnSpMkLst>
            <pc:docMk/>
            <pc:sldMk cId="1652852917" sldId="256"/>
            <ac:cxnSpMk id="177" creationId="{7BD11155-082B-DDC9-7DC8-189C7124BFB5}"/>
          </ac:cxnSpMkLst>
        </pc:cxnChg>
        <pc:cxnChg chg="mod">
          <ac:chgData name="Mendoza Valderrey, Alberto" userId="3ca0a5ef-cfc6-4d76-a1eb-aa1d46514f4a" providerId="ADAL" clId="{4F8E51F9-E0E7-4E38-A829-33EDC4CC36D3}" dt="2024-02-01T01:00:19.034" v="2930"/>
          <ac:cxnSpMkLst>
            <pc:docMk/>
            <pc:sldMk cId="1652852917" sldId="256"/>
            <ac:cxnSpMk id="179" creationId="{60435274-6F93-30F3-F045-D324C3D342F2}"/>
          </ac:cxnSpMkLst>
        </pc:cxnChg>
        <pc:cxnChg chg="mod">
          <ac:chgData name="Mendoza Valderrey, Alberto" userId="3ca0a5ef-cfc6-4d76-a1eb-aa1d46514f4a" providerId="ADAL" clId="{4F8E51F9-E0E7-4E38-A829-33EDC4CC36D3}" dt="2024-02-01T01:00:19.034" v="2930"/>
          <ac:cxnSpMkLst>
            <pc:docMk/>
            <pc:sldMk cId="1652852917" sldId="256"/>
            <ac:cxnSpMk id="181" creationId="{F17AF5AF-5E51-D79B-AC75-44B2BAB5F44D}"/>
          </ac:cxnSpMkLst>
        </pc:cxnChg>
        <pc:cxnChg chg="mod">
          <ac:chgData name="Mendoza Valderrey, Alberto" userId="3ca0a5ef-cfc6-4d76-a1eb-aa1d46514f4a" providerId="ADAL" clId="{4F8E51F9-E0E7-4E38-A829-33EDC4CC36D3}" dt="2024-02-01T01:00:19.034" v="2930"/>
          <ac:cxnSpMkLst>
            <pc:docMk/>
            <pc:sldMk cId="1652852917" sldId="256"/>
            <ac:cxnSpMk id="182" creationId="{E368A0D9-8EEA-C6AB-8D2C-4FAAB563FAE1}"/>
          </ac:cxnSpMkLst>
        </pc:cxnChg>
        <pc:cxnChg chg="mod">
          <ac:chgData name="Mendoza Valderrey, Alberto" userId="3ca0a5ef-cfc6-4d76-a1eb-aa1d46514f4a" providerId="ADAL" clId="{4F8E51F9-E0E7-4E38-A829-33EDC4CC36D3}" dt="2024-02-01T01:00:19.034" v="2930"/>
          <ac:cxnSpMkLst>
            <pc:docMk/>
            <pc:sldMk cId="1652852917" sldId="256"/>
            <ac:cxnSpMk id="184" creationId="{99F103E7-EBA6-864A-448E-B981FD76BE56}"/>
          </ac:cxnSpMkLst>
        </pc:cxnChg>
        <pc:cxnChg chg="mod">
          <ac:chgData name="Mendoza Valderrey, Alberto" userId="3ca0a5ef-cfc6-4d76-a1eb-aa1d46514f4a" providerId="ADAL" clId="{4F8E51F9-E0E7-4E38-A829-33EDC4CC36D3}" dt="2024-02-01T01:00:28.284" v="2932"/>
          <ac:cxnSpMkLst>
            <pc:docMk/>
            <pc:sldMk cId="1652852917" sldId="256"/>
            <ac:cxnSpMk id="186" creationId="{1AD3664B-B1D9-A322-898A-B5DA9A1F2CDF}"/>
          </ac:cxnSpMkLst>
        </pc:cxnChg>
        <pc:cxnChg chg="mod">
          <ac:chgData name="Mendoza Valderrey, Alberto" userId="3ca0a5ef-cfc6-4d76-a1eb-aa1d46514f4a" providerId="ADAL" clId="{4F8E51F9-E0E7-4E38-A829-33EDC4CC36D3}" dt="2024-02-01T01:00:28.284" v="2932"/>
          <ac:cxnSpMkLst>
            <pc:docMk/>
            <pc:sldMk cId="1652852917" sldId="256"/>
            <ac:cxnSpMk id="187" creationId="{40CAE812-0BB9-B8A9-7B1A-4C6FDB25E0A6}"/>
          </ac:cxnSpMkLst>
        </pc:cxnChg>
        <pc:cxnChg chg="mod">
          <ac:chgData name="Mendoza Valderrey, Alberto" userId="3ca0a5ef-cfc6-4d76-a1eb-aa1d46514f4a" providerId="ADAL" clId="{4F8E51F9-E0E7-4E38-A829-33EDC4CC36D3}" dt="2024-02-01T01:00:28.284" v="2932"/>
          <ac:cxnSpMkLst>
            <pc:docMk/>
            <pc:sldMk cId="1652852917" sldId="256"/>
            <ac:cxnSpMk id="189" creationId="{192B650B-EC0E-F131-5D35-79A53D05DB38}"/>
          </ac:cxnSpMkLst>
        </pc:cxnChg>
        <pc:cxnChg chg="mod">
          <ac:chgData name="Mendoza Valderrey, Alberto" userId="3ca0a5ef-cfc6-4d76-a1eb-aa1d46514f4a" providerId="ADAL" clId="{4F8E51F9-E0E7-4E38-A829-33EDC4CC36D3}" dt="2024-02-01T01:00:28.284" v="2932"/>
          <ac:cxnSpMkLst>
            <pc:docMk/>
            <pc:sldMk cId="1652852917" sldId="256"/>
            <ac:cxnSpMk id="191" creationId="{53BC0B65-7726-B96B-6786-EEB7B3C1B75E}"/>
          </ac:cxnSpMkLst>
        </pc:cxnChg>
        <pc:cxnChg chg="mod">
          <ac:chgData name="Mendoza Valderrey, Alberto" userId="3ca0a5ef-cfc6-4d76-a1eb-aa1d46514f4a" providerId="ADAL" clId="{4F8E51F9-E0E7-4E38-A829-33EDC4CC36D3}" dt="2024-02-01T01:00:28.284" v="2932"/>
          <ac:cxnSpMkLst>
            <pc:docMk/>
            <pc:sldMk cId="1652852917" sldId="256"/>
            <ac:cxnSpMk id="192" creationId="{BD818F46-EF1B-E62E-1549-26A1DB23D61A}"/>
          </ac:cxnSpMkLst>
        </pc:cxnChg>
        <pc:cxnChg chg="mod">
          <ac:chgData name="Mendoza Valderrey, Alberto" userId="3ca0a5ef-cfc6-4d76-a1eb-aa1d46514f4a" providerId="ADAL" clId="{4F8E51F9-E0E7-4E38-A829-33EDC4CC36D3}" dt="2024-02-01T01:00:28.284" v="2932"/>
          <ac:cxnSpMkLst>
            <pc:docMk/>
            <pc:sldMk cId="1652852917" sldId="256"/>
            <ac:cxnSpMk id="194" creationId="{FD7BED06-CFDB-8073-B491-315C90FAACFB}"/>
          </ac:cxnSpMkLst>
        </pc:cxnChg>
        <pc:cxnChg chg="mod">
          <ac:chgData name="Mendoza Valderrey, Alberto" userId="3ca0a5ef-cfc6-4d76-a1eb-aa1d46514f4a" providerId="ADAL" clId="{4F8E51F9-E0E7-4E38-A829-33EDC4CC36D3}" dt="2024-02-01T01:00:28.284" v="2932"/>
          <ac:cxnSpMkLst>
            <pc:docMk/>
            <pc:sldMk cId="1652852917" sldId="256"/>
            <ac:cxnSpMk id="196" creationId="{08C8306B-927B-527F-C0A0-5DBBBC0817CE}"/>
          </ac:cxnSpMkLst>
        </pc:cxnChg>
        <pc:cxnChg chg="mod">
          <ac:chgData name="Mendoza Valderrey, Alberto" userId="3ca0a5ef-cfc6-4d76-a1eb-aa1d46514f4a" providerId="ADAL" clId="{4F8E51F9-E0E7-4E38-A829-33EDC4CC36D3}" dt="2024-02-01T01:00:28.284" v="2932"/>
          <ac:cxnSpMkLst>
            <pc:docMk/>
            <pc:sldMk cId="1652852917" sldId="256"/>
            <ac:cxnSpMk id="197" creationId="{1802D407-6048-13F9-67B3-7477959E798F}"/>
          </ac:cxnSpMkLst>
        </pc:cxnChg>
        <pc:cxnChg chg="mod">
          <ac:chgData name="Mendoza Valderrey, Alberto" userId="3ca0a5ef-cfc6-4d76-a1eb-aa1d46514f4a" providerId="ADAL" clId="{4F8E51F9-E0E7-4E38-A829-33EDC4CC36D3}" dt="2024-02-01T01:00:28.284" v="2932"/>
          <ac:cxnSpMkLst>
            <pc:docMk/>
            <pc:sldMk cId="1652852917" sldId="256"/>
            <ac:cxnSpMk id="199" creationId="{D598D6E5-F19A-367F-44AE-14BADD30A830}"/>
          </ac:cxnSpMkLst>
        </pc:cxnChg>
      </pc:sldChg>
      <pc:sldChg chg="addSp delSp modSp mod addCm">
        <pc:chgData name="Mendoza Valderrey, Alberto" userId="3ca0a5ef-cfc6-4d76-a1eb-aa1d46514f4a" providerId="ADAL" clId="{4F8E51F9-E0E7-4E38-A829-33EDC4CC36D3}" dt="2024-02-01T00:36:28.962" v="1517" actId="1035"/>
        <pc:sldMkLst>
          <pc:docMk/>
          <pc:sldMk cId="2030739124" sldId="257"/>
        </pc:sldMkLst>
        <pc:spChg chg="add mod">
          <ac:chgData name="Mendoza Valderrey, Alberto" userId="3ca0a5ef-cfc6-4d76-a1eb-aa1d46514f4a" providerId="ADAL" clId="{4F8E51F9-E0E7-4E38-A829-33EDC4CC36D3}" dt="2024-02-01T00:18:51.791" v="1353" actId="1036"/>
          <ac:spMkLst>
            <pc:docMk/>
            <pc:sldMk cId="2030739124" sldId="257"/>
            <ac:spMk id="3" creationId="{D46BCF73-42D5-6F32-F733-3EC1B096D956}"/>
          </ac:spMkLst>
        </pc:spChg>
        <pc:spChg chg="add mod">
          <ac:chgData name="Mendoza Valderrey, Alberto" userId="3ca0a5ef-cfc6-4d76-a1eb-aa1d46514f4a" providerId="ADAL" clId="{4F8E51F9-E0E7-4E38-A829-33EDC4CC36D3}" dt="2024-02-01T00:18:51.791" v="1353" actId="1036"/>
          <ac:spMkLst>
            <pc:docMk/>
            <pc:sldMk cId="2030739124" sldId="257"/>
            <ac:spMk id="5" creationId="{53C335B9-80BB-A590-C52F-1EB1E835F38D}"/>
          </ac:spMkLst>
        </pc:spChg>
        <pc:spChg chg="add mod">
          <ac:chgData name="Mendoza Valderrey, Alberto" userId="3ca0a5ef-cfc6-4d76-a1eb-aa1d46514f4a" providerId="ADAL" clId="{4F8E51F9-E0E7-4E38-A829-33EDC4CC36D3}" dt="2024-02-01T00:18:51.791" v="1353" actId="1036"/>
          <ac:spMkLst>
            <pc:docMk/>
            <pc:sldMk cId="2030739124" sldId="257"/>
            <ac:spMk id="6" creationId="{80428EE4-6EF3-BA5F-5995-915194F62523}"/>
          </ac:spMkLst>
        </pc:spChg>
        <pc:spChg chg="mod">
          <ac:chgData name="Mendoza Valderrey, Alberto" userId="3ca0a5ef-cfc6-4d76-a1eb-aa1d46514f4a" providerId="ADAL" clId="{4F8E51F9-E0E7-4E38-A829-33EDC4CC36D3}" dt="2024-01-31T23:51:37.284" v="780" actId="1038"/>
          <ac:spMkLst>
            <pc:docMk/>
            <pc:sldMk cId="2030739124" sldId="257"/>
            <ac:spMk id="7" creationId="{0FBE4CC9-90A4-484B-8F85-36578C3064C4}"/>
          </ac:spMkLst>
        </pc:spChg>
        <pc:spChg chg="mod">
          <ac:chgData name="Mendoza Valderrey, Alberto" userId="3ca0a5ef-cfc6-4d76-a1eb-aa1d46514f4a" providerId="ADAL" clId="{4F8E51F9-E0E7-4E38-A829-33EDC4CC36D3}" dt="2024-01-31T23:49:54.306" v="732" actId="1076"/>
          <ac:spMkLst>
            <pc:docMk/>
            <pc:sldMk cId="2030739124" sldId="257"/>
            <ac:spMk id="8" creationId="{41289B7C-7341-0F86-9218-E1A05BEBB806}"/>
          </ac:spMkLst>
        </pc:spChg>
        <pc:spChg chg="mod">
          <ac:chgData name="Mendoza Valderrey, Alberto" userId="3ca0a5ef-cfc6-4d76-a1eb-aa1d46514f4a" providerId="ADAL" clId="{4F8E51F9-E0E7-4E38-A829-33EDC4CC36D3}" dt="2024-01-31T23:49:58.891" v="733" actId="1076"/>
          <ac:spMkLst>
            <pc:docMk/>
            <pc:sldMk cId="2030739124" sldId="257"/>
            <ac:spMk id="9" creationId="{F08DF57D-3F56-43C7-1914-A39950F57411}"/>
          </ac:spMkLst>
        </pc:spChg>
        <pc:spChg chg="mod">
          <ac:chgData name="Mendoza Valderrey, Alberto" userId="3ca0a5ef-cfc6-4d76-a1eb-aa1d46514f4a" providerId="ADAL" clId="{4F8E51F9-E0E7-4E38-A829-33EDC4CC36D3}" dt="2024-01-31T23:50:03.113" v="734" actId="1076"/>
          <ac:spMkLst>
            <pc:docMk/>
            <pc:sldMk cId="2030739124" sldId="257"/>
            <ac:spMk id="10" creationId="{D9012D7B-C556-E7FA-3F2A-9F762252F2F6}"/>
          </ac:spMkLst>
        </pc:spChg>
        <pc:spChg chg="mod">
          <ac:chgData name="Mendoza Valderrey, Alberto" userId="3ca0a5ef-cfc6-4d76-a1eb-aa1d46514f4a" providerId="ADAL" clId="{4F8E51F9-E0E7-4E38-A829-33EDC4CC36D3}" dt="2024-01-31T23:50:08.338" v="735" actId="1076"/>
          <ac:spMkLst>
            <pc:docMk/>
            <pc:sldMk cId="2030739124" sldId="257"/>
            <ac:spMk id="11" creationId="{EF44F2C8-EC5D-5C9B-DC81-968017FA02FF}"/>
          </ac:spMkLst>
        </pc:spChg>
        <pc:spChg chg="mod">
          <ac:chgData name="Mendoza Valderrey, Alberto" userId="3ca0a5ef-cfc6-4d76-a1eb-aa1d46514f4a" providerId="ADAL" clId="{4F8E51F9-E0E7-4E38-A829-33EDC4CC36D3}" dt="2024-01-31T23:50:13.290" v="736" actId="1076"/>
          <ac:spMkLst>
            <pc:docMk/>
            <pc:sldMk cId="2030739124" sldId="257"/>
            <ac:spMk id="12" creationId="{64F304E3-2385-E935-B1EE-26000C6E35E6}"/>
          </ac:spMkLst>
        </pc:spChg>
        <pc:spChg chg="mod">
          <ac:chgData name="Mendoza Valderrey, Alberto" userId="3ca0a5ef-cfc6-4d76-a1eb-aa1d46514f4a" providerId="ADAL" clId="{4F8E51F9-E0E7-4E38-A829-33EDC4CC36D3}" dt="2024-01-31T23:50:15.738" v="737" actId="1076"/>
          <ac:spMkLst>
            <pc:docMk/>
            <pc:sldMk cId="2030739124" sldId="257"/>
            <ac:spMk id="13" creationId="{FCB98A75-AC0C-0DCF-437C-002E39DDFD1A}"/>
          </ac:spMkLst>
        </pc:spChg>
        <pc:spChg chg="mod">
          <ac:chgData name="Mendoza Valderrey, Alberto" userId="3ca0a5ef-cfc6-4d76-a1eb-aa1d46514f4a" providerId="ADAL" clId="{4F8E51F9-E0E7-4E38-A829-33EDC4CC36D3}" dt="2024-01-31T23:50:20.929" v="738" actId="1076"/>
          <ac:spMkLst>
            <pc:docMk/>
            <pc:sldMk cId="2030739124" sldId="257"/>
            <ac:spMk id="14" creationId="{BC0F559F-92BF-4990-A305-262599892711}"/>
          </ac:spMkLst>
        </pc:spChg>
        <pc:spChg chg="mod">
          <ac:chgData name="Mendoza Valderrey, Alberto" userId="3ca0a5ef-cfc6-4d76-a1eb-aa1d46514f4a" providerId="ADAL" clId="{4F8E51F9-E0E7-4E38-A829-33EDC4CC36D3}" dt="2024-01-31T23:51:05.790" v="758" actId="20577"/>
          <ac:spMkLst>
            <pc:docMk/>
            <pc:sldMk cId="2030739124" sldId="257"/>
            <ac:spMk id="15" creationId="{921DA190-8A48-0EA6-1B09-EB38DAC677B6}"/>
          </ac:spMkLst>
        </pc:spChg>
        <pc:spChg chg="mod">
          <ac:chgData name="Mendoza Valderrey, Alberto" userId="3ca0a5ef-cfc6-4d76-a1eb-aa1d46514f4a" providerId="ADAL" clId="{4F8E51F9-E0E7-4E38-A829-33EDC4CC36D3}" dt="2024-01-31T23:51:16" v="760" actId="1035"/>
          <ac:spMkLst>
            <pc:docMk/>
            <pc:sldMk cId="2030739124" sldId="257"/>
            <ac:spMk id="16" creationId="{7B22DAEF-5FC0-1E47-2FAA-1C72019DCC2B}"/>
          </ac:spMkLst>
        </pc:spChg>
        <pc:spChg chg="mod">
          <ac:chgData name="Mendoza Valderrey, Alberto" userId="3ca0a5ef-cfc6-4d76-a1eb-aa1d46514f4a" providerId="ADAL" clId="{4F8E51F9-E0E7-4E38-A829-33EDC4CC36D3}" dt="2024-01-31T23:51:24.426" v="761" actId="1076"/>
          <ac:spMkLst>
            <pc:docMk/>
            <pc:sldMk cId="2030739124" sldId="257"/>
            <ac:spMk id="17" creationId="{666BA23A-6894-984E-E28B-CCF458F9D79E}"/>
          </ac:spMkLst>
        </pc:spChg>
        <pc:spChg chg="mod topLvl">
          <ac:chgData name="Mendoza Valderrey, Alberto" userId="3ca0a5ef-cfc6-4d76-a1eb-aa1d46514f4a" providerId="ADAL" clId="{4F8E51F9-E0E7-4E38-A829-33EDC4CC36D3}" dt="2024-01-31T17:24:19.319" v="200" actId="164"/>
          <ac:spMkLst>
            <pc:docMk/>
            <pc:sldMk cId="2030739124" sldId="257"/>
            <ac:spMk id="19" creationId="{A8DD46B5-E832-B9B6-FE81-0C1CB883D667}"/>
          </ac:spMkLst>
        </pc:spChg>
        <pc:spChg chg="mod topLvl">
          <ac:chgData name="Mendoza Valderrey, Alberto" userId="3ca0a5ef-cfc6-4d76-a1eb-aa1d46514f4a" providerId="ADAL" clId="{4F8E51F9-E0E7-4E38-A829-33EDC4CC36D3}" dt="2024-01-31T17:24:19.319" v="200" actId="164"/>
          <ac:spMkLst>
            <pc:docMk/>
            <pc:sldMk cId="2030739124" sldId="257"/>
            <ac:spMk id="20" creationId="{E3820ECB-BDB4-E25E-4D27-B77F347ACD2D}"/>
          </ac:spMkLst>
        </pc:spChg>
        <pc:spChg chg="mod topLvl">
          <ac:chgData name="Mendoza Valderrey, Alberto" userId="3ca0a5ef-cfc6-4d76-a1eb-aa1d46514f4a" providerId="ADAL" clId="{4F8E51F9-E0E7-4E38-A829-33EDC4CC36D3}" dt="2024-01-31T17:24:19.319" v="200" actId="164"/>
          <ac:spMkLst>
            <pc:docMk/>
            <pc:sldMk cId="2030739124" sldId="257"/>
            <ac:spMk id="23" creationId="{72337C93-435B-0A57-DD33-D7711B8B4A67}"/>
          </ac:spMkLst>
        </pc:spChg>
        <pc:spChg chg="mod topLvl">
          <ac:chgData name="Mendoza Valderrey, Alberto" userId="3ca0a5ef-cfc6-4d76-a1eb-aa1d46514f4a" providerId="ADAL" clId="{4F8E51F9-E0E7-4E38-A829-33EDC4CC36D3}" dt="2024-01-31T17:24:19.319" v="200" actId="164"/>
          <ac:spMkLst>
            <pc:docMk/>
            <pc:sldMk cId="2030739124" sldId="257"/>
            <ac:spMk id="24" creationId="{EE4968CB-7B86-5E20-3C79-7FBF8350B0A4}"/>
          </ac:spMkLst>
        </pc:spChg>
        <pc:spChg chg="mod topLvl">
          <ac:chgData name="Mendoza Valderrey, Alberto" userId="3ca0a5ef-cfc6-4d76-a1eb-aa1d46514f4a" providerId="ADAL" clId="{4F8E51F9-E0E7-4E38-A829-33EDC4CC36D3}" dt="2024-01-31T17:24:19.319" v="200" actId="164"/>
          <ac:spMkLst>
            <pc:docMk/>
            <pc:sldMk cId="2030739124" sldId="257"/>
            <ac:spMk id="25" creationId="{1E9770B2-7A90-A61E-C1BA-8BF219223DFD}"/>
          </ac:spMkLst>
        </pc:spChg>
        <pc:spChg chg="mod">
          <ac:chgData name="Mendoza Valderrey, Alberto" userId="3ca0a5ef-cfc6-4d76-a1eb-aa1d46514f4a" providerId="ADAL" clId="{4F8E51F9-E0E7-4E38-A829-33EDC4CC36D3}" dt="2024-01-31T23:51:53.978" v="781" actId="1076"/>
          <ac:spMkLst>
            <pc:docMk/>
            <pc:sldMk cId="2030739124" sldId="257"/>
            <ac:spMk id="29" creationId="{58E0E189-2CDD-CDAC-C47C-3735F79BD226}"/>
          </ac:spMkLst>
        </pc:spChg>
        <pc:spChg chg="mod">
          <ac:chgData name="Mendoza Valderrey, Alberto" userId="3ca0a5ef-cfc6-4d76-a1eb-aa1d46514f4a" providerId="ADAL" clId="{4F8E51F9-E0E7-4E38-A829-33EDC4CC36D3}" dt="2024-01-31T17:20:33.360" v="14" actId="1038"/>
          <ac:spMkLst>
            <pc:docMk/>
            <pc:sldMk cId="2030739124" sldId="257"/>
            <ac:spMk id="30" creationId="{4F8B98CE-1212-58E5-19E2-6973BC760023}"/>
          </ac:spMkLst>
        </pc:spChg>
        <pc:spChg chg="mod">
          <ac:chgData name="Mendoza Valderrey, Alberto" userId="3ca0a5ef-cfc6-4d76-a1eb-aa1d46514f4a" providerId="ADAL" clId="{4F8E51F9-E0E7-4E38-A829-33EDC4CC36D3}" dt="2024-01-31T17:20:33.360" v="14" actId="1038"/>
          <ac:spMkLst>
            <pc:docMk/>
            <pc:sldMk cId="2030739124" sldId="257"/>
            <ac:spMk id="31" creationId="{7F42CBB3-E109-09F7-5619-85BDFA5DB418}"/>
          </ac:spMkLst>
        </pc:spChg>
        <pc:spChg chg="mod">
          <ac:chgData name="Mendoza Valderrey, Alberto" userId="3ca0a5ef-cfc6-4d76-a1eb-aa1d46514f4a" providerId="ADAL" clId="{4F8E51F9-E0E7-4E38-A829-33EDC4CC36D3}" dt="2024-01-31T17:20:33.360" v="14" actId="1038"/>
          <ac:spMkLst>
            <pc:docMk/>
            <pc:sldMk cId="2030739124" sldId="257"/>
            <ac:spMk id="32" creationId="{A87E56A3-8AF1-8D0C-352C-8022D662AAA8}"/>
          </ac:spMkLst>
        </pc:spChg>
        <pc:spChg chg="mod">
          <ac:chgData name="Mendoza Valderrey, Alberto" userId="3ca0a5ef-cfc6-4d76-a1eb-aa1d46514f4a" providerId="ADAL" clId="{4F8E51F9-E0E7-4E38-A829-33EDC4CC36D3}" dt="2024-01-31T23:51:57.106" v="782" actId="1076"/>
          <ac:spMkLst>
            <pc:docMk/>
            <pc:sldMk cId="2030739124" sldId="257"/>
            <ac:spMk id="33" creationId="{41E20FDD-567A-8987-F0F7-3CC43DD369B3}"/>
          </ac:spMkLst>
        </pc:spChg>
        <pc:spChg chg="mod">
          <ac:chgData name="Mendoza Valderrey, Alberto" userId="3ca0a5ef-cfc6-4d76-a1eb-aa1d46514f4a" providerId="ADAL" clId="{4F8E51F9-E0E7-4E38-A829-33EDC4CC36D3}" dt="2024-01-31T17:20:33.360" v="14" actId="1038"/>
          <ac:spMkLst>
            <pc:docMk/>
            <pc:sldMk cId="2030739124" sldId="257"/>
            <ac:spMk id="34" creationId="{EC81C159-57A7-CEA2-FBD9-E6D464790574}"/>
          </ac:spMkLst>
        </pc:spChg>
        <pc:spChg chg="mod">
          <ac:chgData name="Mendoza Valderrey, Alberto" userId="3ca0a5ef-cfc6-4d76-a1eb-aa1d46514f4a" providerId="ADAL" clId="{4F8E51F9-E0E7-4E38-A829-33EDC4CC36D3}" dt="2024-01-31T17:20:33.360" v="14" actId="1038"/>
          <ac:spMkLst>
            <pc:docMk/>
            <pc:sldMk cId="2030739124" sldId="257"/>
            <ac:spMk id="35" creationId="{5B6D9E33-8D2E-084A-EDF8-29C451355F92}"/>
          </ac:spMkLst>
        </pc:spChg>
        <pc:spChg chg="mod">
          <ac:chgData name="Mendoza Valderrey, Alberto" userId="3ca0a5ef-cfc6-4d76-a1eb-aa1d46514f4a" providerId="ADAL" clId="{4F8E51F9-E0E7-4E38-A829-33EDC4CC36D3}" dt="2024-01-31T17:20:33.360" v="14" actId="1038"/>
          <ac:spMkLst>
            <pc:docMk/>
            <pc:sldMk cId="2030739124" sldId="257"/>
            <ac:spMk id="36" creationId="{4A005218-20A8-DD20-B46E-416E7B66FF7E}"/>
          </ac:spMkLst>
        </pc:spChg>
        <pc:spChg chg="mod">
          <ac:chgData name="Mendoza Valderrey, Alberto" userId="3ca0a5ef-cfc6-4d76-a1eb-aa1d46514f4a" providerId="ADAL" clId="{4F8E51F9-E0E7-4E38-A829-33EDC4CC36D3}" dt="2024-01-31T17:20:33.360" v="14" actId="1038"/>
          <ac:spMkLst>
            <pc:docMk/>
            <pc:sldMk cId="2030739124" sldId="257"/>
            <ac:spMk id="37" creationId="{6E9F5212-FE85-87E3-EE5A-11615DC0BF77}"/>
          </ac:spMkLst>
        </pc:spChg>
        <pc:spChg chg="mod">
          <ac:chgData name="Mendoza Valderrey, Alberto" userId="3ca0a5ef-cfc6-4d76-a1eb-aa1d46514f4a" providerId="ADAL" clId="{4F8E51F9-E0E7-4E38-A829-33EDC4CC36D3}" dt="2024-01-31T17:20:33.360" v="14" actId="1038"/>
          <ac:spMkLst>
            <pc:docMk/>
            <pc:sldMk cId="2030739124" sldId="257"/>
            <ac:spMk id="38" creationId="{374117D6-9AC3-DDEB-DBBE-83CC2EF80982}"/>
          </ac:spMkLst>
        </pc:spChg>
        <pc:spChg chg="mod">
          <ac:chgData name="Mendoza Valderrey, Alberto" userId="3ca0a5ef-cfc6-4d76-a1eb-aa1d46514f4a" providerId="ADAL" clId="{4F8E51F9-E0E7-4E38-A829-33EDC4CC36D3}" dt="2024-01-31T17:20:33.360" v="14" actId="1038"/>
          <ac:spMkLst>
            <pc:docMk/>
            <pc:sldMk cId="2030739124" sldId="257"/>
            <ac:spMk id="39" creationId="{C9DA7B69-3FF9-5F83-8044-52F0B56BEED2}"/>
          </ac:spMkLst>
        </pc:spChg>
        <pc:spChg chg="mod">
          <ac:chgData name="Mendoza Valderrey, Alberto" userId="3ca0a5ef-cfc6-4d76-a1eb-aa1d46514f4a" providerId="ADAL" clId="{4F8E51F9-E0E7-4E38-A829-33EDC4CC36D3}" dt="2024-01-31T17:20:33.360" v="14" actId="1038"/>
          <ac:spMkLst>
            <pc:docMk/>
            <pc:sldMk cId="2030739124" sldId="257"/>
            <ac:spMk id="40" creationId="{A18B02C8-6CC3-A38F-DC93-005F4C301304}"/>
          </ac:spMkLst>
        </pc:spChg>
        <pc:spChg chg="mod">
          <ac:chgData name="Mendoza Valderrey, Alberto" userId="3ca0a5ef-cfc6-4d76-a1eb-aa1d46514f4a" providerId="ADAL" clId="{4F8E51F9-E0E7-4E38-A829-33EDC4CC36D3}" dt="2024-01-31T17:20:33.360" v="14" actId="1038"/>
          <ac:spMkLst>
            <pc:docMk/>
            <pc:sldMk cId="2030739124" sldId="257"/>
            <ac:spMk id="41" creationId="{101ECA0E-C2E1-DD11-4399-50E95F383839}"/>
          </ac:spMkLst>
        </pc:spChg>
        <pc:spChg chg="mod">
          <ac:chgData name="Mendoza Valderrey, Alberto" userId="3ca0a5ef-cfc6-4d76-a1eb-aa1d46514f4a" providerId="ADAL" clId="{4F8E51F9-E0E7-4E38-A829-33EDC4CC36D3}" dt="2024-01-31T17:20:33.360" v="14" actId="1038"/>
          <ac:spMkLst>
            <pc:docMk/>
            <pc:sldMk cId="2030739124" sldId="257"/>
            <ac:spMk id="42" creationId="{8905FE37-BA10-0192-5B36-F34A49566E67}"/>
          </ac:spMkLst>
        </pc:spChg>
        <pc:spChg chg="mod">
          <ac:chgData name="Mendoza Valderrey, Alberto" userId="3ca0a5ef-cfc6-4d76-a1eb-aa1d46514f4a" providerId="ADAL" clId="{4F8E51F9-E0E7-4E38-A829-33EDC4CC36D3}" dt="2024-01-31T17:20:33.360" v="14" actId="1038"/>
          <ac:spMkLst>
            <pc:docMk/>
            <pc:sldMk cId="2030739124" sldId="257"/>
            <ac:spMk id="43" creationId="{F9C4139E-EF17-DFBA-DF35-4052F4A4604C}"/>
          </ac:spMkLst>
        </pc:spChg>
        <pc:spChg chg="add mod">
          <ac:chgData name="Mendoza Valderrey, Alberto" userId="3ca0a5ef-cfc6-4d76-a1eb-aa1d46514f4a" providerId="ADAL" clId="{4F8E51F9-E0E7-4E38-A829-33EDC4CC36D3}" dt="2024-02-01T00:18:51.791" v="1353" actId="1036"/>
          <ac:spMkLst>
            <pc:docMk/>
            <pc:sldMk cId="2030739124" sldId="257"/>
            <ac:spMk id="44" creationId="{477D3BCD-A242-7CB0-C27D-A8B7F4733514}"/>
          </ac:spMkLst>
        </pc:spChg>
        <pc:spChg chg="add mod">
          <ac:chgData name="Mendoza Valderrey, Alberto" userId="3ca0a5ef-cfc6-4d76-a1eb-aa1d46514f4a" providerId="ADAL" clId="{4F8E51F9-E0E7-4E38-A829-33EDC4CC36D3}" dt="2024-02-01T00:18:51.791" v="1353" actId="1036"/>
          <ac:spMkLst>
            <pc:docMk/>
            <pc:sldMk cId="2030739124" sldId="257"/>
            <ac:spMk id="45" creationId="{DA253477-3A7E-BA55-8463-42E879FA9ED6}"/>
          </ac:spMkLst>
        </pc:spChg>
        <pc:spChg chg="add mod">
          <ac:chgData name="Mendoza Valderrey, Alberto" userId="3ca0a5ef-cfc6-4d76-a1eb-aa1d46514f4a" providerId="ADAL" clId="{4F8E51F9-E0E7-4E38-A829-33EDC4CC36D3}" dt="2024-02-01T00:18:51.791" v="1353" actId="1036"/>
          <ac:spMkLst>
            <pc:docMk/>
            <pc:sldMk cId="2030739124" sldId="257"/>
            <ac:spMk id="46" creationId="{6313F510-7E23-C438-31D9-C62BB1406E66}"/>
          </ac:spMkLst>
        </pc:spChg>
        <pc:spChg chg="add del mod">
          <ac:chgData name="Mendoza Valderrey, Alberto" userId="3ca0a5ef-cfc6-4d76-a1eb-aa1d46514f4a" providerId="ADAL" clId="{4F8E51F9-E0E7-4E38-A829-33EDC4CC36D3}" dt="2024-01-31T17:31:02.275" v="276"/>
          <ac:spMkLst>
            <pc:docMk/>
            <pc:sldMk cId="2030739124" sldId="257"/>
            <ac:spMk id="47" creationId="{F316FC70-409D-6018-B473-A12EB3AA81AE}"/>
          </ac:spMkLst>
        </pc:spChg>
        <pc:spChg chg="add mod">
          <ac:chgData name="Mendoza Valderrey, Alberto" userId="3ca0a5ef-cfc6-4d76-a1eb-aa1d46514f4a" providerId="ADAL" clId="{4F8E51F9-E0E7-4E38-A829-33EDC4CC36D3}" dt="2024-02-01T00:18:51.791" v="1353" actId="1036"/>
          <ac:spMkLst>
            <pc:docMk/>
            <pc:sldMk cId="2030739124" sldId="257"/>
            <ac:spMk id="48" creationId="{FA85E17F-86E1-F4D5-283A-CE019BCB1BEC}"/>
          </ac:spMkLst>
        </pc:spChg>
        <pc:spChg chg="add del mod">
          <ac:chgData name="Mendoza Valderrey, Alberto" userId="3ca0a5ef-cfc6-4d76-a1eb-aa1d46514f4a" providerId="ADAL" clId="{4F8E51F9-E0E7-4E38-A829-33EDC4CC36D3}" dt="2024-01-31T17:31:37.872" v="290" actId="478"/>
          <ac:spMkLst>
            <pc:docMk/>
            <pc:sldMk cId="2030739124" sldId="257"/>
            <ac:spMk id="49" creationId="{3038C5E6-E6BB-9031-1FDE-6B36E58EDFE6}"/>
          </ac:spMkLst>
        </pc:spChg>
        <pc:spChg chg="add mod">
          <ac:chgData name="Mendoza Valderrey, Alberto" userId="3ca0a5ef-cfc6-4d76-a1eb-aa1d46514f4a" providerId="ADAL" clId="{4F8E51F9-E0E7-4E38-A829-33EDC4CC36D3}" dt="2024-02-01T00:18:51.791" v="1353" actId="1036"/>
          <ac:spMkLst>
            <pc:docMk/>
            <pc:sldMk cId="2030739124" sldId="257"/>
            <ac:spMk id="50" creationId="{19C3989A-1377-D381-99BA-59954949A542}"/>
          </ac:spMkLst>
        </pc:spChg>
        <pc:spChg chg="add mod">
          <ac:chgData name="Mendoza Valderrey, Alberto" userId="3ca0a5ef-cfc6-4d76-a1eb-aa1d46514f4a" providerId="ADAL" clId="{4F8E51F9-E0E7-4E38-A829-33EDC4CC36D3}" dt="2024-02-01T00:18:51.791" v="1353" actId="1036"/>
          <ac:spMkLst>
            <pc:docMk/>
            <pc:sldMk cId="2030739124" sldId="257"/>
            <ac:spMk id="51" creationId="{7C56ABD9-B49B-4FAA-88E9-4745083178CA}"/>
          </ac:spMkLst>
        </pc:spChg>
        <pc:spChg chg="add del mod">
          <ac:chgData name="Mendoza Valderrey, Alberto" userId="3ca0a5ef-cfc6-4d76-a1eb-aa1d46514f4a" providerId="ADAL" clId="{4F8E51F9-E0E7-4E38-A829-33EDC4CC36D3}" dt="2024-01-31T18:28:22.564" v="330" actId="478"/>
          <ac:spMkLst>
            <pc:docMk/>
            <pc:sldMk cId="2030739124" sldId="257"/>
            <ac:spMk id="52" creationId="{7BCCBA03-6156-A1AE-C607-59FD70DE5E37}"/>
          </ac:spMkLst>
        </pc:spChg>
        <pc:spChg chg="add del mod">
          <ac:chgData name="Mendoza Valderrey, Alberto" userId="3ca0a5ef-cfc6-4d76-a1eb-aa1d46514f4a" providerId="ADAL" clId="{4F8E51F9-E0E7-4E38-A829-33EDC4CC36D3}" dt="2024-01-31T18:28:22.564" v="330" actId="478"/>
          <ac:spMkLst>
            <pc:docMk/>
            <pc:sldMk cId="2030739124" sldId="257"/>
            <ac:spMk id="53" creationId="{EC07D276-0D63-A99C-5A05-F811452BC4FD}"/>
          </ac:spMkLst>
        </pc:spChg>
        <pc:spChg chg="add del mod">
          <ac:chgData name="Mendoza Valderrey, Alberto" userId="3ca0a5ef-cfc6-4d76-a1eb-aa1d46514f4a" providerId="ADAL" clId="{4F8E51F9-E0E7-4E38-A829-33EDC4CC36D3}" dt="2024-01-31T18:28:22.564" v="330" actId="478"/>
          <ac:spMkLst>
            <pc:docMk/>
            <pc:sldMk cId="2030739124" sldId="257"/>
            <ac:spMk id="54" creationId="{7B8A7455-6641-04E7-F33A-9FDFAE827D01}"/>
          </ac:spMkLst>
        </pc:spChg>
        <pc:spChg chg="add del mod">
          <ac:chgData name="Mendoza Valderrey, Alberto" userId="3ca0a5ef-cfc6-4d76-a1eb-aa1d46514f4a" providerId="ADAL" clId="{4F8E51F9-E0E7-4E38-A829-33EDC4CC36D3}" dt="2024-01-31T18:28:23.997" v="331" actId="478"/>
          <ac:spMkLst>
            <pc:docMk/>
            <pc:sldMk cId="2030739124" sldId="257"/>
            <ac:spMk id="55" creationId="{8BCF45DF-0246-C2FD-4268-10EE5D8A989C}"/>
          </ac:spMkLst>
        </pc:spChg>
        <pc:spChg chg="add del mod">
          <ac:chgData name="Mendoza Valderrey, Alberto" userId="3ca0a5ef-cfc6-4d76-a1eb-aa1d46514f4a" providerId="ADAL" clId="{4F8E51F9-E0E7-4E38-A829-33EDC4CC36D3}" dt="2024-01-31T18:32:26.778" v="351" actId="478"/>
          <ac:spMkLst>
            <pc:docMk/>
            <pc:sldMk cId="2030739124" sldId="257"/>
            <ac:spMk id="58" creationId="{AF3EB576-506C-582C-A7ED-233DB8A08B55}"/>
          </ac:spMkLst>
        </pc:spChg>
        <pc:spChg chg="add del mod">
          <ac:chgData name="Mendoza Valderrey, Alberto" userId="3ca0a5ef-cfc6-4d76-a1eb-aa1d46514f4a" providerId="ADAL" clId="{4F8E51F9-E0E7-4E38-A829-33EDC4CC36D3}" dt="2024-02-01T00:29:54.813" v="1396" actId="478"/>
          <ac:spMkLst>
            <pc:docMk/>
            <pc:sldMk cId="2030739124" sldId="257"/>
            <ac:spMk id="59" creationId="{86AC6F00-C740-C870-BB29-BD0C8648A0C2}"/>
          </ac:spMkLst>
        </pc:spChg>
        <pc:spChg chg="add del mod">
          <ac:chgData name="Mendoza Valderrey, Alberto" userId="3ca0a5ef-cfc6-4d76-a1eb-aa1d46514f4a" providerId="ADAL" clId="{4F8E51F9-E0E7-4E38-A829-33EDC4CC36D3}" dt="2024-02-01T00:29:56.087" v="1397" actId="478"/>
          <ac:spMkLst>
            <pc:docMk/>
            <pc:sldMk cId="2030739124" sldId="257"/>
            <ac:spMk id="60" creationId="{A4AB304F-7EE1-3BB8-C341-EA856C9F0BF6}"/>
          </ac:spMkLst>
        </pc:spChg>
        <pc:spChg chg="add del mod">
          <ac:chgData name="Mendoza Valderrey, Alberto" userId="3ca0a5ef-cfc6-4d76-a1eb-aa1d46514f4a" providerId="ADAL" clId="{4F8E51F9-E0E7-4E38-A829-33EDC4CC36D3}" dt="2024-02-01T00:16:44.280" v="1227" actId="478"/>
          <ac:spMkLst>
            <pc:docMk/>
            <pc:sldMk cId="2030739124" sldId="257"/>
            <ac:spMk id="62" creationId="{AE9A0B1F-AA7E-6338-A70A-3019866554E5}"/>
          </ac:spMkLst>
        </pc:spChg>
        <pc:spChg chg="add del mod">
          <ac:chgData name="Mendoza Valderrey, Alberto" userId="3ca0a5ef-cfc6-4d76-a1eb-aa1d46514f4a" providerId="ADAL" clId="{4F8E51F9-E0E7-4E38-A829-33EDC4CC36D3}" dt="2024-02-01T00:16:45.715" v="1228" actId="478"/>
          <ac:spMkLst>
            <pc:docMk/>
            <pc:sldMk cId="2030739124" sldId="257"/>
            <ac:spMk id="63" creationId="{A5AA7E73-01A0-FA68-C264-9A16FD34987D}"/>
          </ac:spMkLst>
        </pc:spChg>
        <pc:spChg chg="add mod">
          <ac:chgData name="Mendoza Valderrey, Alberto" userId="3ca0a5ef-cfc6-4d76-a1eb-aa1d46514f4a" providerId="ADAL" clId="{4F8E51F9-E0E7-4E38-A829-33EDC4CC36D3}" dt="2024-01-31T22:59:49.217" v="623" actId="1076"/>
          <ac:spMkLst>
            <pc:docMk/>
            <pc:sldMk cId="2030739124" sldId="257"/>
            <ac:spMk id="64" creationId="{F4F70868-1084-364D-8A75-20164646E8C0}"/>
          </ac:spMkLst>
        </pc:spChg>
        <pc:spChg chg="add mod">
          <ac:chgData name="Mendoza Valderrey, Alberto" userId="3ca0a5ef-cfc6-4d76-a1eb-aa1d46514f4a" providerId="ADAL" clId="{4F8E51F9-E0E7-4E38-A829-33EDC4CC36D3}" dt="2024-01-31T23:53:17.057" v="809" actId="1076"/>
          <ac:spMkLst>
            <pc:docMk/>
            <pc:sldMk cId="2030739124" sldId="257"/>
            <ac:spMk id="67" creationId="{B18FFE72-7E14-42D4-6A7A-CD6F55BEA912}"/>
          </ac:spMkLst>
        </pc:spChg>
        <pc:spChg chg="add mod">
          <ac:chgData name="Mendoza Valderrey, Alberto" userId="3ca0a5ef-cfc6-4d76-a1eb-aa1d46514f4a" providerId="ADAL" clId="{4F8E51F9-E0E7-4E38-A829-33EDC4CC36D3}" dt="2024-01-31T23:54:03.121" v="820" actId="1076"/>
          <ac:spMkLst>
            <pc:docMk/>
            <pc:sldMk cId="2030739124" sldId="257"/>
            <ac:spMk id="71" creationId="{255F9EE3-7D3B-55A7-37D3-5D38841D03A1}"/>
          </ac:spMkLst>
        </pc:spChg>
        <pc:spChg chg="add mod">
          <ac:chgData name="Mendoza Valderrey, Alberto" userId="3ca0a5ef-cfc6-4d76-a1eb-aa1d46514f4a" providerId="ADAL" clId="{4F8E51F9-E0E7-4E38-A829-33EDC4CC36D3}" dt="2024-01-31T23:54:33.705" v="829" actId="1076"/>
          <ac:spMkLst>
            <pc:docMk/>
            <pc:sldMk cId="2030739124" sldId="257"/>
            <ac:spMk id="74" creationId="{6208C340-ADAF-786D-0BC1-13CBA9003873}"/>
          </ac:spMkLst>
        </pc:spChg>
        <pc:spChg chg="add mod">
          <ac:chgData name="Mendoza Valderrey, Alberto" userId="3ca0a5ef-cfc6-4d76-a1eb-aa1d46514f4a" providerId="ADAL" clId="{4F8E51F9-E0E7-4E38-A829-33EDC4CC36D3}" dt="2024-01-31T23:57:35.744" v="887" actId="1076"/>
          <ac:spMkLst>
            <pc:docMk/>
            <pc:sldMk cId="2030739124" sldId="257"/>
            <ac:spMk id="108" creationId="{6ADB841A-852E-3AF9-2684-A5CA4E77D506}"/>
          </ac:spMkLst>
        </pc:spChg>
        <pc:spChg chg="add mod">
          <ac:chgData name="Mendoza Valderrey, Alberto" userId="3ca0a5ef-cfc6-4d76-a1eb-aa1d46514f4a" providerId="ADAL" clId="{4F8E51F9-E0E7-4E38-A829-33EDC4CC36D3}" dt="2024-01-31T23:58:10.881" v="897" actId="1076"/>
          <ac:spMkLst>
            <pc:docMk/>
            <pc:sldMk cId="2030739124" sldId="257"/>
            <ac:spMk id="110" creationId="{9272D969-46B6-3716-A789-A8A0D5682C6D}"/>
          </ac:spMkLst>
        </pc:spChg>
        <pc:spChg chg="add mod">
          <ac:chgData name="Mendoza Valderrey, Alberto" userId="3ca0a5ef-cfc6-4d76-a1eb-aa1d46514f4a" providerId="ADAL" clId="{4F8E51F9-E0E7-4E38-A829-33EDC4CC36D3}" dt="2024-01-31T23:58:08.169" v="896" actId="1076"/>
          <ac:spMkLst>
            <pc:docMk/>
            <pc:sldMk cId="2030739124" sldId="257"/>
            <ac:spMk id="111" creationId="{C4E22AA1-B674-F59E-4099-3AEB74B7FB5A}"/>
          </ac:spMkLst>
        </pc:spChg>
        <pc:spChg chg="add mod">
          <ac:chgData name="Mendoza Valderrey, Alberto" userId="3ca0a5ef-cfc6-4d76-a1eb-aa1d46514f4a" providerId="ADAL" clId="{4F8E51F9-E0E7-4E38-A829-33EDC4CC36D3}" dt="2024-01-31T23:58:25.200" v="901" actId="1076"/>
          <ac:spMkLst>
            <pc:docMk/>
            <pc:sldMk cId="2030739124" sldId="257"/>
            <ac:spMk id="112" creationId="{5F3FDF87-61AE-2198-1E71-AE75D706D25D}"/>
          </ac:spMkLst>
        </pc:spChg>
        <pc:spChg chg="add mod">
          <ac:chgData name="Mendoza Valderrey, Alberto" userId="3ca0a5ef-cfc6-4d76-a1eb-aa1d46514f4a" providerId="ADAL" clId="{4F8E51F9-E0E7-4E38-A829-33EDC4CC36D3}" dt="2024-01-31T23:58:41.905" v="906" actId="1076"/>
          <ac:spMkLst>
            <pc:docMk/>
            <pc:sldMk cId="2030739124" sldId="257"/>
            <ac:spMk id="113" creationId="{E4A77517-4AB2-38A0-5AD3-2DD67FEBE1D4}"/>
          </ac:spMkLst>
        </pc:spChg>
        <pc:spChg chg="add mod">
          <ac:chgData name="Mendoza Valderrey, Alberto" userId="3ca0a5ef-cfc6-4d76-a1eb-aa1d46514f4a" providerId="ADAL" clId="{4F8E51F9-E0E7-4E38-A829-33EDC4CC36D3}" dt="2024-01-31T23:58:55.407" v="910" actId="1076"/>
          <ac:spMkLst>
            <pc:docMk/>
            <pc:sldMk cId="2030739124" sldId="257"/>
            <ac:spMk id="114" creationId="{7B99F138-3AAD-BBB6-C93F-5DF7DDAC7421}"/>
          </ac:spMkLst>
        </pc:spChg>
        <pc:spChg chg="add mod">
          <ac:chgData name="Mendoza Valderrey, Alberto" userId="3ca0a5ef-cfc6-4d76-a1eb-aa1d46514f4a" providerId="ADAL" clId="{4F8E51F9-E0E7-4E38-A829-33EDC4CC36D3}" dt="2024-01-31T23:59:11.336" v="914" actId="1076"/>
          <ac:spMkLst>
            <pc:docMk/>
            <pc:sldMk cId="2030739124" sldId="257"/>
            <ac:spMk id="115" creationId="{D5D77958-83CB-4BCB-A8F9-1B9B9EB2F121}"/>
          </ac:spMkLst>
        </pc:spChg>
        <pc:spChg chg="add mod">
          <ac:chgData name="Mendoza Valderrey, Alberto" userId="3ca0a5ef-cfc6-4d76-a1eb-aa1d46514f4a" providerId="ADAL" clId="{4F8E51F9-E0E7-4E38-A829-33EDC4CC36D3}" dt="2024-01-31T23:59:30.592" v="918" actId="1076"/>
          <ac:spMkLst>
            <pc:docMk/>
            <pc:sldMk cId="2030739124" sldId="257"/>
            <ac:spMk id="116" creationId="{6002FABF-727E-83B8-B97D-A30BAC706ED8}"/>
          </ac:spMkLst>
        </pc:spChg>
        <pc:spChg chg="add mod">
          <ac:chgData name="Mendoza Valderrey, Alberto" userId="3ca0a5ef-cfc6-4d76-a1eb-aa1d46514f4a" providerId="ADAL" clId="{4F8E51F9-E0E7-4E38-A829-33EDC4CC36D3}" dt="2024-02-01T00:06:14.351" v="922" actId="14100"/>
          <ac:spMkLst>
            <pc:docMk/>
            <pc:sldMk cId="2030739124" sldId="257"/>
            <ac:spMk id="117" creationId="{780C5A6E-0593-9AB4-2DFE-5C4F67D572AC}"/>
          </ac:spMkLst>
        </pc:spChg>
        <pc:spChg chg="mod">
          <ac:chgData name="Mendoza Valderrey, Alberto" userId="3ca0a5ef-cfc6-4d76-a1eb-aa1d46514f4a" providerId="ADAL" clId="{4F8E51F9-E0E7-4E38-A829-33EDC4CC36D3}" dt="2024-02-01T00:18:51.791" v="1353" actId="1036"/>
          <ac:spMkLst>
            <pc:docMk/>
            <pc:sldMk cId="2030739124" sldId="257"/>
            <ac:spMk id="124" creationId="{F1CAA8A6-F90A-02C9-228D-DCE0940F883A}"/>
          </ac:spMkLst>
        </pc:spChg>
        <pc:spChg chg="mod">
          <ac:chgData name="Mendoza Valderrey, Alberto" userId="3ca0a5ef-cfc6-4d76-a1eb-aa1d46514f4a" providerId="ADAL" clId="{4F8E51F9-E0E7-4E38-A829-33EDC4CC36D3}" dt="2024-02-01T00:18:51.791" v="1353" actId="1036"/>
          <ac:spMkLst>
            <pc:docMk/>
            <pc:sldMk cId="2030739124" sldId="257"/>
            <ac:spMk id="125" creationId="{579E7823-EFEB-C846-7D7F-64CDF5C0E948}"/>
          </ac:spMkLst>
        </pc:spChg>
        <pc:spChg chg="del">
          <ac:chgData name="Mendoza Valderrey, Alberto" userId="3ca0a5ef-cfc6-4d76-a1eb-aa1d46514f4a" providerId="ADAL" clId="{4F8E51F9-E0E7-4E38-A829-33EDC4CC36D3}" dt="2024-01-31T17:25:28.836" v="211" actId="478"/>
          <ac:spMkLst>
            <pc:docMk/>
            <pc:sldMk cId="2030739124" sldId="257"/>
            <ac:spMk id="127" creationId="{11D0B1F4-1296-7D1B-90CB-0D5D4477CF7F}"/>
          </ac:spMkLst>
        </pc:spChg>
        <pc:spChg chg="add mod">
          <ac:chgData name="Mendoza Valderrey, Alberto" userId="3ca0a5ef-cfc6-4d76-a1eb-aa1d46514f4a" providerId="ADAL" clId="{4F8E51F9-E0E7-4E38-A829-33EDC4CC36D3}" dt="2024-02-01T00:06:42.077" v="928" actId="1076"/>
          <ac:spMkLst>
            <pc:docMk/>
            <pc:sldMk cId="2030739124" sldId="257"/>
            <ac:spMk id="127" creationId="{ADC847D9-7CE2-FA3A-1C16-ED172FB2EAD3}"/>
          </ac:spMkLst>
        </pc:spChg>
        <pc:spChg chg="add mod">
          <ac:chgData name="Mendoza Valderrey, Alberto" userId="3ca0a5ef-cfc6-4d76-a1eb-aa1d46514f4a" providerId="ADAL" clId="{4F8E51F9-E0E7-4E38-A829-33EDC4CC36D3}" dt="2024-02-01T00:06:56.400" v="932" actId="1076"/>
          <ac:spMkLst>
            <pc:docMk/>
            <pc:sldMk cId="2030739124" sldId="257"/>
            <ac:spMk id="128" creationId="{411A085C-A3AA-7F74-4B50-D014B473A758}"/>
          </ac:spMkLst>
        </pc:spChg>
        <pc:spChg chg="del">
          <ac:chgData name="Mendoza Valderrey, Alberto" userId="3ca0a5ef-cfc6-4d76-a1eb-aa1d46514f4a" providerId="ADAL" clId="{4F8E51F9-E0E7-4E38-A829-33EDC4CC36D3}" dt="2024-01-31T17:25:28.836" v="211" actId="478"/>
          <ac:spMkLst>
            <pc:docMk/>
            <pc:sldMk cId="2030739124" sldId="257"/>
            <ac:spMk id="128" creationId="{79ECEED9-8C12-3619-F5EE-DEA502BDBE40}"/>
          </ac:spMkLst>
        </pc:spChg>
        <pc:spChg chg="add mod">
          <ac:chgData name="Mendoza Valderrey, Alberto" userId="3ca0a5ef-cfc6-4d76-a1eb-aa1d46514f4a" providerId="ADAL" clId="{4F8E51F9-E0E7-4E38-A829-33EDC4CC36D3}" dt="2024-02-01T00:07:45.551" v="940" actId="1076"/>
          <ac:spMkLst>
            <pc:docMk/>
            <pc:sldMk cId="2030739124" sldId="257"/>
            <ac:spMk id="129" creationId="{43D5D9DF-9FB1-53FD-10E7-42845C212F12}"/>
          </ac:spMkLst>
        </pc:spChg>
        <pc:spChg chg="del">
          <ac:chgData name="Mendoza Valderrey, Alberto" userId="3ca0a5ef-cfc6-4d76-a1eb-aa1d46514f4a" providerId="ADAL" clId="{4F8E51F9-E0E7-4E38-A829-33EDC4CC36D3}" dt="2024-01-31T17:25:43.543" v="216" actId="478"/>
          <ac:spMkLst>
            <pc:docMk/>
            <pc:sldMk cId="2030739124" sldId="257"/>
            <ac:spMk id="129" creationId="{4F1F177B-D82B-F76A-6E79-21F92ECBB78E}"/>
          </ac:spMkLst>
        </pc:spChg>
        <pc:spChg chg="del">
          <ac:chgData name="Mendoza Valderrey, Alberto" userId="3ca0a5ef-cfc6-4d76-a1eb-aa1d46514f4a" providerId="ADAL" clId="{4F8E51F9-E0E7-4E38-A829-33EDC4CC36D3}" dt="2024-01-31T17:25:54.057" v="219" actId="478"/>
          <ac:spMkLst>
            <pc:docMk/>
            <pc:sldMk cId="2030739124" sldId="257"/>
            <ac:spMk id="130" creationId="{C98E4BCB-1E75-B2AE-6F6A-A8C1BBFD39EB}"/>
          </ac:spMkLst>
        </pc:spChg>
        <pc:spChg chg="del">
          <ac:chgData name="Mendoza Valderrey, Alberto" userId="3ca0a5ef-cfc6-4d76-a1eb-aa1d46514f4a" providerId="ADAL" clId="{4F8E51F9-E0E7-4E38-A829-33EDC4CC36D3}" dt="2024-01-31T17:25:49.262" v="218" actId="478"/>
          <ac:spMkLst>
            <pc:docMk/>
            <pc:sldMk cId="2030739124" sldId="257"/>
            <ac:spMk id="131" creationId="{2598F66F-74A7-FA2D-6003-F417175DA270}"/>
          </ac:spMkLst>
        </pc:spChg>
        <pc:spChg chg="add del mod">
          <ac:chgData name="Mendoza Valderrey, Alberto" userId="3ca0a5ef-cfc6-4d76-a1eb-aa1d46514f4a" providerId="ADAL" clId="{4F8E51F9-E0E7-4E38-A829-33EDC4CC36D3}" dt="2024-02-01T00:36:28.962" v="1517" actId="1035"/>
          <ac:spMkLst>
            <pc:docMk/>
            <pc:sldMk cId="2030739124" sldId="257"/>
            <ac:spMk id="131" creationId="{FAB88A1E-41C4-D44B-44E0-6C9C34A222E0}"/>
          </ac:spMkLst>
        </pc:spChg>
        <pc:spChg chg="mod">
          <ac:chgData name="Mendoza Valderrey, Alberto" userId="3ca0a5ef-cfc6-4d76-a1eb-aa1d46514f4a" providerId="ADAL" clId="{4F8E51F9-E0E7-4E38-A829-33EDC4CC36D3}" dt="2024-02-01T00:18:51.791" v="1353" actId="1036"/>
          <ac:spMkLst>
            <pc:docMk/>
            <pc:sldMk cId="2030739124" sldId="257"/>
            <ac:spMk id="132" creationId="{FAA7C87B-E436-BA70-EBA1-EAE9AADEC4FA}"/>
          </ac:spMkLst>
        </pc:spChg>
        <pc:spChg chg="mod">
          <ac:chgData name="Mendoza Valderrey, Alberto" userId="3ca0a5ef-cfc6-4d76-a1eb-aa1d46514f4a" providerId="ADAL" clId="{4F8E51F9-E0E7-4E38-A829-33EDC4CC36D3}" dt="2024-02-01T00:18:51.791" v="1353" actId="1036"/>
          <ac:spMkLst>
            <pc:docMk/>
            <pc:sldMk cId="2030739124" sldId="257"/>
            <ac:spMk id="133" creationId="{BB87AC05-738B-ADA4-7D19-1A228DB711B3}"/>
          </ac:spMkLst>
        </pc:spChg>
        <pc:spChg chg="mod">
          <ac:chgData name="Mendoza Valderrey, Alberto" userId="3ca0a5ef-cfc6-4d76-a1eb-aa1d46514f4a" providerId="ADAL" clId="{4F8E51F9-E0E7-4E38-A829-33EDC4CC36D3}" dt="2024-02-01T00:18:51.791" v="1353" actId="1036"/>
          <ac:spMkLst>
            <pc:docMk/>
            <pc:sldMk cId="2030739124" sldId="257"/>
            <ac:spMk id="134" creationId="{29D15C39-C6B4-DC6E-0F7C-A48FF92BDDF3}"/>
          </ac:spMkLst>
        </pc:spChg>
        <pc:spChg chg="mod">
          <ac:chgData name="Mendoza Valderrey, Alberto" userId="3ca0a5ef-cfc6-4d76-a1eb-aa1d46514f4a" providerId="ADAL" clId="{4F8E51F9-E0E7-4E38-A829-33EDC4CC36D3}" dt="2024-02-01T00:18:51.791" v="1353" actId="1036"/>
          <ac:spMkLst>
            <pc:docMk/>
            <pc:sldMk cId="2030739124" sldId="257"/>
            <ac:spMk id="135" creationId="{5F77DD3B-B53B-E829-14B5-7A35FF43AFED}"/>
          </ac:spMkLst>
        </pc:spChg>
        <pc:spChg chg="add mod">
          <ac:chgData name="Mendoza Valderrey, Alberto" userId="3ca0a5ef-cfc6-4d76-a1eb-aa1d46514f4a" providerId="ADAL" clId="{4F8E51F9-E0E7-4E38-A829-33EDC4CC36D3}" dt="2024-02-01T00:14:42.379" v="1204" actId="1038"/>
          <ac:spMkLst>
            <pc:docMk/>
            <pc:sldMk cId="2030739124" sldId="257"/>
            <ac:spMk id="136" creationId="{7D639B15-8268-37C0-C5C0-13A23C43C25C}"/>
          </ac:spMkLst>
        </pc:spChg>
        <pc:spChg chg="del">
          <ac:chgData name="Mendoza Valderrey, Alberto" userId="3ca0a5ef-cfc6-4d76-a1eb-aa1d46514f4a" providerId="ADAL" clId="{4F8E51F9-E0E7-4E38-A829-33EDC4CC36D3}" dt="2024-01-31T17:25:28.836" v="211" actId="478"/>
          <ac:spMkLst>
            <pc:docMk/>
            <pc:sldMk cId="2030739124" sldId="257"/>
            <ac:spMk id="136" creationId="{A62F2B25-A0A5-3839-CB45-F8C67CC51888}"/>
          </ac:spMkLst>
        </pc:spChg>
        <pc:spChg chg="add mod">
          <ac:chgData name="Mendoza Valderrey, Alberto" userId="3ca0a5ef-cfc6-4d76-a1eb-aa1d46514f4a" providerId="ADAL" clId="{4F8E51F9-E0E7-4E38-A829-33EDC4CC36D3}" dt="2024-02-01T00:19:07.180" v="1378" actId="1036"/>
          <ac:spMkLst>
            <pc:docMk/>
            <pc:sldMk cId="2030739124" sldId="257"/>
            <ac:spMk id="137" creationId="{7AF421ED-3262-9246-9117-D428FE1D250E}"/>
          </ac:spMkLst>
        </pc:spChg>
        <pc:spChg chg="del">
          <ac:chgData name="Mendoza Valderrey, Alberto" userId="3ca0a5ef-cfc6-4d76-a1eb-aa1d46514f4a" providerId="ADAL" clId="{4F8E51F9-E0E7-4E38-A829-33EDC4CC36D3}" dt="2024-01-31T17:25:32.187" v="213" actId="478"/>
          <ac:spMkLst>
            <pc:docMk/>
            <pc:sldMk cId="2030739124" sldId="257"/>
            <ac:spMk id="137" creationId="{F92256A1-54EE-A9BA-3461-1616368831CA}"/>
          </ac:spMkLst>
        </pc:spChg>
        <pc:spChg chg="add mod">
          <ac:chgData name="Mendoza Valderrey, Alberto" userId="3ca0a5ef-cfc6-4d76-a1eb-aa1d46514f4a" providerId="ADAL" clId="{4F8E51F9-E0E7-4E38-A829-33EDC4CC36D3}" dt="2024-02-01T00:19:07.180" v="1378" actId="1036"/>
          <ac:spMkLst>
            <pc:docMk/>
            <pc:sldMk cId="2030739124" sldId="257"/>
            <ac:spMk id="138" creationId="{2B8E2653-0ADB-9326-5613-FDD580ACC35D}"/>
          </ac:spMkLst>
        </pc:spChg>
        <pc:spChg chg="del">
          <ac:chgData name="Mendoza Valderrey, Alberto" userId="3ca0a5ef-cfc6-4d76-a1eb-aa1d46514f4a" providerId="ADAL" clId="{4F8E51F9-E0E7-4E38-A829-33EDC4CC36D3}" dt="2024-01-31T17:25:48.414" v="217" actId="478"/>
          <ac:spMkLst>
            <pc:docMk/>
            <pc:sldMk cId="2030739124" sldId="257"/>
            <ac:spMk id="138" creationId="{99170F35-3629-CE5B-AC9F-61CC4313A4E1}"/>
          </ac:spMkLst>
        </pc:spChg>
        <pc:spChg chg="mod">
          <ac:chgData name="Mendoza Valderrey, Alberto" userId="3ca0a5ef-cfc6-4d76-a1eb-aa1d46514f4a" providerId="ADAL" clId="{4F8E51F9-E0E7-4E38-A829-33EDC4CC36D3}" dt="2024-02-01T00:18:51.791" v="1353" actId="1036"/>
          <ac:spMkLst>
            <pc:docMk/>
            <pc:sldMk cId="2030739124" sldId="257"/>
            <ac:spMk id="139" creationId="{81555EC4-881B-CDC7-BF88-08DDF2B1EA9B}"/>
          </ac:spMkLst>
        </pc:spChg>
        <pc:spChg chg="del">
          <ac:chgData name="Mendoza Valderrey, Alberto" userId="3ca0a5ef-cfc6-4d76-a1eb-aa1d46514f4a" providerId="ADAL" clId="{4F8E51F9-E0E7-4E38-A829-33EDC4CC36D3}" dt="2024-01-31T17:26:11.796" v="220" actId="478"/>
          <ac:spMkLst>
            <pc:docMk/>
            <pc:sldMk cId="2030739124" sldId="257"/>
            <ac:spMk id="141" creationId="{07BD209B-A449-7B1C-C51C-E52597FBB37D}"/>
          </ac:spMkLst>
        </pc:spChg>
        <pc:spChg chg="add mod">
          <ac:chgData name="Mendoza Valderrey, Alberto" userId="3ca0a5ef-cfc6-4d76-a1eb-aa1d46514f4a" providerId="ADAL" clId="{4F8E51F9-E0E7-4E38-A829-33EDC4CC36D3}" dt="2024-02-01T00:36:28.962" v="1517" actId="1035"/>
          <ac:spMkLst>
            <pc:docMk/>
            <pc:sldMk cId="2030739124" sldId="257"/>
            <ac:spMk id="141" creationId="{103BC343-EB27-34FB-C819-6E26E212A7F8}"/>
          </ac:spMkLst>
        </pc:spChg>
        <pc:spChg chg="mod">
          <ac:chgData name="Mendoza Valderrey, Alberto" userId="3ca0a5ef-cfc6-4d76-a1eb-aa1d46514f4a" providerId="ADAL" clId="{4F8E51F9-E0E7-4E38-A829-33EDC4CC36D3}" dt="2024-02-01T00:18:51.791" v="1353" actId="1036"/>
          <ac:spMkLst>
            <pc:docMk/>
            <pc:sldMk cId="2030739124" sldId="257"/>
            <ac:spMk id="158" creationId="{E621D120-6870-1F50-A7E0-C011C27A29B7}"/>
          </ac:spMkLst>
        </pc:spChg>
        <pc:spChg chg="mod">
          <ac:chgData name="Mendoza Valderrey, Alberto" userId="3ca0a5ef-cfc6-4d76-a1eb-aa1d46514f4a" providerId="ADAL" clId="{4F8E51F9-E0E7-4E38-A829-33EDC4CC36D3}" dt="2024-02-01T00:18:51.791" v="1353" actId="1036"/>
          <ac:spMkLst>
            <pc:docMk/>
            <pc:sldMk cId="2030739124" sldId="257"/>
            <ac:spMk id="188" creationId="{7BEFD2BA-A076-F33B-B86F-BA9EA5516653}"/>
          </ac:spMkLst>
        </pc:spChg>
        <pc:spChg chg="mod">
          <ac:chgData name="Mendoza Valderrey, Alberto" userId="3ca0a5ef-cfc6-4d76-a1eb-aa1d46514f4a" providerId="ADAL" clId="{4F8E51F9-E0E7-4E38-A829-33EDC4CC36D3}" dt="2024-02-01T00:18:51.791" v="1353" actId="1036"/>
          <ac:spMkLst>
            <pc:docMk/>
            <pc:sldMk cId="2030739124" sldId="257"/>
            <ac:spMk id="189" creationId="{BF0C02E4-EBC4-3A5A-95C3-390886268173}"/>
          </ac:spMkLst>
        </pc:spChg>
        <pc:spChg chg="mod">
          <ac:chgData name="Mendoza Valderrey, Alberto" userId="3ca0a5ef-cfc6-4d76-a1eb-aa1d46514f4a" providerId="ADAL" clId="{4F8E51F9-E0E7-4E38-A829-33EDC4CC36D3}" dt="2024-02-01T00:18:51.791" v="1353" actId="1036"/>
          <ac:spMkLst>
            <pc:docMk/>
            <pc:sldMk cId="2030739124" sldId="257"/>
            <ac:spMk id="190" creationId="{0AF51E9C-B059-EC6B-A109-75A8C370BBAD}"/>
          </ac:spMkLst>
        </pc:spChg>
        <pc:spChg chg="mod">
          <ac:chgData name="Mendoza Valderrey, Alberto" userId="3ca0a5ef-cfc6-4d76-a1eb-aa1d46514f4a" providerId="ADAL" clId="{4F8E51F9-E0E7-4E38-A829-33EDC4CC36D3}" dt="2024-02-01T00:18:51.791" v="1353" actId="1036"/>
          <ac:spMkLst>
            <pc:docMk/>
            <pc:sldMk cId="2030739124" sldId="257"/>
            <ac:spMk id="191" creationId="{CD32C471-12F2-0C4A-580B-8D03FD2DFB75}"/>
          </ac:spMkLst>
        </pc:spChg>
        <pc:spChg chg="mod">
          <ac:chgData name="Mendoza Valderrey, Alberto" userId="3ca0a5ef-cfc6-4d76-a1eb-aa1d46514f4a" providerId="ADAL" clId="{4F8E51F9-E0E7-4E38-A829-33EDC4CC36D3}" dt="2024-02-01T00:18:51.791" v="1353" actId="1036"/>
          <ac:spMkLst>
            <pc:docMk/>
            <pc:sldMk cId="2030739124" sldId="257"/>
            <ac:spMk id="192" creationId="{D04C9E61-AAA6-4FFE-E18D-ABB607469DDC}"/>
          </ac:spMkLst>
        </pc:spChg>
        <pc:spChg chg="mod">
          <ac:chgData name="Mendoza Valderrey, Alberto" userId="3ca0a5ef-cfc6-4d76-a1eb-aa1d46514f4a" providerId="ADAL" clId="{4F8E51F9-E0E7-4E38-A829-33EDC4CC36D3}" dt="2024-02-01T00:18:51.791" v="1353" actId="1036"/>
          <ac:spMkLst>
            <pc:docMk/>
            <pc:sldMk cId="2030739124" sldId="257"/>
            <ac:spMk id="194" creationId="{63160D9E-5E92-E218-1427-E8876C01303E}"/>
          </ac:spMkLst>
        </pc:spChg>
        <pc:spChg chg="add mod">
          <ac:chgData name="Mendoza Valderrey, Alberto" userId="3ca0a5ef-cfc6-4d76-a1eb-aa1d46514f4a" providerId="ADAL" clId="{4F8E51F9-E0E7-4E38-A829-33EDC4CC36D3}" dt="2024-02-01T00:36:28.962" v="1517" actId="1035"/>
          <ac:spMkLst>
            <pc:docMk/>
            <pc:sldMk cId="2030739124" sldId="257"/>
            <ac:spMk id="195" creationId="{E418586F-3004-F04E-2F8B-F448AC9B90BA}"/>
          </ac:spMkLst>
        </pc:spChg>
        <pc:spChg chg="mod">
          <ac:chgData name="Mendoza Valderrey, Alberto" userId="3ca0a5ef-cfc6-4d76-a1eb-aa1d46514f4a" providerId="ADAL" clId="{4F8E51F9-E0E7-4E38-A829-33EDC4CC36D3}" dt="2024-02-01T00:27:52.326" v="1395" actId="20577"/>
          <ac:spMkLst>
            <pc:docMk/>
            <pc:sldMk cId="2030739124" sldId="257"/>
            <ac:spMk id="199" creationId="{5AA5856F-06C3-B5E8-3D8F-E631E521DB65}"/>
          </ac:spMkLst>
        </pc:spChg>
        <pc:spChg chg="add mod">
          <ac:chgData name="Mendoza Valderrey, Alberto" userId="3ca0a5ef-cfc6-4d76-a1eb-aa1d46514f4a" providerId="ADAL" clId="{4F8E51F9-E0E7-4E38-A829-33EDC4CC36D3}" dt="2024-02-01T00:30:31.536" v="1400" actId="1076"/>
          <ac:spMkLst>
            <pc:docMk/>
            <pc:sldMk cId="2030739124" sldId="257"/>
            <ac:spMk id="201" creationId="{1EA4DCDA-5BF2-EA4B-9984-7DFFC56E3E2C}"/>
          </ac:spMkLst>
        </pc:spChg>
        <pc:spChg chg="add mod">
          <ac:chgData name="Mendoza Valderrey, Alberto" userId="3ca0a5ef-cfc6-4d76-a1eb-aa1d46514f4a" providerId="ADAL" clId="{4F8E51F9-E0E7-4E38-A829-33EDC4CC36D3}" dt="2024-02-01T00:33:28.327" v="1443" actId="1076"/>
          <ac:spMkLst>
            <pc:docMk/>
            <pc:sldMk cId="2030739124" sldId="257"/>
            <ac:spMk id="202" creationId="{DE54FD22-0715-5042-4762-DDBCD44E59AD}"/>
          </ac:spMkLst>
        </pc:spChg>
        <pc:spChg chg="add mod">
          <ac:chgData name="Mendoza Valderrey, Alberto" userId="3ca0a5ef-cfc6-4d76-a1eb-aa1d46514f4a" providerId="ADAL" clId="{4F8E51F9-E0E7-4E38-A829-33EDC4CC36D3}" dt="2024-02-01T00:33:31.487" v="1444" actId="1076"/>
          <ac:spMkLst>
            <pc:docMk/>
            <pc:sldMk cId="2030739124" sldId="257"/>
            <ac:spMk id="203" creationId="{686F6990-CDCC-48BD-C5CC-D90E357F94F4}"/>
          </ac:spMkLst>
        </pc:spChg>
        <pc:spChg chg="add mod">
          <ac:chgData name="Mendoza Valderrey, Alberto" userId="3ca0a5ef-cfc6-4d76-a1eb-aa1d46514f4a" providerId="ADAL" clId="{4F8E51F9-E0E7-4E38-A829-33EDC4CC36D3}" dt="2024-02-01T00:33:35.255" v="1445" actId="1076"/>
          <ac:spMkLst>
            <pc:docMk/>
            <pc:sldMk cId="2030739124" sldId="257"/>
            <ac:spMk id="204" creationId="{3B58A7ED-798D-93E0-9841-2E47000C8FA4}"/>
          </ac:spMkLst>
        </pc:spChg>
        <pc:spChg chg="add mod">
          <ac:chgData name="Mendoza Valderrey, Alberto" userId="3ca0a5ef-cfc6-4d76-a1eb-aa1d46514f4a" providerId="ADAL" clId="{4F8E51F9-E0E7-4E38-A829-33EDC4CC36D3}" dt="2024-02-01T00:33:38.519" v="1446" actId="1076"/>
          <ac:spMkLst>
            <pc:docMk/>
            <pc:sldMk cId="2030739124" sldId="257"/>
            <ac:spMk id="205" creationId="{42A4B5E5-A07A-8C7E-5355-AF426E737B86}"/>
          </ac:spMkLst>
        </pc:spChg>
        <pc:spChg chg="add mod">
          <ac:chgData name="Mendoza Valderrey, Alberto" userId="3ca0a5ef-cfc6-4d76-a1eb-aa1d46514f4a" providerId="ADAL" clId="{4F8E51F9-E0E7-4E38-A829-33EDC4CC36D3}" dt="2024-02-01T00:33:44.518" v="1447" actId="1076"/>
          <ac:spMkLst>
            <pc:docMk/>
            <pc:sldMk cId="2030739124" sldId="257"/>
            <ac:spMk id="206" creationId="{CB85C4EC-22C6-607F-F4C5-AB6F53DA9CEF}"/>
          </ac:spMkLst>
        </pc:spChg>
        <pc:spChg chg="add mod">
          <ac:chgData name="Mendoza Valderrey, Alberto" userId="3ca0a5ef-cfc6-4d76-a1eb-aa1d46514f4a" providerId="ADAL" clId="{4F8E51F9-E0E7-4E38-A829-33EDC4CC36D3}" dt="2024-02-01T00:33:48.759" v="1448" actId="1076"/>
          <ac:spMkLst>
            <pc:docMk/>
            <pc:sldMk cId="2030739124" sldId="257"/>
            <ac:spMk id="207" creationId="{096CDF7C-66D6-105F-8800-2BB23CF1EAB3}"/>
          </ac:spMkLst>
        </pc:spChg>
        <pc:spChg chg="add mod">
          <ac:chgData name="Mendoza Valderrey, Alberto" userId="3ca0a5ef-cfc6-4d76-a1eb-aa1d46514f4a" providerId="ADAL" clId="{4F8E51F9-E0E7-4E38-A829-33EDC4CC36D3}" dt="2024-02-01T00:33:55.093" v="1449" actId="1076"/>
          <ac:spMkLst>
            <pc:docMk/>
            <pc:sldMk cId="2030739124" sldId="257"/>
            <ac:spMk id="208" creationId="{4AE7905C-469F-CDE9-BC3E-B874E94C501D}"/>
          </ac:spMkLst>
        </pc:spChg>
        <pc:spChg chg="add mod">
          <ac:chgData name="Mendoza Valderrey, Alberto" userId="3ca0a5ef-cfc6-4d76-a1eb-aa1d46514f4a" providerId="ADAL" clId="{4F8E51F9-E0E7-4E38-A829-33EDC4CC36D3}" dt="2024-02-01T00:33:59.127" v="1450" actId="1076"/>
          <ac:spMkLst>
            <pc:docMk/>
            <pc:sldMk cId="2030739124" sldId="257"/>
            <ac:spMk id="209" creationId="{6F10D31E-FC29-744C-EEAF-610F7445D127}"/>
          </ac:spMkLst>
        </pc:spChg>
        <pc:spChg chg="add mod">
          <ac:chgData name="Mendoza Valderrey, Alberto" userId="3ca0a5ef-cfc6-4d76-a1eb-aa1d46514f4a" providerId="ADAL" clId="{4F8E51F9-E0E7-4E38-A829-33EDC4CC36D3}" dt="2024-02-01T00:34:04.966" v="1451" actId="1076"/>
          <ac:spMkLst>
            <pc:docMk/>
            <pc:sldMk cId="2030739124" sldId="257"/>
            <ac:spMk id="210" creationId="{B5FCF5AB-33A8-800F-25A0-7956B3EF8E5A}"/>
          </ac:spMkLst>
        </pc:spChg>
        <pc:spChg chg="add mod">
          <ac:chgData name="Mendoza Valderrey, Alberto" userId="3ca0a5ef-cfc6-4d76-a1eb-aa1d46514f4a" providerId="ADAL" clId="{4F8E51F9-E0E7-4E38-A829-33EDC4CC36D3}" dt="2024-02-01T00:36:10.560" v="1497" actId="20577"/>
          <ac:spMkLst>
            <pc:docMk/>
            <pc:sldMk cId="2030739124" sldId="257"/>
            <ac:spMk id="211" creationId="{257C2E14-72A7-9D6C-AE52-EE5C504BC77A}"/>
          </ac:spMkLst>
        </pc:spChg>
        <pc:spChg chg="add mod">
          <ac:chgData name="Mendoza Valderrey, Alberto" userId="3ca0a5ef-cfc6-4d76-a1eb-aa1d46514f4a" providerId="ADAL" clId="{4F8E51F9-E0E7-4E38-A829-33EDC4CC36D3}" dt="2024-02-01T00:35:56.629" v="1486" actId="1036"/>
          <ac:spMkLst>
            <pc:docMk/>
            <pc:sldMk cId="2030739124" sldId="257"/>
            <ac:spMk id="212" creationId="{84A1F593-A85C-70C7-C9F3-FEFB39A0ABAA}"/>
          </ac:spMkLst>
        </pc:spChg>
        <pc:grpChg chg="add mod">
          <ac:chgData name="Mendoza Valderrey, Alberto" userId="3ca0a5ef-cfc6-4d76-a1eb-aa1d46514f4a" providerId="ADAL" clId="{4F8E51F9-E0E7-4E38-A829-33EDC4CC36D3}" dt="2024-02-01T00:13:00.526" v="1043" actId="1076"/>
          <ac:grpSpMkLst>
            <pc:docMk/>
            <pc:sldMk cId="2030739124" sldId="257"/>
            <ac:grpSpMk id="2" creationId="{88E0EC0F-218F-8904-CC12-07FD850BB729}"/>
          </ac:grpSpMkLst>
        </pc:grpChg>
        <pc:grpChg chg="del mod">
          <ac:chgData name="Mendoza Valderrey, Alberto" userId="3ca0a5ef-cfc6-4d76-a1eb-aa1d46514f4a" providerId="ADAL" clId="{4F8E51F9-E0E7-4E38-A829-33EDC4CC36D3}" dt="2024-01-31T17:21:19.996" v="16" actId="165"/>
          <ac:grpSpMkLst>
            <pc:docMk/>
            <pc:sldMk cId="2030739124" sldId="257"/>
            <ac:grpSpMk id="18" creationId="{375E59ED-0A8C-8906-8D24-B3B968A78AF2}"/>
          </ac:grpSpMkLst>
        </pc:grpChg>
        <pc:grpChg chg="add mod">
          <ac:chgData name="Mendoza Valderrey, Alberto" userId="3ca0a5ef-cfc6-4d76-a1eb-aa1d46514f4a" providerId="ADAL" clId="{4F8E51F9-E0E7-4E38-A829-33EDC4CC36D3}" dt="2024-02-01T00:27:45.568" v="1390" actId="1076"/>
          <ac:grpSpMkLst>
            <pc:docMk/>
            <pc:sldMk cId="2030739124" sldId="257"/>
            <ac:grpSpMk id="196" creationId="{68F29A1F-5BA9-7906-CDC8-F363B7DE64E3}"/>
          </ac:grpSpMkLst>
        </pc:grpChg>
        <pc:picChg chg="add del mod">
          <ac:chgData name="Mendoza Valderrey, Alberto" userId="3ca0a5ef-cfc6-4d76-a1eb-aa1d46514f4a" providerId="ADAL" clId="{4F8E51F9-E0E7-4E38-A829-33EDC4CC36D3}" dt="2024-01-31T23:49:13.064" v="714" actId="478"/>
          <ac:picMkLst>
            <pc:docMk/>
            <pc:sldMk cId="2030739124" sldId="257"/>
            <ac:picMk id="4" creationId="{A931A929-AEA1-1271-A967-30E1464E4C37}"/>
          </ac:picMkLst>
        </pc:picChg>
        <pc:picChg chg="add mod modCrop">
          <ac:chgData name="Mendoza Valderrey, Alberto" userId="3ca0a5ef-cfc6-4d76-a1eb-aa1d46514f4a" providerId="ADAL" clId="{4F8E51F9-E0E7-4E38-A829-33EDC4CC36D3}" dt="2024-02-01T00:35:35.415" v="1469" actId="732"/>
          <ac:picMkLst>
            <pc:docMk/>
            <pc:sldMk cId="2030739124" sldId="257"/>
            <ac:picMk id="18" creationId="{34C9B71A-CC50-1DC9-AC25-2716003E4E0E}"/>
          </ac:picMkLst>
        </pc:picChg>
        <pc:picChg chg="add del mod">
          <ac:chgData name="Mendoza Valderrey, Alberto" userId="3ca0a5ef-cfc6-4d76-a1eb-aa1d46514f4a" providerId="ADAL" clId="{4F8E51F9-E0E7-4E38-A829-33EDC4CC36D3}" dt="2024-01-31T18:28:22.564" v="330" actId="478"/>
          <ac:picMkLst>
            <pc:docMk/>
            <pc:sldMk cId="2030739124" sldId="257"/>
            <ac:picMk id="47" creationId="{7D219284-9897-9098-184A-D77DD4853967}"/>
          </ac:picMkLst>
        </pc:picChg>
        <pc:picChg chg="add del mod">
          <ac:chgData name="Mendoza Valderrey, Alberto" userId="3ca0a5ef-cfc6-4d76-a1eb-aa1d46514f4a" providerId="ADAL" clId="{4F8E51F9-E0E7-4E38-A829-33EDC4CC36D3}" dt="2024-01-31T18:28:22.564" v="330" actId="478"/>
          <ac:picMkLst>
            <pc:docMk/>
            <pc:sldMk cId="2030739124" sldId="257"/>
            <ac:picMk id="49" creationId="{CAA1D383-12DC-572C-5E07-14B37F326690}"/>
          </ac:picMkLst>
        </pc:picChg>
        <pc:picChg chg="add mod modCrop">
          <ac:chgData name="Mendoza Valderrey, Alberto" userId="3ca0a5ef-cfc6-4d76-a1eb-aa1d46514f4a" providerId="ADAL" clId="{4F8E51F9-E0E7-4E38-A829-33EDC4CC36D3}" dt="2024-02-01T00:36:28.962" v="1517" actId="1035"/>
          <ac:picMkLst>
            <pc:docMk/>
            <pc:sldMk cId="2030739124" sldId="257"/>
            <ac:picMk id="56" creationId="{31D12F4E-B21D-60B7-FC95-2FF29B7EC4D1}"/>
          </ac:picMkLst>
        </pc:picChg>
        <pc:picChg chg="add mod">
          <ac:chgData name="Mendoza Valderrey, Alberto" userId="3ca0a5ef-cfc6-4d76-a1eb-aa1d46514f4a" providerId="ADAL" clId="{4F8E51F9-E0E7-4E38-A829-33EDC4CC36D3}" dt="2024-02-01T00:36:28.962" v="1517" actId="1035"/>
          <ac:picMkLst>
            <pc:docMk/>
            <pc:sldMk cId="2030739124" sldId="257"/>
            <ac:picMk id="57" creationId="{F69BDAC9-D395-03F1-D4F8-CC53E1B4B51C}"/>
          </ac:picMkLst>
        </pc:picChg>
        <pc:picChg chg="add mod modCrop">
          <ac:chgData name="Mendoza Valderrey, Alberto" userId="3ca0a5ef-cfc6-4d76-a1eb-aa1d46514f4a" providerId="ADAL" clId="{4F8E51F9-E0E7-4E38-A829-33EDC4CC36D3}" dt="2024-02-01T00:36:28.962" v="1517" actId="1035"/>
          <ac:picMkLst>
            <pc:docMk/>
            <pc:sldMk cId="2030739124" sldId="257"/>
            <ac:picMk id="61" creationId="{ED3F6FE7-B14C-FAFE-2E9F-D94588376807}"/>
          </ac:picMkLst>
        </pc:picChg>
        <pc:picChg chg="add mod ord modCrop">
          <ac:chgData name="Mendoza Valderrey, Alberto" userId="3ca0a5ef-cfc6-4d76-a1eb-aa1d46514f4a" providerId="ADAL" clId="{4F8E51F9-E0E7-4E38-A829-33EDC4CC36D3}" dt="2024-02-01T00:09:25.663" v="945" actId="2085"/>
          <ac:picMkLst>
            <pc:docMk/>
            <pc:sldMk cId="2030739124" sldId="257"/>
            <ac:picMk id="65" creationId="{2932540B-61E4-308B-AB02-DD772851555D}"/>
          </ac:picMkLst>
        </pc:picChg>
        <pc:picChg chg="mod">
          <ac:chgData name="Mendoza Valderrey, Alberto" userId="3ca0a5ef-cfc6-4d76-a1eb-aa1d46514f4a" providerId="ADAL" clId="{4F8E51F9-E0E7-4E38-A829-33EDC4CC36D3}" dt="2024-02-01T00:18:51.791" v="1353" actId="1036"/>
          <ac:picMkLst>
            <pc:docMk/>
            <pc:sldMk cId="2030739124" sldId="257"/>
            <ac:picMk id="119" creationId="{37D544DA-3643-766A-9605-9B99AF71BEFB}"/>
          </ac:picMkLst>
        </pc:picChg>
        <pc:picChg chg="mod">
          <ac:chgData name="Mendoza Valderrey, Alberto" userId="3ca0a5ef-cfc6-4d76-a1eb-aa1d46514f4a" providerId="ADAL" clId="{4F8E51F9-E0E7-4E38-A829-33EDC4CC36D3}" dt="2024-02-01T00:18:51.791" v="1353" actId="1036"/>
          <ac:picMkLst>
            <pc:docMk/>
            <pc:sldMk cId="2030739124" sldId="257"/>
            <ac:picMk id="120" creationId="{83AA463F-3F35-AE2F-52B5-BB2C7C25C8DB}"/>
          </ac:picMkLst>
        </pc:picChg>
        <pc:picChg chg="mod">
          <ac:chgData name="Mendoza Valderrey, Alberto" userId="3ca0a5ef-cfc6-4d76-a1eb-aa1d46514f4a" providerId="ADAL" clId="{4F8E51F9-E0E7-4E38-A829-33EDC4CC36D3}" dt="2024-02-01T00:18:51.791" v="1353" actId="1036"/>
          <ac:picMkLst>
            <pc:docMk/>
            <pc:sldMk cId="2030739124" sldId="257"/>
            <ac:picMk id="121" creationId="{D7A006EA-278B-9910-09C5-533F03542947}"/>
          </ac:picMkLst>
        </pc:picChg>
        <pc:picChg chg="mod">
          <ac:chgData name="Mendoza Valderrey, Alberto" userId="3ca0a5ef-cfc6-4d76-a1eb-aa1d46514f4a" providerId="ADAL" clId="{4F8E51F9-E0E7-4E38-A829-33EDC4CC36D3}" dt="2024-02-01T00:18:51.791" v="1353" actId="1036"/>
          <ac:picMkLst>
            <pc:docMk/>
            <pc:sldMk cId="2030739124" sldId="257"/>
            <ac:picMk id="122" creationId="{B918B14A-AE80-89BA-3DBF-D12315812667}"/>
          </ac:picMkLst>
        </pc:picChg>
        <pc:picChg chg="mod">
          <ac:chgData name="Mendoza Valderrey, Alberto" userId="3ca0a5ef-cfc6-4d76-a1eb-aa1d46514f4a" providerId="ADAL" clId="{4F8E51F9-E0E7-4E38-A829-33EDC4CC36D3}" dt="2024-02-01T00:18:51.791" v="1353" actId="1036"/>
          <ac:picMkLst>
            <pc:docMk/>
            <pc:sldMk cId="2030739124" sldId="257"/>
            <ac:picMk id="193" creationId="{30C038D6-6371-AAA9-8583-EB23590C76A1}"/>
          </ac:picMkLst>
        </pc:picChg>
        <pc:cxnChg chg="mod topLvl">
          <ac:chgData name="Mendoza Valderrey, Alberto" userId="3ca0a5ef-cfc6-4d76-a1eb-aa1d46514f4a" providerId="ADAL" clId="{4F8E51F9-E0E7-4E38-A829-33EDC4CC36D3}" dt="2024-01-31T17:24:19.319" v="200" actId="164"/>
          <ac:cxnSpMkLst>
            <pc:docMk/>
            <pc:sldMk cId="2030739124" sldId="257"/>
            <ac:cxnSpMk id="21" creationId="{6CE4AF3B-B303-8AAF-3374-777B587EA706}"/>
          </ac:cxnSpMkLst>
        </pc:cxnChg>
        <pc:cxnChg chg="mod topLvl">
          <ac:chgData name="Mendoza Valderrey, Alberto" userId="3ca0a5ef-cfc6-4d76-a1eb-aa1d46514f4a" providerId="ADAL" clId="{4F8E51F9-E0E7-4E38-A829-33EDC4CC36D3}" dt="2024-01-31T17:24:19.319" v="200" actId="164"/>
          <ac:cxnSpMkLst>
            <pc:docMk/>
            <pc:sldMk cId="2030739124" sldId="257"/>
            <ac:cxnSpMk id="22" creationId="{D1773648-6332-C6CA-A08B-8324AA741A08}"/>
          </ac:cxnSpMkLst>
        </pc:cxnChg>
        <pc:cxnChg chg="mod">
          <ac:chgData name="Mendoza Valderrey, Alberto" userId="3ca0a5ef-cfc6-4d76-a1eb-aa1d46514f4a" providerId="ADAL" clId="{4F8E51F9-E0E7-4E38-A829-33EDC4CC36D3}" dt="2024-01-31T17:20:33.360" v="14" actId="1038"/>
          <ac:cxnSpMkLst>
            <pc:docMk/>
            <pc:sldMk cId="2030739124" sldId="257"/>
            <ac:cxnSpMk id="26" creationId="{95873F42-4E25-7A83-C125-8A5EF77A72AE}"/>
          </ac:cxnSpMkLst>
        </pc:cxnChg>
        <pc:cxnChg chg="mod">
          <ac:chgData name="Mendoza Valderrey, Alberto" userId="3ca0a5ef-cfc6-4d76-a1eb-aa1d46514f4a" providerId="ADAL" clId="{4F8E51F9-E0E7-4E38-A829-33EDC4CC36D3}" dt="2024-01-31T17:20:33.360" v="14" actId="1038"/>
          <ac:cxnSpMkLst>
            <pc:docMk/>
            <pc:sldMk cId="2030739124" sldId="257"/>
            <ac:cxnSpMk id="27" creationId="{92D23368-02BB-A378-55DA-6E968C327B41}"/>
          </ac:cxnSpMkLst>
        </pc:cxnChg>
        <pc:cxnChg chg="mod">
          <ac:chgData name="Mendoza Valderrey, Alberto" userId="3ca0a5ef-cfc6-4d76-a1eb-aa1d46514f4a" providerId="ADAL" clId="{4F8E51F9-E0E7-4E38-A829-33EDC4CC36D3}" dt="2024-01-31T17:20:33.360" v="14" actId="1038"/>
          <ac:cxnSpMkLst>
            <pc:docMk/>
            <pc:sldMk cId="2030739124" sldId="257"/>
            <ac:cxnSpMk id="28" creationId="{F12C9A7A-A596-EA51-F361-3FA13D37B81E}"/>
          </ac:cxnSpMkLst>
        </pc:cxnChg>
        <pc:cxnChg chg="add mod">
          <ac:chgData name="Mendoza Valderrey, Alberto" userId="3ca0a5ef-cfc6-4d76-a1eb-aa1d46514f4a" providerId="ADAL" clId="{4F8E51F9-E0E7-4E38-A829-33EDC4CC36D3}" dt="2024-01-31T23:52:53.837" v="803" actId="692"/>
          <ac:cxnSpMkLst>
            <pc:docMk/>
            <pc:sldMk cId="2030739124" sldId="257"/>
            <ac:cxnSpMk id="66" creationId="{926DB50C-F787-8AAF-0235-47523E2684A6}"/>
          </ac:cxnSpMkLst>
        </pc:cxnChg>
        <pc:cxnChg chg="add mod">
          <ac:chgData name="Mendoza Valderrey, Alberto" userId="3ca0a5ef-cfc6-4d76-a1eb-aa1d46514f4a" providerId="ADAL" clId="{4F8E51F9-E0E7-4E38-A829-33EDC4CC36D3}" dt="2024-01-31T23:54:05.185" v="821" actId="1076"/>
          <ac:cxnSpMkLst>
            <pc:docMk/>
            <pc:sldMk cId="2030739124" sldId="257"/>
            <ac:cxnSpMk id="69" creationId="{C09BD84F-5BC8-2F87-C592-BCDDE9437317}"/>
          </ac:cxnSpMkLst>
        </pc:cxnChg>
        <pc:cxnChg chg="add mod">
          <ac:chgData name="Mendoza Valderrey, Alberto" userId="3ca0a5ef-cfc6-4d76-a1eb-aa1d46514f4a" providerId="ADAL" clId="{4F8E51F9-E0E7-4E38-A829-33EDC4CC36D3}" dt="2024-01-31T23:54:15.555" v="824" actId="1076"/>
          <ac:cxnSpMkLst>
            <pc:docMk/>
            <pc:sldMk cId="2030739124" sldId="257"/>
            <ac:cxnSpMk id="72" creationId="{07AC770F-FE30-1633-9EA8-37332F2BFC40}"/>
          </ac:cxnSpMkLst>
        </pc:cxnChg>
        <pc:cxnChg chg="add mod">
          <ac:chgData name="Mendoza Valderrey, Alberto" userId="3ca0a5ef-cfc6-4d76-a1eb-aa1d46514f4a" providerId="ADAL" clId="{4F8E51F9-E0E7-4E38-A829-33EDC4CC36D3}" dt="2024-01-31T23:54:50.145" v="832" actId="1076"/>
          <ac:cxnSpMkLst>
            <pc:docMk/>
            <pc:sldMk cId="2030739124" sldId="257"/>
            <ac:cxnSpMk id="75" creationId="{59765263-E917-A37F-3C50-6DC274E72599}"/>
          </ac:cxnSpMkLst>
        </pc:cxnChg>
        <pc:cxnChg chg="add mod">
          <ac:chgData name="Mendoza Valderrey, Alberto" userId="3ca0a5ef-cfc6-4d76-a1eb-aa1d46514f4a" providerId="ADAL" clId="{4F8E51F9-E0E7-4E38-A829-33EDC4CC36D3}" dt="2024-01-31T23:54:59.032" v="835" actId="1076"/>
          <ac:cxnSpMkLst>
            <pc:docMk/>
            <pc:sldMk cId="2030739124" sldId="257"/>
            <ac:cxnSpMk id="77" creationId="{7C142E8A-1450-79CB-F557-493781BB81F1}"/>
          </ac:cxnSpMkLst>
        </pc:cxnChg>
        <pc:cxnChg chg="add mod">
          <ac:chgData name="Mendoza Valderrey, Alberto" userId="3ca0a5ef-cfc6-4d76-a1eb-aa1d46514f4a" providerId="ADAL" clId="{4F8E51F9-E0E7-4E38-A829-33EDC4CC36D3}" dt="2024-01-31T23:55:07.728" v="839" actId="1076"/>
          <ac:cxnSpMkLst>
            <pc:docMk/>
            <pc:sldMk cId="2030739124" sldId="257"/>
            <ac:cxnSpMk id="79" creationId="{B7521503-3A1F-F79D-DE9F-94CB03A39652}"/>
          </ac:cxnSpMkLst>
        </pc:cxnChg>
        <pc:cxnChg chg="add mod">
          <ac:chgData name="Mendoza Valderrey, Alberto" userId="3ca0a5ef-cfc6-4d76-a1eb-aa1d46514f4a" providerId="ADAL" clId="{4F8E51F9-E0E7-4E38-A829-33EDC4CC36D3}" dt="2024-01-31T23:57:32.775" v="886" actId="14100"/>
          <ac:cxnSpMkLst>
            <pc:docMk/>
            <pc:sldMk cId="2030739124" sldId="257"/>
            <ac:cxnSpMk id="81" creationId="{474B5CD3-B8DF-3308-B912-BF105B8013CD}"/>
          </ac:cxnSpMkLst>
        </pc:cxnChg>
        <pc:cxnChg chg="add mod">
          <ac:chgData name="Mendoza Valderrey, Alberto" userId="3ca0a5ef-cfc6-4d76-a1eb-aa1d46514f4a" providerId="ADAL" clId="{4F8E51F9-E0E7-4E38-A829-33EDC4CC36D3}" dt="2024-01-31T23:55:24.749" v="845" actId="1076"/>
          <ac:cxnSpMkLst>
            <pc:docMk/>
            <pc:sldMk cId="2030739124" sldId="257"/>
            <ac:cxnSpMk id="83" creationId="{06FE546E-389B-F15A-6890-5D892840E3FB}"/>
          </ac:cxnSpMkLst>
        </pc:cxnChg>
        <pc:cxnChg chg="add mod">
          <ac:chgData name="Mendoza Valderrey, Alberto" userId="3ca0a5ef-cfc6-4d76-a1eb-aa1d46514f4a" providerId="ADAL" clId="{4F8E51F9-E0E7-4E38-A829-33EDC4CC36D3}" dt="2024-01-31T23:55:35.977" v="848" actId="1076"/>
          <ac:cxnSpMkLst>
            <pc:docMk/>
            <pc:sldMk cId="2030739124" sldId="257"/>
            <ac:cxnSpMk id="85" creationId="{85BFF7FD-FA9C-BF1E-085D-F9A648A8577E}"/>
          </ac:cxnSpMkLst>
        </pc:cxnChg>
        <pc:cxnChg chg="add mod">
          <ac:chgData name="Mendoza Valderrey, Alberto" userId="3ca0a5ef-cfc6-4d76-a1eb-aa1d46514f4a" providerId="ADAL" clId="{4F8E51F9-E0E7-4E38-A829-33EDC4CC36D3}" dt="2024-01-31T23:55:44.913" v="852" actId="1076"/>
          <ac:cxnSpMkLst>
            <pc:docMk/>
            <pc:sldMk cId="2030739124" sldId="257"/>
            <ac:cxnSpMk id="87" creationId="{8DCC07A2-2E49-D884-2713-18CDD889979C}"/>
          </ac:cxnSpMkLst>
        </pc:cxnChg>
        <pc:cxnChg chg="add mod">
          <ac:chgData name="Mendoza Valderrey, Alberto" userId="3ca0a5ef-cfc6-4d76-a1eb-aa1d46514f4a" providerId="ADAL" clId="{4F8E51F9-E0E7-4E38-A829-33EDC4CC36D3}" dt="2024-01-31T23:56:02.624" v="857" actId="1076"/>
          <ac:cxnSpMkLst>
            <pc:docMk/>
            <pc:sldMk cId="2030739124" sldId="257"/>
            <ac:cxnSpMk id="89" creationId="{3E79516F-420E-59A2-393B-699D19077074}"/>
          </ac:cxnSpMkLst>
        </pc:cxnChg>
        <pc:cxnChg chg="add mod">
          <ac:chgData name="Mendoza Valderrey, Alberto" userId="3ca0a5ef-cfc6-4d76-a1eb-aa1d46514f4a" providerId="ADAL" clId="{4F8E51F9-E0E7-4E38-A829-33EDC4CC36D3}" dt="2024-01-31T23:56:11.873" v="861" actId="14100"/>
          <ac:cxnSpMkLst>
            <pc:docMk/>
            <pc:sldMk cId="2030739124" sldId="257"/>
            <ac:cxnSpMk id="92" creationId="{503FAD63-10BE-338F-1BDD-B6864AD94A31}"/>
          </ac:cxnSpMkLst>
        </pc:cxnChg>
        <pc:cxnChg chg="add mod">
          <ac:chgData name="Mendoza Valderrey, Alberto" userId="3ca0a5ef-cfc6-4d76-a1eb-aa1d46514f4a" providerId="ADAL" clId="{4F8E51F9-E0E7-4E38-A829-33EDC4CC36D3}" dt="2024-02-01T00:06:24.670" v="923" actId="14100"/>
          <ac:cxnSpMkLst>
            <pc:docMk/>
            <pc:sldMk cId="2030739124" sldId="257"/>
            <ac:cxnSpMk id="95" creationId="{21FB5F8F-683B-2B3E-A3B4-FF4A715B1B24}"/>
          </ac:cxnSpMkLst>
        </pc:cxnChg>
        <pc:cxnChg chg="add mod">
          <ac:chgData name="Mendoza Valderrey, Alberto" userId="3ca0a5ef-cfc6-4d76-a1eb-aa1d46514f4a" providerId="ADAL" clId="{4F8E51F9-E0E7-4E38-A829-33EDC4CC36D3}" dt="2024-02-01T00:07:41.687" v="939" actId="1076"/>
          <ac:cxnSpMkLst>
            <pc:docMk/>
            <pc:sldMk cId="2030739124" sldId="257"/>
            <ac:cxnSpMk id="97" creationId="{063F14CB-D18B-86CD-99D9-D31FE4FB6BD5}"/>
          </ac:cxnSpMkLst>
        </pc:cxnChg>
        <pc:cxnChg chg="add del mod">
          <ac:chgData name="Mendoza Valderrey, Alberto" userId="3ca0a5ef-cfc6-4d76-a1eb-aa1d46514f4a" providerId="ADAL" clId="{4F8E51F9-E0E7-4E38-A829-33EDC4CC36D3}" dt="2024-01-31T23:56:50.512" v="876" actId="478"/>
          <ac:cxnSpMkLst>
            <pc:docMk/>
            <pc:sldMk cId="2030739124" sldId="257"/>
            <ac:cxnSpMk id="99" creationId="{864E38F9-824D-116B-5ED6-4D715A9F554A}"/>
          </ac:cxnSpMkLst>
        </pc:cxnChg>
        <pc:cxnChg chg="add mod">
          <ac:chgData name="Mendoza Valderrey, Alberto" userId="3ca0a5ef-cfc6-4d76-a1eb-aa1d46514f4a" providerId="ADAL" clId="{4F8E51F9-E0E7-4E38-A829-33EDC4CC36D3}" dt="2024-01-31T23:57:04.561" v="881" actId="1076"/>
          <ac:cxnSpMkLst>
            <pc:docMk/>
            <pc:sldMk cId="2030739124" sldId="257"/>
            <ac:cxnSpMk id="105" creationId="{F4C37D38-8781-3E8A-C3BA-70645D62DDCC}"/>
          </ac:cxnSpMkLst>
        </pc:cxnChg>
        <pc:cxnChg chg="mod">
          <ac:chgData name="Mendoza Valderrey, Alberto" userId="3ca0a5ef-cfc6-4d76-a1eb-aa1d46514f4a" providerId="ADAL" clId="{4F8E51F9-E0E7-4E38-A829-33EDC4CC36D3}" dt="2024-02-01T00:18:51.791" v="1353" actId="1036"/>
          <ac:cxnSpMkLst>
            <pc:docMk/>
            <pc:sldMk cId="2030739124" sldId="257"/>
            <ac:cxnSpMk id="123" creationId="{65F7583F-4F88-8937-96A3-9B50660E7433}"/>
          </ac:cxnSpMkLst>
        </pc:cxnChg>
        <pc:cxnChg chg="mod">
          <ac:chgData name="Mendoza Valderrey, Alberto" userId="3ca0a5ef-cfc6-4d76-a1eb-aa1d46514f4a" providerId="ADAL" clId="{4F8E51F9-E0E7-4E38-A829-33EDC4CC36D3}" dt="2024-02-01T00:18:51.791" v="1353" actId="1036"/>
          <ac:cxnSpMkLst>
            <pc:docMk/>
            <pc:sldMk cId="2030739124" sldId="257"/>
            <ac:cxnSpMk id="126" creationId="{5FFF1D79-D7BE-1C04-1548-B1DEE322C48B}"/>
          </ac:cxnSpMkLst>
        </pc:cxnChg>
        <pc:cxnChg chg="mod">
          <ac:chgData name="Mendoza Valderrey, Alberto" userId="3ca0a5ef-cfc6-4d76-a1eb-aa1d46514f4a" providerId="ADAL" clId="{4F8E51F9-E0E7-4E38-A829-33EDC4CC36D3}" dt="2024-02-01T00:18:51.791" v="1353" actId="1036"/>
          <ac:cxnSpMkLst>
            <pc:docMk/>
            <pc:sldMk cId="2030739124" sldId="257"/>
            <ac:cxnSpMk id="156" creationId="{07A659AA-B1B9-CFE6-9528-3EAE1B644DEE}"/>
          </ac:cxnSpMkLst>
        </pc:cxnChg>
        <pc:cxnChg chg="mod">
          <ac:chgData name="Mendoza Valderrey, Alberto" userId="3ca0a5ef-cfc6-4d76-a1eb-aa1d46514f4a" providerId="ADAL" clId="{4F8E51F9-E0E7-4E38-A829-33EDC4CC36D3}" dt="2024-02-01T00:18:51.791" v="1353" actId="1036"/>
          <ac:cxnSpMkLst>
            <pc:docMk/>
            <pc:sldMk cId="2030739124" sldId="257"/>
            <ac:cxnSpMk id="157" creationId="{68E9BEA9-48A9-9720-13A1-FF1521033A58}"/>
          </ac:cxnSpMkLst>
        </pc:cxnChg>
        <pc:cxnChg chg="mod">
          <ac:chgData name="Mendoza Valderrey, Alberto" userId="3ca0a5ef-cfc6-4d76-a1eb-aa1d46514f4a" providerId="ADAL" clId="{4F8E51F9-E0E7-4E38-A829-33EDC4CC36D3}" dt="2024-02-01T00:27:40.917" v="1389"/>
          <ac:cxnSpMkLst>
            <pc:docMk/>
            <pc:sldMk cId="2030739124" sldId="257"/>
            <ac:cxnSpMk id="197" creationId="{0B062F5A-9898-E1B7-7C1A-1F5421E68403}"/>
          </ac:cxnSpMkLst>
        </pc:cxnChg>
        <pc:cxnChg chg="mod">
          <ac:chgData name="Mendoza Valderrey, Alberto" userId="3ca0a5ef-cfc6-4d76-a1eb-aa1d46514f4a" providerId="ADAL" clId="{4F8E51F9-E0E7-4E38-A829-33EDC4CC36D3}" dt="2024-02-01T00:27:40.917" v="1389"/>
          <ac:cxnSpMkLst>
            <pc:docMk/>
            <pc:sldMk cId="2030739124" sldId="257"/>
            <ac:cxnSpMk id="198" creationId="{D76781CE-66C1-1B73-036A-D8C79C3114A3}"/>
          </ac:cxnSpMkLst>
        </pc:cxnChg>
        <pc:cxnChg chg="mod">
          <ac:chgData name="Mendoza Valderrey, Alberto" userId="3ca0a5ef-cfc6-4d76-a1eb-aa1d46514f4a" providerId="ADAL" clId="{4F8E51F9-E0E7-4E38-A829-33EDC4CC36D3}" dt="2024-02-01T00:27:40.917" v="1389"/>
          <ac:cxnSpMkLst>
            <pc:docMk/>
            <pc:sldMk cId="2030739124" sldId="257"/>
            <ac:cxnSpMk id="200" creationId="{C0ACF196-82FE-398A-FF7F-C27C0999BF54}"/>
          </ac:cxnSpMkLst>
        </pc:cxnChg>
        <pc:extLst>
          <p:ext xmlns:p="http://schemas.openxmlformats.org/presentationml/2006/main" uri="{D6D511B9-2390-475A-947B-AFAB55BFBCF1}">
            <pc226:cmChg xmlns:pc226="http://schemas.microsoft.com/office/powerpoint/2022/06/main/command" chg="add">
              <pc226:chgData name="Mendoza Valderrey, Alberto" userId="3ca0a5ef-cfc6-4d76-a1eb-aa1d46514f4a" providerId="ADAL" clId="{4F8E51F9-E0E7-4E38-A829-33EDC4CC36D3}" dt="2024-02-01T00:20:05.731" v="1385"/>
              <pc2:cmMkLst xmlns:pc2="http://schemas.microsoft.com/office/powerpoint/2019/9/main/command">
                <pc:docMk/>
                <pc:sldMk cId="2030739124" sldId="257"/>
                <pc2:cmMk id="{2BB4051F-D674-4C9D-9B43-C15D19DD60D4}"/>
              </pc2:cmMkLst>
            </pc226:cmChg>
          </p:ext>
        </pc:extLst>
      </pc:sldChg>
      <pc:sldChg chg="addSp delSp modSp new del mod">
        <pc:chgData name="Mendoza Valderrey, Alberto" userId="3ca0a5ef-cfc6-4d76-a1eb-aa1d46514f4a" providerId="ADAL" clId="{4F8E51F9-E0E7-4E38-A829-33EDC4CC36D3}" dt="2024-01-31T23:47:20.657" v="663" actId="2696"/>
        <pc:sldMkLst>
          <pc:docMk/>
          <pc:sldMk cId="2048808783" sldId="258"/>
        </pc:sldMkLst>
        <pc:spChg chg="del">
          <ac:chgData name="Mendoza Valderrey, Alberto" userId="3ca0a5ef-cfc6-4d76-a1eb-aa1d46514f4a" providerId="ADAL" clId="{4F8E51F9-E0E7-4E38-A829-33EDC4CC36D3}" dt="2024-01-31T23:43:07.327" v="626" actId="478"/>
          <ac:spMkLst>
            <pc:docMk/>
            <pc:sldMk cId="2048808783" sldId="258"/>
            <ac:spMk id="2" creationId="{E508E2A1-80D3-A90D-740F-857AE345194D}"/>
          </ac:spMkLst>
        </pc:spChg>
        <pc:spChg chg="del">
          <ac:chgData name="Mendoza Valderrey, Alberto" userId="3ca0a5ef-cfc6-4d76-a1eb-aa1d46514f4a" providerId="ADAL" clId="{4F8E51F9-E0E7-4E38-A829-33EDC4CC36D3}" dt="2024-01-31T23:43:06.089" v="625" actId="478"/>
          <ac:spMkLst>
            <pc:docMk/>
            <pc:sldMk cId="2048808783" sldId="258"/>
            <ac:spMk id="3" creationId="{6F384400-CB3E-0521-24B2-A7A30DEC9F05}"/>
          </ac:spMkLst>
        </pc:spChg>
        <pc:picChg chg="add mod modCrop">
          <ac:chgData name="Mendoza Valderrey, Alberto" userId="3ca0a5ef-cfc6-4d76-a1eb-aa1d46514f4a" providerId="ADAL" clId="{4F8E51F9-E0E7-4E38-A829-33EDC4CC36D3}" dt="2024-01-31T23:44:21.935" v="637" actId="14100"/>
          <ac:picMkLst>
            <pc:docMk/>
            <pc:sldMk cId="2048808783" sldId="258"/>
            <ac:picMk id="4" creationId="{B031142D-D88A-FD59-53B0-8452BB52FD04}"/>
          </ac:picMkLst>
        </pc:picChg>
      </pc:sldChg>
      <pc:sldChg chg="delSp modSp add del mod">
        <pc:chgData name="Mendoza Valderrey, Alberto" userId="3ca0a5ef-cfc6-4d76-a1eb-aa1d46514f4a" providerId="ADAL" clId="{4F8E51F9-E0E7-4E38-A829-33EDC4CC36D3}" dt="2024-02-01T00:09:55.567" v="949" actId="47"/>
        <pc:sldMkLst>
          <pc:docMk/>
          <pc:sldMk cId="3906778361" sldId="258"/>
        </pc:sldMkLst>
        <pc:grpChg chg="mod">
          <ac:chgData name="Mendoza Valderrey, Alberto" userId="3ca0a5ef-cfc6-4d76-a1eb-aa1d46514f4a" providerId="ADAL" clId="{4F8E51F9-E0E7-4E38-A829-33EDC4CC36D3}" dt="2024-02-01T00:08:44.303" v="943" actId="1076"/>
          <ac:grpSpMkLst>
            <pc:docMk/>
            <pc:sldMk cId="3906778361" sldId="258"/>
            <ac:grpSpMk id="2" creationId="{88E0EC0F-218F-8904-CC12-07FD850BB729}"/>
          </ac:grpSpMkLst>
        </pc:grpChg>
        <pc:picChg chg="mod">
          <ac:chgData name="Mendoza Valderrey, Alberto" userId="3ca0a5ef-cfc6-4d76-a1eb-aa1d46514f4a" providerId="ADAL" clId="{4F8E51F9-E0E7-4E38-A829-33EDC4CC36D3}" dt="2024-02-01T00:08:27.486" v="942" actId="2085"/>
          <ac:picMkLst>
            <pc:docMk/>
            <pc:sldMk cId="3906778361" sldId="258"/>
            <ac:picMk id="4" creationId="{A931A929-AEA1-1271-A967-30E1464E4C37}"/>
          </ac:picMkLst>
        </pc:picChg>
        <pc:picChg chg="del">
          <ac:chgData name="Mendoza Valderrey, Alberto" userId="3ca0a5ef-cfc6-4d76-a1eb-aa1d46514f4a" providerId="ADAL" clId="{4F8E51F9-E0E7-4E38-A829-33EDC4CC36D3}" dt="2024-02-01T00:08:21.155" v="941" actId="478"/>
          <ac:picMkLst>
            <pc:docMk/>
            <pc:sldMk cId="3906778361" sldId="258"/>
            <ac:picMk id="65" creationId="{2932540B-61E4-308B-AB02-DD772851555D}"/>
          </ac:picMkLst>
        </pc:picChg>
      </pc:sldChg>
    </pc:docChg>
  </pc:docChgLst>
  <pc:docChgLst>
    <pc:chgData name="Mendoza Valderrey, Alberto" userId="3ca0a5ef-cfc6-4d76-a1eb-aa1d46514f4a" providerId="ADAL" clId="{F8CD0453-8ED0-46A4-8521-4FFE3B7B613F}"/>
    <pc:docChg chg="modSld">
      <pc:chgData name="Mendoza Valderrey, Alberto" userId="3ca0a5ef-cfc6-4d76-a1eb-aa1d46514f4a" providerId="ADAL" clId="{F8CD0453-8ED0-46A4-8521-4FFE3B7B613F}" dt="2024-02-29T18:51:27.336" v="2" actId="20577"/>
      <pc:docMkLst>
        <pc:docMk/>
      </pc:docMkLst>
      <pc:sldChg chg="addSp modSp mod">
        <pc:chgData name="Mendoza Valderrey, Alberto" userId="3ca0a5ef-cfc6-4d76-a1eb-aa1d46514f4a" providerId="ADAL" clId="{F8CD0453-8ED0-46A4-8521-4FFE3B7B613F}" dt="2024-02-29T18:51:27.336" v="2" actId="20577"/>
        <pc:sldMkLst>
          <pc:docMk/>
          <pc:sldMk cId="2030739124" sldId="257"/>
        </pc:sldMkLst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3" creationId="{D46BCF73-42D5-6F32-F733-3EC1B096D956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5" creationId="{53C335B9-80BB-A590-C52F-1EB1E835F38D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6" creationId="{80428EE4-6EF3-BA5F-5995-915194F62523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7" creationId="{0FBE4CC9-90A4-484B-8F85-36578C3064C4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8" creationId="{41289B7C-7341-0F86-9218-E1A05BEBB806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9" creationId="{F08DF57D-3F56-43C7-1914-A39950F57411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0" creationId="{D9012D7B-C556-E7FA-3F2A-9F762252F2F6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1" creationId="{EF44F2C8-EC5D-5C9B-DC81-968017FA02FF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2" creationId="{64F304E3-2385-E935-B1EE-26000C6E35E6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3" creationId="{FCB98A75-AC0C-0DCF-437C-002E39DDFD1A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4" creationId="{BC0F559F-92BF-4990-A305-262599892711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5" creationId="{921DA190-8A48-0EA6-1B09-EB38DAC677B6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6" creationId="{7B22DAEF-5FC0-1E47-2FAA-1C72019DCC2B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7" creationId="{666BA23A-6894-984E-E28B-CCF458F9D79E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29" creationId="{58E0E189-2CDD-CDAC-C47C-3735F79BD226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30" creationId="{4F8B98CE-1212-58E5-19E2-6973BC760023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31" creationId="{7F42CBB3-E109-09F7-5619-85BDFA5DB418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32" creationId="{A87E56A3-8AF1-8D0C-352C-8022D662AAA8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33" creationId="{41E20FDD-567A-8987-F0F7-3CC43DD369B3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34" creationId="{EC81C159-57A7-CEA2-FBD9-E6D464790574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35" creationId="{5B6D9E33-8D2E-084A-EDF8-29C451355F92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36" creationId="{4A005218-20A8-DD20-B46E-416E7B66FF7E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37" creationId="{6E9F5212-FE85-87E3-EE5A-11615DC0BF77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38" creationId="{374117D6-9AC3-DDEB-DBBE-83CC2EF80982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39" creationId="{C9DA7B69-3FF9-5F83-8044-52F0B56BEED2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40" creationId="{A18B02C8-6CC3-A38F-DC93-005F4C301304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41" creationId="{101ECA0E-C2E1-DD11-4399-50E95F383839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42" creationId="{8905FE37-BA10-0192-5B36-F34A49566E67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43" creationId="{F9C4139E-EF17-DFBA-DF35-4052F4A4604C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44" creationId="{477D3BCD-A242-7CB0-C27D-A8B7F4733514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45" creationId="{DA253477-3A7E-BA55-8463-42E879FA9ED6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46" creationId="{6313F510-7E23-C438-31D9-C62BB1406E66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48" creationId="{FA85E17F-86E1-F4D5-283A-CE019BCB1BEC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49" creationId="{F50EB86C-9323-20E5-23B6-D7C36202C132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50" creationId="{19C3989A-1377-D381-99BA-59954949A542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51" creationId="{7C56ABD9-B49B-4FAA-88E9-4745083178CA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52" creationId="{01B80479-C5A9-F304-B304-2B33BD1EF067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53" creationId="{DC31A655-AF9C-1F61-93DB-130BC214E673}"/>
          </ac:spMkLst>
        </pc:spChg>
        <pc:spChg chg="mod">
          <ac:chgData name="Mendoza Valderrey, Alberto" userId="3ca0a5ef-cfc6-4d76-a1eb-aa1d46514f4a" providerId="ADAL" clId="{F8CD0453-8ED0-46A4-8521-4FFE3B7B613F}" dt="2024-02-29T18:51:27.336" v="2" actId="20577"/>
          <ac:spMkLst>
            <pc:docMk/>
            <pc:sldMk cId="2030739124" sldId="257"/>
            <ac:spMk id="64" creationId="{F4F70868-1084-364D-8A75-20164646E8C0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67" creationId="{B18FFE72-7E14-42D4-6A7A-CD6F55BEA912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71" creationId="{255F9EE3-7D3B-55A7-37D3-5D38841D03A1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74" creationId="{6208C340-ADAF-786D-0BC1-13CBA9003873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08" creationId="{6ADB841A-852E-3AF9-2684-A5CA4E77D506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10" creationId="{9272D969-46B6-3716-A789-A8A0D5682C6D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11" creationId="{C4E22AA1-B674-F59E-4099-3AEB74B7FB5A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12" creationId="{5F3FDF87-61AE-2198-1E71-AE75D706D25D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13" creationId="{E4A77517-4AB2-38A0-5AD3-2DD67FEBE1D4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14" creationId="{7B99F138-3AAD-BBB6-C93F-5DF7DDAC7421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15" creationId="{D5D77958-83CB-4BCB-A8F9-1B9B9EB2F121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16" creationId="{6002FABF-727E-83B8-B97D-A30BAC706ED8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17" creationId="{780C5A6E-0593-9AB4-2DFE-5C4F67D572AC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24" creationId="{F1CAA8A6-F90A-02C9-228D-DCE0940F883A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25" creationId="{579E7823-EFEB-C846-7D7F-64CDF5C0E948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27" creationId="{ADC847D9-7CE2-FA3A-1C16-ED172FB2EAD3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28" creationId="{411A085C-A3AA-7F74-4B50-D014B473A758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29" creationId="{43D5D9DF-9FB1-53FD-10E7-42845C212F12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31" creationId="{FAB88A1E-41C4-D44B-44E0-6C9C34A222E0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32" creationId="{FAA7C87B-E436-BA70-EBA1-EAE9AADEC4FA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33" creationId="{BB87AC05-738B-ADA4-7D19-1A228DB711B3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34" creationId="{29D15C39-C6B4-DC6E-0F7C-A48FF92BDDF3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35" creationId="{5F77DD3B-B53B-E829-14B5-7A35FF43AFED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36" creationId="{7D639B15-8268-37C0-C5C0-13A23C43C25C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37" creationId="{7AF421ED-3262-9246-9117-D428FE1D250E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38" creationId="{2B8E2653-0ADB-9326-5613-FDD580ACC35D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39" creationId="{81555EC4-881B-CDC7-BF88-08DDF2B1EA9B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40" creationId="{943AB37E-1F40-0DAC-FB48-25B50B322A4B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41" creationId="{103BC343-EB27-34FB-C819-6E26E212A7F8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43" creationId="{AED1AE38-2C99-0F42-E783-558067E81D7B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44" creationId="{81EBFC37-D6F2-B4EB-E280-69E6308F50C6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45" creationId="{09436167-F828-9944-A9C6-4F2D248B9289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46" creationId="{EBC37FCE-A845-E6DE-CC55-0A2F035511A1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47" creationId="{8B51D47F-AA95-E01A-010D-B8ACC133EA5C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48" creationId="{BCF5EAAD-83DC-204B-E5E2-E773046CCC13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49" creationId="{B0ABB590-A937-9A2D-BE1F-39065F9540EC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55" creationId="{2F566507-D5CC-C06A-DD10-19A4FD012632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58" creationId="{E621D120-6870-1F50-A7E0-C011C27A29B7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60" creationId="{7B88D28C-575F-8B95-FC74-873AD51FA2B3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61" creationId="{7DD115DD-3397-B416-7CFB-2B42B43EE391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67" creationId="{45CEB492-314E-F0E9-F016-5FCFC2854073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68" creationId="{967AAD88-B91A-A928-402E-0914997EB35B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69" creationId="{A4788DFE-A38F-5083-DD8D-78039AB50AF7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70" creationId="{44547AC5-973A-909E-D7C2-8D8CDB170603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71" creationId="{DC8D83B2-E49D-25C6-0F00-81D7F9F8256E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72" creationId="{5388B659-8607-A522-232E-7C0B22164E84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73" creationId="{F70D8CF3-F56F-2FCC-F392-8A47650C9804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75" creationId="{D4DBA928-3D22-BFFC-F2AE-6E920A95EC0B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76" creationId="{1E1C56D4-48B8-8C67-EC5E-2BABB0486CA2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77" creationId="{0913916A-A496-50CA-989D-F1F3F909D26C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78" creationId="{57EB5D55-3F20-E2AB-1B9B-162BACDF9D4D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79" creationId="{33567E91-D705-3C70-9077-B7967FBF810A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80" creationId="{55400E20-9FA7-1F8D-60FF-E1B9F945057F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81" creationId="{383E62AF-8830-9D26-2095-738F9911C539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82" creationId="{5A1AD4D1-311F-3B8C-1719-45EF41A1F83C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88" creationId="{7BEFD2BA-A076-F33B-B86F-BA9EA5516653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89" creationId="{BF0C02E4-EBC4-3A5A-95C3-390886268173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90" creationId="{0AF51E9C-B059-EC6B-A109-75A8C370BBAD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91" creationId="{CD32C471-12F2-0C4A-580B-8D03FD2DFB75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92" creationId="{D04C9E61-AAA6-4FFE-E18D-ABB607469DDC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94" creationId="{63160D9E-5E92-E218-1427-E8876C01303E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195" creationId="{E418586F-3004-F04E-2F8B-F448AC9B90BA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201" creationId="{1EA4DCDA-5BF2-EA4B-9984-7DFFC56E3E2C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202" creationId="{DE54FD22-0715-5042-4762-DDBCD44E59AD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211" creationId="{257C2E14-72A7-9D6C-AE52-EE5C504BC77A}"/>
          </ac:spMkLst>
        </pc:spChg>
        <pc:spChg chg="mod">
          <ac:chgData name="Mendoza Valderrey, Alberto" userId="3ca0a5ef-cfc6-4d76-a1eb-aa1d46514f4a" providerId="ADAL" clId="{F8CD0453-8ED0-46A4-8521-4FFE3B7B613F}" dt="2024-02-27T03:15:02.019" v="0" actId="164"/>
          <ac:spMkLst>
            <pc:docMk/>
            <pc:sldMk cId="2030739124" sldId="257"/>
            <ac:spMk id="212" creationId="{84A1F593-A85C-70C7-C9F3-FEFB39A0ABAA}"/>
          </ac:spMkLst>
        </pc:spChg>
        <pc:grpChg chg="mod">
          <ac:chgData name="Mendoza Valderrey, Alberto" userId="3ca0a5ef-cfc6-4d76-a1eb-aa1d46514f4a" providerId="ADAL" clId="{F8CD0453-8ED0-46A4-8521-4FFE3B7B613F}" dt="2024-02-27T03:15:02.019" v="0" actId="164"/>
          <ac:grpSpMkLst>
            <pc:docMk/>
            <pc:sldMk cId="2030739124" sldId="257"/>
            <ac:grpSpMk id="2" creationId="{88E0EC0F-218F-8904-CC12-07FD850BB729}"/>
          </ac:grpSpMkLst>
        </pc:grpChg>
        <pc:grpChg chg="add mod">
          <ac:chgData name="Mendoza Valderrey, Alberto" userId="3ca0a5ef-cfc6-4d76-a1eb-aa1d46514f4a" providerId="ADAL" clId="{F8CD0453-8ED0-46A4-8521-4FFE3B7B613F}" dt="2024-02-27T03:15:02.019" v="0" actId="164"/>
          <ac:grpSpMkLst>
            <pc:docMk/>
            <pc:sldMk cId="2030739124" sldId="257"/>
            <ac:grpSpMk id="18" creationId="{7E8CE701-9CCA-A1B9-7B6C-6A8347615013}"/>
          </ac:grpSpMkLst>
        </pc:grpChg>
        <pc:grpChg chg="mod">
          <ac:chgData name="Mendoza Valderrey, Alberto" userId="3ca0a5ef-cfc6-4d76-a1eb-aa1d46514f4a" providerId="ADAL" clId="{F8CD0453-8ED0-46A4-8521-4FFE3B7B613F}" dt="2024-02-27T03:15:02.019" v="0" actId="164"/>
          <ac:grpSpMkLst>
            <pc:docMk/>
            <pc:sldMk cId="2030739124" sldId="257"/>
            <ac:grpSpMk id="150" creationId="{B7BE33BD-1563-2872-6997-E7DF4E061C22}"/>
          </ac:grpSpMkLst>
        </pc:grpChg>
        <pc:grpChg chg="mod">
          <ac:chgData name="Mendoza Valderrey, Alberto" userId="3ca0a5ef-cfc6-4d76-a1eb-aa1d46514f4a" providerId="ADAL" clId="{F8CD0453-8ED0-46A4-8521-4FFE3B7B613F}" dt="2024-02-27T03:15:02.019" v="0" actId="164"/>
          <ac:grpSpMkLst>
            <pc:docMk/>
            <pc:sldMk cId="2030739124" sldId="257"/>
            <ac:grpSpMk id="162" creationId="{18C1E5D5-C2FE-3217-DF93-15E28747976D}"/>
          </ac:grpSpMkLst>
        </pc:grpChg>
        <pc:grpChg chg="mod">
          <ac:chgData name="Mendoza Valderrey, Alberto" userId="3ca0a5ef-cfc6-4d76-a1eb-aa1d46514f4a" providerId="ADAL" clId="{F8CD0453-8ED0-46A4-8521-4FFE3B7B613F}" dt="2024-02-27T03:15:02.019" v="0" actId="164"/>
          <ac:grpSpMkLst>
            <pc:docMk/>
            <pc:sldMk cId="2030739124" sldId="257"/>
            <ac:grpSpMk id="183" creationId="{A9B68FE1-4A9E-7B6D-0290-A24CC0A5A456}"/>
          </ac:grpSpMkLst>
        </pc:grpChg>
        <pc:grpChg chg="mod">
          <ac:chgData name="Mendoza Valderrey, Alberto" userId="3ca0a5ef-cfc6-4d76-a1eb-aa1d46514f4a" providerId="ADAL" clId="{F8CD0453-8ED0-46A4-8521-4FFE3B7B613F}" dt="2024-02-27T03:15:02.019" v="0" actId="164"/>
          <ac:grpSpMkLst>
            <pc:docMk/>
            <pc:sldMk cId="2030739124" sldId="257"/>
            <ac:grpSpMk id="196" creationId="{68F29A1F-5BA9-7906-CDC8-F363B7DE64E3}"/>
          </ac:grpSpMkLst>
        </pc:grpChg>
        <pc:picChg chg="mod">
          <ac:chgData name="Mendoza Valderrey, Alberto" userId="3ca0a5ef-cfc6-4d76-a1eb-aa1d46514f4a" providerId="ADAL" clId="{F8CD0453-8ED0-46A4-8521-4FFE3B7B613F}" dt="2024-02-27T03:15:02.019" v="0" actId="164"/>
          <ac:picMkLst>
            <pc:docMk/>
            <pc:sldMk cId="2030739124" sldId="257"/>
            <ac:picMk id="4" creationId="{934B3CFD-A9EB-C016-7578-17F2D5B9375B}"/>
          </ac:picMkLst>
        </pc:picChg>
        <pc:picChg chg="mod">
          <ac:chgData name="Mendoza Valderrey, Alberto" userId="3ca0a5ef-cfc6-4d76-a1eb-aa1d46514f4a" providerId="ADAL" clId="{F8CD0453-8ED0-46A4-8521-4FFE3B7B613F}" dt="2024-02-27T03:15:02.019" v="0" actId="164"/>
          <ac:picMkLst>
            <pc:docMk/>
            <pc:sldMk cId="2030739124" sldId="257"/>
            <ac:picMk id="47" creationId="{230EB767-C7BA-EBD4-5090-55C2F927F1B0}"/>
          </ac:picMkLst>
        </pc:picChg>
        <pc:picChg chg="mod">
          <ac:chgData name="Mendoza Valderrey, Alberto" userId="3ca0a5ef-cfc6-4d76-a1eb-aa1d46514f4a" providerId="ADAL" clId="{F8CD0453-8ED0-46A4-8521-4FFE3B7B613F}" dt="2024-02-27T03:15:02.019" v="0" actId="164"/>
          <ac:picMkLst>
            <pc:docMk/>
            <pc:sldMk cId="2030739124" sldId="257"/>
            <ac:picMk id="56" creationId="{31D12F4E-B21D-60B7-FC95-2FF29B7EC4D1}"/>
          </ac:picMkLst>
        </pc:picChg>
        <pc:picChg chg="mod">
          <ac:chgData name="Mendoza Valderrey, Alberto" userId="3ca0a5ef-cfc6-4d76-a1eb-aa1d46514f4a" providerId="ADAL" clId="{F8CD0453-8ED0-46A4-8521-4FFE3B7B613F}" dt="2024-02-27T03:15:02.019" v="0" actId="164"/>
          <ac:picMkLst>
            <pc:docMk/>
            <pc:sldMk cId="2030739124" sldId="257"/>
            <ac:picMk id="57" creationId="{F69BDAC9-D395-03F1-D4F8-CC53E1B4B51C}"/>
          </ac:picMkLst>
        </pc:picChg>
        <pc:picChg chg="mod">
          <ac:chgData name="Mendoza Valderrey, Alberto" userId="3ca0a5ef-cfc6-4d76-a1eb-aa1d46514f4a" providerId="ADAL" clId="{F8CD0453-8ED0-46A4-8521-4FFE3B7B613F}" dt="2024-02-27T03:15:02.019" v="0" actId="164"/>
          <ac:picMkLst>
            <pc:docMk/>
            <pc:sldMk cId="2030739124" sldId="257"/>
            <ac:picMk id="61" creationId="{ED3F6FE7-B14C-FAFE-2E9F-D94588376807}"/>
          </ac:picMkLst>
        </pc:picChg>
        <pc:picChg chg="mod">
          <ac:chgData name="Mendoza Valderrey, Alberto" userId="3ca0a5ef-cfc6-4d76-a1eb-aa1d46514f4a" providerId="ADAL" clId="{F8CD0453-8ED0-46A4-8521-4FFE3B7B613F}" dt="2024-02-27T03:15:02.019" v="0" actId="164"/>
          <ac:picMkLst>
            <pc:docMk/>
            <pc:sldMk cId="2030739124" sldId="257"/>
            <ac:picMk id="65" creationId="{2932540B-61E4-308B-AB02-DD772851555D}"/>
          </ac:picMkLst>
        </pc:picChg>
        <pc:picChg chg="mod">
          <ac:chgData name="Mendoza Valderrey, Alberto" userId="3ca0a5ef-cfc6-4d76-a1eb-aa1d46514f4a" providerId="ADAL" clId="{F8CD0453-8ED0-46A4-8521-4FFE3B7B613F}" dt="2024-02-27T03:15:02.019" v="0" actId="164"/>
          <ac:picMkLst>
            <pc:docMk/>
            <pc:sldMk cId="2030739124" sldId="257"/>
            <ac:picMk id="119" creationId="{37D544DA-3643-766A-9605-9B99AF71BEFB}"/>
          </ac:picMkLst>
        </pc:picChg>
        <pc:picChg chg="mod">
          <ac:chgData name="Mendoza Valderrey, Alberto" userId="3ca0a5ef-cfc6-4d76-a1eb-aa1d46514f4a" providerId="ADAL" clId="{F8CD0453-8ED0-46A4-8521-4FFE3B7B613F}" dt="2024-02-27T03:15:02.019" v="0" actId="164"/>
          <ac:picMkLst>
            <pc:docMk/>
            <pc:sldMk cId="2030739124" sldId="257"/>
            <ac:picMk id="120" creationId="{83AA463F-3F35-AE2F-52B5-BB2C7C25C8DB}"/>
          </ac:picMkLst>
        </pc:picChg>
        <pc:picChg chg="mod">
          <ac:chgData name="Mendoza Valderrey, Alberto" userId="3ca0a5ef-cfc6-4d76-a1eb-aa1d46514f4a" providerId="ADAL" clId="{F8CD0453-8ED0-46A4-8521-4FFE3B7B613F}" dt="2024-02-27T03:15:02.019" v="0" actId="164"/>
          <ac:picMkLst>
            <pc:docMk/>
            <pc:sldMk cId="2030739124" sldId="257"/>
            <ac:picMk id="121" creationId="{D7A006EA-278B-9910-09C5-533F03542947}"/>
          </ac:picMkLst>
        </pc:picChg>
        <pc:picChg chg="mod">
          <ac:chgData name="Mendoza Valderrey, Alberto" userId="3ca0a5ef-cfc6-4d76-a1eb-aa1d46514f4a" providerId="ADAL" clId="{F8CD0453-8ED0-46A4-8521-4FFE3B7B613F}" dt="2024-02-27T03:15:02.019" v="0" actId="164"/>
          <ac:picMkLst>
            <pc:docMk/>
            <pc:sldMk cId="2030739124" sldId="257"/>
            <ac:picMk id="122" creationId="{B918B14A-AE80-89BA-3DBF-D12315812667}"/>
          </ac:picMkLst>
        </pc:picChg>
        <pc:picChg chg="mod">
          <ac:chgData name="Mendoza Valderrey, Alberto" userId="3ca0a5ef-cfc6-4d76-a1eb-aa1d46514f4a" providerId="ADAL" clId="{F8CD0453-8ED0-46A4-8521-4FFE3B7B613F}" dt="2024-02-27T03:15:02.019" v="0" actId="164"/>
          <ac:picMkLst>
            <pc:docMk/>
            <pc:sldMk cId="2030739124" sldId="257"/>
            <ac:picMk id="142" creationId="{CCDDD27C-8083-9E72-21A9-5137CFD9EBAA}"/>
          </ac:picMkLst>
        </pc:picChg>
        <pc:picChg chg="mod">
          <ac:chgData name="Mendoza Valderrey, Alberto" userId="3ca0a5ef-cfc6-4d76-a1eb-aa1d46514f4a" providerId="ADAL" clId="{F8CD0453-8ED0-46A4-8521-4FFE3B7B613F}" dt="2024-02-27T03:15:02.019" v="0" actId="164"/>
          <ac:picMkLst>
            <pc:docMk/>
            <pc:sldMk cId="2030739124" sldId="257"/>
            <ac:picMk id="159" creationId="{27201F0E-0F10-D462-EBBD-DD599E248372}"/>
          </ac:picMkLst>
        </pc:picChg>
        <pc:picChg chg="mod">
          <ac:chgData name="Mendoza Valderrey, Alberto" userId="3ca0a5ef-cfc6-4d76-a1eb-aa1d46514f4a" providerId="ADAL" clId="{F8CD0453-8ED0-46A4-8521-4FFE3B7B613F}" dt="2024-02-27T03:15:02.019" v="0" actId="164"/>
          <ac:picMkLst>
            <pc:docMk/>
            <pc:sldMk cId="2030739124" sldId="257"/>
            <ac:picMk id="174" creationId="{2A2FD168-9091-209F-8427-7FED377FC139}"/>
          </ac:picMkLst>
        </pc:picChg>
        <pc:picChg chg="mod">
          <ac:chgData name="Mendoza Valderrey, Alberto" userId="3ca0a5ef-cfc6-4d76-a1eb-aa1d46514f4a" providerId="ADAL" clId="{F8CD0453-8ED0-46A4-8521-4FFE3B7B613F}" dt="2024-02-27T03:15:02.019" v="0" actId="164"/>
          <ac:picMkLst>
            <pc:docMk/>
            <pc:sldMk cId="2030739124" sldId="257"/>
            <ac:picMk id="193" creationId="{30C038D6-6371-AAA9-8583-EB23590C76A1}"/>
          </ac:picMkLst>
        </pc:picChg>
        <pc:cxnChg chg="mod">
          <ac:chgData name="Mendoza Valderrey, Alberto" userId="3ca0a5ef-cfc6-4d76-a1eb-aa1d46514f4a" providerId="ADAL" clId="{F8CD0453-8ED0-46A4-8521-4FFE3B7B613F}" dt="2024-02-27T03:15:02.019" v="0" actId="164"/>
          <ac:cxnSpMkLst>
            <pc:docMk/>
            <pc:sldMk cId="2030739124" sldId="257"/>
            <ac:cxnSpMk id="26" creationId="{95873F42-4E25-7A83-C125-8A5EF77A72AE}"/>
          </ac:cxnSpMkLst>
        </pc:cxnChg>
        <pc:cxnChg chg="mod">
          <ac:chgData name="Mendoza Valderrey, Alberto" userId="3ca0a5ef-cfc6-4d76-a1eb-aa1d46514f4a" providerId="ADAL" clId="{F8CD0453-8ED0-46A4-8521-4FFE3B7B613F}" dt="2024-02-27T03:15:02.019" v="0" actId="164"/>
          <ac:cxnSpMkLst>
            <pc:docMk/>
            <pc:sldMk cId="2030739124" sldId="257"/>
            <ac:cxnSpMk id="27" creationId="{92D23368-02BB-A378-55DA-6E968C327B41}"/>
          </ac:cxnSpMkLst>
        </pc:cxnChg>
        <pc:cxnChg chg="mod">
          <ac:chgData name="Mendoza Valderrey, Alberto" userId="3ca0a5ef-cfc6-4d76-a1eb-aa1d46514f4a" providerId="ADAL" clId="{F8CD0453-8ED0-46A4-8521-4FFE3B7B613F}" dt="2024-02-27T03:15:02.019" v="0" actId="164"/>
          <ac:cxnSpMkLst>
            <pc:docMk/>
            <pc:sldMk cId="2030739124" sldId="257"/>
            <ac:cxnSpMk id="28" creationId="{F12C9A7A-A596-EA51-F361-3FA13D37B81E}"/>
          </ac:cxnSpMkLst>
        </pc:cxnChg>
        <pc:cxnChg chg="mod">
          <ac:chgData name="Mendoza Valderrey, Alberto" userId="3ca0a5ef-cfc6-4d76-a1eb-aa1d46514f4a" providerId="ADAL" clId="{F8CD0453-8ED0-46A4-8521-4FFE3B7B613F}" dt="2024-02-27T03:15:02.019" v="0" actId="164"/>
          <ac:cxnSpMkLst>
            <pc:docMk/>
            <pc:sldMk cId="2030739124" sldId="257"/>
            <ac:cxnSpMk id="66" creationId="{926DB50C-F787-8AAF-0235-47523E2684A6}"/>
          </ac:cxnSpMkLst>
        </pc:cxnChg>
        <pc:cxnChg chg="mod">
          <ac:chgData name="Mendoza Valderrey, Alberto" userId="3ca0a5ef-cfc6-4d76-a1eb-aa1d46514f4a" providerId="ADAL" clId="{F8CD0453-8ED0-46A4-8521-4FFE3B7B613F}" dt="2024-02-27T03:15:02.019" v="0" actId="164"/>
          <ac:cxnSpMkLst>
            <pc:docMk/>
            <pc:sldMk cId="2030739124" sldId="257"/>
            <ac:cxnSpMk id="69" creationId="{C09BD84F-5BC8-2F87-C592-BCDDE9437317}"/>
          </ac:cxnSpMkLst>
        </pc:cxnChg>
        <pc:cxnChg chg="mod">
          <ac:chgData name="Mendoza Valderrey, Alberto" userId="3ca0a5ef-cfc6-4d76-a1eb-aa1d46514f4a" providerId="ADAL" clId="{F8CD0453-8ED0-46A4-8521-4FFE3B7B613F}" dt="2024-02-27T03:15:02.019" v="0" actId="164"/>
          <ac:cxnSpMkLst>
            <pc:docMk/>
            <pc:sldMk cId="2030739124" sldId="257"/>
            <ac:cxnSpMk id="72" creationId="{07AC770F-FE30-1633-9EA8-37332F2BFC40}"/>
          </ac:cxnSpMkLst>
        </pc:cxnChg>
        <pc:cxnChg chg="mod">
          <ac:chgData name="Mendoza Valderrey, Alberto" userId="3ca0a5ef-cfc6-4d76-a1eb-aa1d46514f4a" providerId="ADAL" clId="{F8CD0453-8ED0-46A4-8521-4FFE3B7B613F}" dt="2024-02-27T03:15:02.019" v="0" actId="164"/>
          <ac:cxnSpMkLst>
            <pc:docMk/>
            <pc:sldMk cId="2030739124" sldId="257"/>
            <ac:cxnSpMk id="75" creationId="{59765263-E917-A37F-3C50-6DC274E72599}"/>
          </ac:cxnSpMkLst>
        </pc:cxnChg>
        <pc:cxnChg chg="mod">
          <ac:chgData name="Mendoza Valderrey, Alberto" userId="3ca0a5ef-cfc6-4d76-a1eb-aa1d46514f4a" providerId="ADAL" clId="{F8CD0453-8ED0-46A4-8521-4FFE3B7B613F}" dt="2024-02-27T03:15:02.019" v="0" actId="164"/>
          <ac:cxnSpMkLst>
            <pc:docMk/>
            <pc:sldMk cId="2030739124" sldId="257"/>
            <ac:cxnSpMk id="77" creationId="{7C142E8A-1450-79CB-F557-493781BB81F1}"/>
          </ac:cxnSpMkLst>
        </pc:cxnChg>
        <pc:cxnChg chg="mod">
          <ac:chgData name="Mendoza Valderrey, Alberto" userId="3ca0a5ef-cfc6-4d76-a1eb-aa1d46514f4a" providerId="ADAL" clId="{F8CD0453-8ED0-46A4-8521-4FFE3B7B613F}" dt="2024-02-27T03:15:02.019" v="0" actId="164"/>
          <ac:cxnSpMkLst>
            <pc:docMk/>
            <pc:sldMk cId="2030739124" sldId="257"/>
            <ac:cxnSpMk id="79" creationId="{B7521503-3A1F-F79D-DE9F-94CB03A39652}"/>
          </ac:cxnSpMkLst>
        </pc:cxnChg>
        <pc:cxnChg chg="mod">
          <ac:chgData name="Mendoza Valderrey, Alberto" userId="3ca0a5ef-cfc6-4d76-a1eb-aa1d46514f4a" providerId="ADAL" clId="{F8CD0453-8ED0-46A4-8521-4FFE3B7B613F}" dt="2024-02-27T03:15:02.019" v="0" actId="164"/>
          <ac:cxnSpMkLst>
            <pc:docMk/>
            <pc:sldMk cId="2030739124" sldId="257"/>
            <ac:cxnSpMk id="81" creationId="{474B5CD3-B8DF-3308-B912-BF105B8013CD}"/>
          </ac:cxnSpMkLst>
        </pc:cxnChg>
        <pc:cxnChg chg="mod">
          <ac:chgData name="Mendoza Valderrey, Alberto" userId="3ca0a5ef-cfc6-4d76-a1eb-aa1d46514f4a" providerId="ADAL" clId="{F8CD0453-8ED0-46A4-8521-4FFE3B7B613F}" dt="2024-02-27T03:15:02.019" v="0" actId="164"/>
          <ac:cxnSpMkLst>
            <pc:docMk/>
            <pc:sldMk cId="2030739124" sldId="257"/>
            <ac:cxnSpMk id="83" creationId="{06FE546E-389B-F15A-6890-5D892840E3FB}"/>
          </ac:cxnSpMkLst>
        </pc:cxnChg>
        <pc:cxnChg chg="mod">
          <ac:chgData name="Mendoza Valderrey, Alberto" userId="3ca0a5ef-cfc6-4d76-a1eb-aa1d46514f4a" providerId="ADAL" clId="{F8CD0453-8ED0-46A4-8521-4FFE3B7B613F}" dt="2024-02-27T03:15:02.019" v="0" actId="164"/>
          <ac:cxnSpMkLst>
            <pc:docMk/>
            <pc:sldMk cId="2030739124" sldId="257"/>
            <ac:cxnSpMk id="85" creationId="{85BFF7FD-FA9C-BF1E-085D-F9A648A8577E}"/>
          </ac:cxnSpMkLst>
        </pc:cxnChg>
        <pc:cxnChg chg="mod">
          <ac:chgData name="Mendoza Valderrey, Alberto" userId="3ca0a5ef-cfc6-4d76-a1eb-aa1d46514f4a" providerId="ADAL" clId="{F8CD0453-8ED0-46A4-8521-4FFE3B7B613F}" dt="2024-02-27T03:15:02.019" v="0" actId="164"/>
          <ac:cxnSpMkLst>
            <pc:docMk/>
            <pc:sldMk cId="2030739124" sldId="257"/>
            <ac:cxnSpMk id="87" creationId="{8DCC07A2-2E49-D884-2713-18CDD889979C}"/>
          </ac:cxnSpMkLst>
        </pc:cxnChg>
        <pc:cxnChg chg="mod">
          <ac:chgData name="Mendoza Valderrey, Alberto" userId="3ca0a5ef-cfc6-4d76-a1eb-aa1d46514f4a" providerId="ADAL" clId="{F8CD0453-8ED0-46A4-8521-4FFE3B7B613F}" dt="2024-02-27T03:15:02.019" v="0" actId="164"/>
          <ac:cxnSpMkLst>
            <pc:docMk/>
            <pc:sldMk cId="2030739124" sldId="257"/>
            <ac:cxnSpMk id="89" creationId="{3E79516F-420E-59A2-393B-699D19077074}"/>
          </ac:cxnSpMkLst>
        </pc:cxnChg>
        <pc:cxnChg chg="mod">
          <ac:chgData name="Mendoza Valderrey, Alberto" userId="3ca0a5ef-cfc6-4d76-a1eb-aa1d46514f4a" providerId="ADAL" clId="{F8CD0453-8ED0-46A4-8521-4FFE3B7B613F}" dt="2024-02-27T03:15:02.019" v="0" actId="164"/>
          <ac:cxnSpMkLst>
            <pc:docMk/>
            <pc:sldMk cId="2030739124" sldId="257"/>
            <ac:cxnSpMk id="92" creationId="{503FAD63-10BE-338F-1BDD-B6864AD94A31}"/>
          </ac:cxnSpMkLst>
        </pc:cxnChg>
        <pc:cxnChg chg="mod">
          <ac:chgData name="Mendoza Valderrey, Alberto" userId="3ca0a5ef-cfc6-4d76-a1eb-aa1d46514f4a" providerId="ADAL" clId="{F8CD0453-8ED0-46A4-8521-4FFE3B7B613F}" dt="2024-02-27T03:15:02.019" v="0" actId="164"/>
          <ac:cxnSpMkLst>
            <pc:docMk/>
            <pc:sldMk cId="2030739124" sldId="257"/>
            <ac:cxnSpMk id="95" creationId="{21FB5F8F-683B-2B3E-A3B4-FF4A715B1B24}"/>
          </ac:cxnSpMkLst>
        </pc:cxnChg>
        <pc:cxnChg chg="mod">
          <ac:chgData name="Mendoza Valderrey, Alberto" userId="3ca0a5ef-cfc6-4d76-a1eb-aa1d46514f4a" providerId="ADAL" clId="{F8CD0453-8ED0-46A4-8521-4FFE3B7B613F}" dt="2024-02-27T03:15:02.019" v="0" actId="164"/>
          <ac:cxnSpMkLst>
            <pc:docMk/>
            <pc:sldMk cId="2030739124" sldId="257"/>
            <ac:cxnSpMk id="97" creationId="{063F14CB-D18B-86CD-99D9-D31FE4FB6BD5}"/>
          </ac:cxnSpMkLst>
        </pc:cxnChg>
        <pc:cxnChg chg="mod">
          <ac:chgData name="Mendoza Valderrey, Alberto" userId="3ca0a5ef-cfc6-4d76-a1eb-aa1d46514f4a" providerId="ADAL" clId="{F8CD0453-8ED0-46A4-8521-4FFE3B7B613F}" dt="2024-02-27T03:15:02.019" v="0" actId="164"/>
          <ac:cxnSpMkLst>
            <pc:docMk/>
            <pc:sldMk cId="2030739124" sldId="257"/>
            <ac:cxnSpMk id="105" creationId="{F4C37D38-8781-3E8A-C3BA-70645D62DDCC}"/>
          </ac:cxnSpMkLst>
        </pc:cxnChg>
        <pc:cxnChg chg="mod">
          <ac:chgData name="Mendoza Valderrey, Alberto" userId="3ca0a5ef-cfc6-4d76-a1eb-aa1d46514f4a" providerId="ADAL" clId="{F8CD0453-8ED0-46A4-8521-4FFE3B7B613F}" dt="2024-02-27T03:15:02.019" v="0" actId="164"/>
          <ac:cxnSpMkLst>
            <pc:docMk/>
            <pc:sldMk cId="2030739124" sldId="257"/>
            <ac:cxnSpMk id="123" creationId="{65F7583F-4F88-8937-96A3-9B50660E7433}"/>
          </ac:cxnSpMkLst>
        </pc:cxnChg>
        <pc:cxnChg chg="mod">
          <ac:chgData name="Mendoza Valderrey, Alberto" userId="3ca0a5ef-cfc6-4d76-a1eb-aa1d46514f4a" providerId="ADAL" clId="{F8CD0453-8ED0-46A4-8521-4FFE3B7B613F}" dt="2024-02-27T03:15:02.019" v="0" actId="164"/>
          <ac:cxnSpMkLst>
            <pc:docMk/>
            <pc:sldMk cId="2030739124" sldId="257"/>
            <ac:cxnSpMk id="126" creationId="{5FFF1D79-D7BE-1C04-1548-B1DEE322C48B}"/>
          </ac:cxnSpMkLst>
        </pc:cxnChg>
        <pc:cxnChg chg="mod">
          <ac:chgData name="Mendoza Valderrey, Alberto" userId="3ca0a5ef-cfc6-4d76-a1eb-aa1d46514f4a" providerId="ADAL" clId="{F8CD0453-8ED0-46A4-8521-4FFE3B7B613F}" dt="2024-02-27T03:15:02.019" v="0" actId="164"/>
          <ac:cxnSpMkLst>
            <pc:docMk/>
            <pc:sldMk cId="2030739124" sldId="257"/>
            <ac:cxnSpMk id="156" creationId="{07A659AA-B1B9-CFE6-9528-3EAE1B644DEE}"/>
          </ac:cxnSpMkLst>
        </pc:cxnChg>
        <pc:cxnChg chg="mod">
          <ac:chgData name="Mendoza Valderrey, Alberto" userId="3ca0a5ef-cfc6-4d76-a1eb-aa1d46514f4a" providerId="ADAL" clId="{F8CD0453-8ED0-46A4-8521-4FFE3B7B613F}" dt="2024-02-27T03:15:02.019" v="0" actId="164"/>
          <ac:cxnSpMkLst>
            <pc:docMk/>
            <pc:sldMk cId="2030739124" sldId="257"/>
            <ac:cxnSpMk id="157" creationId="{68E9BEA9-48A9-9720-13A1-FF1521033A58}"/>
          </ac:cxnSpMkLst>
        </pc:cxnChg>
      </pc:sldChg>
    </pc:docChg>
  </pc:docChgLst>
  <pc:docChgLst>
    <pc:chgData name="Mendoza Valderrey, Alberto" userId="3ca0a5ef-cfc6-4d76-a1eb-aa1d46514f4a" providerId="ADAL" clId="{90C7CDD4-EB8E-43B6-B821-996BE93A380A}"/>
    <pc:docChg chg="undo custSel addSld modSld modMainMaster">
      <pc:chgData name="Mendoza Valderrey, Alberto" userId="3ca0a5ef-cfc6-4d76-a1eb-aa1d46514f4a" providerId="ADAL" clId="{90C7CDD4-EB8E-43B6-B821-996BE93A380A}" dt="2024-01-31T02:57:00.138" v="1007" actId="1076"/>
      <pc:docMkLst>
        <pc:docMk/>
      </pc:docMkLst>
      <pc:sldChg chg="addSp delSp modSp new mod">
        <pc:chgData name="Mendoza Valderrey, Alberto" userId="3ca0a5ef-cfc6-4d76-a1eb-aa1d46514f4a" providerId="ADAL" clId="{90C7CDD4-EB8E-43B6-B821-996BE93A380A}" dt="2024-01-31T02:35:28.193" v="335" actId="1035"/>
        <pc:sldMkLst>
          <pc:docMk/>
          <pc:sldMk cId="1652852917" sldId="256"/>
        </pc:sldMkLst>
        <pc:spChg chg="del">
          <ac:chgData name="Mendoza Valderrey, Alberto" userId="3ca0a5ef-cfc6-4d76-a1eb-aa1d46514f4a" providerId="ADAL" clId="{90C7CDD4-EB8E-43B6-B821-996BE93A380A}" dt="2024-01-31T02:24:35.592" v="1" actId="478"/>
          <ac:spMkLst>
            <pc:docMk/>
            <pc:sldMk cId="1652852917" sldId="256"/>
            <ac:spMk id="2" creationId="{3CE4CB3E-50F8-AF38-76AA-56BE3E7C96D7}"/>
          </ac:spMkLst>
        </pc:spChg>
        <pc:spChg chg="del">
          <ac:chgData name="Mendoza Valderrey, Alberto" userId="3ca0a5ef-cfc6-4d76-a1eb-aa1d46514f4a" providerId="ADAL" clId="{90C7CDD4-EB8E-43B6-B821-996BE93A380A}" dt="2024-01-31T02:24:37.135" v="2" actId="478"/>
          <ac:spMkLst>
            <pc:docMk/>
            <pc:sldMk cId="1652852917" sldId="256"/>
            <ac:spMk id="3" creationId="{DD660580-4309-1480-0416-0BFCA879F097}"/>
          </ac:spMkLst>
        </pc:spChg>
        <pc:spChg chg="add mod">
          <ac:chgData name="Mendoza Valderrey, Alberto" userId="3ca0a5ef-cfc6-4d76-a1eb-aa1d46514f4a" providerId="ADAL" clId="{90C7CDD4-EB8E-43B6-B821-996BE93A380A}" dt="2024-01-31T02:33:35.578" v="260"/>
          <ac:spMkLst>
            <pc:docMk/>
            <pc:sldMk cId="1652852917" sldId="256"/>
            <ac:spMk id="4" creationId="{F7FE4A56-827B-699D-647E-9FE77269094D}"/>
          </ac:spMkLst>
        </pc:spChg>
        <pc:spChg chg="add mod">
          <ac:chgData name="Mendoza Valderrey, Alberto" userId="3ca0a5ef-cfc6-4d76-a1eb-aa1d46514f4a" providerId="ADAL" clId="{90C7CDD4-EB8E-43B6-B821-996BE93A380A}" dt="2024-01-31T02:34:13.083" v="274" actId="1035"/>
          <ac:spMkLst>
            <pc:docMk/>
            <pc:sldMk cId="1652852917" sldId="256"/>
            <ac:spMk id="6" creationId="{8113FA29-54B4-9AE5-135B-F5D51FD367B5}"/>
          </ac:spMkLst>
        </pc:spChg>
        <pc:spChg chg="mod">
          <ac:chgData name="Mendoza Valderrey, Alberto" userId="3ca0a5ef-cfc6-4d76-a1eb-aa1d46514f4a" providerId="ADAL" clId="{90C7CDD4-EB8E-43B6-B821-996BE93A380A}" dt="2024-01-31T02:33:35.578" v="260"/>
          <ac:spMkLst>
            <pc:docMk/>
            <pc:sldMk cId="1652852917" sldId="256"/>
            <ac:spMk id="8" creationId="{0697C01E-0CB8-CB9C-E55F-0B425F4D80A8}"/>
          </ac:spMkLst>
        </pc:spChg>
        <pc:spChg chg="add mod">
          <ac:chgData name="Mendoza Valderrey, Alberto" userId="3ca0a5ef-cfc6-4d76-a1eb-aa1d46514f4a" providerId="ADAL" clId="{90C7CDD4-EB8E-43B6-B821-996BE93A380A}" dt="2024-01-31T02:34:13.083" v="274" actId="1035"/>
          <ac:spMkLst>
            <pc:docMk/>
            <pc:sldMk cId="1652852917" sldId="256"/>
            <ac:spMk id="11" creationId="{B3DEBB82-A92C-A3EF-51B4-598FE1CBA1FE}"/>
          </ac:spMkLst>
        </pc:spChg>
        <pc:spChg chg="add mod">
          <ac:chgData name="Mendoza Valderrey, Alberto" userId="3ca0a5ef-cfc6-4d76-a1eb-aa1d46514f4a" providerId="ADAL" clId="{90C7CDD4-EB8E-43B6-B821-996BE93A380A}" dt="2024-01-31T02:34:13.083" v="274" actId="1035"/>
          <ac:spMkLst>
            <pc:docMk/>
            <pc:sldMk cId="1652852917" sldId="256"/>
            <ac:spMk id="12" creationId="{84338C17-ABCC-EFAA-F227-607B882FD349}"/>
          </ac:spMkLst>
        </pc:spChg>
        <pc:spChg chg="add mod">
          <ac:chgData name="Mendoza Valderrey, Alberto" userId="3ca0a5ef-cfc6-4d76-a1eb-aa1d46514f4a" providerId="ADAL" clId="{90C7CDD4-EB8E-43B6-B821-996BE93A380A}" dt="2024-01-31T02:34:13.083" v="274" actId="1035"/>
          <ac:spMkLst>
            <pc:docMk/>
            <pc:sldMk cId="1652852917" sldId="256"/>
            <ac:spMk id="13" creationId="{8D528BAD-7CAF-0D67-11C3-D80C3179B100}"/>
          </ac:spMkLst>
        </pc:spChg>
        <pc:spChg chg="add mod">
          <ac:chgData name="Mendoza Valderrey, Alberto" userId="3ca0a5ef-cfc6-4d76-a1eb-aa1d46514f4a" providerId="ADAL" clId="{90C7CDD4-EB8E-43B6-B821-996BE93A380A}" dt="2024-01-31T02:34:13.083" v="274" actId="1035"/>
          <ac:spMkLst>
            <pc:docMk/>
            <pc:sldMk cId="1652852917" sldId="256"/>
            <ac:spMk id="14" creationId="{C0D4F112-4E93-36E1-9CBC-D5C395C50E3B}"/>
          </ac:spMkLst>
        </pc:spChg>
        <pc:spChg chg="add mod">
          <ac:chgData name="Mendoza Valderrey, Alberto" userId="3ca0a5ef-cfc6-4d76-a1eb-aa1d46514f4a" providerId="ADAL" clId="{90C7CDD4-EB8E-43B6-B821-996BE93A380A}" dt="2024-01-31T02:34:13.083" v="274" actId="1035"/>
          <ac:spMkLst>
            <pc:docMk/>
            <pc:sldMk cId="1652852917" sldId="256"/>
            <ac:spMk id="15" creationId="{5336C22A-171C-4B5C-5D15-A9F829B9C805}"/>
          </ac:spMkLst>
        </pc:spChg>
        <pc:spChg chg="add mod">
          <ac:chgData name="Mendoza Valderrey, Alberto" userId="3ca0a5ef-cfc6-4d76-a1eb-aa1d46514f4a" providerId="ADAL" clId="{90C7CDD4-EB8E-43B6-B821-996BE93A380A}" dt="2024-01-31T02:34:13.083" v="274" actId="1035"/>
          <ac:spMkLst>
            <pc:docMk/>
            <pc:sldMk cId="1652852917" sldId="256"/>
            <ac:spMk id="16" creationId="{6E6A7C5E-AFC9-E3AD-A448-8A573D16A9FE}"/>
          </ac:spMkLst>
        </pc:spChg>
        <pc:spChg chg="add mod">
          <ac:chgData name="Mendoza Valderrey, Alberto" userId="3ca0a5ef-cfc6-4d76-a1eb-aa1d46514f4a" providerId="ADAL" clId="{90C7CDD4-EB8E-43B6-B821-996BE93A380A}" dt="2024-01-31T02:34:13.083" v="274" actId="1035"/>
          <ac:spMkLst>
            <pc:docMk/>
            <pc:sldMk cId="1652852917" sldId="256"/>
            <ac:spMk id="17" creationId="{38038143-A4EA-2235-E696-490E0516D40E}"/>
          </ac:spMkLst>
        </pc:spChg>
        <pc:spChg chg="add mod">
          <ac:chgData name="Mendoza Valderrey, Alberto" userId="3ca0a5ef-cfc6-4d76-a1eb-aa1d46514f4a" providerId="ADAL" clId="{90C7CDD4-EB8E-43B6-B821-996BE93A380A}" dt="2024-01-31T02:34:13.083" v="274" actId="1035"/>
          <ac:spMkLst>
            <pc:docMk/>
            <pc:sldMk cId="1652852917" sldId="256"/>
            <ac:spMk id="18" creationId="{A921C152-753B-86AF-D4FC-D39C0D504CF5}"/>
          </ac:spMkLst>
        </pc:spChg>
        <pc:spChg chg="add mod">
          <ac:chgData name="Mendoza Valderrey, Alberto" userId="3ca0a5ef-cfc6-4d76-a1eb-aa1d46514f4a" providerId="ADAL" clId="{90C7CDD4-EB8E-43B6-B821-996BE93A380A}" dt="2024-01-31T02:34:13.083" v="274" actId="1035"/>
          <ac:spMkLst>
            <pc:docMk/>
            <pc:sldMk cId="1652852917" sldId="256"/>
            <ac:spMk id="19" creationId="{B4CA9ADD-F75C-E627-436A-1513C6B08996}"/>
          </ac:spMkLst>
        </pc:spChg>
        <pc:spChg chg="add mod">
          <ac:chgData name="Mendoza Valderrey, Alberto" userId="3ca0a5ef-cfc6-4d76-a1eb-aa1d46514f4a" providerId="ADAL" clId="{90C7CDD4-EB8E-43B6-B821-996BE93A380A}" dt="2024-01-31T02:34:13.083" v="274" actId="1035"/>
          <ac:spMkLst>
            <pc:docMk/>
            <pc:sldMk cId="1652852917" sldId="256"/>
            <ac:spMk id="20" creationId="{D33AD1E8-F97A-FF38-A915-F605B8EE6091}"/>
          </ac:spMkLst>
        </pc:spChg>
        <pc:spChg chg="add mod">
          <ac:chgData name="Mendoza Valderrey, Alberto" userId="3ca0a5ef-cfc6-4d76-a1eb-aa1d46514f4a" providerId="ADAL" clId="{90C7CDD4-EB8E-43B6-B821-996BE93A380A}" dt="2024-01-31T02:34:13.083" v="274" actId="1035"/>
          <ac:spMkLst>
            <pc:docMk/>
            <pc:sldMk cId="1652852917" sldId="256"/>
            <ac:spMk id="21" creationId="{CA00F5EB-3404-B024-FC81-53BAAFF84A2E}"/>
          </ac:spMkLst>
        </pc:spChg>
        <pc:spChg chg="add mod">
          <ac:chgData name="Mendoza Valderrey, Alberto" userId="3ca0a5ef-cfc6-4d76-a1eb-aa1d46514f4a" providerId="ADAL" clId="{90C7CDD4-EB8E-43B6-B821-996BE93A380A}" dt="2024-01-31T02:34:13.083" v="274" actId="1035"/>
          <ac:spMkLst>
            <pc:docMk/>
            <pc:sldMk cId="1652852917" sldId="256"/>
            <ac:spMk id="22" creationId="{7B796F5E-F72F-89A8-2FE0-C27EB2F6E09D}"/>
          </ac:spMkLst>
        </pc:spChg>
        <pc:spChg chg="add mod">
          <ac:chgData name="Mendoza Valderrey, Alberto" userId="3ca0a5ef-cfc6-4d76-a1eb-aa1d46514f4a" providerId="ADAL" clId="{90C7CDD4-EB8E-43B6-B821-996BE93A380A}" dt="2024-01-31T02:33:35.578" v="260"/>
          <ac:spMkLst>
            <pc:docMk/>
            <pc:sldMk cId="1652852917" sldId="256"/>
            <ac:spMk id="24" creationId="{6098EF30-42CA-18E8-E384-FEA13CD9514E}"/>
          </ac:spMkLst>
        </pc:spChg>
        <pc:spChg chg="add mod">
          <ac:chgData name="Mendoza Valderrey, Alberto" userId="3ca0a5ef-cfc6-4d76-a1eb-aa1d46514f4a" providerId="ADAL" clId="{90C7CDD4-EB8E-43B6-B821-996BE93A380A}" dt="2024-01-31T02:33:35.578" v="260"/>
          <ac:spMkLst>
            <pc:docMk/>
            <pc:sldMk cId="1652852917" sldId="256"/>
            <ac:spMk id="25" creationId="{925A10A4-741C-E089-3760-95752FFB088A}"/>
          </ac:spMkLst>
        </pc:spChg>
        <pc:spChg chg="add mod">
          <ac:chgData name="Mendoza Valderrey, Alberto" userId="3ca0a5ef-cfc6-4d76-a1eb-aa1d46514f4a" providerId="ADAL" clId="{90C7CDD4-EB8E-43B6-B821-996BE93A380A}" dt="2024-01-31T02:33:35.578" v="260"/>
          <ac:spMkLst>
            <pc:docMk/>
            <pc:sldMk cId="1652852917" sldId="256"/>
            <ac:spMk id="26" creationId="{D5FB9FAE-5BD1-06C5-ACB0-467E881E544E}"/>
          </ac:spMkLst>
        </pc:spChg>
        <pc:spChg chg="add mod">
          <ac:chgData name="Mendoza Valderrey, Alberto" userId="3ca0a5ef-cfc6-4d76-a1eb-aa1d46514f4a" providerId="ADAL" clId="{90C7CDD4-EB8E-43B6-B821-996BE93A380A}" dt="2024-01-31T02:33:35.578" v="260"/>
          <ac:spMkLst>
            <pc:docMk/>
            <pc:sldMk cId="1652852917" sldId="256"/>
            <ac:spMk id="27" creationId="{27C4CD06-6E2C-C02F-864B-4E7FA3F2F8FA}"/>
          </ac:spMkLst>
        </pc:spChg>
        <pc:spChg chg="add mod">
          <ac:chgData name="Mendoza Valderrey, Alberto" userId="3ca0a5ef-cfc6-4d76-a1eb-aa1d46514f4a" providerId="ADAL" clId="{90C7CDD4-EB8E-43B6-B821-996BE93A380A}" dt="2024-01-31T02:33:35.578" v="260"/>
          <ac:spMkLst>
            <pc:docMk/>
            <pc:sldMk cId="1652852917" sldId="256"/>
            <ac:spMk id="28" creationId="{245B352C-1E3F-20D8-E9C2-B2E82206BFD6}"/>
          </ac:spMkLst>
        </pc:spChg>
        <pc:spChg chg="add mod">
          <ac:chgData name="Mendoza Valderrey, Alberto" userId="3ca0a5ef-cfc6-4d76-a1eb-aa1d46514f4a" providerId="ADAL" clId="{90C7CDD4-EB8E-43B6-B821-996BE93A380A}" dt="2024-01-31T02:33:35.578" v="260"/>
          <ac:spMkLst>
            <pc:docMk/>
            <pc:sldMk cId="1652852917" sldId="256"/>
            <ac:spMk id="29" creationId="{19369B87-9690-FB63-BB52-980C55990941}"/>
          </ac:spMkLst>
        </pc:spChg>
        <pc:spChg chg="add mod">
          <ac:chgData name="Mendoza Valderrey, Alberto" userId="3ca0a5ef-cfc6-4d76-a1eb-aa1d46514f4a" providerId="ADAL" clId="{90C7CDD4-EB8E-43B6-B821-996BE93A380A}" dt="2024-01-31T02:33:35.578" v="260"/>
          <ac:spMkLst>
            <pc:docMk/>
            <pc:sldMk cId="1652852917" sldId="256"/>
            <ac:spMk id="30" creationId="{5EC2C184-A8D0-1E1C-841C-E4F83E98E9B6}"/>
          </ac:spMkLst>
        </pc:spChg>
        <pc:spChg chg="add mod">
          <ac:chgData name="Mendoza Valderrey, Alberto" userId="3ca0a5ef-cfc6-4d76-a1eb-aa1d46514f4a" providerId="ADAL" clId="{90C7CDD4-EB8E-43B6-B821-996BE93A380A}" dt="2024-01-31T02:33:35.578" v="260"/>
          <ac:spMkLst>
            <pc:docMk/>
            <pc:sldMk cId="1652852917" sldId="256"/>
            <ac:spMk id="31" creationId="{6F342284-778A-F690-4D5D-353242982D85}"/>
          </ac:spMkLst>
        </pc:spChg>
        <pc:spChg chg="mod">
          <ac:chgData name="Mendoza Valderrey, Alberto" userId="3ca0a5ef-cfc6-4d76-a1eb-aa1d46514f4a" providerId="ADAL" clId="{90C7CDD4-EB8E-43B6-B821-996BE93A380A}" dt="2024-01-31T02:33:35.578" v="260"/>
          <ac:spMkLst>
            <pc:docMk/>
            <pc:sldMk cId="1652852917" sldId="256"/>
            <ac:spMk id="35" creationId="{C0E4A550-8CA2-9549-14C4-8A06D013673D}"/>
          </ac:spMkLst>
        </pc:spChg>
        <pc:spChg chg="add mod">
          <ac:chgData name="Mendoza Valderrey, Alberto" userId="3ca0a5ef-cfc6-4d76-a1eb-aa1d46514f4a" providerId="ADAL" clId="{90C7CDD4-EB8E-43B6-B821-996BE93A380A}" dt="2024-01-31T02:34:13.083" v="274" actId="1035"/>
          <ac:spMkLst>
            <pc:docMk/>
            <pc:sldMk cId="1652852917" sldId="256"/>
            <ac:spMk id="37" creationId="{8F8F31C8-03CE-F654-C781-B5B8D1404D3E}"/>
          </ac:spMkLst>
        </pc:spChg>
        <pc:spChg chg="add mod">
          <ac:chgData name="Mendoza Valderrey, Alberto" userId="3ca0a5ef-cfc6-4d76-a1eb-aa1d46514f4a" providerId="ADAL" clId="{90C7CDD4-EB8E-43B6-B821-996BE93A380A}" dt="2024-01-31T02:34:13.083" v="274" actId="1035"/>
          <ac:spMkLst>
            <pc:docMk/>
            <pc:sldMk cId="1652852917" sldId="256"/>
            <ac:spMk id="38" creationId="{79E0D2A7-65AD-E4AC-7933-01A042716293}"/>
          </ac:spMkLst>
        </pc:spChg>
        <pc:spChg chg="add mod">
          <ac:chgData name="Mendoza Valderrey, Alberto" userId="3ca0a5ef-cfc6-4d76-a1eb-aa1d46514f4a" providerId="ADAL" clId="{90C7CDD4-EB8E-43B6-B821-996BE93A380A}" dt="2024-01-31T02:34:13.083" v="274" actId="1035"/>
          <ac:spMkLst>
            <pc:docMk/>
            <pc:sldMk cId="1652852917" sldId="256"/>
            <ac:spMk id="42" creationId="{D1347603-35D1-38BD-70B9-D108063ACD47}"/>
          </ac:spMkLst>
        </pc:spChg>
        <pc:spChg chg="add mod">
          <ac:chgData name="Mendoza Valderrey, Alberto" userId="3ca0a5ef-cfc6-4d76-a1eb-aa1d46514f4a" providerId="ADAL" clId="{90C7CDD4-EB8E-43B6-B821-996BE93A380A}" dt="2024-01-31T02:34:13.083" v="274" actId="1035"/>
          <ac:spMkLst>
            <pc:docMk/>
            <pc:sldMk cId="1652852917" sldId="256"/>
            <ac:spMk id="43" creationId="{849CCA14-EF76-A2D5-ADFC-BB4A7351D73D}"/>
          </ac:spMkLst>
        </pc:spChg>
        <pc:spChg chg="add mod">
          <ac:chgData name="Mendoza Valderrey, Alberto" userId="3ca0a5ef-cfc6-4d76-a1eb-aa1d46514f4a" providerId="ADAL" clId="{90C7CDD4-EB8E-43B6-B821-996BE93A380A}" dt="2024-01-31T02:34:13.083" v="274" actId="1035"/>
          <ac:spMkLst>
            <pc:docMk/>
            <pc:sldMk cId="1652852917" sldId="256"/>
            <ac:spMk id="44" creationId="{9AC273EB-4243-B7CE-DCE5-E2315DFECA82}"/>
          </ac:spMkLst>
        </pc:spChg>
        <pc:spChg chg="add mod">
          <ac:chgData name="Mendoza Valderrey, Alberto" userId="3ca0a5ef-cfc6-4d76-a1eb-aa1d46514f4a" providerId="ADAL" clId="{90C7CDD4-EB8E-43B6-B821-996BE93A380A}" dt="2024-01-31T02:34:13.083" v="274" actId="1035"/>
          <ac:spMkLst>
            <pc:docMk/>
            <pc:sldMk cId="1652852917" sldId="256"/>
            <ac:spMk id="45" creationId="{1280E8CD-4BE5-11B3-E323-44C4415AD5A8}"/>
          </ac:spMkLst>
        </pc:spChg>
        <pc:spChg chg="add mod">
          <ac:chgData name="Mendoza Valderrey, Alberto" userId="3ca0a5ef-cfc6-4d76-a1eb-aa1d46514f4a" providerId="ADAL" clId="{90C7CDD4-EB8E-43B6-B821-996BE93A380A}" dt="2024-01-31T02:34:13.083" v="274" actId="1035"/>
          <ac:spMkLst>
            <pc:docMk/>
            <pc:sldMk cId="1652852917" sldId="256"/>
            <ac:spMk id="46" creationId="{97203481-DEDB-86AD-4CBF-D9D7CD993AF4}"/>
          </ac:spMkLst>
        </pc:spChg>
        <pc:spChg chg="add mod">
          <ac:chgData name="Mendoza Valderrey, Alberto" userId="3ca0a5ef-cfc6-4d76-a1eb-aa1d46514f4a" providerId="ADAL" clId="{90C7CDD4-EB8E-43B6-B821-996BE93A380A}" dt="2024-01-31T02:34:13.083" v="274" actId="1035"/>
          <ac:spMkLst>
            <pc:docMk/>
            <pc:sldMk cId="1652852917" sldId="256"/>
            <ac:spMk id="47" creationId="{54AA1A9F-E949-7A81-5D80-84A7E349ABFC}"/>
          </ac:spMkLst>
        </pc:spChg>
        <pc:spChg chg="add mod">
          <ac:chgData name="Mendoza Valderrey, Alberto" userId="3ca0a5ef-cfc6-4d76-a1eb-aa1d46514f4a" providerId="ADAL" clId="{90C7CDD4-EB8E-43B6-B821-996BE93A380A}" dt="2024-01-31T02:34:13.083" v="274" actId="1035"/>
          <ac:spMkLst>
            <pc:docMk/>
            <pc:sldMk cId="1652852917" sldId="256"/>
            <ac:spMk id="48" creationId="{52E99609-C44D-763C-F339-BE7579E475DE}"/>
          </ac:spMkLst>
        </pc:spChg>
        <pc:spChg chg="add mod">
          <ac:chgData name="Mendoza Valderrey, Alberto" userId="3ca0a5ef-cfc6-4d76-a1eb-aa1d46514f4a" providerId="ADAL" clId="{90C7CDD4-EB8E-43B6-B821-996BE93A380A}" dt="2024-01-31T02:34:13.083" v="274" actId="1035"/>
          <ac:spMkLst>
            <pc:docMk/>
            <pc:sldMk cId="1652852917" sldId="256"/>
            <ac:spMk id="51" creationId="{B2D9B45F-1686-8D82-0ABF-481A1B9FC923}"/>
          </ac:spMkLst>
        </pc:spChg>
        <pc:spChg chg="add mod">
          <ac:chgData name="Mendoza Valderrey, Alberto" userId="3ca0a5ef-cfc6-4d76-a1eb-aa1d46514f4a" providerId="ADAL" clId="{90C7CDD4-EB8E-43B6-B821-996BE93A380A}" dt="2024-01-31T02:33:35.578" v="260"/>
          <ac:spMkLst>
            <pc:docMk/>
            <pc:sldMk cId="1652852917" sldId="256"/>
            <ac:spMk id="53" creationId="{67C21F2B-26A5-415F-D97E-8FE3F8424CE4}"/>
          </ac:spMkLst>
        </pc:spChg>
        <pc:spChg chg="add mod">
          <ac:chgData name="Mendoza Valderrey, Alberto" userId="3ca0a5ef-cfc6-4d76-a1eb-aa1d46514f4a" providerId="ADAL" clId="{90C7CDD4-EB8E-43B6-B821-996BE93A380A}" dt="2024-01-31T02:33:35.578" v="260"/>
          <ac:spMkLst>
            <pc:docMk/>
            <pc:sldMk cId="1652852917" sldId="256"/>
            <ac:spMk id="54" creationId="{7C9666FB-A579-6471-92D9-140CC9953295}"/>
          </ac:spMkLst>
        </pc:spChg>
        <pc:spChg chg="add mod">
          <ac:chgData name="Mendoza Valderrey, Alberto" userId="3ca0a5ef-cfc6-4d76-a1eb-aa1d46514f4a" providerId="ADAL" clId="{90C7CDD4-EB8E-43B6-B821-996BE93A380A}" dt="2024-01-31T02:33:35.578" v="260"/>
          <ac:spMkLst>
            <pc:docMk/>
            <pc:sldMk cId="1652852917" sldId="256"/>
            <ac:spMk id="55" creationId="{32038E89-01EC-16D0-4F5D-F5D25545B9EA}"/>
          </ac:spMkLst>
        </pc:spChg>
        <pc:spChg chg="add mod">
          <ac:chgData name="Mendoza Valderrey, Alberto" userId="3ca0a5ef-cfc6-4d76-a1eb-aa1d46514f4a" providerId="ADAL" clId="{90C7CDD4-EB8E-43B6-B821-996BE93A380A}" dt="2024-01-31T02:33:35.578" v="260"/>
          <ac:spMkLst>
            <pc:docMk/>
            <pc:sldMk cId="1652852917" sldId="256"/>
            <ac:spMk id="56" creationId="{FCBE7A43-3D16-CC79-041A-B4006DA642C0}"/>
          </ac:spMkLst>
        </pc:spChg>
        <pc:spChg chg="add mod">
          <ac:chgData name="Mendoza Valderrey, Alberto" userId="3ca0a5ef-cfc6-4d76-a1eb-aa1d46514f4a" providerId="ADAL" clId="{90C7CDD4-EB8E-43B6-B821-996BE93A380A}" dt="2024-01-31T02:33:35.578" v="260"/>
          <ac:spMkLst>
            <pc:docMk/>
            <pc:sldMk cId="1652852917" sldId="256"/>
            <ac:spMk id="57" creationId="{C8CDA92C-DA46-0A48-4E44-A88288F7424B}"/>
          </ac:spMkLst>
        </pc:spChg>
        <pc:spChg chg="add mod">
          <ac:chgData name="Mendoza Valderrey, Alberto" userId="3ca0a5ef-cfc6-4d76-a1eb-aa1d46514f4a" providerId="ADAL" clId="{90C7CDD4-EB8E-43B6-B821-996BE93A380A}" dt="2024-01-31T02:33:35.578" v="260"/>
          <ac:spMkLst>
            <pc:docMk/>
            <pc:sldMk cId="1652852917" sldId="256"/>
            <ac:spMk id="58" creationId="{5B4BEEAC-22A7-C2D7-0F91-228BD12CAF6E}"/>
          </ac:spMkLst>
        </pc:spChg>
        <pc:spChg chg="add mod">
          <ac:chgData name="Mendoza Valderrey, Alberto" userId="3ca0a5ef-cfc6-4d76-a1eb-aa1d46514f4a" providerId="ADAL" clId="{90C7CDD4-EB8E-43B6-B821-996BE93A380A}" dt="2024-01-31T02:33:35.578" v="260"/>
          <ac:spMkLst>
            <pc:docMk/>
            <pc:sldMk cId="1652852917" sldId="256"/>
            <ac:spMk id="59" creationId="{CD250BC1-09E0-F675-9E1D-8E01921C719B}"/>
          </ac:spMkLst>
        </pc:spChg>
        <pc:spChg chg="add mod">
          <ac:chgData name="Mendoza Valderrey, Alberto" userId="3ca0a5ef-cfc6-4d76-a1eb-aa1d46514f4a" providerId="ADAL" clId="{90C7CDD4-EB8E-43B6-B821-996BE93A380A}" dt="2024-01-31T02:33:35.578" v="260"/>
          <ac:spMkLst>
            <pc:docMk/>
            <pc:sldMk cId="1652852917" sldId="256"/>
            <ac:spMk id="60" creationId="{9910B533-A008-FA50-AB58-EFDF1D13652A}"/>
          </ac:spMkLst>
        </pc:spChg>
        <pc:spChg chg="mod">
          <ac:chgData name="Mendoza Valderrey, Alberto" userId="3ca0a5ef-cfc6-4d76-a1eb-aa1d46514f4a" providerId="ADAL" clId="{90C7CDD4-EB8E-43B6-B821-996BE93A380A}" dt="2024-01-31T02:33:35.578" v="260"/>
          <ac:spMkLst>
            <pc:docMk/>
            <pc:sldMk cId="1652852917" sldId="256"/>
            <ac:spMk id="64" creationId="{44280590-F7EC-0D82-914D-1DD20324A966}"/>
          </ac:spMkLst>
        </pc:spChg>
        <pc:spChg chg="add mod">
          <ac:chgData name="Mendoza Valderrey, Alberto" userId="3ca0a5ef-cfc6-4d76-a1eb-aa1d46514f4a" providerId="ADAL" clId="{90C7CDD4-EB8E-43B6-B821-996BE93A380A}" dt="2024-01-31T02:33:35.578" v="260"/>
          <ac:spMkLst>
            <pc:docMk/>
            <pc:sldMk cId="1652852917" sldId="256"/>
            <ac:spMk id="66" creationId="{7F13430E-3190-5D32-6FAE-DA2307455F2B}"/>
          </ac:spMkLst>
        </pc:spChg>
        <pc:spChg chg="add mod">
          <ac:chgData name="Mendoza Valderrey, Alberto" userId="3ca0a5ef-cfc6-4d76-a1eb-aa1d46514f4a" providerId="ADAL" clId="{90C7CDD4-EB8E-43B6-B821-996BE93A380A}" dt="2024-01-31T02:33:35.578" v="260"/>
          <ac:spMkLst>
            <pc:docMk/>
            <pc:sldMk cId="1652852917" sldId="256"/>
            <ac:spMk id="67" creationId="{CA80CBF0-AD59-D834-7F2B-A485047DBC68}"/>
          </ac:spMkLst>
        </pc:spChg>
        <pc:spChg chg="add mod">
          <ac:chgData name="Mendoza Valderrey, Alberto" userId="3ca0a5ef-cfc6-4d76-a1eb-aa1d46514f4a" providerId="ADAL" clId="{90C7CDD4-EB8E-43B6-B821-996BE93A380A}" dt="2024-01-31T02:34:13.083" v="274" actId="1035"/>
          <ac:spMkLst>
            <pc:docMk/>
            <pc:sldMk cId="1652852917" sldId="256"/>
            <ac:spMk id="68" creationId="{BB66211D-DE05-ACA4-8B94-5EC8EFA8AC52}"/>
          </ac:spMkLst>
        </pc:spChg>
        <pc:spChg chg="add mod">
          <ac:chgData name="Mendoza Valderrey, Alberto" userId="3ca0a5ef-cfc6-4d76-a1eb-aa1d46514f4a" providerId="ADAL" clId="{90C7CDD4-EB8E-43B6-B821-996BE93A380A}" dt="2024-01-31T02:34:13.083" v="274" actId="1035"/>
          <ac:spMkLst>
            <pc:docMk/>
            <pc:sldMk cId="1652852917" sldId="256"/>
            <ac:spMk id="69" creationId="{8F7D5F62-AA52-0087-38AC-326C2D335539}"/>
          </ac:spMkLst>
        </pc:spChg>
        <pc:spChg chg="add mod">
          <ac:chgData name="Mendoza Valderrey, Alberto" userId="3ca0a5ef-cfc6-4d76-a1eb-aa1d46514f4a" providerId="ADAL" clId="{90C7CDD4-EB8E-43B6-B821-996BE93A380A}" dt="2024-01-31T02:34:13.083" v="274" actId="1035"/>
          <ac:spMkLst>
            <pc:docMk/>
            <pc:sldMk cId="1652852917" sldId="256"/>
            <ac:spMk id="70" creationId="{EAF2BDAB-6978-DAA6-EB47-946085A6A8F3}"/>
          </ac:spMkLst>
        </pc:spChg>
        <pc:spChg chg="add mod">
          <ac:chgData name="Mendoza Valderrey, Alberto" userId="3ca0a5ef-cfc6-4d76-a1eb-aa1d46514f4a" providerId="ADAL" clId="{90C7CDD4-EB8E-43B6-B821-996BE93A380A}" dt="2024-01-31T02:34:13.083" v="274" actId="1035"/>
          <ac:spMkLst>
            <pc:docMk/>
            <pc:sldMk cId="1652852917" sldId="256"/>
            <ac:spMk id="71" creationId="{8F3C8732-EC74-CE3C-2E1B-9E12F69C4099}"/>
          </ac:spMkLst>
        </pc:spChg>
        <pc:spChg chg="add mod">
          <ac:chgData name="Mendoza Valderrey, Alberto" userId="3ca0a5ef-cfc6-4d76-a1eb-aa1d46514f4a" providerId="ADAL" clId="{90C7CDD4-EB8E-43B6-B821-996BE93A380A}" dt="2024-01-31T02:34:13.083" v="274" actId="1035"/>
          <ac:spMkLst>
            <pc:docMk/>
            <pc:sldMk cId="1652852917" sldId="256"/>
            <ac:spMk id="72" creationId="{92891E6A-35C1-9601-D980-253E50BD29F3}"/>
          </ac:spMkLst>
        </pc:spChg>
        <pc:spChg chg="add mod">
          <ac:chgData name="Mendoza Valderrey, Alberto" userId="3ca0a5ef-cfc6-4d76-a1eb-aa1d46514f4a" providerId="ADAL" clId="{90C7CDD4-EB8E-43B6-B821-996BE93A380A}" dt="2024-01-31T02:34:13.083" v="274" actId="1035"/>
          <ac:spMkLst>
            <pc:docMk/>
            <pc:sldMk cId="1652852917" sldId="256"/>
            <ac:spMk id="73" creationId="{BB23D4D7-2E6A-B2B8-A741-D31F129F3249}"/>
          </ac:spMkLst>
        </pc:spChg>
        <pc:spChg chg="add mod">
          <ac:chgData name="Mendoza Valderrey, Alberto" userId="3ca0a5ef-cfc6-4d76-a1eb-aa1d46514f4a" providerId="ADAL" clId="{90C7CDD4-EB8E-43B6-B821-996BE93A380A}" dt="2024-01-31T02:34:13.083" v="274" actId="1035"/>
          <ac:spMkLst>
            <pc:docMk/>
            <pc:sldMk cId="1652852917" sldId="256"/>
            <ac:spMk id="74" creationId="{F02E32B5-C36A-843B-A481-286F22D046DB}"/>
          </ac:spMkLst>
        </pc:spChg>
        <pc:spChg chg="add mod">
          <ac:chgData name="Mendoza Valderrey, Alberto" userId="3ca0a5ef-cfc6-4d76-a1eb-aa1d46514f4a" providerId="ADAL" clId="{90C7CDD4-EB8E-43B6-B821-996BE93A380A}" dt="2024-01-31T02:34:13.083" v="274" actId="1035"/>
          <ac:spMkLst>
            <pc:docMk/>
            <pc:sldMk cId="1652852917" sldId="256"/>
            <ac:spMk id="75" creationId="{91C09D38-54C6-5B61-2835-86922E52041C}"/>
          </ac:spMkLst>
        </pc:spChg>
        <pc:spChg chg="add mod">
          <ac:chgData name="Mendoza Valderrey, Alberto" userId="3ca0a5ef-cfc6-4d76-a1eb-aa1d46514f4a" providerId="ADAL" clId="{90C7CDD4-EB8E-43B6-B821-996BE93A380A}" dt="2024-01-31T02:33:35.578" v="260"/>
          <ac:spMkLst>
            <pc:docMk/>
            <pc:sldMk cId="1652852917" sldId="256"/>
            <ac:spMk id="77" creationId="{2C0177ED-D2E3-0350-6096-FEE2A570546C}"/>
          </ac:spMkLst>
        </pc:spChg>
        <pc:spChg chg="add mod">
          <ac:chgData name="Mendoza Valderrey, Alberto" userId="3ca0a5ef-cfc6-4d76-a1eb-aa1d46514f4a" providerId="ADAL" clId="{90C7CDD4-EB8E-43B6-B821-996BE93A380A}" dt="2024-01-31T02:33:35.578" v="260"/>
          <ac:spMkLst>
            <pc:docMk/>
            <pc:sldMk cId="1652852917" sldId="256"/>
            <ac:spMk id="78" creationId="{83BAEACA-51E3-BBAB-D4BD-960EE5863611}"/>
          </ac:spMkLst>
        </pc:spChg>
        <pc:spChg chg="add mod">
          <ac:chgData name="Mendoza Valderrey, Alberto" userId="3ca0a5ef-cfc6-4d76-a1eb-aa1d46514f4a" providerId="ADAL" clId="{90C7CDD4-EB8E-43B6-B821-996BE93A380A}" dt="2024-01-31T02:33:35.578" v="260"/>
          <ac:spMkLst>
            <pc:docMk/>
            <pc:sldMk cId="1652852917" sldId="256"/>
            <ac:spMk id="79" creationId="{A8A5F15D-06D3-A5CF-3453-FBC5D5616435}"/>
          </ac:spMkLst>
        </pc:spChg>
        <pc:spChg chg="add mod">
          <ac:chgData name="Mendoza Valderrey, Alberto" userId="3ca0a5ef-cfc6-4d76-a1eb-aa1d46514f4a" providerId="ADAL" clId="{90C7CDD4-EB8E-43B6-B821-996BE93A380A}" dt="2024-01-31T02:33:35.578" v="260"/>
          <ac:spMkLst>
            <pc:docMk/>
            <pc:sldMk cId="1652852917" sldId="256"/>
            <ac:spMk id="80" creationId="{44BA89D6-9E5E-3D0C-4C4F-2483798A757C}"/>
          </ac:spMkLst>
        </pc:spChg>
        <pc:spChg chg="add mod">
          <ac:chgData name="Mendoza Valderrey, Alberto" userId="3ca0a5ef-cfc6-4d76-a1eb-aa1d46514f4a" providerId="ADAL" clId="{90C7CDD4-EB8E-43B6-B821-996BE93A380A}" dt="2024-01-31T02:33:35.578" v="260"/>
          <ac:spMkLst>
            <pc:docMk/>
            <pc:sldMk cId="1652852917" sldId="256"/>
            <ac:spMk id="81" creationId="{32DC9442-D117-DC37-50B2-35F97C3926C3}"/>
          </ac:spMkLst>
        </pc:spChg>
        <pc:spChg chg="add mod">
          <ac:chgData name="Mendoza Valderrey, Alberto" userId="3ca0a5ef-cfc6-4d76-a1eb-aa1d46514f4a" providerId="ADAL" clId="{90C7CDD4-EB8E-43B6-B821-996BE93A380A}" dt="2024-01-31T02:33:35.578" v="260"/>
          <ac:spMkLst>
            <pc:docMk/>
            <pc:sldMk cId="1652852917" sldId="256"/>
            <ac:spMk id="82" creationId="{5EE530AF-4508-A59A-2E66-1BD90DB0FA73}"/>
          </ac:spMkLst>
        </pc:spChg>
        <pc:spChg chg="add mod">
          <ac:chgData name="Mendoza Valderrey, Alberto" userId="3ca0a5ef-cfc6-4d76-a1eb-aa1d46514f4a" providerId="ADAL" clId="{90C7CDD4-EB8E-43B6-B821-996BE93A380A}" dt="2024-01-31T02:33:35.578" v="260"/>
          <ac:spMkLst>
            <pc:docMk/>
            <pc:sldMk cId="1652852917" sldId="256"/>
            <ac:spMk id="83" creationId="{52BC0855-0236-9213-EFDD-ADA2BFA0369A}"/>
          </ac:spMkLst>
        </pc:spChg>
        <pc:spChg chg="add mod">
          <ac:chgData name="Mendoza Valderrey, Alberto" userId="3ca0a5ef-cfc6-4d76-a1eb-aa1d46514f4a" providerId="ADAL" clId="{90C7CDD4-EB8E-43B6-B821-996BE93A380A}" dt="2024-01-31T02:33:35.578" v="260"/>
          <ac:spMkLst>
            <pc:docMk/>
            <pc:sldMk cId="1652852917" sldId="256"/>
            <ac:spMk id="84" creationId="{711B6472-60EE-D251-CD79-4C2B78CACDAD}"/>
          </ac:spMkLst>
        </pc:spChg>
        <pc:spChg chg="add mod">
          <ac:chgData name="Mendoza Valderrey, Alberto" userId="3ca0a5ef-cfc6-4d76-a1eb-aa1d46514f4a" providerId="ADAL" clId="{90C7CDD4-EB8E-43B6-B821-996BE93A380A}" dt="2024-01-31T02:33:35.578" v="260"/>
          <ac:spMkLst>
            <pc:docMk/>
            <pc:sldMk cId="1652852917" sldId="256"/>
            <ac:spMk id="85" creationId="{2DF19A4C-FC1D-A553-E11D-C167A9EE5CD8}"/>
          </ac:spMkLst>
        </pc:spChg>
        <pc:spChg chg="mod">
          <ac:chgData name="Mendoza Valderrey, Alberto" userId="3ca0a5ef-cfc6-4d76-a1eb-aa1d46514f4a" providerId="ADAL" clId="{90C7CDD4-EB8E-43B6-B821-996BE93A380A}" dt="2024-01-31T02:33:35.578" v="260"/>
          <ac:spMkLst>
            <pc:docMk/>
            <pc:sldMk cId="1652852917" sldId="256"/>
            <ac:spMk id="89" creationId="{226E2D30-C79E-2C5E-15A7-9D355395239D}"/>
          </ac:spMkLst>
        </pc:spChg>
        <pc:spChg chg="add mod">
          <ac:chgData name="Mendoza Valderrey, Alberto" userId="3ca0a5ef-cfc6-4d76-a1eb-aa1d46514f4a" providerId="ADAL" clId="{90C7CDD4-EB8E-43B6-B821-996BE93A380A}" dt="2024-01-31T02:35:13.781" v="292" actId="1035"/>
          <ac:spMkLst>
            <pc:docMk/>
            <pc:sldMk cId="1652852917" sldId="256"/>
            <ac:spMk id="92" creationId="{EEC9F0DD-27F6-53A1-7597-2D17280AF4C3}"/>
          </ac:spMkLst>
        </pc:spChg>
        <pc:spChg chg="add mod">
          <ac:chgData name="Mendoza Valderrey, Alberto" userId="3ca0a5ef-cfc6-4d76-a1eb-aa1d46514f4a" providerId="ADAL" clId="{90C7CDD4-EB8E-43B6-B821-996BE93A380A}" dt="2024-01-31T02:35:13.781" v="292" actId="1035"/>
          <ac:spMkLst>
            <pc:docMk/>
            <pc:sldMk cId="1652852917" sldId="256"/>
            <ac:spMk id="95" creationId="{4047D12E-9111-6C23-89C4-5F4521F2AD7F}"/>
          </ac:spMkLst>
        </pc:spChg>
        <pc:spChg chg="add mod">
          <ac:chgData name="Mendoza Valderrey, Alberto" userId="3ca0a5ef-cfc6-4d76-a1eb-aa1d46514f4a" providerId="ADAL" clId="{90C7CDD4-EB8E-43B6-B821-996BE93A380A}" dt="2024-01-31T02:35:13.781" v="292" actId="1035"/>
          <ac:spMkLst>
            <pc:docMk/>
            <pc:sldMk cId="1652852917" sldId="256"/>
            <ac:spMk id="96" creationId="{43222342-5B33-BEEE-D137-A26E51769218}"/>
          </ac:spMkLst>
        </pc:spChg>
        <pc:spChg chg="add mod">
          <ac:chgData name="Mendoza Valderrey, Alberto" userId="3ca0a5ef-cfc6-4d76-a1eb-aa1d46514f4a" providerId="ADAL" clId="{90C7CDD4-EB8E-43B6-B821-996BE93A380A}" dt="2024-01-31T02:35:13.781" v="292" actId="1035"/>
          <ac:spMkLst>
            <pc:docMk/>
            <pc:sldMk cId="1652852917" sldId="256"/>
            <ac:spMk id="97" creationId="{A97B8EE9-5F51-1ADD-9043-38CFC8EF64FD}"/>
          </ac:spMkLst>
        </pc:spChg>
        <pc:spChg chg="add mod">
          <ac:chgData name="Mendoza Valderrey, Alberto" userId="3ca0a5ef-cfc6-4d76-a1eb-aa1d46514f4a" providerId="ADAL" clId="{90C7CDD4-EB8E-43B6-B821-996BE93A380A}" dt="2024-01-31T02:35:13.781" v="292" actId="1035"/>
          <ac:spMkLst>
            <pc:docMk/>
            <pc:sldMk cId="1652852917" sldId="256"/>
            <ac:spMk id="98" creationId="{30FF2F09-02C6-5FCC-77F2-95CA1735AEA7}"/>
          </ac:spMkLst>
        </pc:spChg>
        <pc:spChg chg="add mod">
          <ac:chgData name="Mendoza Valderrey, Alberto" userId="3ca0a5ef-cfc6-4d76-a1eb-aa1d46514f4a" providerId="ADAL" clId="{90C7CDD4-EB8E-43B6-B821-996BE93A380A}" dt="2024-01-31T02:35:13.781" v="292" actId="1035"/>
          <ac:spMkLst>
            <pc:docMk/>
            <pc:sldMk cId="1652852917" sldId="256"/>
            <ac:spMk id="99" creationId="{AF6420B6-4836-F1E5-F10E-071BE2FD3777}"/>
          </ac:spMkLst>
        </pc:spChg>
        <pc:spChg chg="add mod">
          <ac:chgData name="Mendoza Valderrey, Alberto" userId="3ca0a5ef-cfc6-4d76-a1eb-aa1d46514f4a" providerId="ADAL" clId="{90C7CDD4-EB8E-43B6-B821-996BE93A380A}" dt="2024-01-31T02:35:13.781" v="292" actId="1035"/>
          <ac:spMkLst>
            <pc:docMk/>
            <pc:sldMk cId="1652852917" sldId="256"/>
            <ac:spMk id="100" creationId="{F5538F71-BC23-8EFE-548A-CDBBDB7449D9}"/>
          </ac:spMkLst>
        </pc:spChg>
        <pc:spChg chg="add mod">
          <ac:chgData name="Mendoza Valderrey, Alberto" userId="3ca0a5ef-cfc6-4d76-a1eb-aa1d46514f4a" providerId="ADAL" clId="{90C7CDD4-EB8E-43B6-B821-996BE93A380A}" dt="2024-01-31T02:35:13.781" v="292" actId="1035"/>
          <ac:spMkLst>
            <pc:docMk/>
            <pc:sldMk cId="1652852917" sldId="256"/>
            <ac:spMk id="101" creationId="{618758D5-3658-7F70-3D7C-DE836C6EF4D5}"/>
          </ac:spMkLst>
        </pc:spChg>
        <pc:spChg chg="add mod">
          <ac:chgData name="Mendoza Valderrey, Alberto" userId="3ca0a5ef-cfc6-4d76-a1eb-aa1d46514f4a" providerId="ADAL" clId="{90C7CDD4-EB8E-43B6-B821-996BE93A380A}" dt="2024-01-31T02:35:28.193" v="335" actId="1035"/>
          <ac:spMkLst>
            <pc:docMk/>
            <pc:sldMk cId="1652852917" sldId="256"/>
            <ac:spMk id="102" creationId="{B64B7A49-4BC4-A1CB-30BE-E8B6B3871FD4}"/>
          </ac:spMkLst>
        </pc:spChg>
        <pc:spChg chg="add mod">
          <ac:chgData name="Mendoza Valderrey, Alberto" userId="3ca0a5ef-cfc6-4d76-a1eb-aa1d46514f4a" providerId="ADAL" clId="{90C7CDD4-EB8E-43B6-B821-996BE93A380A}" dt="2024-01-31T02:35:28.193" v="335" actId="1035"/>
          <ac:spMkLst>
            <pc:docMk/>
            <pc:sldMk cId="1652852917" sldId="256"/>
            <ac:spMk id="103" creationId="{07FA942B-926B-E910-A089-D8FD8ED839A7}"/>
          </ac:spMkLst>
        </pc:spChg>
        <pc:spChg chg="add mod">
          <ac:chgData name="Mendoza Valderrey, Alberto" userId="3ca0a5ef-cfc6-4d76-a1eb-aa1d46514f4a" providerId="ADAL" clId="{90C7CDD4-EB8E-43B6-B821-996BE93A380A}" dt="2024-01-31T02:35:28.193" v="335" actId="1035"/>
          <ac:spMkLst>
            <pc:docMk/>
            <pc:sldMk cId="1652852917" sldId="256"/>
            <ac:spMk id="104" creationId="{353E69BE-D856-8785-2801-33B89041F25C}"/>
          </ac:spMkLst>
        </pc:spChg>
        <pc:spChg chg="add mod">
          <ac:chgData name="Mendoza Valderrey, Alberto" userId="3ca0a5ef-cfc6-4d76-a1eb-aa1d46514f4a" providerId="ADAL" clId="{90C7CDD4-EB8E-43B6-B821-996BE93A380A}" dt="2024-01-31T02:35:28.193" v="335" actId="1035"/>
          <ac:spMkLst>
            <pc:docMk/>
            <pc:sldMk cId="1652852917" sldId="256"/>
            <ac:spMk id="105" creationId="{F100F3FA-0889-C912-98A7-FDF1EC73FACE}"/>
          </ac:spMkLst>
        </pc:spChg>
        <pc:spChg chg="add mod">
          <ac:chgData name="Mendoza Valderrey, Alberto" userId="3ca0a5ef-cfc6-4d76-a1eb-aa1d46514f4a" providerId="ADAL" clId="{90C7CDD4-EB8E-43B6-B821-996BE93A380A}" dt="2024-01-31T02:35:28.193" v="335" actId="1035"/>
          <ac:spMkLst>
            <pc:docMk/>
            <pc:sldMk cId="1652852917" sldId="256"/>
            <ac:spMk id="106" creationId="{DB2E2F42-0F95-8702-8E1B-09BD019126F0}"/>
          </ac:spMkLst>
        </pc:spChg>
        <pc:spChg chg="add mod">
          <ac:chgData name="Mendoza Valderrey, Alberto" userId="3ca0a5ef-cfc6-4d76-a1eb-aa1d46514f4a" providerId="ADAL" clId="{90C7CDD4-EB8E-43B6-B821-996BE93A380A}" dt="2024-01-31T02:35:28.193" v="335" actId="1035"/>
          <ac:spMkLst>
            <pc:docMk/>
            <pc:sldMk cId="1652852917" sldId="256"/>
            <ac:spMk id="107" creationId="{74116D1D-3A7B-5E69-6A84-382326E83867}"/>
          </ac:spMkLst>
        </pc:spChg>
        <pc:spChg chg="add mod">
          <ac:chgData name="Mendoza Valderrey, Alberto" userId="3ca0a5ef-cfc6-4d76-a1eb-aa1d46514f4a" providerId="ADAL" clId="{90C7CDD4-EB8E-43B6-B821-996BE93A380A}" dt="2024-01-31T02:35:28.193" v="335" actId="1035"/>
          <ac:spMkLst>
            <pc:docMk/>
            <pc:sldMk cId="1652852917" sldId="256"/>
            <ac:spMk id="108" creationId="{24238419-D72A-1314-C551-30A3CCA78D90}"/>
          </ac:spMkLst>
        </pc:spChg>
        <pc:spChg chg="add mod">
          <ac:chgData name="Mendoza Valderrey, Alberto" userId="3ca0a5ef-cfc6-4d76-a1eb-aa1d46514f4a" providerId="ADAL" clId="{90C7CDD4-EB8E-43B6-B821-996BE93A380A}" dt="2024-01-31T02:35:22.119" v="310" actId="1035"/>
          <ac:spMkLst>
            <pc:docMk/>
            <pc:sldMk cId="1652852917" sldId="256"/>
            <ac:spMk id="109" creationId="{FD022E5B-C154-2B26-7C51-CB0202C5633E}"/>
          </ac:spMkLst>
        </pc:spChg>
        <pc:grpChg chg="add mod">
          <ac:chgData name="Mendoza Valderrey, Alberto" userId="3ca0a5ef-cfc6-4d76-a1eb-aa1d46514f4a" providerId="ADAL" clId="{90C7CDD4-EB8E-43B6-B821-996BE93A380A}" dt="2024-01-31T02:34:13.083" v="274" actId="1035"/>
          <ac:grpSpMkLst>
            <pc:docMk/>
            <pc:sldMk cId="1652852917" sldId="256"/>
            <ac:grpSpMk id="7" creationId="{E05EC9A2-2B42-71C9-BA72-1D0997B1172C}"/>
          </ac:grpSpMkLst>
        </pc:grpChg>
        <pc:grpChg chg="add mod">
          <ac:chgData name="Mendoza Valderrey, Alberto" userId="3ca0a5ef-cfc6-4d76-a1eb-aa1d46514f4a" providerId="ADAL" clId="{90C7CDD4-EB8E-43B6-B821-996BE93A380A}" dt="2024-01-31T02:33:35.578" v="260"/>
          <ac:grpSpMkLst>
            <pc:docMk/>
            <pc:sldMk cId="1652852917" sldId="256"/>
            <ac:grpSpMk id="32" creationId="{6BCAB29C-F29F-823A-62BF-0CD59CBF7997}"/>
          </ac:grpSpMkLst>
        </pc:grpChg>
        <pc:grpChg chg="add mod">
          <ac:chgData name="Mendoza Valderrey, Alberto" userId="3ca0a5ef-cfc6-4d76-a1eb-aa1d46514f4a" providerId="ADAL" clId="{90C7CDD4-EB8E-43B6-B821-996BE93A380A}" dt="2024-01-31T02:33:35.578" v="260"/>
          <ac:grpSpMkLst>
            <pc:docMk/>
            <pc:sldMk cId="1652852917" sldId="256"/>
            <ac:grpSpMk id="61" creationId="{0DD6CF78-2C29-9B48-135B-181959E65D89}"/>
          </ac:grpSpMkLst>
        </pc:grpChg>
        <pc:grpChg chg="add mod">
          <ac:chgData name="Mendoza Valderrey, Alberto" userId="3ca0a5ef-cfc6-4d76-a1eb-aa1d46514f4a" providerId="ADAL" clId="{90C7CDD4-EB8E-43B6-B821-996BE93A380A}" dt="2024-01-31T02:33:35.578" v="260"/>
          <ac:grpSpMkLst>
            <pc:docMk/>
            <pc:sldMk cId="1652852917" sldId="256"/>
            <ac:grpSpMk id="86" creationId="{655CA869-85E8-C450-B8E0-6C84644980DF}"/>
          </ac:grpSpMkLst>
        </pc:grpChg>
        <pc:picChg chg="add mod">
          <ac:chgData name="Mendoza Valderrey, Alberto" userId="3ca0a5ef-cfc6-4d76-a1eb-aa1d46514f4a" providerId="ADAL" clId="{90C7CDD4-EB8E-43B6-B821-996BE93A380A}" dt="2024-01-31T02:34:13.083" v="274" actId="1035"/>
          <ac:picMkLst>
            <pc:docMk/>
            <pc:sldMk cId="1652852917" sldId="256"/>
            <ac:picMk id="5" creationId="{8B145BCA-AE18-5133-6282-08511FC202D2}"/>
          </ac:picMkLst>
        </pc:picChg>
        <pc:picChg chg="add mod">
          <ac:chgData name="Mendoza Valderrey, Alberto" userId="3ca0a5ef-cfc6-4d76-a1eb-aa1d46514f4a" providerId="ADAL" clId="{90C7CDD4-EB8E-43B6-B821-996BE93A380A}" dt="2024-01-31T02:33:35.578" v="260"/>
          <ac:picMkLst>
            <pc:docMk/>
            <pc:sldMk cId="1652852917" sldId="256"/>
            <ac:picMk id="23" creationId="{9B5ABF52-3CB8-4DBD-1780-A5D933412A31}"/>
          </ac:picMkLst>
        </pc:picChg>
        <pc:picChg chg="add del mod">
          <ac:chgData name="Mendoza Valderrey, Alberto" userId="3ca0a5ef-cfc6-4d76-a1eb-aa1d46514f4a" providerId="ADAL" clId="{90C7CDD4-EB8E-43B6-B821-996BE93A380A}" dt="2024-01-31T02:26:17.912" v="11" actId="478"/>
          <ac:picMkLst>
            <pc:docMk/>
            <pc:sldMk cId="1652852917" sldId="256"/>
            <ac:picMk id="39" creationId="{3315E5CA-0104-6B26-F3CE-A54DD8240D81}"/>
          </ac:picMkLst>
        </pc:picChg>
        <pc:picChg chg="add del mod">
          <ac:chgData name="Mendoza Valderrey, Alberto" userId="3ca0a5ef-cfc6-4d76-a1eb-aa1d46514f4a" providerId="ADAL" clId="{90C7CDD4-EB8E-43B6-B821-996BE93A380A}" dt="2024-01-31T02:26:17.912" v="11" actId="478"/>
          <ac:picMkLst>
            <pc:docMk/>
            <pc:sldMk cId="1652852917" sldId="256"/>
            <ac:picMk id="40" creationId="{598D90C3-4E18-3F99-4DE9-EA9DFAA71267}"/>
          </ac:picMkLst>
        </pc:picChg>
        <pc:picChg chg="add mod">
          <ac:chgData name="Mendoza Valderrey, Alberto" userId="3ca0a5ef-cfc6-4d76-a1eb-aa1d46514f4a" providerId="ADAL" clId="{90C7CDD4-EB8E-43B6-B821-996BE93A380A}" dt="2024-01-31T02:34:13.083" v="274" actId="1035"/>
          <ac:picMkLst>
            <pc:docMk/>
            <pc:sldMk cId="1652852917" sldId="256"/>
            <ac:picMk id="41" creationId="{114FF8DD-AD8F-CF7C-DE3F-E08DFC992624}"/>
          </ac:picMkLst>
        </pc:picChg>
        <pc:picChg chg="add mod">
          <ac:chgData name="Mendoza Valderrey, Alberto" userId="3ca0a5ef-cfc6-4d76-a1eb-aa1d46514f4a" providerId="ADAL" clId="{90C7CDD4-EB8E-43B6-B821-996BE93A380A}" dt="2024-01-31T02:33:35.578" v="260"/>
          <ac:picMkLst>
            <pc:docMk/>
            <pc:sldMk cId="1652852917" sldId="256"/>
            <ac:picMk id="52" creationId="{FEA76DBD-1CB5-E229-6EC1-7E413DD3F5E0}"/>
          </ac:picMkLst>
        </pc:picChg>
        <pc:picChg chg="add mod">
          <ac:chgData name="Mendoza Valderrey, Alberto" userId="3ca0a5ef-cfc6-4d76-a1eb-aa1d46514f4a" providerId="ADAL" clId="{90C7CDD4-EB8E-43B6-B821-996BE93A380A}" dt="2024-01-31T02:33:35.578" v="260"/>
          <ac:picMkLst>
            <pc:docMk/>
            <pc:sldMk cId="1652852917" sldId="256"/>
            <ac:picMk id="76" creationId="{8CE53928-3F9E-3EB8-5FB5-C84D04AC05D5}"/>
          </ac:picMkLst>
        </pc:picChg>
        <pc:picChg chg="add mod">
          <ac:chgData name="Mendoza Valderrey, Alberto" userId="3ca0a5ef-cfc6-4d76-a1eb-aa1d46514f4a" providerId="ADAL" clId="{90C7CDD4-EB8E-43B6-B821-996BE93A380A}" dt="2024-01-31T02:35:13.781" v="292" actId="1035"/>
          <ac:picMkLst>
            <pc:docMk/>
            <pc:sldMk cId="1652852917" sldId="256"/>
            <ac:picMk id="91" creationId="{3A34B4F1-C1EC-DC51-F88D-981EE7CFB14B}"/>
          </ac:picMkLst>
        </pc:picChg>
        <pc:cxnChg chg="mod">
          <ac:chgData name="Mendoza Valderrey, Alberto" userId="3ca0a5ef-cfc6-4d76-a1eb-aa1d46514f4a" providerId="ADAL" clId="{90C7CDD4-EB8E-43B6-B821-996BE93A380A}" dt="2024-01-31T02:33:35.578" v="260"/>
          <ac:cxnSpMkLst>
            <pc:docMk/>
            <pc:sldMk cId="1652852917" sldId="256"/>
            <ac:cxnSpMk id="9" creationId="{B42FDA5E-A7D9-3628-07D2-4B575AD45955}"/>
          </ac:cxnSpMkLst>
        </pc:cxnChg>
        <pc:cxnChg chg="mod">
          <ac:chgData name="Mendoza Valderrey, Alberto" userId="3ca0a5ef-cfc6-4d76-a1eb-aa1d46514f4a" providerId="ADAL" clId="{90C7CDD4-EB8E-43B6-B821-996BE93A380A}" dt="2024-01-31T02:33:35.578" v="260"/>
          <ac:cxnSpMkLst>
            <pc:docMk/>
            <pc:sldMk cId="1652852917" sldId="256"/>
            <ac:cxnSpMk id="10" creationId="{E91557CA-E2B8-27DA-56C7-B6D87F57B40E}"/>
          </ac:cxnSpMkLst>
        </pc:cxnChg>
        <pc:cxnChg chg="mod">
          <ac:chgData name="Mendoza Valderrey, Alberto" userId="3ca0a5ef-cfc6-4d76-a1eb-aa1d46514f4a" providerId="ADAL" clId="{90C7CDD4-EB8E-43B6-B821-996BE93A380A}" dt="2024-01-31T02:33:35.578" v="260"/>
          <ac:cxnSpMkLst>
            <pc:docMk/>
            <pc:sldMk cId="1652852917" sldId="256"/>
            <ac:cxnSpMk id="33" creationId="{ADB2294E-411F-157C-0BD2-5831EFFD94ED}"/>
          </ac:cxnSpMkLst>
        </pc:cxnChg>
        <pc:cxnChg chg="mod">
          <ac:chgData name="Mendoza Valderrey, Alberto" userId="3ca0a5ef-cfc6-4d76-a1eb-aa1d46514f4a" providerId="ADAL" clId="{90C7CDD4-EB8E-43B6-B821-996BE93A380A}" dt="2024-01-31T02:33:35.578" v="260"/>
          <ac:cxnSpMkLst>
            <pc:docMk/>
            <pc:sldMk cId="1652852917" sldId="256"/>
            <ac:cxnSpMk id="34" creationId="{AA05ECD3-427A-6457-C354-EEED31E55D40}"/>
          </ac:cxnSpMkLst>
        </pc:cxnChg>
        <pc:cxnChg chg="mod">
          <ac:chgData name="Mendoza Valderrey, Alberto" userId="3ca0a5ef-cfc6-4d76-a1eb-aa1d46514f4a" providerId="ADAL" clId="{90C7CDD4-EB8E-43B6-B821-996BE93A380A}" dt="2024-01-31T02:33:35.578" v="260"/>
          <ac:cxnSpMkLst>
            <pc:docMk/>
            <pc:sldMk cId="1652852917" sldId="256"/>
            <ac:cxnSpMk id="36" creationId="{109CB2D2-D5C9-0CF0-0D42-21376D7A9E9E}"/>
          </ac:cxnSpMkLst>
        </pc:cxnChg>
        <pc:cxnChg chg="add mod">
          <ac:chgData name="Mendoza Valderrey, Alberto" userId="3ca0a5ef-cfc6-4d76-a1eb-aa1d46514f4a" providerId="ADAL" clId="{90C7CDD4-EB8E-43B6-B821-996BE93A380A}" dt="2024-01-31T02:34:13.083" v="274" actId="1035"/>
          <ac:cxnSpMkLst>
            <pc:docMk/>
            <pc:sldMk cId="1652852917" sldId="256"/>
            <ac:cxnSpMk id="49" creationId="{201C8F08-5455-7CCD-9DAC-70B5A972EB78}"/>
          </ac:cxnSpMkLst>
        </pc:cxnChg>
        <pc:cxnChg chg="add mod">
          <ac:chgData name="Mendoza Valderrey, Alberto" userId="3ca0a5ef-cfc6-4d76-a1eb-aa1d46514f4a" providerId="ADAL" clId="{90C7CDD4-EB8E-43B6-B821-996BE93A380A}" dt="2024-01-31T02:34:13.083" v="274" actId="1035"/>
          <ac:cxnSpMkLst>
            <pc:docMk/>
            <pc:sldMk cId="1652852917" sldId="256"/>
            <ac:cxnSpMk id="50" creationId="{172FC20E-3AC1-94AD-B912-6C7B41AA8257}"/>
          </ac:cxnSpMkLst>
        </pc:cxnChg>
        <pc:cxnChg chg="mod">
          <ac:chgData name="Mendoza Valderrey, Alberto" userId="3ca0a5ef-cfc6-4d76-a1eb-aa1d46514f4a" providerId="ADAL" clId="{90C7CDD4-EB8E-43B6-B821-996BE93A380A}" dt="2024-01-31T02:33:35.578" v="260"/>
          <ac:cxnSpMkLst>
            <pc:docMk/>
            <pc:sldMk cId="1652852917" sldId="256"/>
            <ac:cxnSpMk id="62" creationId="{1B3288BD-93E1-C0B7-985F-85A4711A66CE}"/>
          </ac:cxnSpMkLst>
        </pc:cxnChg>
        <pc:cxnChg chg="mod">
          <ac:chgData name="Mendoza Valderrey, Alberto" userId="3ca0a5ef-cfc6-4d76-a1eb-aa1d46514f4a" providerId="ADAL" clId="{90C7CDD4-EB8E-43B6-B821-996BE93A380A}" dt="2024-01-31T02:33:35.578" v="260"/>
          <ac:cxnSpMkLst>
            <pc:docMk/>
            <pc:sldMk cId="1652852917" sldId="256"/>
            <ac:cxnSpMk id="63" creationId="{6FBBCF35-BE79-327A-BAF9-CF37359E3C8A}"/>
          </ac:cxnSpMkLst>
        </pc:cxnChg>
        <pc:cxnChg chg="mod">
          <ac:chgData name="Mendoza Valderrey, Alberto" userId="3ca0a5ef-cfc6-4d76-a1eb-aa1d46514f4a" providerId="ADAL" clId="{90C7CDD4-EB8E-43B6-B821-996BE93A380A}" dt="2024-01-31T02:33:35.578" v="260"/>
          <ac:cxnSpMkLst>
            <pc:docMk/>
            <pc:sldMk cId="1652852917" sldId="256"/>
            <ac:cxnSpMk id="65" creationId="{579F00BA-899B-BBDB-B1D8-A532ECEBCEEF}"/>
          </ac:cxnSpMkLst>
        </pc:cxnChg>
        <pc:cxnChg chg="mod">
          <ac:chgData name="Mendoza Valderrey, Alberto" userId="3ca0a5ef-cfc6-4d76-a1eb-aa1d46514f4a" providerId="ADAL" clId="{90C7CDD4-EB8E-43B6-B821-996BE93A380A}" dt="2024-01-31T02:33:35.578" v="260"/>
          <ac:cxnSpMkLst>
            <pc:docMk/>
            <pc:sldMk cId="1652852917" sldId="256"/>
            <ac:cxnSpMk id="87" creationId="{77D36516-4534-D13A-B1A2-E6E878D0620D}"/>
          </ac:cxnSpMkLst>
        </pc:cxnChg>
        <pc:cxnChg chg="mod">
          <ac:chgData name="Mendoza Valderrey, Alberto" userId="3ca0a5ef-cfc6-4d76-a1eb-aa1d46514f4a" providerId="ADAL" clId="{90C7CDD4-EB8E-43B6-B821-996BE93A380A}" dt="2024-01-31T02:33:35.578" v="260"/>
          <ac:cxnSpMkLst>
            <pc:docMk/>
            <pc:sldMk cId="1652852917" sldId="256"/>
            <ac:cxnSpMk id="88" creationId="{85C56F5A-440E-BA92-3962-ED5AF40EC56F}"/>
          </ac:cxnSpMkLst>
        </pc:cxnChg>
        <pc:cxnChg chg="mod">
          <ac:chgData name="Mendoza Valderrey, Alberto" userId="3ca0a5ef-cfc6-4d76-a1eb-aa1d46514f4a" providerId="ADAL" clId="{90C7CDD4-EB8E-43B6-B821-996BE93A380A}" dt="2024-01-31T02:33:35.578" v="260"/>
          <ac:cxnSpMkLst>
            <pc:docMk/>
            <pc:sldMk cId="1652852917" sldId="256"/>
            <ac:cxnSpMk id="90" creationId="{9B5C707E-6038-4C68-632C-7165A8032508}"/>
          </ac:cxnSpMkLst>
        </pc:cxnChg>
        <pc:cxnChg chg="add mod">
          <ac:chgData name="Mendoza Valderrey, Alberto" userId="3ca0a5ef-cfc6-4d76-a1eb-aa1d46514f4a" providerId="ADAL" clId="{90C7CDD4-EB8E-43B6-B821-996BE93A380A}" dt="2024-01-31T02:35:13.781" v="292" actId="1035"/>
          <ac:cxnSpMkLst>
            <pc:docMk/>
            <pc:sldMk cId="1652852917" sldId="256"/>
            <ac:cxnSpMk id="93" creationId="{DB375F48-B7F3-481D-EFD1-C6DF37B7285C}"/>
          </ac:cxnSpMkLst>
        </pc:cxnChg>
        <pc:cxnChg chg="add mod">
          <ac:chgData name="Mendoza Valderrey, Alberto" userId="3ca0a5ef-cfc6-4d76-a1eb-aa1d46514f4a" providerId="ADAL" clId="{90C7CDD4-EB8E-43B6-B821-996BE93A380A}" dt="2024-01-31T02:35:13.781" v="292" actId="1035"/>
          <ac:cxnSpMkLst>
            <pc:docMk/>
            <pc:sldMk cId="1652852917" sldId="256"/>
            <ac:cxnSpMk id="94" creationId="{BDFAA0D9-125F-6F6E-52B1-F897C4D8B96F}"/>
          </ac:cxnSpMkLst>
        </pc:cxnChg>
      </pc:sldChg>
      <pc:sldChg chg="addSp delSp modSp new mod">
        <pc:chgData name="Mendoza Valderrey, Alberto" userId="3ca0a5ef-cfc6-4d76-a1eb-aa1d46514f4a" providerId="ADAL" clId="{90C7CDD4-EB8E-43B6-B821-996BE93A380A}" dt="2024-01-31T02:57:00.138" v="1007" actId="1076"/>
        <pc:sldMkLst>
          <pc:docMk/>
          <pc:sldMk cId="2030739124" sldId="257"/>
        </pc:sldMkLst>
        <pc:spChg chg="del">
          <ac:chgData name="Mendoza Valderrey, Alberto" userId="3ca0a5ef-cfc6-4d76-a1eb-aa1d46514f4a" providerId="ADAL" clId="{90C7CDD4-EB8E-43B6-B821-996BE93A380A}" dt="2024-01-31T02:35:39.690" v="337" actId="478"/>
          <ac:spMkLst>
            <pc:docMk/>
            <pc:sldMk cId="2030739124" sldId="257"/>
            <ac:spMk id="2" creationId="{4118368D-B35F-4CD5-5EF5-A1C9BF5B9B1F}"/>
          </ac:spMkLst>
        </pc:spChg>
        <pc:spChg chg="del">
          <ac:chgData name="Mendoza Valderrey, Alberto" userId="3ca0a5ef-cfc6-4d76-a1eb-aa1d46514f4a" providerId="ADAL" clId="{90C7CDD4-EB8E-43B6-B821-996BE93A380A}" dt="2024-01-31T02:35:42.121" v="338" actId="478"/>
          <ac:spMkLst>
            <pc:docMk/>
            <pc:sldMk cId="2030739124" sldId="257"/>
            <ac:spMk id="3" creationId="{12325D6E-D9BC-185B-0EAC-C90B88E24E9F}"/>
          </ac:spMkLst>
        </pc:spChg>
        <pc:spChg chg="add del mod">
          <ac:chgData name="Mendoza Valderrey, Alberto" userId="3ca0a5ef-cfc6-4d76-a1eb-aa1d46514f4a" providerId="ADAL" clId="{90C7CDD4-EB8E-43B6-B821-996BE93A380A}" dt="2024-01-31T02:40:54.604" v="358" actId="478"/>
          <ac:spMkLst>
            <pc:docMk/>
            <pc:sldMk cId="2030739124" sldId="257"/>
            <ac:spMk id="5" creationId="{3B9EC94A-81C5-D06F-12F5-65AC78F94678}"/>
          </ac:spMkLst>
        </pc:spChg>
        <pc:spChg chg="add del mod">
          <ac:chgData name="Mendoza Valderrey, Alberto" userId="3ca0a5ef-cfc6-4d76-a1eb-aa1d46514f4a" providerId="ADAL" clId="{90C7CDD4-EB8E-43B6-B821-996BE93A380A}" dt="2024-01-31T02:40:57.107" v="359" actId="478"/>
          <ac:spMkLst>
            <pc:docMk/>
            <pc:sldMk cId="2030739124" sldId="257"/>
            <ac:spMk id="6" creationId="{D0D1BC6C-AFA7-CA16-E2BD-3D14C0007587}"/>
          </ac:spMkLst>
        </pc:spChg>
        <pc:spChg chg="add mod">
          <ac:chgData name="Mendoza Valderrey, Alberto" userId="3ca0a5ef-cfc6-4d76-a1eb-aa1d46514f4a" providerId="ADAL" clId="{90C7CDD4-EB8E-43B6-B821-996BE93A380A}" dt="2024-01-31T02:54:03.751" v="775" actId="1038"/>
          <ac:spMkLst>
            <pc:docMk/>
            <pc:sldMk cId="2030739124" sldId="257"/>
            <ac:spMk id="7" creationId="{0FBE4CC9-90A4-484B-8F85-36578C3064C4}"/>
          </ac:spMkLst>
        </pc:spChg>
        <pc:spChg chg="add mod">
          <ac:chgData name="Mendoza Valderrey, Alberto" userId="3ca0a5ef-cfc6-4d76-a1eb-aa1d46514f4a" providerId="ADAL" clId="{90C7CDD4-EB8E-43B6-B821-996BE93A380A}" dt="2024-01-31T02:54:03.751" v="775" actId="1038"/>
          <ac:spMkLst>
            <pc:docMk/>
            <pc:sldMk cId="2030739124" sldId="257"/>
            <ac:spMk id="8" creationId="{41289B7C-7341-0F86-9218-E1A05BEBB806}"/>
          </ac:spMkLst>
        </pc:spChg>
        <pc:spChg chg="add mod">
          <ac:chgData name="Mendoza Valderrey, Alberto" userId="3ca0a5ef-cfc6-4d76-a1eb-aa1d46514f4a" providerId="ADAL" clId="{90C7CDD4-EB8E-43B6-B821-996BE93A380A}" dt="2024-01-31T02:54:03.751" v="775" actId="1038"/>
          <ac:spMkLst>
            <pc:docMk/>
            <pc:sldMk cId="2030739124" sldId="257"/>
            <ac:spMk id="9" creationId="{F08DF57D-3F56-43C7-1914-A39950F57411}"/>
          </ac:spMkLst>
        </pc:spChg>
        <pc:spChg chg="add mod">
          <ac:chgData name="Mendoza Valderrey, Alberto" userId="3ca0a5ef-cfc6-4d76-a1eb-aa1d46514f4a" providerId="ADAL" clId="{90C7CDD4-EB8E-43B6-B821-996BE93A380A}" dt="2024-01-31T02:54:03.751" v="775" actId="1038"/>
          <ac:spMkLst>
            <pc:docMk/>
            <pc:sldMk cId="2030739124" sldId="257"/>
            <ac:spMk id="10" creationId="{D9012D7B-C556-E7FA-3F2A-9F762252F2F6}"/>
          </ac:spMkLst>
        </pc:spChg>
        <pc:spChg chg="add mod">
          <ac:chgData name="Mendoza Valderrey, Alberto" userId="3ca0a5ef-cfc6-4d76-a1eb-aa1d46514f4a" providerId="ADAL" clId="{90C7CDD4-EB8E-43B6-B821-996BE93A380A}" dt="2024-01-31T02:54:03.751" v="775" actId="1038"/>
          <ac:spMkLst>
            <pc:docMk/>
            <pc:sldMk cId="2030739124" sldId="257"/>
            <ac:spMk id="11" creationId="{EF44F2C8-EC5D-5C9B-DC81-968017FA02FF}"/>
          </ac:spMkLst>
        </pc:spChg>
        <pc:spChg chg="add mod">
          <ac:chgData name="Mendoza Valderrey, Alberto" userId="3ca0a5ef-cfc6-4d76-a1eb-aa1d46514f4a" providerId="ADAL" clId="{90C7CDD4-EB8E-43B6-B821-996BE93A380A}" dt="2024-01-31T02:54:03.751" v="775" actId="1038"/>
          <ac:spMkLst>
            <pc:docMk/>
            <pc:sldMk cId="2030739124" sldId="257"/>
            <ac:spMk id="12" creationId="{64F304E3-2385-E935-B1EE-26000C6E35E6}"/>
          </ac:spMkLst>
        </pc:spChg>
        <pc:spChg chg="add mod">
          <ac:chgData name="Mendoza Valderrey, Alberto" userId="3ca0a5ef-cfc6-4d76-a1eb-aa1d46514f4a" providerId="ADAL" clId="{90C7CDD4-EB8E-43B6-B821-996BE93A380A}" dt="2024-01-31T02:54:03.751" v="775" actId="1038"/>
          <ac:spMkLst>
            <pc:docMk/>
            <pc:sldMk cId="2030739124" sldId="257"/>
            <ac:spMk id="13" creationId="{FCB98A75-AC0C-0DCF-437C-002E39DDFD1A}"/>
          </ac:spMkLst>
        </pc:spChg>
        <pc:spChg chg="add mod">
          <ac:chgData name="Mendoza Valderrey, Alberto" userId="3ca0a5ef-cfc6-4d76-a1eb-aa1d46514f4a" providerId="ADAL" clId="{90C7CDD4-EB8E-43B6-B821-996BE93A380A}" dt="2024-01-31T02:54:03.751" v="775" actId="1038"/>
          <ac:spMkLst>
            <pc:docMk/>
            <pc:sldMk cId="2030739124" sldId="257"/>
            <ac:spMk id="14" creationId="{BC0F559F-92BF-4990-A305-262599892711}"/>
          </ac:spMkLst>
        </pc:spChg>
        <pc:spChg chg="add mod">
          <ac:chgData name="Mendoza Valderrey, Alberto" userId="3ca0a5ef-cfc6-4d76-a1eb-aa1d46514f4a" providerId="ADAL" clId="{90C7CDD4-EB8E-43B6-B821-996BE93A380A}" dt="2024-01-31T02:54:03.751" v="775" actId="1038"/>
          <ac:spMkLst>
            <pc:docMk/>
            <pc:sldMk cId="2030739124" sldId="257"/>
            <ac:spMk id="15" creationId="{921DA190-8A48-0EA6-1B09-EB38DAC677B6}"/>
          </ac:spMkLst>
        </pc:spChg>
        <pc:spChg chg="add mod">
          <ac:chgData name="Mendoza Valderrey, Alberto" userId="3ca0a5ef-cfc6-4d76-a1eb-aa1d46514f4a" providerId="ADAL" clId="{90C7CDD4-EB8E-43B6-B821-996BE93A380A}" dt="2024-01-31T02:54:03.751" v="775" actId="1038"/>
          <ac:spMkLst>
            <pc:docMk/>
            <pc:sldMk cId="2030739124" sldId="257"/>
            <ac:spMk id="16" creationId="{7B22DAEF-5FC0-1E47-2FAA-1C72019DCC2B}"/>
          </ac:spMkLst>
        </pc:spChg>
        <pc:spChg chg="add mod">
          <ac:chgData name="Mendoza Valderrey, Alberto" userId="3ca0a5ef-cfc6-4d76-a1eb-aa1d46514f4a" providerId="ADAL" clId="{90C7CDD4-EB8E-43B6-B821-996BE93A380A}" dt="2024-01-31T02:54:03.751" v="775" actId="1038"/>
          <ac:spMkLst>
            <pc:docMk/>
            <pc:sldMk cId="2030739124" sldId="257"/>
            <ac:spMk id="17" creationId="{666BA23A-6894-984E-E28B-CCF458F9D79E}"/>
          </ac:spMkLst>
        </pc:spChg>
        <pc:spChg chg="mod">
          <ac:chgData name="Mendoza Valderrey, Alberto" userId="3ca0a5ef-cfc6-4d76-a1eb-aa1d46514f4a" providerId="ADAL" clId="{90C7CDD4-EB8E-43B6-B821-996BE93A380A}" dt="2024-01-31T02:37:08.741" v="339"/>
          <ac:spMkLst>
            <pc:docMk/>
            <pc:sldMk cId="2030739124" sldId="257"/>
            <ac:spMk id="19" creationId="{A8DD46B5-E832-B9B6-FE81-0C1CB883D667}"/>
          </ac:spMkLst>
        </pc:spChg>
        <pc:spChg chg="mod">
          <ac:chgData name="Mendoza Valderrey, Alberto" userId="3ca0a5ef-cfc6-4d76-a1eb-aa1d46514f4a" providerId="ADAL" clId="{90C7CDD4-EB8E-43B6-B821-996BE93A380A}" dt="2024-01-31T02:37:08.741" v="339"/>
          <ac:spMkLst>
            <pc:docMk/>
            <pc:sldMk cId="2030739124" sldId="257"/>
            <ac:spMk id="20" creationId="{E3820ECB-BDB4-E25E-4D27-B77F347ACD2D}"/>
          </ac:spMkLst>
        </pc:spChg>
        <pc:spChg chg="mod">
          <ac:chgData name="Mendoza Valderrey, Alberto" userId="3ca0a5ef-cfc6-4d76-a1eb-aa1d46514f4a" providerId="ADAL" clId="{90C7CDD4-EB8E-43B6-B821-996BE93A380A}" dt="2024-01-31T02:37:08.741" v="339"/>
          <ac:spMkLst>
            <pc:docMk/>
            <pc:sldMk cId="2030739124" sldId="257"/>
            <ac:spMk id="23" creationId="{72337C93-435B-0A57-DD33-D7711B8B4A67}"/>
          </ac:spMkLst>
        </pc:spChg>
        <pc:spChg chg="mod">
          <ac:chgData name="Mendoza Valderrey, Alberto" userId="3ca0a5ef-cfc6-4d76-a1eb-aa1d46514f4a" providerId="ADAL" clId="{90C7CDD4-EB8E-43B6-B821-996BE93A380A}" dt="2024-01-31T02:37:08.741" v="339"/>
          <ac:spMkLst>
            <pc:docMk/>
            <pc:sldMk cId="2030739124" sldId="257"/>
            <ac:spMk id="24" creationId="{EE4968CB-7B86-5E20-3C79-7FBF8350B0A4}"/>
          </ac:spMkLst>
        </pc:spChg>
        <pc:spChg chg="mod">
          <ac:chgData name="Mendoza Valderrey, Alberto" userId="3ca0a5ef-cfc6-4d76-a1eb-aa1d46514f4a" providerId="ADAL" clId="{90C7CDD4-EB8E-43B6-B821-996BE93A380A}" dt="2024-01-31T02:37:08.741" v="339"/>
          <ac:spMkLst>
            <pc:docMk/>
            <pc:sldMk cId="2030739124" sldId="257"/>
            <ac:spMk id="25" creationId="{1E9770B2-7A90-A61E-C1BA-8BF219223DFD}"/>
          </ac:spMkLst>
        </pc:spChg>
        <pc:spChg chg="add mod">
          <ac:chgData name="Mendoza Valderrey, Alberto" userId="3ca0a5ef-cfc6-4d76-a1eb-aa1d46514f4a" providerId="ADAL" clId="{90C7CDD4-EB8E-43B6-B821-996BE93A380A}" dt="2024-01-31T02:54:03.751" v="775" actId="1038"/>
          <ac:spMkLst>
            <pc:docMk/>
            <pc:sldMk cId="2030739124" sldId="257"/>
            <ac:spMk id="29" creationId="{58E0E189-2CDD-CDAC-C47C-3735F79BD226}"/>
          </ac:spMkLst>
        </pc:spChg>
        <pc:spChg chg="add mod">
          <ac:chgData name="Mendoza Valderrey, Alberto" userId="3ca0a5ef-cfc6-4d76-a1eb-aa1d46514f4a" providerId="ADAL" clId="{90C7CDD4-EB8E-43B6-B821-996BE93A380A}" dt="2024-01-31T02:54:03.751" v="775" actId="1038"/>
          <ac:spMkLst>
            <pc:docMk/>
            <pc:sldMk cId="2030739124" sldId="257"/>
            <ac:spMk id="30" creationId="{4F8B98CE-1212-58E5-19E2-6973BC760023}"/>
          </ac:spMkLst>
        </pc:spChg>
        <pc:spChg chg="add mod">
          <ac:chgData name="Mendoza Valderrey, Alberto" userId="3ca0a5ef-cfc6-4d76-a1eb-aa1d46514f4a" providerId="ADAL" clId="{90C7CDD4-EB8E-43B6-B821-996BE93A380A}" dt="2024-01-31T02:54:03.751" v="775" actId="1038"/>
          <ac:spMkLst>
            <pc:docMk/>
            <pc:sldMk cId="2030739124" sldId="257"/>
            <ac:spMk id="31" creationId="{7F42CBB3-E109-09F7-5619-85BDFA5DB418}"/>
          </ac:spMkLst>
        </pc:spChg>
        <pc:spChg chg="add mod">
          <ac:chgData name="Mendoza Valderrey, Alberto" userId="3ca0a5ef-cfc6-4d76-a1eb-aa1d46514f4a" providerId="ADAL" clId="{90C7CDD4-EB8E-43B6-B821-996BE93A380A}" dt="2024-01-31T02:54:03.751" v="775" actId="1038"/>
          <ac:spMkLst>
            <pc:docMk/>
            <pc:sldMk cId="2030739124" sldId="257"/>
            <ac:spMk id="32" creationId="{A87E56A3-8AF1-8D0C-352C-8022D662AAA8}"/>
          </ac:spMkLst>
        </pc:spChg>
        <pc:spChg chg="add mod">
          <ac:chgData name="Mendoza Valderrey, Alberto" userId="3ca0a5ef-cfc6-4d76-a1eb-aa1d46514f4a" providerId="ADAL" clId="{90C7CDD4-EB8E-43B6-B821-996BE93A380A}" dt="2024-01-31T02:54:03.751" v="775" actId="1038"/>
          <ac:spMkLst>
            <pc:docMk/>
            <pc:sldMk cId="2030739124" sldId="257"/>
            <ac:spMk id="33" creationId="{41E20FDD-567A-8987-F0F7-3CC43DD369B3}"/>
          </ac:spMkLst>
        </pc:spChg>
        <pc:spChg chg="add mod">
          <ac:chgData name="Mendoza Valderrey, Alberto" userId="3ca0a5ef-cfc6-4d76-a1eb-aa1d46514f4a" providerId="ADAL" clId="{90C7CDD4-EB8E-43B6-B821-996BE93A380A}" dt="2024-01-31T02:54:03.751" v="775" actId="1038"/>
          <ac:spMkLst>
            <pc:docMk/>
            <pc:sldMk cId="2030739124" sldId="257"/>
            <ac:spMk id="34" creationId="{EC81C159-57A7-CEA2-FBD9-E6D464790574}"/>
          </ac:spMkLst>
        </pc:spChg>
        <pc:spChg chg="add mod">
          <ac:chgData name="Mendoza Valderrey, Alberto" userId="3ca0a5ef-cfc6-4d76-a1eb-aa1d46514f4a" providerId="ADAL" clId="{90C7CDD4-EB8E-43B6-B821-996BE93A380A}" dt="2024-01-31T02:54:03.751" v="775" actId="1038"/>
          <ac:spMkLst>
            <pc:docMk/>
            <pc:sldMk cId="2030739124" sldId="257"/>
            <ac:spMk id="35" creationId="{5B6D9E33-8D2E-084A-EDF8-29C451355F92}"/>
          </ac:spMkLst>
        </pc:spChg>
        <pc:spChg chg="add mod">
          <ac:chgData name="Mendoza Valderrey, Alberto" userId="3ca0a5ef-cfc6-4d76-a1eb-aa1d46514f4a" providerId="ADAL" clId="{90C7CDD4-EB8E-43B6-B821-996BE93A380A}" dt="2024-01-31T02:54:03.751" v="775" actId="1038"/>
          <ac:spMkLst>
            <pc:docMk/>
            <pc:sldMk cId="2030739124" sldId="257"/>
            <ac:spMk id="36" creationId="{4A005218-20A8-DD20-B46E-416E7B66FF7E}"/>
          </ac:spMkLst>
        </pc:spChg>
        <pc:spChg chg="add mod">
          <ac:chgData name="Mendoza Valderrey, Alberto" userId="3ca0a5ef-cfc6-4d76-a1eb-aa1d46514f4a" providerId="ADAL" clId="{90C7CDD4-EB8E-43B6-B821-996BE93A380A}" dt="2024-01-31T02:54:03.751" v="775" actId="1038"/>
          <ac:spMkLst>
            <pc:docMk/>
            <pc:sldMk cId="2030739124" sldId="257"/>
            <ac:spMk id="37" creationId="{6E9F5212-FE85-87E3-EE5A-11615DC0BF77}"/>
          </ac:spMkLst>
        </pc:spChg>
        <pc:spChg chg="add mod">
          <ac:chgData name="Mendoza Valderrey, Alberto" userId="3ca0a5ef-cfc6-4d76-a1eb-aa1d46514f4a" providerId="ADAL" clId="{90C7CDD4-EB8E-43B6-B821-996BE93A380A}" dt="2024-01-31T02:54:03.751" v="775" actId="1038"/>
          <ac:spMkLst>
            <pc:docMk/>
            <pc:sldMk cId="2030739124" sldId="257"/>
            <ac:spMk id="38" creationId="{374117D6-9AC3-DDEB-DBBE-83CC2EF80982}"/>
          </ac:spMkLst>
        </pc:spChg>
        <pc:spChg chg="add mod">
          <ac:chgData name="Mendoza Valderrey, Alberto" userId="3ca0a5ef-cfc6-4d76-a1eb-aa1d46514f4a" providerId="ADAL" clId="{90C7CDD4-EB8E-43B6-B821-996BE93A380A}" dt="2024-01-31T02:54:03.751" v="775" actId="1038"/>
          <ac:spMkLst>
            <pc:docMk/>
            <pc:sldMk cId="2030739124" sldId="257"/>
            <ac:spMk id="39" creationId="{C9DA7B69-3FF9-5F83-8044-52F0B56BEED2}"/>
          </ac:spMkLst>
        </pc:spChg>
        <pc:spChg chg="add mod">
          <ac:chgData name="Mendoza Valderrey, Alberto" userId="3ca0a5ef-cfc6-4d76-a1eb-aa1d46514f4a" providerId="ADAL" clId="{90C7CDD4-EB8E-43B6-B821-996BE93A380A}" dt="2024-01-31T02:54:03.751" v="775" actId="1038"/>
          <ac:spMkLst>
            <pc:docMk/>
            <pc:sldMk cId="2030739124" sldId="257"/>
            <ac:spMk id="40" creationId="{A18B02C8-6CC3-A38F-DC93-005F4C301304}"/>
          </ac:spMkLst>
        </pc:spChg>
        <pc:spChg chg="add mod">
          <ac:chgData name="Mendoza Valderrey, Alberto" userId="3ca0a5ef-cfc6-4d76-a1eb-aa1d46514f4a" providerId="ADAL" clId="{90C7CDD4-EB8E-43B6-B821-996BE93A380A}" dt="2024-01-31T02:54:03.751" v="775" actId="1038"/>
          <ac:spMkLst>
            <pc:docMk/>
            <pc:sldMk cId="2030739124" sldId="257"/>
            <ac:spMk id="41" creationId="{101ECA0E-C2E1-DD11-4399-50E95F383839}"/>
          </ac:spMkLst>
        </pc:spChg>
        <pc:spChg chg="add mod">
          <ac:chgData name="Mendoza Valderrey, Alberto" userId="3ca0a5ef-cfc6-4d76-a1eb-aa1d46514f4a" providerId="ADAL" clId="{90C7CDD4-EB8E-43B6-B821-996BE93A380A}" dt="2024-01-31T02:54:03.751" v="775" actId="1038"/>
          <ac:spMkLst>
            <pc:docMk/>
            <pc:sldMk cId="2030739124" sldId="257"/>
            <ac:spMk id="42" creationId="{8905FE37-BA10-0192-5B36-F34A49566E67}"/>
          </ac:spMkLst>
        </pc:spChg>
        <pc:spChg chg="add mod">
          <ac:chgData name="Mendoza Valderrey, Alberto" userId="3ca0a5ef-cfc6-4d76-a1eb-aa1d46514f4a" providerId="ADAL" clId="{90C7CDD4-EB8E-43B6-B821-996BE93A380A}" dt="2024-01-31T02:54:03.751" v="775" actId="1038"/>
          <ac:spMkLst>
            <pc:docMk/>
            <pc:sldMk cId="2030739124" sldId="257"/>
            <ac:spMk id="43" creationId="{F9C4139E-EF17-DFBA-DF35-4052F4A4604C}"/>
          </ac:spMkLst>
        </pc:spChg>
        <pc:spChg chg="add del mod">
          <ac:chgData name="Mendoza Valderrey, Alberto" userId="3ca0a5ef-cfc6-4d76-a1eb-aa1d46514f4a" providerId="ADAL" clId="{90C7CDD4-EB8E-43B6-B821-996BE93A380A}" dt="2024-01-31T02:37:56.951" v="344"/>
          <ac:spMkLst>
            <pc:docMk/>
            <pc:sldMk cId="2030739124" sldId="257"/>
            <ac:spMk id="44" creationId="{31918A34-CB61-A435-CC6E-FC08C2503942}"/>
          </ac:spMkLst>
        </pc:spChg>
        <pc:spChg chg="add del mod">
          <ac:chgData name="Mendoza Valderrey, Alberto" userId="3ca0a5ef-cfc6-4d76-a1eb-aa1d46514f4a" providerId="ADAL" clId="{90C7CDD4-EB8E-43B6-B821-996BE93A380A}" dt="2024-01-31T02:37:56.951" v="344"/>
          <ac:spMkLst>
            <pc:docMk/>
            <pc:sldMk cId="2030739124" sldId="257"/>
            <ac:spMk id="50" creationId="{8DEC639B-9D14-BA3B-235C-FE0185F724F6}"/>
          </ac:spMkLst>
        </pc:spChg>
        <pc:spChg chg="add del mod">
          <ac:chgData name="Mendoza Valderrey, Alberto" userId="3ca0a5ef-cfc6-4d76-a1eb-aa1d46514f4a" providerId="ADAL" clId="{90C7CDD4-EB8E-43B6-B821-996BE93A380A}" dt="2024-01-31T02:37:56.951" v="344"/>
          <ac:spMkLst>
            <pc:docMk/>
            <pc:sldMk cId="2030739124" sldId="257"/>
            <ac:spMk id="51" creationId="{91B70529-8C8F-984F-FF76-586A7C8E13C8}"/>
          </ac:spMkLst>
        </pc:spChg>
        <pc:spChg chg="add del mod">
          <ac:chgData name="Mendoza Valderrey, Alberto" userId="3ca0a5ef-cfc6-4d76-a1eb-aa1d46514f4a" providerId="ADAL" clId="{90C7CDD4-EB8E-43B6-B821-996BE93A380A}" dt="2024-01-31T02:37:56.951" v="344"/>
          <ac:spMkLst>
            <pc:docMk/>
            <pc:sldMk cId="2030739124" sldId="257"/>
            <ac:spMk id="53" creationId="{996535D4-1D74-9B46-846F-F75B0DB2ADA8}"/>
          </ac:spMkLst>
        </pc:spChg>
        <pc:spChg chg="add del mod">
          <ac:chgData name="Mendoza Valderrey, Alberto" userId="3ca0a5ef-cfc6-4d76-a1eb-aa1d46514f4a" providerId="ADAL" clId="{90C7CDD4-EB8E-43B6-B821-996BE93A380A}" dt="2024-01-31T02:37:56.951" v="344"/>
          <ac:spMkLst>
            <pc:docMk/>
            <pc:sldMk cId="2030739124" sldId="257"/>
            <ac:spMk id="54" creationId="{7B3B4390-6F0B-28F9-AC05-AEFFF048F1C3}"/>
          </ac:spMkLst>
        </pc:spChg>
        <pc:spChg chg="add del mod">
          <ac:chgData name="Mendoza Valderrey, Alberto" userId="3ca0a5ef-cfc6-4d76-a1eb-aa1d46514f4a" providerId="ADAL" clId="{90C7CDD4-EB8E-43B6-B821-996BE93A380A}" dt="2024-01-31T02:37:56.951" v="344"/>
          <ac:spMkLst>
            <pc:docMk/>
            <pc:sldMk cId="2030739124" sldId="257"/>
            <ac:spMk id="55" creationId="{4CCEA777-8B4C-86D0-5AE6-339123BD13A6}"/>
          </ac:spMkLst>
        </pc:spChg>
        <pc:spChg chg="add del mod">
          <ac:chgData name="Mendoza Valderrey, Alberto" userId="3ca0a5ef-cfc6-4d76-a1eb-aa1d46514f4a" providerId="ADAL" clId="{90C7CDD4-EB8E-43B6-B821-996BE93A380A}" dt="2024-01-31T02:37:56.951" v="344"/>
          <ac:spMkLst>
            <pc:docMk/>
            <pc:sldMk cId="2030739124" sldId="257"/>
            <ac:spMk id="56" creationId="{C0B87C50-FAD7-B00F-1BC8-8D797CC2C5C7}"/>
          </ac:spMkLst>
        </pc:spChg>
        <pc:spChg chg="add del mod">
          <ac:chgData name="Mendoza Valderrey, Alberto" userId="3ca0a5ef-cfc6-4d76-a1eb-aa1d46514f4a" providerId="ADAL" clId="{90C7CDD4-EB8E-43B6-B821-996BE93A380A}" dt="2024-01-31T02:37:56.951" v="344"/>
          <ac:spMkLst>
            <pc:docMk/>
            <pc:sldMk cId="2030739124" sldId="257"/>
            <ac:spMk id="57" creationId="{81275C3B-C2DF-7ACD-EF3F-D7C320017AE2}"/>
          </ac:spMkLst>
        </pc:spChg>
        <pc:spChg chg="add del mod">
          <ac:chgData name="Mendoza Valderrey, Alberto" userId="3ca0a5ef-cfc6-4d76-a1eb-aa1d46514f4a" providerId="ADAL" clId="{90C7CDD4-EB8E-43B6-B821-996BE93A380A}" dt="2024-01-31T02:37:56.951" v="344"/>
          <ac:spMkLst>
            <pc:docMk/>
            <pc:sldMk cId="2030739124" sldId="257"/>
            <ac:spMk id="58" creationId="{73E95A00-35DF-6977-28A1-529542D35744}"/>
          </ac:spMkLst>
        </pc:spChg>
        <pc:spChg chg="add del mod">
          <ac:chgData name="Mendoza Valderrey, Alberto" userId="3ca0a5ef-cfc6-4d76-a1eb-aa1d46514f4a" providerId="ADAL" clId="{90C7CDD4-EB8E-43B6-B821-996BE93A380A}" dt="2024-01-31T02:37:56.951" v="344"/>
          <ac:spMkLst>
            <pc:docMk/>
            <pc:sldMk cId="2030739124" sldId="257"/>
            <ac:spMk id="59" creationId="{CCCE1C69-DE9E-9DDC-6650-BF61C9176426}"/>
          </ac:spMkLst>
        </pc:spChg>
        <pc:spChg chg="add del mod">
          <ac:chgData name="Mendoza Valderrey, Alberto" userId="3ca0a5ef-cfc6-4d76-a1eb-aa1d46514f4a" providerId="ADAL" clId="{90C7CDD4-EB8E-43B6-B821-996BE93A380A}" dt="2024-01-31T02:37:56.951" v="344"/>
          <ac:spMkLst>
            <pc:docMk/>
            <pc:sldMk cId="2030739124" sldId="257"/>
            <ac:spMk id="60" creationId="{FD6E5FC6-77AF-5D9C-AF5E-6EEF2BD53741}"/>
          </ac:spMkLst>
        </pc:spChg>
        <pc:spChg chg="add del mod">
          <ac:chgData name="Mendoza Valderrey, Alberto" userId="3ca0a5ef-cfc6-4d76-a1eb-aa1d46514f4a" providerId="ADAL" clId="{90C7CDD4-EB8E-43B6-B821-996BE93A380A}" dt="2024-01-31T02:37:56.951" v="344"/>
          <ac:spMkLst>
            <pc:docMk/>
            <pc:sldMk cId="2030739124" sldId="257"/>
            <ac:spMk id="61" creationId="{4A75C6D7-9086-5C6F-9178-3F65D466DF36}"/>
          </ac:spMkLst>
        </pc:spChg>
        <pc:spChg chg="add del mod">
          <ac:chgData name="Mendoza Valderrey, Alberto" userId="3ca0a5ef-cfc6-4d76-a1eb-aa1d46514f4a" providerId="ADAL" clId="{90C7CDD4-EB8E-43B6-B821-996BE93A380A}" dt="2024-01-31T02:37:56.951" v="344"/>
          <ac:spMkLst>
            <pc:docMk/>
            <pc:sldMk cId="2030739124" sldId="257"/>
            <ac:spMk id="62" creationId="{57D2F742-45AE-D34A-EFB6-63BD0C0BB314}"/>
          </ac:spMkLst>
        </pc:spChg>
        <pc:spChg chg="add del mod">
          <ac:chgData name="Mendoza Valderrey, Alberto" userId="3ca0a5ef-cfc6-4d76-a1eb-aa1d46514f4a" providerId="ADAL" clId="{90C7CDD4-EB8E-43B6-B821-996BE93A380A}" dt="2024-01-31T02:37:56.951" v="344"/>
          <ac:spMkLst>
            <pc:docMk/>
            <pc:sldMk cId="2030739124" sldId="257"/>
            <ac:spMk id="63" creationId="{45FB22FD-FA7E-16C2-31A5-C6D9F6B863C3}"/>
          </ac:spMkLst>
        </pc:spChg>
        <pc:spChg chg="add del mod">
          <ac:chgData name="Mendoza Valderrey, Alberto" userId="3ca0a5ef-cfc6-4d76-a1eb-aa1d46514f4a" providerId="ADAL" clId="{90C7CDD4-EB8E-43B6-B821-996BE93A380A}" dt="2024-01-31T02:37:56.951" v="344"/>
          <ac:spMkLst>
            <pc:docMk/>
            <pc:sldMk cId="2030739124" sldId="257"/>
            <ac:spMk id="64" creationId="{4823CBEF-A7FC-F37F-36D1-B2DF3CBEC12A}"/>
          </ac:spMkLst>
        </pc:spChg>
        <pc:spChg chg="add del mod">
          <ac:chgData name="Mendoza Valderrey, Alberto" userId="3ca0a5ef-cfc6-4d76-a1eb-aa1d46514f4a" providerId="ADAL" clId="{90C7CDD4-EB8E-43B6-B821-996BE93A380A}" dt="2024-01-31T02:37:56.951" v="344"/>
          <ac:spMkLst>
            <pc:docMk/>
            <pc:sldMk cId="2030739124" sldId="257"/>
            <ac:spMk id="65" creationId="{ED3B426A-263B-0426-399F-DA381CA716FC}"/>
          </ac:spMkLst>
        </pc:spChg>
        <pc:spChg chg="add del mod">
          <ac:chgData name="Mendoza Valderrey, Alberto" userId="3ca0a5ef-cfc6-4d76-a1eb-aa1d46514f4a" providerId="ADAL" clId="{90C7CDD4-EB8E-43B6-B821-996BE93A380A}" dt="2024-01-31T02:37:56.951" v="344"/>
          <ac:spMkLst>
            <pc:docMk/>
            <pc:sldMk cId="2030739124" sldId="257"/>
            <ac:spMk id="66" creationId="{A03FB833-F842-C609-4B7E-A3FEA75DE47E}"/>
          </ac:spMkLst>
        </pc:spChg>
        <pc:spChg chg="add del mod">
          <ac:chgData name="Mendoza Valderrey, Alberto" userId="3ca0a5ef-cfc6-4d76-a1eb-aa1d46514f4a" providerId="ADAL" clId="{90C7CDD4-EB8E-43B6-B821-996BE93A380A}" dt="2024-01-31T02:37:56.951" v="344"/>
          <ac:spMkLst>
            <pc:docMk/>
            <pc:sldMk cId="2030739124" sldId="257"/>
            <ac:spMk id="67" creationId="{8ED84DDD-E799-35EB-4A30-68043703439A}"/>
          </ac:spMkLst>
        </pc:spChg>
        <pc:spChg chg="add del mod">
          <ac:chgData name="Mendoza Valderrey, Alberto" userId="3ca0a5ef-cfc6-4d76-a1eb-aa1d46514f4a" providerId="ADAL" clId="{90C7CDD4-EB8E-43B6-B821-996BE93A380A}" dt="2024-01-31T02:37:56.951" v="344"/>
          <ac:spMkLst>
            <pc:docMk/>
            <pc:sldMk cId="2030739124" sldId="257"/>
            <ac:spMk id="69" creationId="{4B5FD308-6275-820F-3547-A1082133A52B}"/>
          </ac:spMkLst>
        </pc:spChg>
        <pc:spChg chg="add del mod">
          <ac:chgData name="Mendoza Valderrey, Alberto" userId="3ca0a5ef-cfc6-4d76-a1eb-aa1d46514f4a" providerId="ADAL" clId="{90C7CDD4-EB8E-43B6-B821-996BE93A380A}" dt="2024-01-31T02:37:56.951" v="344"/>
          <ac:spMkLst>
            <pc:docMk/>
            <pc:sldMk cId="2030739124" sldId="257"/>
            <ac:spMk id="70" creationId="{305AF263-67B1-9B63-F581-9106889706BA}"/>
          </ac:spMkLst>
        </pc:spChg>
        <pc:spChg chg="add del mod">
          <ac:chgData name="Mendoza Valderrey, Alberto" userId="3ca0a5ef-cfc6-4d76-a1eb-aa1d46514f4a" providerId="ADAL" clId="{90C7CDD4-EB8E-43B6-B821-996BE93A380A}" dt="2024-01-31T02:37:56.951" v="344"/>
          <ac:spMkLst>
            <pc:docMk/>
            <pc:sldMk cId="2030739124" sldId="257"/>
            <ac:spMk id="71" creationId="{89D1D564-5D0F-2CBA-40FE-C10FD7A1C998}"/>
          </ac:spMkLst>
        </pc:spChg>
        <pc:spChg chg="add del mod">
          <ac:chgData name="Mendoza Valderrey, Alberto" userId="3ca0a5ef-cfc6-4d76-a1eb-aa1d46514f4a" providerId="ADAL" clId="{90C7CDD4-EB8E-43B6-B821-996BE93A380A}" dt="2024-01-31T02:37:56.951" v="344"/>
          <ac:spMkLst>
            <pc:docMk/>
            <pc:sldMk cId="2030739124" sldId="257"/>
            <ac:spMk id="72" creationId="{3EFA18D7-8909-5D76-FA9A-EC6D0795F17D}"/>
          </ac:spMkLst>
        </pc:spChg>
        <pc:spChg chg="add del mod">
          <ac:chgData name="Mendoza Valderrey, Alberto" userId="3ca0a5ef-cfc6-4d76-a1eb-aa1d46514f4a" providerId="ADAL" clId="{90C7CDD4-EB8E-43B6-B821-996BE93A380A}" dt="2024-01-31T02:37:56.951" v="344"/>
          <ac:spMkLst>
            <pc:docMk/>
            <pc:sldMk cId="2030739124" sldId="257"/>
            <ac:spMk id="73" creationId="{3C337276-0052-E9A5-142C-3BA65200517A}"/>
          </ac:spMkLst>
        </pc:spChg>
        <pc:spChg chg="add del mod">
          <ac:chgData name="Mendoza Valderrey, Alberto" userId="3ca0a5ef-cfc6-4d76-a1eb-aa1d46514f4a" providerId="ADAL" clId="{90C7CDD4-EB8E-43B6-B821-996BE93A380A}" dt="2024-01-31T02:37:56.951" v="344"/>
          <ac:spMkLst>
            <pc:docMk/>
            <pc:sldMk cId="2030739124" sldId="257"/>
            <ac:spMk id="74" creationId="{6CD155E2-ACC7-D26D-F9F4-3667D57D335E}"/>
          </ac:spMkLst>
        </pc:spChg>
        <pc:spChg chg="add del mod">
          <ac:chgData name="Mendoza Valderrey, Alberto" userId="3ca0a5ef-cfc6-4d76-a1eb-aa1d46514f4a" providerId="ADAL" clId="{90C7CDD4-EB8E-43B6-B821-996BE93A380A}" dt="2024-01-31T02:37:56.951" v="344"/>
          <ac:spMkLst>
            <pc:docMk/>
            <pc:sldMk cId="2030739124" sldId="257"/>
            <ac:spMk id="75" creationId="{41C34C6F-F492-12B3-6524-1E772D7E6854}"/>
          </ac:spMkLst>
        </pc:spChg>
        <pc:spChg chg="mod">
          <ac:chgData name="Mendoza Valderrey, Alberto" userId="3ca0a5ef-cfc6-4d76-a1eb-aa1d46514f4a" providerId="ADAL" clId="{90C7CDD4-EB8E-43B6-B821-996BE93A380A}" dt="2024-01-31T02:37:43.295" v="341"/>
          <ac:spMkLst>
            <pc:docMk/>
            <pc:sldMk cId="2030739124" sldId="257"/>
            <ac:spMk id="79" creationId="{A85B1CB8-F071-F58A-E4E0-38B33A42709A}"/>
          </ac:spMkLst>
        </pc:spChg>
        <pc:spChg chg="add del mod">
          <ac:chgData name="Mendoza Valderrey, Alberto" userId="3ca0a5ef-cfc6-4d76-a1eb-aa1d46514f4a" providerId="ADAL" clId="{90C7CDD4-EB8E-43B6-B821-996BE93A380A}" dt="2024-01-31T02:37:56.951" v="344"/>
          <ac:spMkLst>
            <pc:docMk/>
            <pc:sldMk cId="2030739124" sldId="257"/>
            <ac:spMk id="81" creationId="{56194BE8-3FA7-3DA8-E2C5-E75ADD151DE0}"/>
          </ac:spMkLst>
        </pc:spChg>
        <pc:spChg chg="add del mod">
          <ac:chgData name="Mendoza Valderrey, Alberto" userId="3ca0a5ef-cfc6-4d76-a1eb-aa1d46514f4a" providerId="ADAL" clId="{90C7CDD4-EB8E-43B6-B821-996BE93A380A}" dt="2024-01-31T02:37:56.951" v="344"/>
          <ac:spMkLst>
            <pc:docMk/>
            <pc:sldMk cId="2030739124" sldId="257"/>
            <ac:spMk id="84" creationId="{93C4B46F-49BC-6504-E3AD-5889A27E08D5}"/>
          </ac:spMkLst>
        </pc:spChg>
        <pc:spChg chg="add del mod">
          <ac:chgData name="Mendoza Valderrey, Alberto" userId="3ca0a5ef-cfc6-4d76-a1eb-aa1d46514f4a" providerId="ADAL" clId="{90C7CDD4-EB8E-43B6-B821-996BE93A380A}" dt="2024-01-31T02:37:56.951" v="344"/>
          <ac:spMkLst>
            <pc:docMk/>
            <pc:sldMk cId="2030739124" sldId="257"/>
            <ac:spMk id="86" creationId="{0F289273-4466-E77F-8A9D-0F02488E0F27}"/>
          </ac:spMkLst>
        </pc:spChg>
        <pc:spChg chg="add del mod">
          <ac:chgData name="Mendoza Valderrey, Alberto" userId="3ca0a5ef-cfc6-4d76-a1eb-aa1d46514f4a" providerId="ADAL" clId="{90C7CDD4-EB8E-43B6-B821-996BE93A380A}" dt="2024-01-31T02:37:56.951" v="344"/>
          <ac:spMkLst>
            <pc:docMk/>
            <pc:sldMk cId="2030739124" sldId="257"/>
            <ac:spMk id="87" creationId="{AD6AEBC1-139B-7DA7-B8F1-A4CD85569D83}"/>
          </ac:spMkLst>
        </pc:spChg>
        <pc:spChg chg="mod">
          <ac:chgData name="Mendoza Valderrey, Alberto" userId="3ca0a5ef-cfc6-4d76-a1eb-aa1d46514f4a" providerId="ADAL" clId="{90C7CDD4-EB8E-43B6-B821-996BE93A380A}" dt="2024-01-31T02:37:43.295" v="341"/>
          <ac:spMkLst>
            <pc:docMk/>
            <pc:sldMk cId="2030739124" sldId="257"/>
            <ac:spMk id="91" creationId="{1C99B714-C2E8-7272-450A-0EDFEFB71FB4}"/>
          </ac:spMkLst>
        </pc:spChg>
        <pc:spChg chg="add del mod">
          <ac:chgData name="Mendoza Valderrey, Alberto" userId="3ca0a5ef-cfc6-4d76-a1eb-aa1d46514f4a" providerId="ADAL" clId="{90C7CDD4-EB8E-43B6-B821-996BE93A380A}" dt="2024-01-31T02:37:56.951" v="344"/>
          <ac:spMkLst>
            <pc:docMk/>
            <pc:sldMk cId="2030739124" sldId="257"/>
            <ac:spMk id="93" creationId="{C581A231-7EB2-9714-9386-69CB04D89E91}"/>
          </ac:spMkLst>
        </pc:spChg>
        <pc:spChg chg="add del mod">
          <ac:chgData name="Mendoza Valderrey, Alberto" userId="3ca0a5ef-cfc6-4d76-a1eb-aa1d46514f4a" providerId="ADAL" clId="{90C7CDD4-EB8E-43B6-B821-996BE93A380A}" dt="2024-01-31T02:37:56.951" v="344"/>
          <ac:spMkLst>
            <pc:docMk/>
            <pc:sldMk cId="2030739124" sldId="257"/>
            <ac:spMk id="94" creationId="{41C16550-3CD8-8452-23D4-F5A0CC0D1E3F}"/>
          </ac:spMkLst>
        </pc:spChg>
        <pc:spChg chg="add del mod">
          <ac:chgData name="Mendoza Valderrey, Alberto" userId="3ca0a5ef-cfc6-4d76-a1eb-aa1d46514f4a" providerId="ADAL" clId="{90C7CDD4-EB8E-43B6-B821-996BE93A380A}" dt="2024-01-31T02:37:56.951" v="344"/>
          <ac:spMkLst>
            <pc:docMk/>
            <pc:sldMk cId="2030739124" sldId="257"/>
            <ac:spMk id="95" creationId="{93A77989-7081-D6BC-EDFB-05F45B71C6F2}"/>
          </ac:spMkLst>
        </pc:spChg>
        <pc:spChg chg="add del mod">
          <ac:chgData name="Mendoza Valderrey, Alberto" userId="3ca0a5ef-cfc6-4d76-a1eb-aa1d46514f4a" providerId="ADAL" clId="{90C7CDD4-EB8E-43B6-B821-996BE93A380A}" dt="2024-01-31T02:37:56.951" v="344"/>
          <ac:spMkLst>
            <pc:docMk/>
            <pc:sldMk cId="2030739124" sldId="257"/>
            <ac:spMk id="96" creationId="{82C61D88-051A-62D3-8EF6-A219FD32C1AC}"/>
          </ac:spMkLst>
        </pc:spChg>
        <pc:spChg chg="add del mod">
          <ac:chgData name="Mendoza Valderrey, Alberto" userId="3ca0a5ef-cfc6-4d76-a1eb-aa1d46514f4a" providerId="ADAL" clId="{90C7CDD4-EB8E-43B6-B821-996BE93A380A}" dt="2024-01-31T02:37:56.951" v="344"/>
          <ac:spMkLst>
            <pc:docMk/>
            <pc:sldMk cId="2030739124" sldId="257"/>
            <ac:spMk id="97" creationId="{23C0714E-C5E6-AF7E-FFF7-841BB41A6CDF}"/>
          </ac:spMkLst>
        </pc:spChg>
        <pc:spChg chg="add del mod">
          <ac:chgData name="Mendoza Valderrey, Alberto" userId="3ca0a5ef-cfc6-4d76-a1eb-aa1d46514f4a" providerId="ADAL" clId="{90C7CDD4-EB8E-43B6-B821-996BE93A380A}" dt="2024-01-31T02:37:56.951" v="344"/>
          <ac:spMkLst>
            <pc:docMk/>
            <pc:sldMk cId="2030739124" sldId="257"/>
            <ac:spMk id="98" creationId="{639B6A99-C704-02F3-25BB-1AA0B117EF92}"/>
          </ac:spMkLst>
        </pc:spChg>
        <pc:spChg chg="add del mod">
          <ac:chgData name="Mendoza Valderrey, Alberto" userId="3ca0a5ef-cfc6-4d76-a1eb-aa1d46514f4a" providerId="ADAL" clId="{90C7CDD4-EB8E-43B6-B821-996BE93A380A}" dt="2024-01-31T02:37:56.951" v="344"/>
          <ac:spMkLst>
            <pc:docMk/>
            <pc:sldMk cId="2030739124" sldId="257"/>
            <ac:spMk id="99" creationId="{476725AF-38CD-91B4-528F-5A8213D72A17}"/>
          </ac:spMkLst>
        </pc:spChg>
        <pc:spChg chg="add del mod">
          <ac:chgData name="Mendoza Valderrey, Alberto" userId="3ca0a5ef-cfc6-4d76-a1eb-aa1d46514f4a" providerId="ADAL" clId="{90C7CDD4-EB8E-43B6-B821-996BE93A380A}" dt="2024-01-31T02:37:56.951" v="344"/>
          <ac:spMkLst>
            <pc:docMk/>
            <pc:sldMk cId="2030739124" sldId="257"/>
            <ac:spMk id="101" creationId="{CC3A2EA1-E427-82D8-C500-CBE1CB3757F2}"/>
          </ac:spMkLst>
        </pc:spChg>
        <pc:spChg chg="add del mod">
          <ac:chgData name="Mendoza Valderrey, Alberto" userId="3ca0a5ef-cfc6-4d76-a1eb-aa1d46514f4a" providerId="ADAL" clId="{90C7CDD4-EB8E-43B6-B821-996BE93A380A}" dt="2024-01-31T02:37:56.951" v="344"/>
          <ac:spMkLst>
            <pc:docMk/>
            <pc:sldMk cId="2030739124" sldId="257"/>
            <ac:spMk id="102" creationId="{CAA961C7-0998-8B7E-4F36-1D05372A9528}"/>
          </ac:spMkLst>
        </pc:spChg>
        <pc:spChg chg="add del mod">
          <ac:chgData name="Mendoza Valderrey, Alberto" userId="3ca0a5ef-cfc6-4d76-a1eb-aa1d46514f4a" providerId="ADAL" clId="{90C7CDD4-EB8E-43B6-B821-996BE93A380A}" dt="2024-01-31T02:37:56.951" v="344"/>
          <ac:spMkLst>
            <pc:docMk/>
            <pc:sldMk cId="2030739124" sldId="257"/>
            <ac:spMk id="103" creationId="{42DA553F-44FD-BC9A-C87D-478ECB752D73}"/>
          </ac:spMkLst>
        </pc:spChg>
        <pc:spChg chg="add del mod">
          <ac:chgData name="Mendoza Valderrey, Alberto" userId="3ca0a5ef-cfc6-4d76-a1eb-aa1d46514f4a" providerId="ADAL" clId="{90C7CDD4-EB8E-43B6-B821-996BE93A380A}" dt="2024-01-31T02:37:56.951" v="344"/>
          <ac:spMkLst>
            <pc:docMk/>
            <pc:sldMk cId="2030739124" sldId="257"/>
            <ac:spMk id="104" creationId="{BD0C0D58-3EA7-FE1A-1ACB-97550A01DB7D}"/>
          </ac:spMkLst>
        </pc:spChg>
        <pc:spChg chg="add del mod">
          <ac:chgData name="Mendoza Valderrey, Alberto" userId="3ca0a5ef-cfc6-4d76-a1eb-aa1d46514f4a" providerId="ADAL" clId="{90C7CDD4-EB8E-43B6-B821-996BE93A380A}" dt="2024-01-31T02:37:56.951" v="344"/>
          <ac:spMkLst>
            <pc:docMk/>
            <pc:sldMk cId="2030739124" sldId="257"/>
            <ac:spMk id="105" creationId="{12EAE802-7896-1A22-3783-6E8BDCCD2D29}"/>
          </ac:spMkLst>
        </pc:spChg>
        <pc:spChg chg="add del mod">
          <ac:chgData name="Mendoza Valderrey, Alberto" userId="3ca0a5ef-cfc6-4d76-a1eb-aa1d46514f4a" providerId="ADAL" clId="{90C7CDD4-EB8E-43B6-B821-996BE93A380A}" dt="2024-01-31T02:37:56.951" v="344"/>
          <ac:spMkLst>
            <pc:docMk/>
            <pc:sldMk cId="2030739124" sldId="257"/>
            <ac:spMk id="106" creationId="{5BA2EE61-BD08-99AC-0843-8031344AECA8}"/>
          </ac:spMkLst>
        </pc:spChg>
        <pc:spChg chg="add del mod">
          <ac:chgData name="Mendoza Valderrey, Alberto" userId="3ca0a5ef-cfc6-4d76-a1eb-aa1d46514f4a" providerId="ADAL" clId="{90C7CDD4-EB8E-43B6-B821-996BE93A380A}" dt="2024-01-31T02:37:56.951" v="344"/>
          <ac:spMkLst>
            <pc:docMk/>
            <pc:sldMk cId="2030739124" sldId="257"/>
            <ac:spMk id="107" creationId="{C742B51F-AD97-4012-29F9-EDFF9F6E0208}"/>
          </ac:spMkLst>
        </pc:spChg>
        <pc:spChg chg="add del mod">
          <ac:chgData name="Mendoza Valderrey, Alberto" userId="3ca0a5ef-cfc6-4d76-a1eb-aa1d46514f4a" providerId="ADAL" clId="{90C7CDD4-EB8E-43B6-B821-996BE93A380A}" dt="2024-01-31T02:37:56.951" v="344"/>
          <ac:spMkLst>
            <pc:docMk/>
            <pc:sldMk cId="2030739124" sldId="257"/>
            <ac:spMk id="108" creationId="{7EC304E9-3FFA-78CF-4A64-5D4F128EBF0E}"/>
          </ac:spMkLst>
        </pc:spChg>
        <pc:spChg chg="mod">
          <ac:chgData name="Mendoza Valderrey, Alberto" userId="3ca0a5ef-cfc6-4d76-a1eb-aa1d46514f4a" providerId="ADAL" clId="{90C7CDD4-EB8E-43B6-B821-996BE93A380A}" dt="2024-01-31T02:37:43.295" v="341"/>
          <ac:spMkLst>
            <pc:docMk/>
            <pc:sldMk cId="2030739124" sldId="257"/>
            <ac:spMk id="112" creationId="{3ED3B416-625B-DFDC-CEF3-037EC75DACE9}"/>
          </ac:spMkLst>
        </pc:spChg>
        <pc:spChg chg="add del mod">
          <ac:chgData name="Mendoza Valderrey, Alberto" userId="3ca0a5ef-cfc6-4d76-a1eb-aa1d46514f4a" providerId="ADAL" clId="{90C7CDD4-EB8E-43B6-B821-996BE93A380A}" dt="2024-01-31T02:39:10.744" v="352" actId="478"/>
          <ac:spMkLst>
            <pc:docMk/>
            <pc:sldMk cId="2030739124" sldId="257"/>
            <ac:spMk id="118" creationId="{3AA28A0B-C5E0-B6C0-802C-938E424944C8}"/>
          </ac:spMkLst>
        </pc:spChg>
        <pc:spChg chg="add mod">
          <ac:chgData name="Mendoza Valderrey, Alberto" userId="3ca0a5ef-cfc6-4d76-a1eb-aa1d46514f4a" providerId="ADAL" clId="{90C7CDD4-EB8E-43B6-B821-996BE93A380A}" dt="2024-01-31T02:52:30.719" v="590" actId="1076"/>
          <ac:spMkLst>
            <pc:docMk/>
            <pc:sldMk cId="2030739124" sldId="257"/>
            <ac:spMk id="124" creationId="{F1CAA8A6-F90A-02C9-228D-DCE0940F883A}"/>
          </ac:spMkLst>
        </pc:spChg>
        <pc:spChg chg="add mod">
          <ac:chgData name="Mendoza Valderrey, Alberto" userId="3ca0a5ef-cfc6-4d76-a1eb-aa1d46514f4a" providerId="ADAL" clId="{90C7CDD4-EB8E-43B6-B821-996BE93A380A}" dt="2024-01-31T02:52:30.719" v="590" actId="1076"/>
          <ac:spMkLst>
            <pc:docMk/>
            <pc:sldMk cId="2030739124" sldId="257"/>
            <ac:spMk id="125" creationId="{579E7823-EFEB-C846-7D7F-64CDF5C0E948}"/>
          </ac:spMkLst>
        </pc:spChg>
        <pc:spChg chg="add mod">
          <ac:chgData name="Mendoza Valderrey, Alberto" userId="3ca0a5ef-cfc6-4d76-a1eb-aa1d46514f4a" providerId="ADAL" clId="{90C7CDD4-EB8E-43B6-B821-996BE93A380A}" dt="2024-01-31T02:48:09.881" v="566" actId="1076"/>
          <ac:spMkLst>
            <pc:docMk/>
            <pc:sldMk cId="2030739124" sldId="257"/>
            <ac:spMk id="127" creationId="{11D0B1F4-1296-7D1B-90CB-0D5D4477CF7F}"/>
          </ac:spMkLst>
        </pc:spChg>
        <pc:spChg chg="add mod">
          <ac:chgData name="Mendoza Valderrey, Alberto" userId="3ca0a5ef-cfc6-4d76-a1eb-aa1d46514f4a" providerId="ADAL" clId="{90C7CDD4-EB8E-43B6-B821-996BE93A380A}" dt="2024-01-31T02:48:09.881" v="566" actId="1076"/>
          <ac:spMkLst>
            <pc:docMk/>
            <pc:sldMk cId="2030739124" sldId="257"/>
            <ac:spMk id="128" creationId="{79ECEED9-8C12-3619-F5EE-DEA502BDBE40}"/>
          </ac:spMkLst>
        </pc:spChg>
        <pc:spChg chg="add mod">
          <ac:chgData name="Mendoza Valderrey, Alberto" userId="3ca0a5ef-cfc6-4d76-a1eb-aa1d46514f4a" providerId="ADAL" clId="{90C7CDD4-EB8E-43B6-B821-996BE93A380A}" dt="2024-01-31T02:56:00.482" v="1000" actId="1038"/>
          <ac:spMkLst>
            <pc:docMk/>
            <pc:sldMk cId="2030739124" sldId="257"/>
            <ac:spMk id="129" creationId="{4F1F177B-D82B-F76A-6E79-21F92ECBB78E}"/>
          </ac:spMkLst>
        </pc:spChg>
        <pc:spChg chg="add mod">
          <ac:chgData name="Mendoza Valderrey, Alberto" userId="3ca0a5ef-cfc6-4d76-a1eb-aa1d46514f4a" providerId="ADAL" clId="{90C7CDD4-EB8E-43B6-B821-996BE93A380A}" dt="2024-01-31T02:52:30.719" v="590" actId="1076"/>
          <ac:spMkLst>
            <pc:docMk/>
            <pc:sldMk cId="2030739124" sldId="257"/>
            <ac:spMk id="130" creationId="{C98E4BCB-1E75-B2AE-6F6A-A8C1BBFD39EB}"/>
          </ac:spMkLst>
        </pc:spChg>
        <pc:spChg chg="add mod">
          <ac:chgData name="Mendoza Valderrey, Alberto" userId="3ca0a5ef-cfc6-4d76-a1eb-aa1d46514f4a" providerId="ADAL" clId="{90C7CDD4-EB8E-43B6-B821-996BE93A380A}" dt="2024-01-31T02:56:00.482" v="1000" actId="1038"/>
          <ac:spMkLst>
            <pc:docMk/>
            <pc:sldMk cId="2030739124" sldId="257"/>
            <ac:spMk id="131" creationId="{2598F66F-74A7-FA2D-6003-F417175DA270}"/>
          </ac:spMkLst>
        </pc:spChg>
        <pc:spChg chg="add mod">
          <ac:chgData name="Mendoza Valderrey, Alberto" userId="3ca0a5ef-cfc6-4d76-a1eb-aa1d46514f4a" providerId="ADAL" clId="{90C7CDD4-EB8E-43B6-B821-996BE93A380A}" dt="2024-01-31T02:52:09.272" v="588" actId="1076"/>
          <ac:spMkLst>
            <pc:docMk/>
            <pc:sldMk cId="2030739124" sldId="257"/>
            <ac:spMk id="132" creationId="{FAA7C87B-E436-BA70-EBA1-EAE9AADEC4FA}"/>
          </ac:spMkLst>
        </pc:spChg>
        <pc:spChg chg="add mod">
          <ac:chgData name="Mendoza Valderrey, Alberto" userId="3ca0a5ef-cfc6-4d76-a1eb-aa1d46514f4a" providerId="ADAL" clId="{90C7CDD4-EB8E-43B6-B821-996BE93A380A}" dt="2024-01-31T02:52:03.109" v="587" actId="1076"/>
          <ac:spMkLst>
            <pc:docMk/>
            <pc:sldMk cId="2030739124" sldId="257"/>
            <ac:spMk id="133" creationId="{BB87AC05-738B-ADA4-7D19-1A228DB711B3}"/>
          </ac:spMkLst>
        </pc:spChg>
        <pc:spChg chg="add mod">
          <ac:chgData name="Mendoza Valderrey, Alberto" userId="3ca0a5ef-cfc6-4d76-a1eb-aa1d46514f4a" providerId="ADAL" clId="{90C7CDD4-EB8E-43B6-B821-996BE93A380A}" dt="2024-01-31T02:48:09.881" v="566" actId="1076"/>
          <ac:spMkLst>
            <pc:docMk/>
            <pc:sldMk cId="2030739124" sldId="257"/>
            <ac:spMk id="134" creationId="{29D15C39-C6B4-DC6E-0F7C-A48FF92BDDF3}"/>
          </ac:spMkLst>
        </pc:spChg>
        <pc:spChg chg="add mod">
          <ac:chgData name="Mendoza Valderrey, Alberto" userId="3ca0a5ef-cfc6-4d76-a1eb-aa1d46514f4a" providerId="ADAL" clId="{90C7CDD4-EB8E-43B6-B821-996BE93A380A}" dt="2024-01-31T02:48:09.881" v="566" actId="1076"/>
          <ac:spMkLst>
            <pc:docMk/>
            <pc:sldMk cId="2030739124" sldId="257"/>
            <ac:spMk id="135" creationId="{5F77DD3B-B53B-E829-14B5-7A35FF43AFED}"/>
          </ac:spMkLst>
        </pc:spChg>
        <pc:spChg chg="add mod">
          <ac:chgData name="Mendoza Valderrey, Alberto" userId="3ca0a5ef-cfc6-4d76-a1eb-aa1d46514f4a" providerId="ADAL" clId="{90C7CDD4-EB8E-43B6-B821-996BE93A380A}" dt="2024-01-31T02:48:09.881" v="566" actId="1076"/>
          <ac:spMkLst>
            <pc:docMk/>
            <pc:sldMk cId="2030739124" sldId="257"/>
            <ac:spMk id="136" creationId="{A62F2B25-A0A5-3839-CB45-F8C67CC51888}"/>
          </ac:spMkLst>
        </pc:spChg>
        <pc:spChg chg="add mod">
          <ac:chgData name="Mendoza Valderrey, Alberto" userId="3ca0a5ef-cfc6-4d76-a1eb-aa1d46514f4a" providerId="ADAL" clId="{90C7CDD4-EB8E-43B6-B821-996BE93A380A}" dt="2024-01-31T02:48:09.881" v="566" actId="1076"/>
          <ac:spMkLst>
            <pc:docMk/>
            <pc:sldMk cId="2030739124" sldId="257"/>
            <ac:spMk id="137" creationId="{F92256A1-54EE-A9BA-3461-1616368831CA}"/>
          </ac:spMkLst>
        </pc:spChg>
        <pc:spChg chg="add mod">
          <ac:chgData name="Mendoza Valderrey, Alberto" userId="3ca0a5ef-cfc6-4d76-a1eb-aa1d46514f4a" providerId="ADAL" clId="{90C7CDD4-EB8E-43B6-B821-996BE93A380A}" dt="2024-01-31T02:38:38.608" v="348" actId="1076"/>
          <ac:spMkLst>
            <pc:docMk/>
            <pc:sldMk cId="2030739124" sldId="257"/>
            <ac:spMk id="138" creationId="{99170F35-3629-CE5B-AC9F-61CC4313A4E1}"/>
          </ac:spMkLst>
        </pc:spChg>
        <pc:spChg chg="add mod">
          <ac:chgData name="Mendoza Valderrey, Alberto" userId="3ca0a5ef-cfc6-4d76-a1eb-aa1d46514f4a" providerId="ADAL" clId="{90C7CDD4-EB8E-43B6-B821-996BE93A380A}" dt="2024-01-31T02:56:00.482" v="1000" actId="1038"/>
          <ac:spMkLst>
            <pc:docMk/>
            <pc:sldMk cId="2030739124" sldId="257"/>
            <ac:spMk id="139" creationId="{81555EC4-881B-CDC7-BF88-08DDF2B1EA9B}"/>
          </ac:spMkLst>
        </pc:spChg>
        <pc:spChg chg="add mod">
          <ac:chgData name="Mendoza Valderrey, Alberto" userId="3ca0a5ef-cfc6-4d76-a1eb-aa1d46514f4a" providerId="ADAL" clId="{90C7CDD4-EB8E-43B6-B821-996BE93A380A}" dt="2024-01-31T02:38:38.608" v="348" actId="1076"/>
          <ac:spMkLst>
            <pc:docMk/>
            <pc:sldMk cId="2030739124" sldId="257"/>
            <ac:spMk id="140" creationId="{943AB37E-1F40-0DAC-FB48-25B50B322A4B}"/>
          </ac:spMkLst>
        </pc:spChg>
        <pc:spChg chg="add mod">
          <ac:chgData name="Mendoza Valderrey, Alberto" userId="3ca0a5ef-cfc6-4d76-a1eb-aa1d46514f4a" providerId="ADAL" clId="{90C7CDD4-EB8E-43B6-B821-996BE93A380A}" dt="2024-01-31T02:48:09.881" v="566" actId="1076"/>
          <ac:spMkLst>
            <pc:docMk/>
            <pc:sldMk cId="2030739124" sldId="257"/>
            <ac:spMk id="141" creationId="{07BD209B-A449-7B1C-C51C-E52597FBB37D}"/>
          </ac:spMkLst>
        </pc:spChg>
        <pc:spChg chg="add mod">
          <ac:chgData name="Mendoza Valderrey, Alberto" userId="3ca0a5ef-cfc6-4d76-a1eb-aa1d46514f4a" providerId="ADAL" clId="{90C7CDD4-EB8E-43B6-B821-996BE93A380A}" dt="2024-01-31T02:56:24.357" v="1003" actId="1076"/>
          <ac:spMkLst>
            <pc:docMk/>
            <pc:sldMk cId="2030739124" sldId="257"/>
            <ac:spMk id="143" creationId="{AED1AE38-2C99-0F42-E783-558067E81D7B}"/>
          </ac:spMkLst>
        </pc:spChg>
        <pc:spChg chg="add mod">
          <ac:chgData name="Mendoza Valderrey, Alberto" userId="3ca0a5ef-cfc6-4d76-a1eb-aa1d46514f4a" providerId="ADAL" clId="{90C7CDD4-EB8E-43B6-B821-996BE93A380A}" dt="2024-01-31T02:56:24.357" v="1003" actId="1076"/>
          <ac:spMkLst>
            <pc:docMk/>
            <pc:sldMk cId="2030739124" sldId="257"/>
            <ac:spMk id="144" creationId="{81EBFC37-D6F2-B4EB-E280-69E6308F50C6}"/>
          </ac:spMkLst>
        </pc:spChg>
        <pc:spChg chg="add mod">
          <ac:chgData name="Mendoza Valderrey, Alberto" userId="3ca0a5ef-cfc6-4d76-a1eb-aa1d46514f4a" providerId="ADAL" clId="{90C7CDD4-EB8E-43B6-B821-996BE93A380A}" dt="2024-01-31T02:56:24.357" v="1003" actId="1076"/>
          <ac:spMkLst>
            <pc:docMk/>
            <pc:sldMk cId="2030739124" sldId="257"/>
            <ac:spMk id="145" creationId="{09436167-F828-9944-A9C6-4F2D248B9289}"/>
          </ac:spMkLst>
        </pc:spChg>
        <pc:spChg chg="add mod">
          <ac:chgData name="Mendoza Valderrey, Alberto" userId="3ca0a5ef-cfc6-4d76-a1eb-aa1d46514f4a" providerId="ADAL" clId="{90C7CDD4-EB8E-43B6-B821-996BE93A380A}" dt="2024-01-31T02:56:24.357" v="1003" actId="1076"/>
          <ac:spMkLst>
            <pc:docMk/>
            <pc:sldMk cId="2030739124" sldId="257"/>
            <ac:spMk id="146" creationId="{EBC37FCE-A845-E6DE-CC55-0A2F035511A1}"/>
          </ac:spMkLst>
        </pc:spChg>
        <pc:spChg chg="add mod">
          <ac:chgData name="Mendoza Valderrey, Alberto" userId="3ca0a5ef-cfc6-4d76-a1eb-aa1d46514f4a" providerId="ADAL" clId="{90C7CDD4-EB8E-43B6-B821-996BE93A380A}" dt="2024-01-31T02:56:24.357" v="1003" actId="1076"/>
          <ac:spMkLst>
            <pc:docMk/>
            <pc:sldMk cId="2030739124" sldId="257"/>
            <ac:spMk id="147" creationId="{8B51D47F-AA95-E01A-010D-B8ACC133EA5C}"/>
          </ac:spMkLst>
        </pc:spChg>
        <pc:spChg chg="add mod">
          <ac:chgData name="Mendoza Valderrey, Alberto" userId="3ca0a5ef-cfc6-4d76-a1eb-aa1d46514f4a" providerId="ADAL" clId="{90C7CDD4-EB8E-43B6-B821-996BE93A380A}" dt="2024-01-31T02:56:24.357" v="1003" actId="1076"/>
          <ac:spMkLst>
            <pc:docMk/>
            <pc:sldMk cId="2030739124" sldId="257"/>
            <ac:spMk id="148" creationId="{BCF5EAAD-83DC-204B-E5E2-E773046CCC13}"/>
          </ac:spMkLst>
        </pc:spChg>
        <pc:spChg chg="add mod">
          <ac:chgData name="Mendoza Valderrey, Alberto" userId="3ca0a5ef-cfc6-4d76-a1eb-aa1d46514f4a" providerId="ADAL" clId="{90C7CDD4-EB8E-43B6-B821-996BE93A380A}" dt="2024-01-31T02:56:24.357" v="1003" actId="1076"/>
          <ac:spMkLst>
            <pc:docMk/>
            <pc:sldMk cId="2030739124" sldId="257"/>
            <ac:spMk id="149" creationId="{B0ABB590-A937-9A2D-BE1F-39065F9540EC}"/>
          </ac:spMkLst>
        </pc:spChg>
        <pc:spChg chg="mod">
          <ac:chgData name="Mendoza Valderrey, Alberto" userId="3ca0a5ef-cfc6-4d76-a1eb-aa1d46514f4a" providerId="ADAL" clId="{90C7CDD4-EB8E-43B6-B821-996BE93A380A}" dt="2024-01-31T02:38:07.810" v="346"/>
          <ac:spMkLst>
            <pc:docMk/>
            <pc:sldMk cId="2030739124" sldId="257"/>
            <ac:spMk id="153" creationId="{396E2242-A464-46E9-49FF-88B62DA18DF4}"/>
          </ac:spMkLst>
        </pc:spChg>
        <pc:spChg chg="add mod">
          <ac:chgData name="Mendoza Valderrey, Alberto" userId="3ca0a5ef-cfc6-4d76-a1eb-aa1d46514f4a" providerId="ADAL" clId="{90C7CDD4-EB8E-43B6-B821-996BE93A380A}" dt="2024-01-31T02:56:24.357" v="1003" actId="1076"/>
          <ac:spMkLst>
            <pc:docMk/>
            <pc:sldMk cId="2030739124" sldId="257"/>
            <ac:spMk id="155" creationId="{2F566507-D5CC-C06A-DD10-19A4FD012632}"/>
          </ac:spMkLst>
        </pc:spChg>
        <pc:spChg chg="add mod">
          <ac:chgData name="Mendoza Valderrey, Alberto" userId="3ca0a5ef-cfc6-4d76-a1eb-aa1d46514f4a" providerId="ADAL" clId="{90C7CDD4-EB8E-43B6-B821-996BE93A380A}" dt="2024-01-31T02:56:00.482" v="1000" actId="1038"/>
          <ac:spMkLst>
            <pc:docMk/>
            <pc:sldMk cId="2030739124" sldId="257"/>
            <ac:spMk id="158" creationId="{E621D120-6870-1F50-A7E0-C011C27A29B7}"/>
          </ac:spMkLst>
        </pc:spChg>
        <pc:spChg chg="add mod">
          <ac:chgData name="Mendoza Valderrey, Alberto" userId="3ca0a5ef-cfc6-4d76-a1eb-aa1d46514f4a" providerId="ADAL" clId="{90C7CDD4-EB8E-43B6-B821-996BE93A380A}" dt="2024-01-31T02:56:35.826" v="1004" actId="1076"/>
          <ac:spMkLst>
            <pc:docMk/>
            <pc:sldMk cId="2030739124" sldId="257"/>
            <ac:spMk id="160" creationId="{7B88D28C-575F-8B95-FC74-873AD51FA2B3}"/>
          </ac:spMkLst>
        </pc:spChg>
        <pc:spChg chg="add mod">
          <ac:chgData name="Mendoza Valderrey, Alberto" userId="3ca0a5ef-cfc6-4d76-a1eb-aa1d46514f4a" providerId="ADAL" clId="{90C7CDD4-EB8E-43B6-B821-996BE93A380A}" dt="2024-01-31T02:56:35.826" v="1004" actId="1076"/>
          <ac:spMkLst>
            <pc:docMk/>
            <pc:sldMk cId="2030739124" sldId="257"/>
            <ac:spMk id="161" creationId="{7DD115DD-3397-B416-7CFB-2B42B43EE391}"/>
          </ac:spMkLst>
        </pc:spChg>
        <pc:spChg chg="mod">
          <ac:chgData name="Mendoza Valderrey, Alberto" userId="3ca0a5ef-cfc6-4d76-a1eb-aa1d46514f4a" providerId="ADAL" clId="{90C7CDD4-EB8E-43B6-B821-996BE93A380A}" dt="2024-01-31T02:38:07.810" v="346"/>
          <ac:spMkLst>
            <pc:docMk/>
            <pc:sldMk cId="2030739124" sldId="257"/>
            <ac:spMk id="165" creationId="{276941B8-49E3-5A73-3437-525E82BE700A}"/>
          </ac:spMkLst>
        </pc:spChg>
        <pc:spChg chg="add mod">
          <ac:chgData name="Mendoza Valderrey, Alberto" userId="3ca0a5ef-cfc6-4d76-a1eb-aa1d46514f4a" providerId="ADAL" clId="{90C7CDD4-EB8E-43B6-B821-996BE93A380A}" dt="2024-01-31T02:56:35.826" v="1004" actId="1076"/>
          <ac:spMkLst>
            <pc:docMk/>
            <pc:sldMk cId="2030739124" sldId="257"/>
            <ac:spMk id="167" creationId="{45CEB492-314E-F0E9-F016-5FCFC2854073}"/>
          </ac:spMkLst>
        </pc:spChg>
        <pc:spChg chg="add mod">
          <ac:chgData name="Mendoza Valderrey, Alberto" userId="3ca0a5ef-cfc6-4d76-a1eb-aa1d46514f4a" providerId="ADAL" clId="{90C7CDD4-EB8E-43B6-B821-996BE93A380A}" dt="2024-01-31T02:56:35.826" v="1004" actId="1076"/>
          <ac:spMkLst>
            <pc:docMk/>
            <pc:sldMk cId="2030739124" sldId="257"/>
            <ac:spMk id="168" creationId="{967AAD88-B91A-A928-402E-0914997EB35B}"/>
          </ac:spMkLst>
        </pc:spChg>
        <pc:spChg chg="add mod">
          <ac:chgData name="Mendoza Valderrey, Alberto" userId="3ca0a5ef-cfc6-4d76-a1eb-aa1d46514f4a" providerId="ADAL" clId="{90C7CDD4-EB8E-43B6-B821-996BE93A380A}" dt="2024-01-31T02:56:35.826" v="1004" actId="1076"/>
          <ac:spMkLst>
            <pc:docMk/>
            <pc:sldMk cId="2030739124" sldId="257"/>
            <ac:spMk id="169" creationId="{A4788DFE-A38F-5083-DD8D-78039AB50AF7}"/>
          </ac:spMkLst>
        </pc:spChg>
        <pc:spChg chg="add mod">
          <ac:chgData name="Mendoza Valderrey, Alberto" userId="3ca0a5ef-cfc6-4d76-a1eb-aa1d46514f4a" providerId="ADAL" clId="{90C7CDD4-EB8E-43B6-B821-996BE93A380A}" dt="2024-01-31T02:56:35.826" v="1004" actId="1076"/>
          <ac:spMkLst>
            <pc:docMk/>
            <pc:sldMk cId="2030739124" sldId="257"/>
            <ac:spMk id="170" creationId="{44547AC5-973A-909E-D7C2-8D8CDB170603}"/>
          </ac:spMkLst>
        </pc:spChg>
        <pc:spChg chg="add mod">
          <ac:chgData name="Mendoza Valderrey, Alberto" userId="3ca0a5ef-cfc6-4d76-a1eb-aa1d46514f4a" providerId="ADAL" clId="{90C7CDD4-EB8E-43B6-B821-996BE93A380A}" dt="2024-01-31T02:56:35.826" v="1004" actId="1076"/>
          <ac:spMkLst>
            <pc:docMk/>
            <pc:sldMk cId="2030739124" sldId="257"/>
            <ac:spMk id="171" creationId="{DC8D83B2-E49D-25C6-0F00-81D7F9F8256E}"/>
          </ac:spMkLst>
        </pc:spChg>
        <pc:spChg chg="add mod">
          <ac:chgData name="Mendoza Valderrey, Alberto" userId="3ca0a5ef-cfc6-4d76-a1eb-aa1d46514f4a" providerId="ADAL" clId="{90C7CDD4-EB8E-43B6-B821-996BE93A380A}" dt="2024-01-31T02:56:35.826" v="1004" actId="1076"/>
          <ac:spMkLst>
            <pc:docMk/>
            <pc:sldMk cId="2030739124" sldId="257"/>
            <ac:spMk id="172" creationId="{5388B659-8607-A522-232E-7C0B22164E84}"/>
          </ac:spMkLst>
        </pc:spChg>
        <pc:spChg chg="add mod">
          <ac:chgData name="Mendoza Valderrey, Alberto" userId="3ca0a5ef-cfc6-4d76-a1eb-aa1d46514f4a" providerId="ADAL" clId="{90C7CDD4-EB8E-43B6-B821-996BE93A380A}" dt="2024-01-31T02:56:35.826" v="1004" actId="1076"/>
          <ac:spMkLst>
            <pc:docMk/>
            <pc:sldMk cId="2030739124" sldId="257"/>
            <ac:spMk id="173" creationId="{F70D8CF3-F56F-2FCC-F392-8A47650C9804}"/>
          </ac:spMkLst>
        </pc:spChg>
        <pc:spChg chg="add mod">
          <ac:chgData name="Mendoza Valderrey, Alberto" userId="3ca0a5ef-cfc6-4d76-a1eb-aa1d46514f4a" providerId="ADAL" clId="{90C7CDD4-EB8E-43B6-B821-996BE93A380A}" dt="2024-01-31T02:57:00.138" v="1007" actId="1076"/>
          <ac:spMkLst>
            <pc:docMk/>
            <pc:sldMk cId="2030739124" sldId="257"/>
            <ac:spMk id="175" creationId="{D4DBA928-3D22-BFFC-F2AE-6E920A95EC0B}"/>
          </ac:spMkLst>
        </pc:spChg>
        <pc:spChg chg="add mod">
          <ac:chgData name="Mendoza Valderrey, Alberto" userId="3ca0a5ef-cfc6-4d76-a1eb-aa1d46514f4a" providerId="ADAL" clId="{90C7CDD4-EB8E-43B6-B821-996BE93A380A}" dt="2024-01-31T02:57:00.138" v="1007" actId="1076"/>
          <ac:spMkLst>
            <pc:docMk/>
            <pc:sldMk cId="2030739124" sldId="257"/>
            <ac:spMk id="176" creationId="{1E1C56D4-48B8-8C67-EC5E-2BABB0486CA2}"/>
          </ac:spMkLst>
        </pc:spChg>
        <pc:spChg chg="add mod">
          <ac:chgData name="Mendoza Valderrey, Alberto" userId="3ca0a5ef-cfc6-4d76-a1eb-aa1d46514f4a" providerId="ADAL" clId="{90C7CDD4-EB8E-43B6-B821-996BE93A380A}" dt="2024-01-31T02:57:00.138" v="1007" actId="1076"/>
          <ac:spMkLst>
            <pc:docMk/>
            <pc:sldMk cId="2030739124" sldId="257"/>
            <ac:spMk id="177" creationId="{0913916A-A496-50CA-989D-F1F3F909D26C}"/>
          </ac:spMkLst>
        </pc:spChg>
        <pc:spChg chg="add mod">
          <ac:chgData name="Mendoza Valderrey, Alberto" userId="3ca0a5ef-cfc6-4d76-a1eb-aa1d46514f4a" providerId="ADAL" clId="{90C7CDD4-EB8E-43B6-B821-996BE93A380A}" dt="2024-01-31T02:57:00.138" v="1007" actId="1076"/>
          <ac:spMkLst>
            <pc:docMk/>
            <pc:sldMk cId="2030739124" sldId="257"/>
            <ac:spMk id="178" creationId="{57EB5D55-3F20-E2AB-1B9B-162BACDF9D4D}"/>
          </ac:spMkLst>
        </pc:spChg>
        <pc:spChg chg="add mod">
          <ac:chgData name="Mendoza Valderrey, Alberto" userId="3ca0a5ef-cfc6-4d76-a1eb-aa1d46514f4a" providerId="ADAL" clId="{90C7CDD4-EB8E-43B6-B821-996BE93A380A}" dt="2024-01-31T02:57:00.138" v="1007" actId="1076"/>
          <ac:spMkLst>
            <pc:docMk/>
            <pc:sldMk cId="2030739124" sldId="257"/>
            <ac:spMk id="179" creationId="{33567E91-D705-3C70-9077-B7967FBF810A}"/>
          </ac:spMkLst>
        </pc:spChg>
        <pc:spChg chg="add mod">
          <ac:chgData name="Mendoza Valderrey, Alberto" userId="3ca0a5ef-cfc6-4d76-a1eb-aa1d46514f4a" providerId="ADAL" clId="{90C7CDD4-EB8E-43B6-B821-996BE93A380A}" dt="2024-01-31T02:57:00.138" v="1007" actId="1076"/>
          <ac:spMkLst>
            <pc:docMk/>
            <pc:sldMk cId="2030739124" sldId="257"/>
            <ac:spMk id="180" creationId="{55400E20-9FA7-1F8D-60FF-E1B9F945057F}"/>
          </ac:spMkLst>
        </pc:spChg>
        <pc:spChg chg="add mod">
          <ac:chgData name="Mendoza Valderrey, Alberto" userId="3ca0a5ef-cfc6-4d76-a1eb-aa1d46514f4a" providerId="ADAL" clId="{90C7CDD4-EB8E-43B6-B821-996BE93A380A}" dt="2024-01-31T02:57:00.138" v="1007" actId="1076"/>
          <ac:spMkLst>
            <pc:docMk/>
            <pc:sldMk cId="2030739124" sldId="257"/>
            <ac:spMk id="181" creationId="{383E62AF-8830-9D26-2095-738F9911C539}"/>
          </ac:spMkLst>
        </pc:spChg>
        <pc:spChg chg="add mod">
          <ac:chgData name="Mendoza Valderrey, Alberto" userId="3ca0a5ef-cfc6-4d76-a1eb-aa1d46514f4a" providerId="ADAL" clId="{90C7CDD4-EB8E-43B6-B821-996BE93A380A}" dt="2024-01-31T02:57:00.138" v="1007" actId="1076"/>
          <ac:spMkLst>
            <pc:docMk/>
            <pc:sldMk cId="2030739124" sldId="257"/>
            <ac:spMk id="182" creationId="{5A1AD4D1-311F-3B8C-1719-45EF41A1F83C}"/>
          </ac:spMkLst>
        </pc:spChg>
        <pc:spChg chg="mod">
          <ac:chgData name="Mendoza Valderrey, Alberto" userId="3ca0a5ef-cfc6-4d76-a1eb-aa1d46514f4a" providerId="ADAL" clId="{90C7CDD4-EB8E-43B6-B821-996BE93A380A}" dt="2024-01-31T02:38:07.810" v="346"/>
          <ac:spMkLst>
            <pc:docMk/>
            <pc:sldMk cId="2030739124" sldId="257"/>
            <ac:spMk id="186" creationId="{DE0BC07A-E774-2547-0F2A-188EEC722D36}"/>
          </ac:spMkLst>
        </pc:spChg>
        <pc:spChg chg="add mod">
          <ac:chgData name="Mendoza Valderrey, Alberto" userId="3ca0a5ef-cfc6-4d76-a1eb-aa1d46514f4a" providerId="ADAL" clId="{90C7CDD4-EB8E-43B6-B821-996BE93A380A}" dt="2024-01-31T02:55:13.014" v="788" actId="1036"/>
          <ac:spMkLst>
            <pc:docMk/>
            <pc:sldMk cId="2030739124" sldId="257"/>
            <ac:spMk id="188" creationId="{7BEFD2BA-A076-F33B-B86F-BA9EA5516653}"/>
          </ac:spMkLst>
        </pc:spChg>
        <pc:spChg chg="add mod">
          <ac:chgData name="Mendoza Valderrey, Alberto" userId="3ca0a5ef-cfc6-4d76-a1eb-aa1d46514f4a" providerId="ADAL" clId="{90C7CDD4-EB8E-43B6-B821-996BE93A380A}" dt="2024-01-31T02:55:13.014" v="788" actId="1036"/>
          <ac:spMkLst>
            <pc:docMk/>
            <pc:sldMk cId="2030739124" sldId="257"/>
            <ac:spMk id="189" creationId="{BF0C02E4-EBC4-3A5A-95C3-390886268173}"/>
          </ac:spMkLst>
        </pc:spChg>
        <pc:spChg chg="add mod">
          <ac:chgData name="Mendoza Valderrey, Alberto" userId="3ca0a5ef-cfc6-4d76-a1eb-aa1d46514f4a" providerId="ADAL" clId="{90C7CDD4-EB8E-43B6-B821-996BE93A380A}" dt="2024-01-31T02:55:13.014" v="788" actId="1036"/>
          <ac:spMkLst>
            <pc:docMk/>
            <pc:sldMk cId="2030739124" sldId="257"/>
            <ac:spMk id="190" creationId="{0AF51E9C-B059-EC6B-A109-75A8C370BBAD}"/>
          </ac:spMkLst>
        </pc:spChg>
        <pc:spChg chg="add mod">
          <ac:chgData name="Mendoza Valderrey, Alberto" userId="3ca0a5ef-cfc6-4d76-a1eb-aa1d46514f4a" providerId="ADAL" clId="{90C7CDD4-EB8E-43B6-B821-996BE93A380A}" dt="2024-01-31T02:55:13.014" v="788" actId="1036"/>
          <ac:spMkLst>
            <pc:docMk/>
            <pc:sldMk cId="2030739124" sldId="257"/>
            <ac:spMk id="191" creationId="{CD32C471-12F2-0C4A-580B-8D03FD2DFB75}"/>
          </ac:spMkLst>
        </pc:spChg>
        <pc:spChg chg="add mod">
          <ac:chgData name="Mendoza Valderrey, Alberto" userId="3ca0a5ef-cfc6-4d76-a1eb-aa1d46514f4a" providerId="ADAL" clId="{90C7CDD4-EB8E-43B6-B821-996BE93A380A}" dt="2024-01-31T02:55:25.820" v="796" actId="1036"/>
          <ac:spMkLst>
            <pc:docMk/>
            <pc:sldMk cId="2030739124" sldId="257"/>
            <ac:spMk id="192" creationId="{D04C9E61-AAA6-4FFE-E18D-ABB607469DDC}"/>
          </ac:spMkLst>
        </pc:spChg>
        <pc:spChg chg="add mod">
          <ac:chgData name="Mendoza Valderrey, Alberto" userId="3ca0a5ef-cfc6-4d76-a1eb-aa1d46514f4a" providerId="ADAL" clId="{90C7CDD4-EB8E-43B6-B821-996BE93A380A}" dt="2024-01-31T02:55:25.820" v="796" actId="1036"/>
          <ac:spMkLst>
            <pc:docMk/>
            <pc:sldMk cId="2030739124" sldId="257"/>
            <ac:spMk id="194" creationId="{63160D9E-5E92-E218-1427-E8876C01303E}"/>
          </ac:spMkLst>
        </pc:spChg>
        <pc:grpChg chg="add mod">
          <ac:chgData name="Mendoza Valderrey, Alberto" userId="3ca0a5ef-cfc6-4d76-a1eb-aa1d46514f4a" providerId="ADAL" clId="{90C7CDD4-EB8E-43B6-B821-996BE93A380A}" dt="2024-01-31T02:54:03.751" v="775" actId="1038"/>
          <ac:grpSpMkLst>
            <pc:docMk/>
            <pc:sldMk cId="2030739124" sldId="257"/>
            <ac:grpSpMk id="18" creationId="{375E59ED-0A8C-8906-8D24-B3B968A78AF2}"/>
          </ac:grpSpMkLst>
        </pc:grpChg>
        <pc:grpChg chg="add del mod">
          <ac:chgData name="Mendoza Valderrey, Alberto" userId="3ca0a5ef-cfc6-4d76-a1eb-aa1d46514f4a" providerId="ADAL" clId="{90C7CDD4-EB8E-43B6-B821-996BE93A380A}" dt="2024-01-31T02:37:56.951" v="344"/>
          <ac:grpSpMkLst>
            <pc:docMk/>
            <pc:sldMk cId="2030739124" sldId="257"/>
            <ac:grpSpMk id="76" creationId="{1C21C7AD-CE55-8E45-834A-51737C930459}"/>
          </ac:grpSpMkLst>
        </pc:grpChg>
        <pc:grpChg chg="add del mod">
          <ac:chgData name="Mendoza Valderrey, Alberto" userId="3ca0a5ef-cfc6-4d76-a1eb-aa1d46514f4a" providerId="ADAL" clId="{90C7CDD4-EB8E-43B6-B821-996BE93A380A}" dt="2024-01-31T02:37:56.951" v="344"/>
          <ac:grpSpMkLst>
            <pc:docMk/>
            <pc:sldMk cId="2030739124" sldId="257"/>
            <ac:grpSpMk id="88" creationId="{57725F98-1DC7-DEAD-C628-1347F914C4B3}"/>
          </ac:grpSpMkLst>
        </pc:grpChg>
        <pc:grpChg chg="add del mod">
          <ac:chgData name="Mendoza Valderrey, Alberto" userId="3ca0a5ef-cfc6-4d76-a1eb-aa1d46514f4a" providerId="ADAL" clId="{90C7CDD4-EB8E-43B6-B821-996BE93A380A}" dt="2024-01-31T02:37:56.951" v="344"/>
          <ac:grpSpMkLst>
            <pc:docMk/>
            <pc:sldMk cId="2030739124" sldId="257"/>
            <ac:grpSpMk id="109" creationId="{97B3BB90-1632-1B81-A39A-58480D50673D}"/>
          </ac:grpSpMkLst>
        </pc:grpChg>
        <pc:grpChg chg="add mod">
          <ac:chgData name="Mendoza Valderrey, Alberto" userId="3ca0a5ef-cfc6-4d76-a1eb-aa1d46514f4a" providerId="ADAL" clId="{90C7CDD4-EB8E-43B6-B821-996BE93A380A}" dt="2024-01-31T02:56:24.357" v="1003" actId="1076"/>
          <ac:grpSpMkLst>
            <pc:docMk/>
            <pc:sldMk cId="2030739124" sldId="257"/>
            <ac:grpSpMk id="150" creationId="{B7BE33BD-1563-2872-6997-E7DF4E061C22}"/>
          </ac:grpSpMkLst>
        </pc:grpChg>
        <pc:grpChg chg="add mod">
          <ac:chgData name="Mendoza Valderrey, Alberto" userId="3ca0a5ef-cfc6-4d76-a1eb-aa1d46514f4a" providerId="ADAL" clId="{90C7CDD4-EB8E-43B6-B821-996BE93A380A}" dt="2024-01-31T02:56:35.826" v="1004" actId="1076"/>
          <ac:grpSpMkLst>
            <pc:docMk/>
            <pc:sldMk cId="2030739124" sldId="257"/>
            <ac:grpSpMk id="162" creationId="{18C1E5D5-C2FE-3217-DF93-15E28747976D}"/>
          </ac:grpSpMkLst>
        </pc:grpChg>
        <pc:grpChg chg="add mod">
          <ac:chgData name="Mendoza Valderrey, Alberto" userId="3ca0a5ef-cfc6-4d76-a1eb-aa1d46514f4a" providerId="ADAL" clId="{90C7CDD4-EB8E-43B6-B821-996BE93A380A}" dt="2024-01-31T02:57:00.138" v="1007" actId="1076"/>
          <ac:grpSpMkLst>
            <pc:docMk/>
            <pc:sldMk cId="2030739124" sldId="257"/>
            <ac:grpSpMk id="183" creationId="{A9B68FE1-4A9E-7B6D-0290-A24CC0A5A456}"/>
          </ac:grpSpMkLst>
        </pc:grpChg>
        <pc:picChg chg="add mod">
          <ac:chgData name="Mendoza Valderrey, Alberto" userId="3ca0a5ef-cfc6-4d76-a1eb-aa1d46514f4a" providerId="ADAL" clId="{90C7CDD4-EB8E-43B6-B821-996BE93A380A}" dt="2024-01-31T02:54:03.751" v="775" actId="1038"/>
          <ac:picMkLst>
            <pc:docMk/>
            <pc:sldMk cId="2030739124" sldId="257"/>
            <ac:picMk id="4" creationId="{A931A929-AEA1-1271-A967-30E1464E4C37}"/>
          </ac:picMkLst>
        </pc:picChg>
        <pc:picChg chg="add del mod">
          <ac:chgData name="Mendoza Valderrey, Alberto" userId="3ca0a5ef-cfc6-4d76-a1eb-aa1d46514f4a" providerId="ADAL" clId="{90C7CDD4-EB8E-43B6-B821-996BE93A380A}" dt="2024-01-31T02:37:56.951" v="344"/>
          <ac:picMkLst>
            <pc:docMk/>
            <pc:sldMk cId="2030739124" sldId="257"/>
            <ac:picMk id="45" creationId="{5BCC3B39-54F5-96FE-9B2C-B7A154E11F85}"/>
          </ac:picMkLst>
        </pc:picChg>
        <pc:picChg chg="add del mod">
          <ac:chgData name="Mendoza Valderrey, Alberto" userId="3ca0a5ef-cfc6-4d76-a1eb-aa1d46514f4a" providerId="ADAL" clId="{90C7CDD4-EB8E-43B6-B821-996BE93A380A}" dt="2024-01-31T02:37:56.951" v="344"/>
          <ac:picMkLst>
            <pc:docMk/>
            <pc:sldMk cId="2030739124" sldId="257"/>
            <ac:picMk id="46" creationId="{105FEBBF-64C1-60A7-A14E-FAAF87B980DC}"/>
          </ac:picMkLst>
        </pc:picChg>
        <pc:picChg chg="add del mod">
          <ac:chgData name="Mendoza Valderrey, Alberto" userId="3ca0a5ef-cfc6-4d76-a1eb-aa1d46514f4a" providerId="ADAL" clId="{90C7CDD4-EB8E-43B6-B821-996BE93A380A}" dt="2024-01-31T02:37:56.951" v="344"/>
          <ac:picMkLst>
            <pc:docMk/>
            <pc:sldMk cId="2030739124" sldId="257"/>
            <ac:picMk id="47" creationId="{9357532C-57E9-DE9D-F90E-13936E19FAAB}"/>
          </ac:picMkLst>
        </pc:picChg>
        <pc:picChg chg="add del mod">
          <ac:chgData name="Mendoza Valderrey, Alberto" userId="3ca0a5ef-cfc6-4d76-a1eb-aa1d46514f4a" providerId="ADAL" clId="{90C7CDD4-EB8E-43B6-B821-996BE93A380A}" dt="2024-01-31T02:37:56.951" v="344"/>
          <ac:picMkLst>
            <pc:docMk/>
            <pc:sldMk cId="2030739124" sldId="257"/>
            <ac:picMk id="48" creationId="{13193D7D-0BFC-82B4-6DC2-D3FA16FEA261}"/>
          </ac:picMkLst>
        </pc:picChg>
        <pc:picChg chg="add del mod">
          <ac:chgData name="Mendoza Valderrey, Alberto" userId="3ca0a5ef-cfc6-4d76-a1eb-aa1d46514f4a" providerId="ADAL" clId="{90C7CDD4-EB8E-43B6-B821-996BE93A380A}" dt="2024-01-31T02:37:56.951" v="344"/>
          <ac:picMkLst>
            <pc:docMk/>
            <pc:sldMk cId="2030739124" sldId="257"/>
            <ac:picMk id="68" creationId="{BD1FEAB2-54DD-C861-31F4-C354FCC8E360}"/>
          </ac:picMkLst>
        </pc:picChg>
        <pc:picChg chg="add del mod">
          <ac:chgData name="Mendoza Valderrey, Alberto" userId="3ca0a5ef-cfc6-4d76-a1eb-aa1d46514f4a" providerId="ADAL" clId="{90C7CDD4-EB8E-43B6-B821-996BE93A380A}" dt="2024-01-31T02:37:56.951" v="344"/>
          <ac:picMkLst>
            <pc:docMk/>
            <pc:sldMk cId="2030739124" sldId="257"/>
            <ac:picMk id="85" creationId="{01DD3D82-C50C-1845-33C0-60E3ADE049A9}"/>
          </ac:picMkLst>
        </pc:picChg>
        <pc:picChg chg="add del mod">
          <ac:chgData name="Mendoza Valderrey, Alberto" userId="3ca0a5ef-cfc6-4d76-a1eb-aa1d46514f4a" providerId="ADAL" clId="{90C7CDD4-EB8E-43B6-B821-996BE93A380A}" dt="2024-01-31T02:37:56.951" v="344"/>
          <ac:picMkLst>
            <pc:docMk/>
            <pc:sldMk cId="2030739124" sldId="257"/>
            <ac:picMk id="100" creationId="{D6B473A0-109A-BF24-8A77-35DA1DFA3A59}"/>
          </ac:picMkLst>
        </pc:picChg>
        <pc:picChg chg="add mod">
          <ac:chgData name="Mendoza Valderrey, Alberto" userId="3ca0a5ef-cfc6-4d76-a1eb-aa1d46514f4a" providerId="ADAL" clId="{90C7CDD4-EB8E-43B6-B821-996BE93A380A}" dt="2024-01-31T02:51:46.866" v="586" actId="1076"/>
          <ac:picMkLst>
            <pc:docMk/>
            <pc:sldMk cId="2030739124" sldId="257"/>
            <ac:picMk id="119" creationId="{37D544DA-3643-766A-9605-9B99AF71BEFB}"/>
          </ac:picMkLst>
        </pc:picChg>
        <pc:picChg chg="add mod">
          <ac:chgData name="Mendoza Valderrey, Alberto" userId="3ca0a5ef-cfc6-4d76-a1eb-aa1d46514f4a" providerId="ADAL" clId="{90C7CDD4-EB8E-43B6-B821-996BE93A380A}" dt="2024-01-31T02:51:15.256" v="583" actId="1076"/>
          <ac:picMkLst>
            <pc:docMk/>
            <pc:sldMk cId="2030739124" sldId="257"/>
            <ac:picMk id="120" creationId="{83AA463F-3F35-AE2F-52B5-BB2C7C25C8DB}"/>
          </ac:picMkLst>
        </pc:picChg>
        <pc:picChg chg="add mod">
          <ac:chgData name="Mendoza Valderrey, Alberto" userId="3ca0a5ef-cfc6-4d76-a1eb-aa1d46514f4a" providerId="ADAL" clId="{90C7CDD4-EB8E-43B6-B821-996BE93A380A}" dt="2024-01-31T02:51:24.760" v="584" actId="14100"/>
          <ac:picMkLst>
            <pc:docMk/>
            <pc:sldMk cId="2030739124" sldId="257"/>
            <ac:picMk id="121" creationId="{D7A006EA-278B-9910-09C5-533F03542947}"/>
          </ac:picMkLst>
        </pc:picChg>
        <pc:picChg chg="add mod">
          <ac:chgData name="Mendoza Valderrey, Alberto" userId="3ca0a5ef-cfc6-4d76-a1eb-aa1d46514f4a" providerId="ADAL" clId="{90C7CDD4-EB8E-43B6-B821-996BE93A380A}" dt="2024-01-31T02:51:04.027" v="582" actId="1076"/>
          <ac:picMkLst>
            <pc:docMk/>
            <pc:sldMk cId="2030739124" sldId="257"/>
            <ac:picMk id="122" creationId="{B918B14A-AE80-89BA-3DBF-D12315812667}"/>
          </ac:picMkLst>
        </pc:picChg>
        <pc:picChg chg="add mod">
          <ac:chgData name="Mendoza Valderrey, Alberto" userId="3ca0a5ef-cfc6-4d76-a1eb-aa1d46514f4a" providerId="ADAL" clId="{90C7CDD4-EB8E-43B6-B821-996BE93A380A}" dt="2024-01-31T02:56:24.357" v="1003" actId="1076"/>
          <ac:picMkLst>
            <pc:docMk/>
            <pc:sldMk cId="2030739124" sldId="257"/>
            <ac:picMk id="142" creationId="{CCDDD27C-8083-9E72-21A9-5137CFD9EBAA}"/>
          </ac:picMkLst>
        </pc:picChg>
        <pc:picChg chg="add mod">
          <ac:chgData name="Mendoza Valderrey, Alberto" userId="3ca0a5ef-cfc6-4d76-a1eb-aa1d46514f4a" providerId="ADAL" clId="{90C7CDD4-EB8E-43B6-B821-996BE93A380A}" dt="2024-01-31T02:56:35.826" v="1004" actId="1076"/>
          <ac:picMkLst>
            <pc:docMk/>
            <pc:sldMk cId="2030739124" sldId="257"/>
            <ac:picMk id="159" creationId="{27201F0E-0F10-D462-EBBD-DD599E248372}"/>
          </ac:picMkLst>
        </pc:picChg>
        <pc:picChg chg="add mod">
          <ac:chgData name="Mendoza Valderrey, Alberto" userId="3ca0a5ef-cfc6-4d76-a1eb-aa1d46514f4a" providerId="ADAL" clId="{90C7CDD4-EB8E-43B6-B821-996BE93A380A}" dt="2024-01-31T02:57:00.138" v="1007" actId="1076"/>
          <ac:picMkLst>
            <pc:docMk/>
            <pc:sldMk cId="2030739124" sldId="257"/>
            <ac:picMk id="174" creationId="{2A2FD168-9091-209F-8427-7FED377FC139}"/>
          </ac:picMkLst>
        </pc:picChg>
        <pc:picChg chg="add mod">
          <ac:chgData name="Mendoza Valderrey, Alberto" userId="3ca0a5ef-cfc6-4d76-a1eb-aa1d46514f4a" providerId="ADAL" clId="{90C7CDD4-EB8E-43B6-B821-996BE93A380A}" dt="2024-01-31T02:55:13.014" v="788" actId="1036"/>
          <ac:picMkLst>
            <pc:docMk/>
            <pc:sldMk cId="2030739124" sldId="257"/>
            <ac:picMk id="193" creationId="{30C038D6-6371-AAA9-8583-EB23590C76A1}"/>
          </ac:picMkLst>
        </pc:picChg>
        <pc:cxnChg chg="mod">
          <ac:chgData name="Mendoza Valderrey, Alberto" userId="3ca0a5ef-cfc6-4d76-a1eb-aa1d46514f4a" providerId="ADAL" clId="{90C7CDD4-EB8E-43B6-B821-996BE93A380A}" dt="2024-01-31T02:37:08.741" v="339"/>
          <ac:cxnSpMkLst>
            <pc:docMk/>
            <pc:sldMk cId="2030739124" sldId="257"/>
            <ac:cxnSpMk id="21" creationId="{6CE4AF3B-B303-8AAF-3374-777B587EA706}"/>
          </ac:cxnSpMkLst>
        </pc:cxnChg>
        <pc:cxnChg chg="mod">
          <ac:chgData name="Mendoza Valderrey, Alberto" userId="3ca0a5ef-cfc6-4d76-a1eb-aa1d46514f4a" providerId="ADAL" clId="{90C7CDD4-EB8E-43B6-B821-996BE93A380A}" dt="2024-01-31T02:37:08.741" v="339"/>
          <ac:cxnSpMkLst>
            <pc:docMk/>
            <pc:sldMk cId="2030739124" sldId="257"/>
            <ac:cxnSpMk id="22" creationId="{D1773648-6332-C6CA-A08B-8324AA741A08}"/>
          </ac:cxnSpMkLst>
        </pc:cxnChg>
        <pc:cxnChg chg="add mod">
          <ac:chgData name="Mendoza Valderrey, Alberto" userId="3ca0a5ef-cfc6-4d76-a1eb-aa1d46514f4a" providerId="ADAL" clId="{90C7CDD4-EB8E-43B6-B821-996BE93A380A}" dt="2024-01-31T02:54:03.751" v="775" actId="1038"/>
          <ac:cxnSpMkLst>
            <pc:docMk/>
            <pc:sldMk cId="2030739124" sldId="257"/>
            <ac:cxnSpMk id="26" creationId="{95873F42-4E25-7A83-C125-8A5EF77A72AE}"/>
          </ac:cxnSpMkLst>
        </pc:cxnChg>
        <pc:cxnChg chg="add mod">
          <ac:chgData name="Mendoza Valderrey, Alberto" userId="3ca0a5ef-cfc6-4d76-a1eb-aa1d46514f4a" providerId="ADAL" clId="{90C7CDD4-EB8E-43B6-B821-996BE93A380A}" dt="2024-01-31T02:54:03.751" v="775" actId="1038"/>
          <ac:cxnSpMkLst>
            <pc:docMk/>
            <pc:sldMk cId="2030739124" sldId="257"/>
            <ac:cxnSpMk id="27" creationId="{92D23368-02BB-A378-55DA-6E968C327B41}"/>
          </ac:cxnSpMkLst>
        </pc:cxnChg>
        <pc:cxnChg chg="add mod">
          <ac:chgData name="Mendoza Valderrey, Alberto" userId="3ca0a5ef-cfc6-4d76-a1eb-aa1d46514f4a" providerId="ADAL" clId="{90C7CDD4-EB8E-43B6-B821-996BE93A380A}" dt="2024-01-31T02:54:03.751" v="775" actId="1038"/>
          <ac:cxnSpMkLst>
            <pc:docMk/>
            <pc:sldMk cId="2030739124" sldId="257"/>
            <ac:cxnSpMk id="28" creationId="{F12C9A7A-A596-EA51-F361-3FA13D37B81E}"/>
          </ac:cxnSpMkLst>
        </pc:cxnChg>
        <pc:cxnChg chg="add del mod">
          <ac:chgData name="Mendoza Valderrey, Alberto" userId="3ca0a5ef-cfc6-4d76-a1eb-aa1d46514f4a" providerId="ADAL" clId="{90C7CDD4-EB8E-43B6-B821-996BE93A380A}" dt="2024-01-31T02:37:56.951" v="344"/>
          <ac:cxnSpMkLst>
            <pc:docMk/>
            <pc:sldMk cId="2030739124" sldId="257"/>
            <ac:cxnSpMk id="49" creationId="{BFC6F58A-EDB9-1D7A-B265-F6D6F5C05EAD}"/>
          </ac:cxnSpMkLst>
        </pc:cxnChg>
        <pc:cxnChg chg="add del mod">
          <ac:chgData name="Mendoza Valderrey, Alberto" userId="3ca0a5ef-cfc6-4d76-a1eb-aa1d46514f4a" providerId="ADAL" clId="{90C7CDD4-EB8E-43B6-B821-996BE93A380A}" dt="2024-01-31T02:37:56.951" v="344"/>
          <ac:cxnSpMkLst>
            <pc:docMk/>
            <pc:sldMk cId="2030739124" sldId="257"/>
            <ac:cxnSpMk id="52" creationId="{36ED4E44-7DB8-546F-7FB6-ED5D3A98DD94}"/>
          </ac:cxnSpMkLst>
        </pc:cxnChg>
        <pc:cxnChg chg="mod">
          <ac:chgData name="Mendoza Valderrey, Alberto" userId="3ca0a5ef-cfc6-4d76-a1eb-aa1d46514f4a" providerId="ADAL" clId="{90C7CDD4-EB8E-43B6-B821-996BE93A380A}" dt="2024-01-31T02:37:43.295" v="341"/>
          <ac:cxnSpMkLst>
            <pc:docMk/>
            <pc:sldMk cId="2030739124" sldId="257"/>
            <ac:cxnSpMk id="77" creationId="{724FDF3B-42E5-6D66-6DF2-B7250B8A90E3}"/>
          </ac:cxnSpMkLst>
        </pc:cxnChg>
        <pc:cxnChg chg="mod">
          <ac:chgData name="Mendoza Valderrey, Alberto" userId="3ca0a5ef-cfc6-4d76-a1eb-aa1d46514f4a" providerId="ADAL" clId="{90C7CDD4-EB8E-43B6-B821-996BE93A380A}" dt="2024-01-31T02:37:43.295" v="341"/>
          <ac:cxnSpMkLst>
            <pc:docMk/>
            <pc:sldMk cId="2030739124" sldId="257"/>
            <ac:cxnSpMk id="78" creationId="{30B95638-DECC-8BE0-BEDE-F115853EFF92}"/>
          </ac:cxnSpMkLst>
        </pc:cxnChg>
        <pc:cxnChg chg="mod">
          <ac:chgData name="Mendoza Valderrey, Alberto" userId="3ca0a5ef-cfc6-4d76-a1eb-aa1d46514f4a" providerId="ADAL" clId="{90C7CDD4-EB8E-43B6-B821-996BE93A380A}" dt="2024-01-31T02:37:43.295" v="341"/>
          <ac:cxnSpMkLst>
            <pc:docMk/>
            <pc:sldMk cId="2030739124" sldId="257"/>
            <ac:cxnSpMk id="80" creationId="{772265DA-C177-8FBE-0724-24EE2E703B32}"/>
          </ac:cxnSpMkLst>
        </pc:cxnChg>
        <pc:cxnChg chg="add del mod">
          <ac:chgData name="Mendoza Valderrey, Alberto" userId="3ca0a5ef-cfc6-4d76-a1eb-aa1d46514f4a" providerId="ADAL" clId="{90C7CDD4-EB8E-43B6-B821-996BE93A380A}" dt="2024-01-31T02:37:56.951" v="344"/>
          <ac:cxnSpMkLst>
            <pc:docMk/>
            <pc:sldMk cId="2030739124" sldId="257"/>
            <ac:cxnSpMk id="82" creationId="{1633FEA8-F970-F66C-C72C-786182723B30}"/>
          </ac:cxnSpMkLst>
        </pc:cxnChg>
        <pc:cxnChg chg="add del mod">
          <ac:chgData name="Mendoza Valderrey, Alberto" userId="3ca0a5ef-cfc6-4d76-a1eb-aa1d46514f4a" providerId="ADAL" clId="{90C7CDD4-EB8E-43B6-B821-996BE93A380A}" dt="2024-01-31T02:37:56.951" v="344"/>
          <ac:cxnSpMkLst>
            <pc:docMk/>
            <pc:sldMk cId="2030739124" sldId="257"/>
            <ac:cxnSpMk id="83" creationId="{7B1E71AA-3F5A-1486-8C64-A6A42E1209F2}"/>
          </ac:cxnSpMkLst>
        </pc:cxnChg>
        <pc:cxnChg chg="mod">
          <ac:chgData name="Mendoza Valderrey, Alberto" userId="3ca0a5ef-cfc6-4d76-a1eb-aa1d46514f4a" providerId="ADAL" clId="{90C7CDD4-EB8E-43B6-B821-996BE93A380A}" dt="2024-01-31T02:37:43.295" v="341"/>
          <ac:cxnSpMkLst>
            <pc:docMk/>
            <pc:sldMk cId="2030739124" sldId="257"/>
            <ac:cxnSpMk id="89" creationId="{E5DE6E3D-E9F4-F192-F3AE-E2444EBAFF40}"/>
          </ac:cxnSpMkLst>
        </pc:cxnChg>
        <pc:cxnChg chg="mod">
          <ac:chgData name="Mendoza Valderrey, Alberto" userId="3ca0a5ef-cfc6-4d76-a1eb-aa1d46514f4a" providerId="ADAL" clId="{90C7CDD4-EB8E-43B6-B821-996BE93A380A}" dt="2024-01-31T02:37:43.295" v="341"/>
          <ac:cxnSpMkLst>
            <pc:docMk/>
            <pc:sldMk cId="2030739124" sldId="257"/>
            <ac:cxnSpMk id="90" creationId="{0837F759-687B-4718-BEE7-F01F19DED75E}"/>
          </ac:cxnSpMkLst>
        </pc:cxnChg>
        <pc:cxnChg chg="mod">
          <ac:chgData name="Mendoza Valderrey, Alberto" userId="3ca0a5ef-cfc6-4d76-a1eb-aa1d46514f4a" providerId="ADAL" clId="{90C7CDD4-EB8E-43B6-B821-996BE93A380A}" dt="2024-01-31T02:37:43.295" v="341"/>
          <ac:cxnSpMkLst>
            <pc:docMk/>
            <pc:sldMk cId="2030739124" sldId="257"/>
            <ac:cxnSpMk id="92" creationId="{680E8ED7-1B59-403C-E36E-E326DE407117}"/>
          </ac:cxnSpMkLst>
        </pc:cxnChg>
        <pc:cxnChg chg="mod">
          <ac:chgData name="Mendoza Valderrey, Alberto" userId="3ca0a5ef-cfc6-4d76-a1eb-aa1d46514f4a" providerId="ADAL" clId="{90C7CDD4-EB8E-43B6-B821-996BE93A380A}" dt="2024-01-31T02:37:43.295" v="341"/>
          <ac:cxnSpMkLst>
            <pc:docMk/>
            <pc:sldMk cId="2030739124" sldId="257"/>
            <ac:cxnSpMk id="110" creationId="{21E697E5-2D60-6BE8-1E79-B746131B356A}"/>
          </ac:cxnSpMkLst>
        </pc:cxnChg>
        <pc:cxnChg chg="mod">
          <ac:chgData name="Mendoza Valderrey, Alberto" userId="3ca0a5ef-cfc6-4d76-a1eb-aa1d46514f4a" providerId="ADAL" clId="{90C7CDD4-EB8E-43B6-B821-996BE93A380A}" dt="2024-01-31T02:37:43.295" v="341"/>
          <ac:cxnSpMkLst>
            <pc:docMk/>
            <pc:sldMk cId="2030739124" sldId="257"/>
            <ac:cxnSpMk id="111" creationId="{B675D3DA-B1FB-B76F-582D-94F950DDE661}"/>
          </ac:cxnSpMkLst>
        </pc:cxnChg>
        <pc:cxnChg chg="mod">
          <ac:chgData name="Mendoza Valderrey, Alberto" userId="3ca0a5ef-cfc6-4d76-a1eb-aa1d46514f4a" providerId="ADAL" clId="{90C7CDD4-EB8E-43B6-B821-996BE93A380A}" dt="2024-01-31T02:37:43.295" v="341"/>
          <ac:cxnSpMkLst>
            <pc:docMk/>
            <pc:sldMk cId="2030739124" sldId="257"/>
            <ac:cxnSpMk id="113" creationId="{3B9477D0-7318-A0ED-0E91-787B726756EE}"/>
          </ac:cxnSpMkLst>
        </pc:cxnChg>
        <pc:cxnChg chg="add mod">
          <ac:chgData name="Mendoza Valderrey, Alberto" userId="3ca0a5ef-cfc6-4d76-a1eb-aa1d46514f4a" providerId="ADAL" clId="{90C7CDD4-EB8E-43B6-B821-996BE93A380A}" dt="2024-01-31T02:52:30.719" v="590" actId="1076"/>
          <ac:cxnSpMkLst>
            <pc:docMk/>
            <pc:sldMk cId="2030739124" sldId="257"/>
            <ac:cxnSpMk id="123" creationId="{65F7583F-4F88-8937-96A3-9B50660E7433}"/>
          </ac:cxnSpMkLst>
        </pc:cxnChg>
        <pc:cxnChg chg="add mod">
          <ac:chgData name="Mendoza Valderrey, Alberto" userId="3ca0a5ef-cfc6-4d76-a1eb-aa1d46514f4a" providerId="ADAL" clId="{90C7CDD4-EB8E-43B6-B821-996BE93A380A}" dt="2024-01-31T02:52:30.719" v="590" actId="1076"/>
          <ac:cxnSpMkLst>
            <pc:docMk/>
            <pc:sldMk cId="2030739124" sldId="257"/>
            <ac:cxnSpMk id="126" creationId="{5FFF1D79-D7BE-1C04-1548-B1DEE322C48B}"/>
          </ac:cxnSpMkLst>
        </pc:cxnChg>
        <pc:cxnChg chg="mod">
          <ac:chgData name="Mendoza Valderrey, Alberto" userId="3ca0a5ef-cfc6-4d76-a1eb-aa1d46514f4a" providerId="ADAL" clId="{90C7CDD4-EB8E-43B6-B821-996BE93A380A}" dt="2024-01-31T02:38:07.810" v="346"/>
          <ac:cxnSpMkLst>
            <pc:docMk/>
            <pc:sldMk cId="2030739124" sldId="257"/>
            <ac:cxnSpMk id="151" creationId="{36F6EAD8-11BC-5A89-B10C-32A277024EA6}"/>
          </ac:cxnSpMkLst>
        </pc:cxnChg>
        <pc:cxnChg chg="mod">
          <ac:chgData name="Mendoza Valderrey, Alberto" userId="3ca0a5ef-cfc6-4d76-a1eb-aa1d46514f4a" providerId="ADAL" clId="{90C7CDD4-EB8E-43B6-B821-996BE93A380A}" dt="2024-01-31T02:38:07.810" v="346"/>
          <ac:cxnSpMkLst>
            <pc:docMk/>
            <pc:sldMk cId="2030739124" sldId="257"/>
            <ac:cxnSpMk id="152" creationId="{5FE3E1DF-EF96-52A8-E22E-2A51E96BC2DC}"/>
          </ac:cxnSpMkLst>
        </pc:cxnChg>
        <pc:cxnChg chg="mod">
          <ac:chgData name="Mendoza Valderrey, Alberto" userId="3ca0a5ef-cfc6-4d76-a1eb-aa1d46514f4a" providerId="ADAL" clId="{90C7CDD4-EB8E-43B6-B821-996BE93A380A}" dt="2024-01-31T02:38:07.810" v="346"/>
          <ac:cxnSpMkLst>
            <pc:docMk/>
            <pc:sldMk cId="2030739124" sldId="257"/>
            <ac:cxnSpMk id="154" creationId="{29F5A45A-AB6E-2A31-DD5B-25DEFAB2E948}"/>
          </ac:cxnSpMkLst>
        </pc:cxnChg>
        <pc:cxnChg chg="add mod">
          <ac:chgData name="Mendoza Valderrey, Alberto" userId="3ca0a5ef-cfc6-4d76-a1eb-aa1d46514f4a" providerId="ADAL" clId="{90C7CDD4-EB8E-43B6-B821-996BE93A380A}" dt="2024-01-31T02:56:00.482" v="1000" actId="1038"/>
          <ac:cxnSpMkLst>
            <pc:docMk/>
            <pc:sldMk cId="2030739124" sldId="257"/>
            <ac:cxnSpMk id="156" creationId="{07A659AA-B1B9-CFE6-9528-3EAE1B644DEE}"/>
          </ac:cxnSpMkLst>
        </pc:cxnChg>
        <pc:cxnChg chg="add mod">
          <ac:chgData name="Mendoza Valderrey, Alberto" userId="3ca0a5ef-cfc6-4d76-a1eb-aa1d46514f4a" providerId="ADAL" clId="{90C7CDD4-EB8E-43B6-B821-996BE93A380A}" dt="2024-01-31T02:56:00.482" v="1000" actId="1038"/>
          <ac:cxnSpMkLst>
            <pc:docMk/>
            <pc:sldMk cId="2030739124" sldId="257"/>
            <ac:cxnSpMk id="157" creationId="{68E9BEA9-48A9-9720-13A1-FF1521033A58}"/>
          </ac:cxnSpMkLst>
        </pc:cxnChg>
        <pc:cxnChg chg="mod">
          <ac:chgData name="Mendoza Valderrey, Alberto" userId="3ca0a5ef-cfc6-4d76-a1eb-aa1d46514f4a" providerId="ADAL" clId="{90C7CDD4-EB8E-43B6-B821-996BE93A380A}" dt="2024-01-31T02:38:07.810" v="346"/>
          <ac:cxnSpMkLst>
            <pc:docMk/>
            <pc:sldMk cId="2030739124" sldId="257"/>
            <ac:cxnSpMk id="163" creationId="{55692E2F-4EB0-0D86-3FBB-D170BC82EF6F}"/>
          </ac:cxnSpMkLst>
        </pc:cxnChg>
        <pc:cxnChg chg="mod">
          <ac:chgData name="Mendoza Valderrey, Alberto" userId="3ca0a5ef-cfc6-4d76-a1eb-aa1d46514f4a" providerId="ADAL" clId="{90C7CDD4-EB8E-43B6-B821-996BE93A380A}" dt="2024-01-31T02:38:07.810" v="346"/>
          <ac:cxnSpMkLst>
            <pc:docMk/>
            <pc:sldMk cId="2030739124" sldId="257"/>
            <ac:cxnSpMk id="164" creationId="{57DEB214-FABE-23D2-0BFD-5786E56D2F75}"/>
          </ac:cxnSpMkLst>
        </pc:cxnChg>
        <pc:cxnChg chg="mod">
          <ac:chgData name="Mendoza Valderrey, Alberto" userId="3ca0a5ef-cfc6-4d76-a1eb-aa1d46514f4a" providerId="ADAL" clId="{90C7CDD4-EB8E-43B6-B821-996BE93A380A}" dt="2024-01-31T02:38:07.810" v="346"/>
          <ac:cxnSpMkLst>
            <pc:docMk/>
            <pc:sldMk cId="2030739124" sldId="257"/>
            <ac:cxnSpMk id="166" creationId="{52BB6197-6F69-7640-5B40-49E52AEE4CC8}"/>
          </ac:cxnSpMkLst>
        </pc:cxnChg>
        <pc:cxnChg chg="mod">
          <ac:chgData name="Mendoza Valderrey, Alberto" userId="3ca0a5ef-cfc6-4d76-a1eb-aa1d46514f4a" providerId="ADAL" clId="{90C7CDD4-EB8E-43B6-B821-996BE93A380A}" dt="2024-01-31T02:38:07.810" v="346"/>
          <ac:cxnSpMkLst>
            <pc:docMk/>
            <pc:sldMk cId="2030739124" sldId="257"/>
            <ac:cxnSpMk id="184" creationId="{AF69F3ED-8B60-FDFF-7B5F-D18C61FF90E9}"/>
          </ac:cxnSpMkLst>
        </pc:cxnChg>
        <pc:cxnChg chg="mod">
          <ac:chgData name="Mendoza Valderrey, Alberto" userId="3ca0a5ef-cfc6-4d76-a1eb-aa1d46514f4a" providerId="ADAL" clId="{90C7CDD4-EB8E-43B6-B821-996BE93A380A}" dt="2024-01-31T02:38:07.810" v="346"/>
          <ac:cxnSpMkLst>
            <pc:docMk/>
            <pc:sldMk cId="2030739124" sldId="257"/>
            <ac:cxnSpMk id="185" creationId="{52B0FAE2-02CB-033C-4B50-03DD9BC1A1AB}"/>
          </ac:cxnSpMkLst>
        </pc:cxnChg>
        <pc:cxnChg chg="mod">
          <ac:chgData name="Mendoza Valderrey, Alberto" userId="3ca0a5ef-cfc6-4d76-a1eb-aa1d46514f4a" providerId="ADAL" clId="{90C7CDD4-EB8E-43B6-B821-996BE93A380A}" dt="2024-01-31T02:38:07.810" v="346"/>
          <ac:cxnSpMkLst>
            <pc:docMk/>
            <pc:sldMk cId="2030739124" sldId="257"/>
            <ac:cxnSpMk id="187" creationId="{FCBFB130-7572-7684-64F5-3B6DF165C209}"/>
          </ac:cxnSpMkLst>
        </pc:cxnChg>
      </pc:sldChg>
      <pc:sldMasterChg chg="modSp modSldLayout">
        <pc:chgData name="Mendoza Valderrey, Alberto" userId="3ca0a5ef-cfc6-4d76-a1eb-aa1d46514f4a" providerId="ADAL" clId="{90C7CDD4-EB8E-43B6-B821-996BE93A380A}" dt="2024-01-31T02:33:35.578" v="260"/>
        <pc:sldMasterMkLst>
          <pc:docMk/>
          <pc:sldMasterMk cId="3504811012" sldId="2147483648"/>
        </pc:sldMasterMkLst>
        <pc:spChg chg="mod">
          <ac:chgData name="Mendoza Valderrey, Alberto" userId="3ca0a5ef-cfc6-4d76-a1eb-aa1d46514f4a" providerId="ADAL" clId="{90C7CDD4-EB8E-43B6-B821-996BE93A380A}" dt="2024-01-31T02:33:35.578" v="260"/>
          <ac:spMkLst>
            <pc:docMk/>
            <pc:sldMasterMk cId="3504811012" sldId="2147483648"/>
            <ac:spMk id="2" creationId="{EB518628-2004-C612-F409-0D402F98B83B}"/>
          </ac:spMkLst>
        </pc:spChg>
        <pc:spChg chg="mod">
          <ac:chgData name="Mendoza Valderrey, Alberto" userId="3ca0a5ef-cfc6-4d76-a1eb-aa1d46514f4a" providerId="ADAL" clId="{90C7CDD4-EB8E-43B6-B821-996BE93A380A}" dt="2024-01-31T02:33:35.578" v="260"/>
          <ac:spMkLst>
            <pc:docMk/>
            <pc:sldMasterMk cId="3504811012" sldId="2147483648"/>
            <ac:spMk id="3" creationId="{02C69432-464D-6AB2-1417-9FE257F910E4}"/>
          </ac:spMkLst>
        </pc:spChg>
        <pc:spChg chg="mod">
          <ac:chgData name="Mendoza Valderrey, Alberto" userId="3ca0a5ef-cfc6-4d76-a1eb-aa1d46514f4a" providerId="ADAL" clId="{90C7CDD4-EB8E-43B6-B821-996BE93A380A}" dt="2024-01-31T02:33:35.578" v="260"/>
          <ac:spMkLst>
            <pc:docMk/>
            <pc:sldMasterMk cId="3504811012" sldId="2147483648"/>
            <ac:spMk id="4" creationId="{D8B114E9-7C24-7679-B8F2-61F45495E1AA}"/>
          </ac:spMkLst>
        </pc:spChg>
        <pc:spChg chg="mod">
          <ac:chgData name="Mendoza Valderrey, Alberto" userId="3ca0a5ef-cfc6-4d76-a1eb-aa1d46514f4a" providerId="ADAL" clId="{90C7CDD4-EB8E-43B6-B821-996BE93A380A}" dt="2024-01-31T02:33:35.578" v="260"/>
          <ac:spMkLst>
            <pc:docMk/>
            <pc:sldMasterMk cId="3504811012" sldId="2147483648"/>
            <ac:spMk id="5" creationId="{4D1E9D40-546E-85A7-C042-18E32647B345}"/>
          </ac:spMkLst>
        </pc:spChg>
        <pc:spChg chg="mod">
          <ac:chgData name="Mendoza Valderrey, Alberto" userId="3ca0a5ef-cfc6-4d76-a1eb-aa1d46514f4a" providerId="ADAL" clId="{90C7CDD4-EB8E-43B6-B821-996BE93A380A}" dt="2024-01-31T02:33:35.578" v="260"/>
          <ac:spMkLst>
            <pc:docMk/>
            <pc:sldMasterMk cId="3504811012" sldId="2147483648"/>
            <ac:spMk id="6" creationId="{5FE9A144-9274-2DEE-0B52-6C5DB852EAC6}"/>
          </ac:spMkLst>
        </pc:spChg>
        <pc:sldLayoutChg chg="modSp">
          <pc:chgData name="Mendoza Valderrey, Alberto" userId="3ca0a5ef-cfc6-4d76-a1eb-aa1d46514f4a" providerId="ADAL" clId="{90C7CDD4-EB8E-43B6-B821-996BE93A380A}" dt="2024-01-31T02:33:35.578" v="260"/>
          <pc:sldLayoutMkLst>
            <pc:docMk/>
            <pc:sldMasterMk cId="3504811012" sldId="2147483648"/>
            <pc:sldLayoutMk cId="840826458" sldId="2147483649"/>
          </pc:sldLayoutMkLst>
          <pc:spChg chg="mod">
            <ac:chgData name="Mendoza Valderrey, Alberto" userId="3ca0a5ef-cfc6-4d76-a1eb-aa1d46514f4a" providerId="ADAL" clId="{90C7CDD4-EB8E-43B6-B821-996BE93A380A}" dt="2024-01-31T02:33:35.578" v="260"/>
            <ac:spMkLst>
              <pc:docMk/>
              <pc:sldMasterMk cId="3504811012" sldId="2147483648"/>
              <pc:sldLayoutMk cId="840826458" sldId="2147483649"/>
              <ac:spMk id="2" creationId="{8BF2D0E1-3448-C813-6B29-7EF4290F86E2}"/>
            </ac:spMkLst>
          </pc:spChg>
          <pc:spChg chg="mod">
            <ac:chgData name="Mendoza Valderrey, Alberto" userId="3ca0a5ef-cfc6-4d76-a1eb-aa1d46514f4a" providerId="ADAL" clId="{90C7CDD4-EB8E-43B6-B821-996BE93A380A}" dt="2024-01-31T02:33:35.578" v="260"/>
            <ac:spMkLst>
              <pc:docMk/>
              <pc:sldMasterMk cId="3504811012" sldId="2147483648"/>
              <pc:sldLayoutMk cId="840826458" sldId="2147483649"/>
              <ac:spMk id="3" creationId="{869A4E48-1A79-4858-DB48-8B89DC31759E}"/>
            </ac:spMkLst>
          </pc:spChg>
        </pc:sldLayoutChg>
        <pc:sldLayoutChg chg="modSp">
          <pc:chgData name="Mendoza Valderrey, Alberto" userId="3ca0a5ef-cfc6-4d76-a1eb-aa1d46514f4a" providerId="ADAL" clId="{90C7CDD4-EB8E-43B6-B821-996BE93A380A}" dt="2024-01-31T02:33:35.578" v="260"/>
          <pc:sldLayoutMkLst>
            <pc:docMk/>
            <pc:sldMasterMk cId="3504811012" sldId="2147483648"/>
            <pc:sldLayoutMk cId="2091228332" sldId="2147483651"/>
          </pc:sldLayoutMkLst>
          <pc:spChg chg="mod">
            <ac:chgData name="Mendoza Valderrey, Alberto" userId="3ca0a5ef-cfc6-4d76-a1eb-aa1d46514f4a" providerId="ADAL" clId="{90C7CDD4-EB8E-43B6-B821-996BE93A380A}" dt="2024-01-31T02:33:35.578" v="260"/>
            <ac:spMkLst>
              <pc:docMk/>
              <pc:sldMasterMk cId="3504811012" sldId="2147483648"/>
              <pc:sldLayoutMk cId="2091228332" sldId="2147483651"/>
              <ac:spMk id="2" creationId="{239D332F-DC5B-D9BF-9878-83BEE93DAB68}"/>
            </ac:spMkLst>
          </pc:spChg>
          <pc:spChg chg="mod">
            <ac:chgData name="Mendoza Valderrey, Alberto" userId="3ca0a5ef-cfc6-4d76-a1eb-aa1d46514f4a" providerId="ADAL" clId="{90C7CDD4-EB8E-43B6-B821-996BE93A380A}" dt="2024-01-31T02:33:35.578" v="260"/>
            <ac:spMkLst>
              <pc:docMk/>
              <pc:sldMasterMk cId="3504811012" sldId="2147483648"/>
              <pc:sldLayoutMk cId="2091228332" sldId="2147483651"/>
              <ac:spMk id="3" creationId="{67F79EC2-407F-2BB9-E6E1-8D6CC3C2A33C}"/>
            </ac:spMkLst>
          </pc:spChg>
        </pc:sldLayoutChg>
        <pc:sldLayoutChg chg="modSp">
          <pc:chgData name="Mendoza Valderrey, Alberto" userId="3ca0a5ef-cfc6-4d76-a1eb-aa1d46514f4a" providerId="ADAL" clId="{90C7CDD4-EB8E-43B6-B821-996BE93A380A}" dt="2024-01-31T02:33:35.578" v="260"/>
          <pc:sldLayoutMkLst>
            <pc:docMk/>
            <pc:sldMasterMk cId="3504811012" sldId="2147483648"/>
            <pc:sldLayoutMk cId="836068149" sldId="2147483652"/>
          </pc:sldLayoutMkLst>
          <pc:spChg chg="mod">
            <ac:chgData name="Mendoza Valderrey, Alberto" userId="3ca0a5ef-cfc6-4d76-a1eb-aa1d46514f4a" providerId="ADAL" clId="{90C7CDD4-EB8E-43B6-B821-996BE93A380A}" dt="2024-01-31T02:33:35.578" v="260"/>
            <ac:spMkLst>
              <pc:docMk/>
              <pc:sldMasterMk cId="3504811012" sldId="2147483648"/>
              <pc:sldLayoutMk cId="836068149" sldId="2147483652"/>
              <ac:spMk id="3" creationId="{BD8F0852-5CB5-9830-F1AD-ACFB8DE7D8A4}"/>
            </ac:spMkLst>
          </pc:spChg>
          <pc:spChg chg="mod">
            <ac:chgData name="Mendoza Valderrey, Alberto" userId="3ca0a5ef-cfc6-4d76-a1eb-aa1d46514f4a" providerId="ADAL" clId="{90C7CDD4-EB8E-43B6-B821-996BE93A380A}" dt="2024-01-31T02:33:35.578" v="260"/>
            <ac:spMkLst>
              <pc:docMk/>
              <pc:sldMasterMk cId="3504811012" sldId="2147483648"/>
              <pc:sldLayoutMk cId="836068149" sldId="2147483652"/>
              <ac:spMk id="4" creationId="{4674A226-D011-FE9B-54E2-AD12EBD40BC7}"/>
            </ac:spMkLst>
          </pc:spChg>
        </pc:sldLayoutChg>
        <pc:sldLayoutChg chg="modSp">
          <pc:chgData name="Mendoza Valderrey, Alberto" userId="3ca0a5ef-cfc6-4d76-a1eb-aa1d46514f4a" providerId="ADAL" clId="{90C7CDD4-EB8E-43B6-B821-996BE93A380A}" dt="2024-01-31T02:33:35.578" v="260"/>
          <pc:sldLayoutMkLst>
            <pc:docMk/>
            <pc:sldMasterMk cId="3504811012" sldId="2147483648"/>
            <pc:sldLayoutMk cId="3506623020" sldId="2147483653"/>
          </pc:sldLayoutMkLst>
          <pc:spChg chg="mod">
            <ac:chgData name="Mendoza Valderrey, Alberto" userId="3ca0a5ef-cfc6-4d76-a1eb-aa1d46514f4a" providerId="ADAL" clId="{90C7CDD4-EB8E-43B6-B821-996BE93A380A}" dt="2024-01-31T02:33:35.578" v="260"/>
            <ac:spMkLst>
              <pc:docMk/>
              <pc:sldMasterMk cId="3504811012" sldId="2147483648"/>
              <pc:sldLayoutMk cId="3506623020" sldId="2147483653"/>
              <ac:spMk id="2" creationId="{B3F82CF0-4A54-F9EC-A89E-70795B909729}"/>
            </ac:spMkLst>
          </pc:spChg>
          <pc:spChg chg="mod">
            <ac:chgData name="Mendoza Valderrey, Alberto" userId="3ca0a5ef-cfc6-4d76-a1eb-aa1d46514f4a" providerId="ADAL" clId="{90C7CDD4-EB8E-43B6-B821-996BE93A380A}" dt="2024-01-31T02:33:35.578" v="260"/>
            <ac:spMkLst>
              <pc:docMk/>
              <pc:sldMasterMk cId="3504811012" sldId="2147483648"/>
              <pc:sldLayoutMk cId="3506623020" sldId="2147483653"/>
              <ac:spMk id="3" creationId="{FF335E3A-F0A0-AAF7-53F2-1D1D9DEDADD8}"/>
            </ac:spMkLst>
          </pc:spChg>
          <pc:spChg chg="mod">
            <ac:chgData name="Mendoza Valderrey, Alberto" userId="3ca0a5ef-cfc6-4d76-a1eb-aa1d46514f4a" providerId="ADAL" clId="{90C7CDD4-EB8E-43B6-B821-996BE93A380A}" dt="2024-01-31T02:33:35.578" v="260"/>
            <ac:spMkLst>
              <pc:docMk/>
              <pc:sldMasterMk cId="3504811012" sldId="2147483648"/>
              <pc:sldLayoutMk cId="3506623020" sldId="2147483653"/>
              <ac:spMk id="4" creationId="{AABA1F07-F1E0-9091-6FDD-8E246514E647}"/>
            </ac:spMkLst>
          </pc:spChg>
          <pc:spChg chg="mod">
            <ac:chgData name="Mendoza Valderrey, Alberto" userId="3ca0a5ef-cfc6-4d76-a1eb-aa1d46514f4a" providerId="ADAL" clId="{90C7CDD4-EB8E-43B6-B821-996BE93A380A}" dt="2024-01-31T02:33:35.578" v="260"/>
            <ac:spMkLst>
              <pc:docMk/>
              <pc:sldMasterMk cId="3504811012" sldId="2147483648"/>
              <pc:sldLayoutMk cId="3506623020" sldId="2147483653"/>
              <ac:spMk id="5" creationId="{75B7D33F-1485-96ED-2AEC-F2C8D37CEFDD}"/>
            </ac:spMkLst>
          </pc:spChg>
          <pc:spChg chg="mod">
            <ac:chgData name="Mendoza Valderrey, Alberto" userId="3ca0a5ef-cfc6-4d76-a1eb-aa1d46514f4a" providerId="ADAL" clId="{90C7CDD4-EB8E-43B6-B821-996BE93A380A}" dt="2024-01-31T02:33:35.578" v="260"/>
            <ac:spMkLst>
              <pc:docMk/>
              <pc:sldMasterMk cId="3504811012" sldId="2147483648"/>
              <pc:sldLayoutMk cId="3506623020" sldId="2147483653"/>
              <ac:spMk id="6" creationId="{6121533B-57E8-7965-9F0D-A66AEB5A88B1}"/>
            </ac:spMkLst>
          </pc:spChg>
        </pc:sldLayoutChg>
        <pc:sldLayoutChg chg="modSp">
          <pc:chgData name="Mendoza Valderrey, Alberto" userId="3ca0a5ef-cfc6-4d76-a1eb-aa1d46514f4a" providerId="ADAL" clId="{90C7CDD4-EB8E-43B6-B821-996BE93A380A}" dt="2024-01-31T02:33:35.578" v="260"/>
          <pc:sldLayoutMkLst>
            <pc:docMk/>
            <pc:sldMasterMk cId="3504811012" sldId="2147483648"/>
            <pc:sldLayoutMk cId="1657517792" sldId="2147483656"/>
          </pc:sldLayoutMkLst>
          <pc:spChg chg="mod">
            <ac:chgData name="Mendoza Valderrey, Alberto" userId="3ca0a5ef-cfc6-4d76-a1eb-aa1d46514f4a" providerId="ADAL" clId="{90C7CDD4-EB8E-43B6-B821-996BE93A380A}" dt="2024-01-31T02:33:35.578" v="260"/>
            <ac:spMkLst>
              <pc:docMk/>
              <pc:sldMasterMk cId="3504811012" sldId="2147483648"/>
              <pc:sldLayoutMk cId="1657517792" sldId="2147483656"/>
              <ac:spMk id="2" creationId="{BF68BB71-8F7A-EB98-0F88-1DE3B5A866AB}"/>
            </ac:spMkLst>
          </pc:spChg>
          <pc:spChg chg="mod">
            <ac:chgData name="Mendoza Valderrey, Alberto" userId="3ca0a5ef-cfc6-4d76-a1eb-aa1d46514f4a" providerId="ADAL" clId="{90C7CDD4-EB8E-43B6-B821-996BE93A380A}" dt="2024-01-31T02:33:35.578" v="260"/>
            <ac:spMkLst>
              <pc:docMk/>
              <pc:sldMasterMk cId="3504811012" sldId="2147483648"/>
              <pc:sldLayoutMk cId="1657517792" sldId="2147483656"/>
              <ac:spMk id="3" creationId="{0D0BEC6E-B41A-7CAE-631C-012099025B99}"/>
            </ac:spMkLst>
          </pc:spChg>
          <pc:spChg chg="mod">
            <ac:chgData name="Mendoza Valderrey, Alberto" userId="3ca0a5ef-cfc6-4d76-a1eb-aa1d46514f4a" providerId="ADAL" clId="{90C7CDD4-EB8E-43B6-B821-996BE93A380A}" dt="2024-01-31T02:33:35.578" v="260"/>
            <ac:spMkLst>
              <pc:docMk/>
              <pc:sldMasterMk cId="3504811012" sldId="2147483648"/>
              <pc:sldLayoutMk cId="1657517792" sldId="2147483656"/>
              <ac:spMk id="4" creationId="{C366065C-6F69-B0A7-4D24-D2D1B61EF1F7}"/>
            </ac:spMkLst>
          </pc:spChg>
        </pc:sldLayoutChg>
        <pc:sldLayoutChg chg="modSp">
          <pc:chgData name="Mendoza Valderrey, Alberto" userId="3ca0a5ef-cfc6-4d76-a1eb-aa1d46514f4a" providerId="ADAL" clId="{90C7CDD4-EB8E-43B6-B821-996BE93A380A}" dt="2024-01-31T02:33:35.578" v="260"/>
          <pc:sldLayoutMkLst>
            <pc:docMk/>
            <pc:sldMasterMk cId="3504811012" sldId="2147483648"/>
            <pc:sldLayoutMk cId="2368845667" sldId="2147483657"/>
          </pc:sldLayoutMkLst>
          <pc:spChg chg="mod">
            <ac:chgData name="Mendoza Valderrey, Alberto" userId="3ca0a5ef-cfc6-4d76-a1eb-aa1d46514f4a" providerId="ADAL" clId="{90C7CDD4-EB8E-43B6-B821-996BE93A380A}" dt="2024-01-31T02:33:35.578" v="260"/>
            <ac:spMkLst>
              <pc:docMk/>
              <pc:sldMasterMk cId="3504811012" sldId="2147483648"/>
              <pc:sldLayoutMk cId="2368845667" sldId="2147483657"/>
              <ac:spMk id="2" creationId="{35FD3452-20B7-4591-D9D2-BC9690B63878}"/>
            </ac:spMkLst>
          </pc:spChg>
          <pc:spChg chg="mod">
            <ac:chgData name="Mendoza Valderrey, Alberto" userId="3ca0a5ef-cfc6-4d76-a1eb-aa1d46514f4a" providerId="ADAL" clId="{90C7CDD4-EB8E-43B6-B821-996BE93A380A}" dt="2024-01-31T02:33:35.578" v="260"/>
            <ac:spMkLst>
              <pc:docMk/>
              <pc:sldMasterMk cId="3504811012" sldId="2147483648"/>
              <pc:sldLayoutMk cId="2368845667" sldId="2147483657"/>
              <ac:spMk id="3" creationId="{80A75752-7A5E-C630-881D-6CF108AB61D9}"/>
            </ac:spMkLst>
          </pc:spChg>
          <pc:spChg chg="mod">
            <ac:chgData name="Mendoza Valderrey, Alberto" userId="3ca0a5ef-cfc6-4d76-a1eb-aa1d46514f4a" providerId="ADAL" clId="{90C7CDD4-EB8E-43B6-B821-996BE93A380A}" dt="2024-01-31T02:33:35.578" v="260"/>
            <ac:spMkLst>
              <pc:docMk/>
              <pc:sldMasterMk cId="3504811012" sldId="2147483648"/>
              <pc:sldLayoutMk cId="2368845667" sldId="2147483657"/>
              <ac:spMk id="4" creationId="{0AB391EE-6B54-E69E-408C-153AAAAD3E1A}"/>
            </ac:spMkLst>
          </pc:spChg>
        </pc:sldLayoutChg>
        <pc:sldLayoutChg chg="modSp">
          <pc:chgData name="Mendoza Valderrey, Alberto" userId="3ca0a5ef-cfc6-4d76-a1eb-aa1d46514f4a" providerId="ADAL" clId="{90C7CDD4-EB8E-43B6-B821-996BE93A380A}" dt="2024-01-31T02:33:35.578" v="260"/>
          <pc:sldLayoutMkLst>
            <pc:docMk/>
            <pc:sldMasterMk cId="3504811012" sldId="2147483648"/>
            <pc:sldLayoutMk cId="3772591658" sldId="2147483659"/>
          </pc:sldLayoutMkLst>
          <pc:spChg chg="mod">
            <ac:chgData name="Mendoza Valderrey, Alberto" userId="3ca0a5ef-cfc6-4d76-a1eb-aa1d46514f4a" providerId="ADAL" clId="{90C7CDD4-EB8E-43B6-B821-996BE93A380A}" dt="2024-01-31T02:33:35.578" v="260"/>
            <ac:spMkLst>
              <pc:docMk/>
              <pc:sldMasterMk cId="3504811012" sldId="2147483648"/>
              <pc:sldLayoutMk cId="3772591658" sldId="2147483659"/>
              <ac:spMk id="2" creationId="{97540A18-0EF5-468D-567C-60FF66A589C4}"/>
            </ac:spMkLst>
          </pc:spChg>
          <pc:spChg chg="mod">
            <ac:chgData name="Mendoza Valderrey, Alberto" userId="3ca0a5ef-cfc6-4d76-a1eb-aa1d46514f4a" providerId="ADAL" clId="{90C7CDD4-EB8E-43B6-B821-996BE93A380A}" dt="2024-01-31T02:33:35.578" v="260"/>
            <ac:spMkLst>
              <pc:docMk/>
              <pc:sldMasterMk cId="3504811012" sldId="2147483648"/>
              <pc:sldLayoutMk cId="3772591658" sldId="2147483659"/>
              <ac:spMk id="3" creationId="{A8CE0963-83EC-2817-9EBC-F6DFE95B6C31}"/>
            </ac:spMkLst>
          </pc:spChg>
        </pc:sldLayoutChg>
      </pc:sldMaster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256943"/>
            <a:ext cx="9144000" cy="2673891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033949"/>
            <a:ext cx="9144000" cy="1854300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7FDAEF-DCCC-448B-AB9A-B04044F1D5EE}" type="datetimeFigureOut">
              <a:rPr lang="en-US" smtClean="0"/>
              <a:t>2/2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F2BCB-7755-44BC-901F-BB2AB35A2B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73497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7FDAEF-DCCC-448B-AB9A-B04044F1D5EE}" type="datetimeFigureOut">
              <a:rPr lang="en-US" smtClean="0"/>
              <a:t>2/2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F2BCB-7755-44BC-901F-BB2AB35A2B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35141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408906"/>
            <a:ext cx="2628900" cy="650872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408906"/>
            <a:ext cx="7734300" cy="650872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7FDAEF-DCCC-448B-AB9A-B04044F1D5EE}" type="datetimeFigureOut">
              <a:rPr lang="en-US" smtClean="0"/>
              <a:t>2/2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F2BCB-7755-44BC-901F-BB2AB35A2B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48304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7FDAEF-DCCC-448B-AB9A-B04044F1D5EE}" type="datetimeFigureOut">
              <a:rPr lang="en-US" smtClean="0"/>
              <a:t>2/2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F2BCB-7755-44BC-901F-BB2AB35A2B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44604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914749"/>
            <a:ext cx="10515600" cy="3194801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5139774"/>
            <a:ext cx="10515600" cy="1680071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7FDAEF-DCCC-448B-AB9A-B04044F1D5EE}" type="datetimeFigureOut">
              <a:rPr lang="en-US" smtClean="0"/>
              <a:t>2/2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F2BCB-7755-44BC-901F-BB2AB35A2B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39359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044531"/>
            <a:ext cx="5181600" cy="487309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044531"/>
            <a:ext cx="5181600" cy="487309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7FDAEF-DCCC-448B-AB9A-B04044F1D5EE}" type="datetimeFigureOut">
              <a:rPr lang="en-US" smtClean="0"/>
              <a:t>2/2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F2BCB-7755-44BC-901F-BB2AB35A2B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49383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08907"/>
            <a:ext cx="10515600" cy="148450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882747"/>
            <a:ext cx="5157787" cy="92270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805452"/>
            <a:ext cx="5157787" cy="412639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882747"/>
            <a:ext cx="5183188" cy="92270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805452"/>
            <a:ext cx="5183188" cy="412639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7FDAEF-DCCC-448B-AB9A-B04044F1D5EE}" type="datetimeFigureOut">
              <a:rPr lang="en-US" smtClean="0"/>
              <a:t>2/29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F2BCB-7755-44BC-901F-BB2AB35A2B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17753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7FDAEF-DCCC-448B-AB9A-B04044F1D5EE}" type="datetimeFigureOut">
              <a:rPr lang="en-US" smtClean="0"/>
              <a:t>2/29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F2BCB-7755-44BC-901F-BB2AB35A2B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21674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7FDAEF-DCCC-448B-AB9A-B04044F1D5EE}" type="datetimeFigureOut">
              <a:rPr lang="en-US" smtClean="0"/>
              <a:t>2/29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F2BCB-7755-44BC-901F-BB2AB35A2B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10035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512022"/>
            <a:ext cx="3932237" cy="1792076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105825"/>
            <a:ext cx="6172200" cy="5458009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304097"/>
            <a:ext cx="3932237" cy="4268626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7FDAEF-DCCC-448B-AB9A-B04044F1D5EE}" type="datetimeFigureOut">
              <a:rPr lang="en-US" smtClean="0"/>
              <a:t>2/2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F2BCB-7755-44BC-901F-BB2AB35A2B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59748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512022"/>
            <a:ext cx="3932237" cy="1792076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105825"/>
            <a:ext cx="6172200" cy="5458009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304097"/>
            <a:ext cx="3932237" cy="4268626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7FDAEF-DCCC-448B-AB9A-B04044F1D5EE}" type="datetimeFigureOut">
              <a:rPr lang="en-US" smtClean="0"/>
              <a:t>2/2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F2BCB-7755-44BC-901F-BB2AB35A2B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08492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08907"/>
            <a:ext cx="10515600" cy="148450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044531"/>
            <a:ext cx="10515600" cy="487309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7118524"/>
            <a:ext cx="2743200" cy="4089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7FDAEF-DCCC-448B-AB9A-B04044F1D5EE}" type="datetimeFigureOut">
              <a:rPr lang="en-US" smtClean="0"/>
              <a:t>2/2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7118524"/>
            <a:ext cx="4114800" cy="4089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7118524"/>
            <a:ext cx="2743200" cy="4089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6F2BCB-7755-44BC-901F-BB2AB35A2B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57612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emf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emf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emf"/><Relationship Id="rId14" Type="http://schemas.openxmlformats.org/officeDocument/2006/relationships/image" Target="../media/image1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>
            <a:extLst>
              <a:ext uri="{FF2B5EF4-FFF2-40B4-BE49-F238E27FC236}">
                <a16:creationId xmlns:a16="http://schemas.microsoft.com/office/drawing/2014/main" id="{7E8CE701-9CCA-A1B9-7B6C-6A8347615013}"/>
              </a:ext>
            </a:extLst>
          </p:cNvPr>
          <p:cNvGrpSpPr/>
          <p:nvPr/>
        </p:nvGrpSpPr>
        <p:grpSpPr>
          <a:xfrm>
            <a:off x="20761" y="58277"/>
            <a:ext cx="12140280" cy="7623736"/>
            <a:chOff x="20761" y="58277"/>
            <a:chExt cx="12140280" cy="7623736"/>
          </a:xfrm>
        </p:grpSpPr>
        <p:pic>
          <p:nvPicPr>
            <p:cNvPr id="65" name="Picture 64">
              <a:extLst>
                <a:ext uri="{FF2B5EF4-FFF2-40B4-BE49-F238E27FC236}">
                  <a16:creationId xmlns:a16="http://schemas.microsoft.com/office/drawing/2014/main" id="{2932540B-61E4-308B-AB02-DD772851555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4627" t="8631" r="75005" b="20188"/>
            <a:stretch/>
          </p:blipFill>
          <p:spPr>
            <a:xfrm>
              <a:off x="4072307" y="3575245"/>
              <a:ext cx="3407943" cy="3721608"/>
            </a:xfrm>
            <a:prstGeom prst="rect">
              <a:avLst/>
            </a:prstGeom>
            <a:ln>
              <a:noFill/>
            </a:ln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0FBE4CC9-90A4-484B-8F85-36578C3064C4}"/>
                </a:ext>
              </a:extLst>
            </p:cNvPr>
            <p:cNvSpPr txBox="1"/>
            <p:nvPr/>
          </p:nvSpPr>
          <p:spPr>
            <a:xfrm rot="16200000">
              <a:off x="1910285" y="5325401"/>
              <a:ext cx="3779257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-log10 pValue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41289B7C-7341-0F86-9218-E1A05BEBB806}"/>
                </a:ext>
              </a:extLst>
            </p:cNvPr>
            <p:cNvSpPr txBox="1"/>
            <p:nvPr/>
          </p:nvSpPr>
          <p:spPr>
            <a:xfrm>
              <a:off x="3877147" y="4049759"/>
              <a:ext cx="314097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3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F08DF57D-3F56-43C7-1914-A39950F57411}"/>
                </a:ext>
              </a:extLst>
            </p:cNvPr>
            <p:cNvSpPr txBox="1"/>
            <p:nvPr/>
          </p:nvSpPr>
          <p:spPr>
            <a:xfrm>
              <a:off x="3823557" y="4522399"/>
              <a:ext cx="314098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00" b="1"/>
                <a:t>2.5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D9012D7B-C556-E7FA-3F2A-9F762252F2F6}"/>
                </a:ext>
              </a:extLst>
            </p:cNvPr>
            <p:cNvSpPr txBox="1"/>
            <p:nvPr/>
          </p:nvSpPr>
          <p:spPr>
            <a:xfrm>
              <a:off x="3882078" y="5003586"/>
              <a:ext cx="312993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00" b="1"/>
                <a:t>2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EF44F2C8-EC5D-5C9B-DC81-968017FA02FF}"/>
                </a:ext>
              </a:extLst>
            </p:cNvPr>
            <p:cNvSpPr txBox="1"/>
            <p:nvPr/>
          </p:nvSpPr>
          <p:spPr>
            <a:xfrm>
              <a:off x="3819807" y="5496978"/>
              <a:ext cx="314098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1.5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64F304E3-2385-E935-B1EE-26000C6E35E6}"/>
                </a:ext>
              </a:extLst>
            </p:cNvPr>
            <p:cNvSpPr txBox="1"/>
            <p:nvPr/>
          </p:nvSpPr>
          <p:spPr>
            <a:xfrm>
              <a:off x="3876302" y="5984272"/>
              <a:ext cx="314098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00" b="1"/>
                <a:t>1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FCB98A75-AC0C-0DCF-437C-002E39DDFD1A}"/>
                </a:ext>
              </a:extLst>
            </p:cNvPr>
            <p:cNvSpPr txBox="1"/>
            <p:nvPr/>
          </p:nvSpPr>
          <p:spPr>
            <a:xfrm>
              <a:off x="3789008" y="6481783"/>
              <a:ext cx="314098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0.5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BC0F559F-92BF-4990-A305-262599892711}"/>
                </a:ext>
              </a:extLst>
            </p:cNvPr>
            <p:cNvSpPr txBox="1"/>
            <p:nvPr/>
          </p:nvSpPr>
          <p:spPr>
            <a:xfrm>
              <a:off x="3871038" y="6963888"/>
              <a:ext cx="314098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0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921DA190-8A48-0EA6-1B09-EB38DAC677B6}"/>
                </a:ext>
              </a:extLst>
            </p:cNvPr>
            <p:cNvSpPr txBox="1"/>
            <p:nvPr/>
          </p:nvSpPr>
          <p:spPr>
            <a:xfrm>
              <a:off x="4072307" y="7261576"/>
              <a:ext cx="34511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              -1                                              0                                              1        </a:t>
              </a:r>
            </a:p>
            <a:p>
              <a:pPr algn="ctr"/>
              <a:r>
                <a:rPr lang="en-US" sz="800" b="1" dirty="0"/>
                <a:t>Log2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7B22DAEF-5FC0-1E47-2FAA-1C72019DCC2B}"/>
                </a:ext>
              </a:extLst>
            </p:cNvPr>
            <p:cNvSpPr txBox="1"/>
            <p:nvPr/>
          </p:nvSpPr>
          <p:spPr>
            <a:xfrm>
              <a:off x="3465561" y="7343459"/>
              <a:ext cx="127333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PM</a:t>
              </a:r>
            </a:p>
            <a:p>
              <a:pPr algn="ctr"/>
              <a:r>
                <a:rPr lang="en-US" sz="800" dirty="0"/>
                <a:t>2 FFPE (n=8 AOIs)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666BA23A-6894-984E-E28B-CCF458F9D79E}"/>
                </a:ext>
              </a:extLst>
            </p:cNvPr>
            <p:cNvSpPr txBox="1"/>
            <p:nvPr/>
          </p:nvSpPr>
          <p:spPr>
            <a:xfrm>
              <a:off x="6728435" y="7341771"/>
              <a:ext cx="95469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MBM </a:t>
              </a:r>
            </a:p>
            <a:p>
              <a:pPr algn="ctr"/>
              <a:r>
                <a:rPr lang="en-US" sz="800" dirty="0"/>
                <a:t>2 FFPE (n=8 AOIs)</a:t>
              </a:r>
            </a:p>
          </p:txBody>
        </p:sp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88E0EC0F-218F-8904-CC12-07FD850BB729}"/>
                </a:ext>
              </a:extLst>
            </p:cNvPr>
            <p:cNvGrpSpPr/>
            <p:nvPr/>
          </p:nvGrpSpPr>
          <p:grpSpPr>
            <a:xfrm>
              <a:off x="3516507" y="3528663"/>
              <a:ext cx="1515390" cy="475589"/>
              <a:chOff x="6302278" y="3493827"/>
              <a:chExt cx="1515390" cy="475589"/>
            </a:xfrm>
          </p:grpSpPr>
          <p:sp>
            <p:nvSpPr>
              <p:cNvPr id="19" name="Rectangle 18">
                <a:extLst>
                  <a:ext uri="{FF2B5EF4-FFF2-40B4-BE49-F238E27FC236}">
                    <a16:creationId xmlns:a16="http://schemas.microsoft.com/office/drawing/2014/main" id="{A8DD46B5-E832-B9B6-FE81-0C1CB883D667}"/>
                  </a:ext>
                </a:extLst>
              </p:cNvPr>
              <p:cNvSpPr/>
              <p:nvPr/>
            </p:nvSpPr>
            <p:spPr>
              <a:xfrm>
                <a:off x="6302278" y="3493827"/>
                <a:ext cx="1486223" cy="475589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tx1">
                    <a:lumMod val="50000"/>
                    <a:lumOff val="50000"/>
                  </a:schemeClr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E3820ECB-BDB4-E25E-4D27-B77F347ACD2D}"/>
                  </a:ext>
                </a:extLst>
              </p:cNvPr>
              <p:cNvSpPr txBox="1"/>
              <p:nvPr/>
            </p:nvSpPr>
            <p:spPr>
              <a:xfrm>
                <a:off x="6601154" y="3493827"/>
                <a:ext cx="1212751" cy="20005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/>
                  <a:t>All proteins</a:t>
                </a:r>
              </a:p>
            </p:txBody>
          </p:sp>
          <p:cxnSp>
            <p:nvCxnSpPr>
              <p:cNvPr id="21" name="Straight Connector 20">
                <a:extLst>
                  <a:ext uri="{FF2B5EF4-FFF2-40B4-BE49-F238E27FC236}">
                    <a16:creationId xmlns:a16="http://schemas.microsoft.com/office/drawing/2014/main" id="{6CE4AF3B-B303-8AAF-3374-777B587EA70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365483" y="3722410"/>
                <a:ext cx="532614" cy="0"/>
              </a:xfrm>
              <a:prstGeom prst="line">
                <a:avLst/>
              </a:prstGeom>
              <a:ln w="22225">
                <a:solidFill>
                  <a:srgbClr val="FF0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Straight Connector 21">
                <a:extLst>
                  <a:ext uri="{FF2B5EF4-FFF2-40B4-BE49-F238E27FC236}">
                    <a16:creationId xmlns:a16="http://schemas.microsoft.com/office/drawing/2014/main" id="{D1773648-6332-C6CA-A08B-8324AA741A0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360655" y="3889685"/>
                <a:ext cx="532614" cy="0"/>
              </a:xfrm>
              <a:prstGeom prst="line">
                <a:avLst/>
              </a:prstGeom>
              <a:ln w="22225">
                <a:solidFill>
                  <a:srgbClr val="00B05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" name="Oval 22">
                <a:extLst>
                  <a:ext uri="{FF2B5EF4-FFF2-40B4-BE49-F238E27FC236}">
                    <a16:creationId xmlns:a16="http://schemas.microsoft.com/office/drawing/2014/main" id="{72337C93-435B-0A57-DD33-D7711B8B4A67}"/>
                  </a:ext>
                </a:extLst>
              </p:cNvPr>
              <p:cNvSpPr/>
              <p:nvPr/>
            </p:nvSpPr>
            <p:spPr>
              <a:xfrm>
                <a:off x="6551256" y="3530104"/>
                <a:ext cx="133350" cy="123702"/>
              </a:xfrm>
              <a:prstGeom prst="ellipse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EE4968CB-7B86-5E20-3C79-7FBF8350B0A4}"/>
                  </a:ext>
                </a:extLst>
              </p:cNvPr>
              <p:cNvSpPr txBox="1"/>
              <p:nvPr/>
            </p:nvSpPr>
            <p:spPr>
              <a:xfrm>
                <a:off x="6594804" y="3631540"/>
                <a:ext cx="1222864" cy="20005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700" dirty="0"/>
                  <a:t>Significance threshold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1E9770B2-7A90-A61E-C1BA-8BF219223DFD}"/>
                  </a:ext>
                </a:extLst>
              </p:cNvPr>
              <p:cNvSpPr txBox="1"/>
              <p:nvPr/>
            </p:nvSpPr>
            <p:spPr>
              <a:xfrm>
                <a:off x="6569401" y="3763498"/>
                <a:ext cx="1216514" cy="20005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i="1" dirty="0"/>
                  <a:t>P </a:t>
                </a:r>
                <a:r>
                  <a:rPr lang="en-US" sz="700" dirty="0"/>
                  <a:t>value</a:t>
                </a:r>
              </a:p>
            </p:txBody>
          </p:sp>
        </p:grpSp>
        <p:cxnSp>
          <p:nvCxnSpPr>
            <p:cNvPr id="26" name="Straight Connector 25">
              <a:extLst>
                <a:ext uri="{FF2B5EF4-FFF2-40B4-BE49-F238E27FC236}">
                  <a16:creationId xmlns:a16="http://schemas.microsoft.com/office/drawing/2014/main" id="{95873F42-4E25-7A83-C125-8A5EF77A72AE}"/>
                </a:ext>
              </a:extLst>
            </p:cNvPr>
            <p:cNvCxnSpPr>
              <a:cxnSpLocks/>
            </p:cNvCxnSpPr>
            <p:nvPr/>
          </p:nvCxnSpPr>
          <p:spPr>
            <a:xfrm>
              <a:off x="6252085" y="3717412"/>
              <a:ext cx="0" cy="3605340"/>
            </a:xfrm>
            <a:prstGeom prst="line">
              <a:avLst/>
            </a:prstGeom>
            <a:ln w="22225">
              <a:solidFill>
                <a:srgbClr val="FF000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id="{92D23368-02BB-A378-55DA-6E968C327B41}"/>
                </a:ext>
              </a:extLst>
            </p:cNvPr>
            <p:cNvCxnSpPr>
              <a:cxnSpLocks/>
            </p:cNvCxnSpPr>
            <p:nvPr/>
          </p:nvCxnSpPr>
          <p:spPr>
            <a:xfrm>
              <a:off x="4970973" y="3759712"/>
              <a:ext cx="0" cy="3605340"/>
            </a:xfrm>
            <a:prstGeom prst="line">
              <a:avLst/>
            </a:prstGeom>
            <a:ln w="22225">
              <a:solidFill>
                <a:srgbClr val="FF000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Connector 27">
              <a:extLst>
                <a:ext uri="{FF2B5EF4-FFF2-40B4-BE49-F238E27FC236}">
                  <a16:creationId xmlns:a16="http://schemas.microsoft.com/office/drawing/2014/main" id="{F12C9A7A-A596-EA51-F361-3FA13D37B81E}"/>
                </a:ext>
              </a:extLst>
            </p:cNvPr>
            <p:cNvCxnSpPr>
              <a:cxnSpLocks/>
            </p:cNvCxnSpPr>
            <p:nvPr/>
          </p:nvCxnSpPr>
          <p:spPr>
            <a:xfrm>
              <a:off x="4020027" y="5807280"/>
              <a:ext cx="3451160" cy="0"/>
            </a:xfrm>
            <a:prstGeom prst="line">
              <a:avLst/>
            </a:prstGeom>
            <a:ln w="22225">
              <a:solidFill>
                <a:srgbClr val="00B05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Oval 28">
              <a:extLst>
                <a:ext uri="{FF2B5EF4-FFF2-40B4-BE49-F238E27FC236}">
                  <a16:creationId xmlns:a16="http://schemas.microsoft.com/office/drawing/2014/main" id="{58E0E189-2CDD-CDAC-C47C-3735F79BD226}"/>
                </a:ext>
              </a:extLst>
            </p:cNvPr>
            <p:cNvSpPr/>
            <p:nvPr/>
          </p:nvSpPr>
          <p:spPr>
            <a:xfrm>
              <a:off x="6493352" y="5730587"/>
              <a:ext cx="72794" cy="69887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" name="Oval 29">
              <a:extLst>
                <a:ext uri="{FF2B5EF4-FFF2-40B4-BE49-F238E27FC236}">
                  <a16:creationId xmlns:a16="http://schemas.microsoft.com/office/drawing/2014/main" id="{4F8B98CE-1212-58E5-19E2-6973BC760023}"/>
                </a:ext>
              </a:extLst>
            </p:cNvPr>
            <p:cNvSpPr/>
            <p:nvPr/>
          </p:nvSpPr>
          <p:spPr>
            <a:xfrm>
              <a:off x="6760160" y="5267713"/>
              <a:ext cx="72794" cy="69887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" name="Oval 30">
              <a:extLst>
                <a:ext uri="{FF2B5EF4-FFF2-40B4-BE49-F238E27FC236}">
                  <a16:creationId xmlns:a16="http://schemas.microsoft.com/office/drawing/2014/main" id="{7F42CBB3-E109-09F7-5619-85BDFA5DB418}"/>
                </a:ext>
              </a:extLst>
            </p:cNvPr>
            <p:cNvSpPr/>
            <p:nvPr/>
          </p:nvSpPr>
          <p:spPr>
            <a:xfrm>
              <a:off x="6820475" y="3933720"/>
              <a:ext cx="72794" cy="69887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" name="Oval 31">
              <a:extLst>
                <a:ext uri="{FF2B5EF4-FFF2-40B4-BE49-F238E27FC236}">
                  <a16:creationId xmlns:a16="http://schemas.microsoft.com/office/drawing/2014/main" id="{A87E56A3-8AF1-8D0C-352C-8022D662AAA8}"/>
                </a:ext>
              </a:extLst>
            </p:cNvPr>
            <p:cNvSpPr/>
            <p:nvPr/>
          </p:nvSpPr>
          <p:spPr>
            <a:xfrm>
              <a:off x="4795131" y="4258019"/>
              <a:ext cx="72794" cy="69887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" name="Oval 32">
              <a:extLst>
                <a:ext uri="{FF2B5EF4-FFF2-40B4-BE49-F238E27FC236}">
                  <a16:creationId xmlns:a16="http://schemas.microsoft.com/office/drawing/2014/main" id="{41E20FDD-567A-8987-F0F7-3CC43DD369B3}"/>
                </a:ext>
              </a:extLst>
            </p:cNvPr>
            <p:cNvSpPr/>
            <p:nvPr/>
          </p:nvSpPr>
          <p:spPr>
            <a:xfrm>
              <a:off x="4855245" y="4346036"/>
              <a:ext cx="72794" cy="69887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4" name="Oval 33">
              <a:extLst>
                <a:ext uri="{FF2B5EF4-FFF2-40B4-BE49-F238E27FC236}">
                  <a16:creationId xmlns:a16="http://schemas.microsoft.com/office/drawing/2014/main" id="{EC81C159-57A7-CEA2-FBD9-E6D464790574}"/>
                </a:ext>
              </a:extLst>
            </p:cNvPr>
            <p:cNvSpPr/>
            <p:nvPr/>
          </p:nvSpPr>
          <p:spPr>
            <a:xfrm>
              <a:off x="4799343" y="5287185"/>
              <a:ext cx="72794" cy="69887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5" name="Oval 34">
              <a:extLst>
                <a:ext uri="{FF2B5EF4-FFF2-40B4-BE49-F238E27FC236}">
                  <a16:creationId xmlns:a16="http://schemas.microsoft.com/office/drawing/2014/main" id="{5B6D9E33-8D2E-084A-EDF8-29C451355F92}"/>
                </a:ext>
              </a:extLst>
            </p:cNvPr>
            <p:cNvSpPr/>
            <p:nvPr/>
          </p:nvSpPr>
          <p:spPr>
            <a:xfrm>
              <a:off x="4138136" y="5730036"/>
              <a:ext cx="72794" cy="69887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6" name="Oval 35">
              <a:extLst>
                <a:ext uri="{FF2B5EF4-FFF2-40B4-BE49-F238E27FC236}">
                  <a16:creationId xmlns:a16="http://schemas.microsoft.com/office/drawing/2014/main" id="{4A005218-20A8-DD20-B46E-416E7B66FF7E}"/>
                </a:ext>
              </a:extLst>
            </p:cNvPr>
            <p:cNvSpPr/>
            <p:nvPr/>
          </p:nvSpPr>
          <p:spPr>
            <a:xfrm>
              <a:off x="4984325" y="5337600"/>
              <a:ext cx="72794" cy="69887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7" name="Oval 36">
              <a:extLst>
                <a:ext uri="{FF2B5EF4-FFF2-40B4-BE49-F238E27FC236}">
                  <a16:creationId xmlns:a16="http://schemas.microsoft.com/office/drawing/2014/main" id="{6E9F5212-FE85-87E3-EE5A-11615DC0BF77}"/>
                </a:ext>
              </a:extLst>
            </p:cNvPr>
            <p:cNvSpPr/>
            <p:nvPr/>
          </p:nvSpPr>
          <p:spPr>
            <a:xfrm>
              <a:off x="5067697" y="5649160"/>
              <a:ext cx="72794" cy="69887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" name="Oval 37">
              <a:extLst>
                <a:ext uri="{FF2B5EF4-FFF2-40B4-BE49-F238E27FC236}">
                  <a16:creationId xmlns:a16="http://schemas.microsoft.com/office/drawing/2014/main" id="{374117D6-9AC3-DDEB-DBBE-83CC2EF80982}"/>
                </a:ext>
              </a:extLst>
            </p:cNvPr>
            <p:cNvSpPr/>
            <p:nvPr/>
          </p:nvSpPr>
          <p:spPr>
            <a:xfrm>
              <a:off x="5179662" y="5720340"/>
              <a:ext cx="72794" cy="69887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9" name="Oval 38">
              <a:extLst>
                <a:ext uri="{FF2B5EF4-FFF2-40B4-BE49-F238E27FC236}">
                  <a16:creationId xmlns:a16="http://schemas.microsoft.com/office/drawing/2014/main" id="{C9DA7B69-3FF9-5F83-8044-52F0B56BEED2}"/>
                </a:ext>
              </a:extLst>
            </p:cNvPr>
            <p:cNvSpPr/>
            <p:nvPr/>
          </p:nvSpPr>
          <p:spPr>
            <a:xfrm>
              <a:off x="4962457" y="5736330"/>
              <a:ext cx="72794" cy="69887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" name="Oval 39">
              <a:extLst>
                <a:ext uri="{FF2B5EF4-FFF2-40B4-BE49-F238E27FC236}">
                  <a16:creationId xmlns:a16="http://schemas.microsoft.com/office/drawing/2014/main" id="{A18B02C8-6CC3-A38F-DC93-005F4C301304}"/>
                </a:ext>
              </a:extLst>
            </p:cNvPr>
            <p:cNvSpPr/>
            <p:nvPr/>
          </p:nvSpPr>
          <p:spPr>
            <a:xfrm>
              <a:off x="4738895" y="5602423"/>
              <a:ext cx="72794" cy="69887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1" name="Oval 40">
              <a:extLst>
                <a:ext uri="{FF2B5EF4-FFF2-40B4-BE49-F238E27FC236}">
                  <a16:creationId xmlns:a16="http://schemas.microsoft.com/office/drawing/2014/main" id="{101ECA0E-C2E1-DD11-4399-50E95F383839}"/>
                </a:ext>
              </a:extLst>
            </p:cNvPr>
            <p:cNvSpPr/>
            <p:nvPr/>
          </p:nvSpPr>
          <p:spPr>
            <a:xfrm>
              <a:off x="4676559" y="5598765"/>
              <a:ext cx="72794" cy="69887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2" name="Oval 41">
              <a:extLst>
                <a:ext uri="{FF2B5EF4-FFF2-40B4-BE49-F238E27FC236}">
                  <a16:creationId xmlns:a16="http://schemas.microsoft.com/office/drawing/2014/main" id="{8905FE37-BA10-0192-5B36-F34A49566E67}"/>
                </a:ext>
              </a:extLst>
            </p:cNvPr>
            <p:cNvSpPr/>
            <p:nvPr/>
          </p:nvSpPr>
          <p:spPr>
            <a:xfrm>
              <a:off x="4499308" y="5614216"/>
              <a:ext cx="72794" cy="69887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3" name="Oval 42">
              <a:extLst>
                <a:ext uri="{FF2B5EF4-FFF2-40B4-BE49-F238E27FC236}">
                  <a16:creationId xmlns:a16="http://schemas.microsoft.com/office/drawing/2014/main" id="{F9C4139E-EF17-DFBA-DF35-4052F4A4604C}"/>
                </a:ext>
              </a:extLst>
            </p:cNvPr>
            <p:cNvSpPr/>
            <p:nvPr/>
          </p:nvSpPr>
          <p:spPr>
            <a:xfrm>
              <a:off x="4560068" y="5685410"/>
              <a:ext cx="72794" cy="69887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119" name="Picture 118" descr="A picture containing text, screenshot, diagram, design&#10;&#10;Description automatically generated">
              <a:extLst>
                <a:ext uri="{FF2B5EF4-FFF2-40B4-BE49-F238E27FC236}">
                  <a16:creationId xmlns:a16="http://schemas.microsoft.com/office/drawing/2014/main" id="{37D544DA-3643-766A-9605-9B99AF71BEF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31" b="9822"/>
            <a:stretch/>
          </p:blipFill>
          <p:spPr>
            <a:xfrm>
              <a:off x="10233825" y="1891729"/>
              <a:ext cx="1657135" cy="164592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20" name="Picture 119" descr="A picture containing screenshot, colorfulness, graphics&#10;&#10;Description automatically generated">
              <a:extLst>
                <a:ext uri="{FF2B5EF4-FFF2-40B4-BE49-F238E27FC236}">
                  <a16:creationId xmlns:a16="http://schemas.microsoft.com/office/drawing/2014/main" id="{83AA463F-3F35-AE2F-52B5-BB2C7C25C8D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914" b="9033"/>
            <a:stretch/>
          </p:blipFill>
          <p:spPr>
            <a:xfrm>
              <a:off x="8426038" y="1871790"/>
              <a:ext cx="1613604" cy="164592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21" name="Picture 120" descr="A picture containing screenshot, text, colorfulness, graphics&#10;&#10;Description automatically generated">
              <a:extLst>
                <a:ext uri="{FF2B5EF4-FFF2-40B4-BE49-F238E27FC236}">
                  <a16:creationId xmlns:a16="http://schemas.microsoft.com/office/drawing/2014/main" id="{D7A006EA-278B-9910-09C5-533F0354294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517" b="9728"/>
            <a:stretch/>
          </p:blipFill>
          <p:spPr>
            <a:xfrm>
              <a:off x="10257992" y="237080"/>
              <a:ext cx="1632968" cy="164592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22" name="Picture 121" descr="A picture containing screenshot, colorfulness, text, graphics&#10;&#10;Description automatically generated">
              <a:extLst>
                <a:ext uri="{FF2B5EF4-FFF2-40B4-BE49-F238E27FC236}">
                  <a16:creationId xmlns:a16="http://schemas.microsoft.com/office/drawing/2014/main" id="{B918B14A-AE80-89BA-3DBF-D1231581266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03" r="-1" b="9414"/>
            <a:stretch/>
          </p:blipFill>
          <p:spPr>
            <a:xfrm>
              <a:off x="8442797" y="241596"/>
              <a:ext cx="1637990" cy="1645920"/>
            </a:xfrm>
            <a:prstGeom prst="rect">
              <a:avLst/>
            </a:prstGeom>
            <a:ln>
              <a:noFill/>
            </a:ln>
          </p:spPr>
        </p:pic>
        <p:cxnSp>
          <p:nvCxnSpPr>
            <p:cNvPr id="123" name="Straight Arrow Connector 122">
              <a:extLst>
                <a:ext uri="{FF2B5EF4-FFF2-40B4-BE49-F238E27FC236}">
                  <a16:creationId xmlns:a16="http://schemas.microsoft.com/office/drawing/2014/main" id="{65F7583F-4F88-8937-96A3-9B50660E743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231855" y="2859396"/>
              <a:ext cx="0" cy="509301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F1CAA8A6-F90A-02C9-228D-DCE0940F883A}"/>
                </a:ext>
              </a:extLst>
            </p:cNvPr>
            <p:cNvSpPr txBox="1"/>
            <p:nvPr/>
          </p:nvSpPr>
          <p:spPr>
            <a:xfrm rot="16200000">
              <a:off x="8020597" y="3423287"/>
              <a:ext cx="42334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CD56</a:t>
              </a:r>
            </a:p>
          </p:txBody>
        </p:sp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579E7823-EFEB-C846-7D7F-64CDF5C0E948}"/>
                </a:ext>
              </a:extLst>
            </p:cNvPr>
            <p:cNvSpPr txBox="1"/>
            <p:nvPr/>
          </p:nvSpPr>
          <p:spPr>
            <a:xfrm>
              <a:off x="8192334" y="3530042"/>
              <a:ext cx="39983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CD3</a:t>
              </a:r>
            </a:p>
          </p:txBody>
        </p:sp>
        <p:cxnSp>
          <p:nvCxnSpPr>
            <p:cNvPr id="126" name="Straight Arrow Connector 125">
              <a:extLst>
                <a:ext uri="{FF2B5EF4-FFF2-40B4-BE49-F238E27FC236}">
                  <a16:creationId xmlns:a16="http://schemas.microsoft.com/office/drawing/2014/main" id="{5FFF1D79-D7BE-1C04-1548-B1DEE322C48B}"/>
                </a:ext>
              </a:extLst>
            </p:cNvPr>
            <p:cNvCxnSpPr>
              <a:cxnSpLocks/>
            </p:cNvCxnSpPr>
            <p:nvPr/>
          </p:nvCxnSpPr>
          <p:spPr>
            <a:xfrm>
              <a:off x="8532293" y="3637807"/>
              <a:ext cx="432899" cy="3196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FAA7C87B-E436-BA70-EBA1-EAE9AADEC4FA}"/>
                </a:ext>
              </a:extLst>
            </p:cNvPr>
            <p:cNvSpPr txBox="1"/>
            <p:nvPr/>
          </p:nvSpPr>
          <p:spPr>
            <a:xfrm rot="16200000">
              <a:off x="7580856" y="2527742"/>
              <a:ext cx="1389095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MBM</a:t>
              </a:r>
            </a:p>
          </p:txBody>
        </p:sp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BB87AC05-738B-ADA4-7D19-1A228DB711B3}"/>
                </a:ext>
              </a:extLst>
            </p:cNvPr>
            <p:cNvSpPr txBox="1"/>
            <p:nvPr/>
          </p:nvSpPr>
          <p:spPr>
            <a:xfrm rot="16200000">
              <a:off x="7730741" y="946527"/>
              <a:ext cx="1024627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/>
                <a:t>PM</a:t>
              </a:r>
            </a:p>
          </p:txBody>
        </p:sp>
        <p:sp>
          <p:nvSpPr>
            <p:cNvPr id="134" name="Rectangle 133">
              <a:extLst>
                <a:ext uri="{FF2B5EF4-FFF2-40B4-BE49-F238E27FC236}">
                  <a16:creationId xmlns:a16="http://schemas.microsoft.com/office/drawing/2014/main" id="{29D15C39-C6B4-DC6E-0F7C-A48FF92BDDF3}"/>
                </a:ext>
              </a:extLst>
            </p:cNvPr>
            <p:cNvSpPr/>
            <p:nvPr/>
          </p:nvSpPr>
          <p:spPr>
            <a:xfrm>
              <a:off x="9337479" y="351138"/>
              <a:ext cx="235791" cy="8008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5" name="Rectangle 134">
              <a:extLst>
                <a:ext uri="{FF2B5EF4-FFF2-40B4-BE49-F238E27FC236}">
                  <a16:creationId xmlns:a16="http://schemas.microsoft.com/office/drawing/2014/main" id="{5F77DD3B-B53B-E829-14B5-7A35FF43AFED}"/>
                </a:ext>
              </a:extLst>
            </p:cNvPr>
            <p:cNvSpPr/>
            <p:nvPr/>
          </p:nvSpPr>
          <p:spPr>
            <a:xfrm>
              <a:off x="9684855" y="1563645"/>
              <a:ext cx="296632" cy="14067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81555EC4-881B-CDC7-BF88-08DDF2B1EA9B}"/>
                </a:ext>
              </a:extLst>
            </p:cNvPr>
            <p:cNvSpPr txBox="1"/>
            <p:nvPr/>
          </p:nvSpPr>
          <p:spPr>
            <a:xfrm>
              <a:off x="10180075" y="3521274"/>
              <a:ext cx="43289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CD16</a:t>
              </a:r>
            </a:p>
          </p:txBody>
        </p:sp>
        <p:sp>
          <p:nvSpPr>
            <p:cNvPr id="140" name="Rectangle 139">
              <a:extLst>
                <a:ext uri="{FF2B5EF4-FFF2-40B4-BE49-F238E27FC236}">
                  <a16:creationId xmlns:a16="http://schemas.microsoft.com/office/drawing/2014/main" id="{943AB37E-1F40-0DAC-FB48-25B50B322A4B}"/>
                </a:ext>
              </a:extLst>
            </p:cNvPr>
            <p:cNvSpPr/>
            <p:nvPr/>
          </p:nvSpPr>
          <p:spPr>
            <a:xfrm>
              <a:off x="11162933" y="4145634"/>
              <a:ext cx="240285" cy="8008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142" name="Picture 141">
              <a:extLst>
                <a:ext uri="{FF2B5EF4-FFF2-40B4-BE49-F238E27FC236}">
                  <a16:creationId xmlns:a16="http://schemas.microsoft.com/office/drawing/2014/main" id="{CCDDD27C-8083-9E72-21A9-5137CFD9EBA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17869" t="14872" r="14813" b="11972"/>
            <a:stretch/>
          </p:blipFill>
          <p:spPr>
            <a:xfrm>
              <a:off x="8406116" y="4500318"/>
              <a:ext cx="1554709" cy="1183785"/>
            </a:xfrm>
            <a:prstGeom prst="rect">
              <a:avLst/>
            </a:prstGeom>
            <a:ln>
              <a:noFill/>
            </a:ln>
          </p:spPr>
        </p:pic>
        <p:sp>
          <p:nvSpPr>
            <p:cNvPr id="143" name="TextBox 142">
              <a:extLst>
                <a:ext uri="{FF2B5EF4-FFF2-40B4-BE49-F238E27FC236}">
                  <a16:creationId xmlns:a16="http://schemas.microsoft.com/office/drawing/2014/main" id="{AED1AE38-2C99-0F42-E783-558067E81D7B}"/>
                </a:ext>
              </a:extLst>
            </p:cNvPr>
            <p:cNvSpPr txBox="1"/>
            <p:nvPr/>
          </p:nvSpPr>
          <p:spPr>
            <a:xfrm>
              <a:off x="8406116" y="4213077"/>
              <a:ext cx="166963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/>
                <a:t>CD3- CD56+</a:t>
              </a:r>
            </a:p>
          </p:txBody>
        </p:sp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id="{81EBFC37-D6F2-B4EB-E280-69E6308F50C6}"/>
                </a:ext>
              </a:extLst>
            </p:cNvPr>
            <p:cNvSpPr txBox="1"/>
            <p:nvPr/>
          </p:nvSpPr>
          <p:spPr>
            <a:xfrm>
              <a:off x="8208839" y="4462462"/>
              <a:ext cx="26692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lIns="0" rIns="0" rtlCol="0" anchor="ctr" anchorCtr="0">
              <a:spAutoFit/>
            </a:bodyPr>
            <a:lstStyle/>
            <a:p>
              <a:pPr algn="ctr"/>
              <a:r>
                <a:rPr lang="en-US" sz="800" b="1"/>
                <a:t>80</a:t>
              </a:r>
            </a:p>
          </p:txBody>
        </p:sp>
        <p:sp>
          <p:nvSpPr>
            <p:cNvPr id="145" name="TextBox 144">
              <a:extLst>
                <a:ext uri="{FF2B5EF4-FFF2-40B4-BE49-F238E27FC236}">
                  <a16:creationId xmlns:a16="http://schemas.microsoft.com/office/drawing/2014/main" id="{09436167-F828-9944-A9C6-4F2D248B9289}"/>
                </a:ext>
              </a:extLst>
            </p:cNvPr>
            <p:cNvSpPr txBox="1"/>
            <p:nvPr/>
          </p:nvSpPr>
          <p:spPr>
            <a:xfrm>
              <a:off x="8208731" y="4727098"/>
              <a:ext cx="26692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lIns="0" rIns="0" rtlCol="0" anchor="ctr" anchorCtr="0">
              <a:spAutoFit/>
            </a:bodyPr>
            <a:lstStyle/>
            <a:p>
              <a:pPr algn="ctr"/>
              <a:r>
                <a:rPr lang="en-US" sz="800" b="1"/>
                <a:t>60</a:t>
              </a:r>
            </a:p>
          </p:txBody>
        </p:sp>
        <p:sp>
          <p:nvSpPr>
            <p:cNvPr id="146" name="TextBox 145">
              <a:extLst>
                <a:ext uri="{FF2B5EF4-FFF2-40B4-BE49-F238E27FC236}">
                  <a16:creationId xmlns:a16="http://schemas.microsoft.com/office/drawing/2014/main" id="{EBC37FCE-A845-E6DE-CC55-0A2F035511A1}"/>
                </a:ext>
              </a:extLst>
            </p:cNvPr>
            <p:cNvSpPr txBox="1"/>
            <p:nvPr/>
          </p:nvSpPr>
          <p:spPr>
            <a:xfrm>
              <a:off x="8212854" y="4991734"/>
              <a:ext cx="26692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lIns="0" rIns="0" rtlCol="0" anchor="ctr" anchorCtr="0">
              <a:spAutoFit/>
            </a:bodyPr>
            <a:lstStyle/>
            <a:p>
              <a:pPr algn="ctr"/>
              <a:r>
                <a:rPr lang="en-US" sz="800" b="1"/>
                <a:t>40</a:t>
              </a:r>
            </a:p>
          </p:txBody>
        </p:sp>
        <p:sp>
          <p:nvSpPr>
            <p:cNvPr id="147" name="TextBox 146">
              <a:extLst>
                <a:ext uri="{FF2B5EF4-FFF2-40B4-BE49-F238E27FC236}">
                  <a16:creationId xmlns:a16="http://schemas.microsoft.com/office/drawing/2014/main" id="{8B51D47F-AA95-E01A-010D-B8ACC133EA5C}"/>
                </a:ext>
              </a:extLst>
            </p:cNvPr>
            <p:cNvSpPr txBox="1"/>
            <p:nvPr/>
          </p:nvSpPr>
          <p:spPr>
            <a:xfrm>
              <a:off x="8212848" y="5266094"/>
              <a:ext cx="26692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lIns="0" rIns="0" rtlCol="0" anchor="ctr" anchorCtr="0">
              <a:spAutoFit/>
            </a:bodyPr>
            <a:lstStyle/>
            <a:p>
              <a:pPr algn="ctr"/>
              <a:r>
                <a:rPr lang="en-US" sz="800" b="1"/>
                <a:t>20</a:t>
              </a:r>
            </a:p>
          </p:txBody>
        </p:sp>
        <p:sp>
          <p:nvSpPr>
            <p:cNvPr id="148" name="TextBox 147">
              <a:extLst>
                <a:ext uri="{FF2B5EF4-FFF2-40B4-BE49-F238E27FC236}">
                  <a16:creationId xmlns:a16="http://schemas.microsoft.com/office/drawing/2014/main" id="{BCF5EAAD-83DC-204B-E5E2-E773046CCC13}"/>
                </a:ext>
              </a:extLst>
            </p:cNvPr>
            <p:cNvSpPr txBox="1"/>
            <p:nvPr/>
          </p:nvSpPr>
          <p:spPr>
            <a:xfrm>
              <a:off x="8225080" y="5530730"/>
              <a:ext cx="26692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lIns="0" rIns="0" rtlCol="0" anchor="ctr" anchorCtr="0">
              <a:spAutoFit/>
            </a:bodyPr>
            <a:lstStyle/>
            <a:p>
              <a:pPr algn="ctr"/>
              <a:r>
                <a:rPr lang="en-US" sz="800" b="1"/>
                <a:t>0</a:t>
              </a:r>
            </a:p>
          </p:txBody>
        </p:sp>
        <p:sp>
          <p:nvSpPr>
            <p:cNvPr id="149" name="TextBox 148">
              <a:extLst>
                <a:ext uri="{FF2B5EF4-FFF2-40B4-BE49-F238E27FC236}">
                  <a16:creationId xmlns:a16="http://schemas.microsoft.com/office/drawing/2014/main" id="{B0ABB590-A937-9A2D-BE1F-39065F9540EC}"/>
                </a:ext>
              </a:extLst>
            </p:cNvPr>
            <p:cNvSpPr txBox="1"/>
            <p:nvPr/>
          </p:nvSpPr>
          <p:spPr>
            <a:xfrm>
              <a:off x="8406116" y="5684781"/>
              <a:ext cx="166963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/>
                <a:t>    PM (</a:t>
              </a:r>
              <a:r>
                <a:rPr lang="en-US" sz="800" i="1"/>
                <a:t>n</a:t>
              </a:r>
              <a:r>
                <a:rPr lang="en-US" sz="800"/>
                <a:t>=14)                MBM (</a:t>
              </a:r>
              <a:r>
                <a:rPr lang="en-US" sz="800" i="1"/>
                <a:t>n</a:t>
              </a:r>
              <a:r>
                <a:rPr lang="en-US" sz="800"/>
                <a:t>=6)</a:t>
              </a:r>
            </a:p>
          </p:txBody>
        </p:sp>
        <p:grpSp>
          <p:nvGrpSpPr>
            <p:cNvPr id="150" name="Group 149">
              <a:extLst>
                <a:ext uri="{FF2B5EF4-FFF2-40B4-BE49-F238E27FC236}">
                  <a16:creationId xmlns:a16="http://schemas.microsoft.com/office/drawing/2014/main" id="{B7BE33BD-1563-2872-6997-E7DF4E061C22}"/>
                </a:ext>
              </a:extLst>
            </p:cNvPr>
            <p:cNvGrpSpPr/>
            <p:nvPr/>
          </p:nvGrpSpPr>
          <p:grpSpPr>
            <a:xfrm>
              <a:off x="8887409" y="4468974"/>
              <a:ext cx="821565" cy="228660"/>
              <a:chOff x="873626" y="5798195"/>
              <a:chExt cx="838218" cy="228660"/>
            </a:xfrm>
          </p:grpSpPr>
          <p:cxnSp>
            <p:nvCxnSpPr>
              <p:cNvPr id="151" name="Straight Connector 150">
                <a:extLst>
                  <a:ext uri="{FF2B5EF4-FFF2-40B4-BE49-F238E27FC236}">
                    <a16:creationId xmlns:a16="http://schemas.microsoft.com/office/drawing/2014/main" id="{36F6EAD8-11BC-5A89-B10C-32A277024EA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74657" y="6000468"/>
                <a:ext cx="1359" cy="26387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2" name="Straight Connector 151">
                <a:extLst>
                  <a:ext uri="{FF2B5EF4-FFF2-40B4-BE49-F238E27FC236}">
                    <a16:creationId xmlns:a16="http://schemas.microsoft.com/office/drawing/2014/main" id="{5FE3E1DF-EF96-52A8-E22E-2A51E96BC2D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74570" y="6006340"/>
                <a:ext cx="83716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3" name="TextBox 152">
                <a:extLst>
                  <a:ext uri="{FF2B5EF4-FFF2-40B4-BE49-F238E27FC236}">
                    <a16:creationId xmlns:a16="http://schemas.microsoft.com/office/drawing/2014/main" id="{396E2242-A464-46E9-49FF-88B62DA18DF4}"/>
                  </a:ext>
                </a:extLst>
              </p:cNvPr>
              <p:cNvSpPr txBox="1"/>
              <p:nvPr/>
            </p:nvSpPr>
            <p:spPr>
              <a:xfrm>
                <a:off x="873626" y="5798195"/>
                <a:ext cx="83821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i="1" dirty="0"/>
                  <a:t>P </a:t>
                </a:r>
                <a:r>
                  <a:rPr lang="en-US" sz="800" b="1" dirty="0"/>
                  <a:t>= 0.0026</a:t>
                </a:r>
              </a:p>
            </p:txBody>
          </p:sp>
          <p:cxnSp>
            <p:nvCxnSpPr>
              <p:cNvPr id="154" name="Straight Connector 153">
                <a:extLst>
                  <a:ext uri="{FF2B5EF4-FFF2-40B4-BE49-F238E27FC236}">
                    <a16:creationId xmlns:a16="http://schemas.microsoft.com/office/drawing/2014/main" id="{29F5A45A-AB6E-2A31-DD5B-25DEFAB2E94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710485" y="6000468"/>
                <a:ext cx="1359" cy="26387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55" name="TextBox 154">
              <a:extLst>
                <a:ext uri="{FF2B5EF4-FFF2-40B4-BE49-F238E27FC236}">
                  <a16:creationId xmlns:a16="http://schemas.microsoft.com/office/drawing/2014/main" id="{2F566507-D5CC-C06A-DD10-19A4FD012632}"/>
                </a:ext>
              </a:extLst>
            </p:cNvPr>
            <p:cNvSpPr txBox="1"/>
            <p:nvPr/>
          </p:nvSpPr>
          <p:spPr>
            <a:xfrm rot="16200000">
              <a:off x="7491145" y="4977654"/>
              <a:ext cx="1313709" cy="33855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b="1"/>
              </a:lvl1pPr>
            </a:lstStyle>
            <a:p>
              <a:pPr algn="ctr"/>
              <a:r>
                <a:rPr lang="en-US" sz="800" b="0"/>
                <a:t>% of CD3-CD56+ cells </a:t>
              </a:r>
            </a:p>
            <a:p>
              <a:pPr algn="ctr"/>
              <a:r>
                <a:rPr lang="en-US" sz="800" b="0"/>
                <a:t>(gated on CD45+ cells)</a:t>
              </a:r>
            </a:p>
          </p:txBody>
        </p:sp>
        <p:cxnSp>
          <p:nvCxnSpPr>
            <p:cNvPr id="156" name="Straight Arrow Connector 155">
              <a:extLst>
                <a:ext uri="{FF2B5EF4-FFF2-40B4-BE49-F238E27FC236}">
                  <a16:creationId xmlns:a16="http://schemas.microsoft.com/office/drawing/2014/main" id="{07A659AA-B1B9-CFE6-9528-3EAE1B644DEE}"/>
                </a:ext>
              </a:extLst>
            </p:cNvPr>
            <p:cNvCxnSpPr>
              <a:cxnSpLocks/>
            </p:cNvCxnSpPr>
            <p:nvPr/>
          </p:nvCxnSpPr>
          <p:spPr>
            <a:xfrm>
              <a:off x="10551212" y="3633468"/>
              <a:ext cx="432899" cy="3196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7" name="Straight Arrow Connector 156">
              <a:extLst>
                <a:ext uri="{FF2B5EF4-FFF2-40B4-BE49-F238E27FC236}">
                  <a16:creationId xmlns:a16="http://schemas.microsoft.com/office/drawing/2014/main" id="{68E9BEA9-48A9-9720-13A1-FF1521033A5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186537" y="2858729"/>
              <a:ext cx="0" cy="509301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8" name="TextBox 157">
              <a:extLst>
                <a:ext uri="{FF2B5EF4-FFF2-40B4-BE49-F238E27FC236}">
                  <a16:creationId xmlns:a16="http://schemas.microsoft.com/office/drawing/2014/main" id="{E621D120-6870-1F50-A7E0-C011C27A29B7}"/>
                </a:ext>
              </a:extLst>
            </p:cNvPr>
            <p:cNvSpPr txBox="1"/>
            <p:nvPr/>
          </p:nvSpPr>
          <p:spPr>
            <a:xfrm rot="16200000">
              <a:off x="9989440" y="3412810"/>
              <a:ext cx="42334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CD56</a:t>
              </a:r>
            </a:p>
          </p:txBody>
        </p:sp>
        <p:pic>
          <p:nvPicPr>
            <p:cNvPr id="159" name="Picture 158">
              <a:extLst>
                <a:ext uri="{FF2B5EF4-FFF2-40B4-BE49-F238E27FC236}">
                  <a16:creationId xmlns:a16="http://schemas.microsoft.com/office/drawing/2014/main" id="{27201F0E-0F10-D462-EBBD-DD599E24837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19083" t="13935" r="12885" b="11956"/>
            <a:stretch/>
          </p:blipFill>
          <p:spPr>
            <a:xfrm>
              <a:off x="10453464" y="4459368"/>
              <a:ext cx="1642012" cy="1230361"/>
            </a:xfrm>
            <a:prstGeom prst="rect">
              <a:avLst/>
            </a:prstGeom>
            <a:ln>
              <a:noFill/>
            </a:ln>
          </p:spPr>
        </p:pic>
        <p:sp>
          <p:nvSpPr>
            <p:cNvPr id="160" name="TextBox 159">
              <a:extLst>
                <a:ext uri="{FF2B5EF4-FFF2-40B4-BE49-F238E27FC236}">
                  <a16:creationId xmlns:a16="http://schemas.microsoft.com/office/drawing/2014/main" id="{7B88D28C-575F-8B95-FC74-873AD51FA2B3}"/>
                </a:ext>
              </a:extLst>
            </p:cNvPr>
            <p:cNvSpPr txBox="1"/>
            <p:nvPr/>
          </p:nvSpPr>
          <p:spPr>
            <a:xfrm>
              <a:off x="10519029" y="4221873"/>
              <a:ext cx="16420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/>
                <a:t>CD56 bright</a:t>
              </a:r>
            </a:p>
          </p:txBody>
        </p:sp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7DD115DD-3397-B416-7CFB-2B42B43EE391}"/>
                </a:ext>
              </a:extLst>
            </p:cNvPr>
            <p:cNvSpPr txBox="1"/>
            <p:nvPr/>
          </p:nvSpPr>
          <p:spPr>
            <a:xfrm>
              <a:off x="10439832" y="5710953"/>
              <a:ext cx="166963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/>
                <a:t>          PM (</a:t>
              </a:r>
              <a:r>
                <a:rPr lang="en-US" sz="800" i="1"/>
                <a:t>n</a:t>
              </a:r>
              <a:r>
                <a:rPr lang="en-US" sz="800"/>
                <a:t>=14)                MBM (</a:t>
              </a:r>
              <a:r>
                <a:rPr lang="en-US" sz="800" i="1"/>
                <a:t>n</a:t>
              </a:r>
              <a:r>
                <a:rPr lang="en-US" sz="800"/>
                <a:t>=6)</a:t>
              </a:r>
            </a:p>
          </p:txBody>
        </p:sp>
        <p:grpSp>
          <p:nvGrpSpPr>
            <p:cNvPr id="162" name="Group 161">
              <a:extLst>
                <a:ext uri="{FF2B5EF4-FFF2-40B4-BE49-F238E27FC236}">
                  <a16:creationId xmlns:a16="http://schemas.microsoft.com/office/drawing/2014/main" id="{18C1E5D5-C2FE-3217-DF93-15E28747976D}"/>
                </a:ext>
              </a:extLst>
            </p:cNvPr>
            <p:cNvGrpSpPr/>
            <p:nvPr/>
          </p:nvGrpSpPr>
          <p:grpSpPr>
            <a:xfrm>
              <a:off x="10944932" y="4477780"/>
              <a:ext cx="821565" cy="228660"/>
              <a:chOff x="873626" y="5798195"/>
              <a:chExt cx="838218" cy="228660"/>
            </a:xfrm>
          </p:grpSpPr>
          <p:cxnSp>
            <p:nvCxnSpPr>
              <p:cNvPr id="163" name="Straight Connector 162">
                <a:extLst>
                  <a:ext uri="{FF2B5EF4-FFF2-40B4-BE49-F238E27FC236}">
                    <a16:creationId xmlns:a16="http://schemas.microsoft.com/office/drawing/2014/main" id="{55692E2F-4EB0-0D86-3FBB-D170BC82EF6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74657" y="6000468"/>
                <a:ext cx="1359" cy="26387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4" name="Straight Connector 163">
                <a:extLst>
                  <a:ext uri="{FF2B5EF4-FFF2-40B4-BE49-F238E27FC236}">
                    <a16:creationId xmlns:a16="http://schemas.microsoft.com/office/drawing/2014/main" id="{57DEB214-FABE-23D2-0BFD-5786E56D2F7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74570" y="6006340"/>
                <a:ext cx="83716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5" name="TextBox 164">
                <a:extLst>
                  <a:ext uri="{FF2B5EF4-FFF2-40B4-BE49-F238E27FC236}">
                    <a16:creationId xmlns:a16="http://schemas.microsoft.com/office/drawing/2014/main" id="{276941B8-49E3-5A73-3437-525E82BE700A}"/>
                  </a:ext>
                </a:extLst>
              </p:cNvPr>
              <p:cNvSpPr txBox="1"/>
              <p:nvPr/>
            </p:nvSpPr>
            <p:spPr>
              <a:xfrm>
                <a:off x="873626" y="5798195"/>
                <a:ext cx="83821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i="1" dirty="0"/>
                  <a:t>P </a:t>
                </a:r>
                <a:r>
                  <a:rPr lang="en-US" sz="800" b="1" dirty="0"/>
                  <a:t>= 0.0059</a:t>
                </a:r>
              </a:p>
            </p:txBody>
          </p:sp>
          <p:cxnSp>
            <p:nvCxnSpPr>
              <p:cNvPr id="166" name="Straight Connector 165">
                <a:extLst>
                  <a:ext uri="{FF2B5EF4-FFF2-40B4-BE49-F238E27FC236}">
                    <a16:creationId xmlns:a16="http://schemas.microsoft.com/office/drawing/2014/main" id="{52BB6197-6F69-7640-5B40-49E52AEE4CC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710485" y="6000468"/>
                <a:ext cx="1359" cy="26387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45CEB492-314E-F0E9-F016-5FCFC2854073}"/>
                </a:ext>
              </a:extLst>
            </p:cNvPr>
            <p:cNvSpPr txBox="1"/>
            <p:nvPr/>
          </p:nvSpPr>
          <p:spPr>
            <a:xfrm rot="16200000">
              <a:off x="9461632" y="4912153"/>
              <a:ext cx="1388563" cy="33855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b="1"/>
              </a:lvl1pPr>
            </a:lstStyle>
            <a:p>
              <a:pPr algn="ctr"/>
              <a:r>
                <a:rPr lang="en-US" sz="800" b="0"/>
                <a:t>% of CD3-CD56 bright cells </a:t>
              </a:r>
            </a:p>
            <a:p>
              <a:pPr algn="ctr"/>
              <a:r>
                <a:rPr lang="en-US" sz="800" b="0"/>
                <a:t>(gated on CD3- CD56+ cells)</a:t>
              </a:r>
            </a:p>
          </p:txBody>
        </p:sp>
        <p:sp>
          <p:nvSpPr>
            <p:cNvPr id="168" name="TextBox 167">
              <a:extLst>
                <a:ext uri="{FF2B5EF4-FFF2-40B4-BE49-F238E27FC236}">
                  <a16:creationId xmlns:a16="http://schemas.microsoft.com/office/drawing/2014/main" id="{967AAD88-B91A-A928-402E-0914997EB35B}"/>
                </a:ext>
              </a:extLst>
            </p:cNvPr>
            <p:cNvSpPr txBox="1"/>
            <p:nvPr/>
          </p:nvSpPr>
          <p:spPr>
            <a:xfrm>
              <a:off x="10243559" y="4428831"/>
              <a:ext cx="26692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lIns="0" rIns="0" rtlCol="0" anchor="ctr" anchorCtr="0">
              <a:spAutoFit/>
            </a:bodyPr>
            <a:lstStyle/>
            <a:p>
              <a:pPr algn="ctr"/>
              <a:r>
                <a:rPr lang="en-US" sz="800" b="1"/>
                <a:t>110</a:t>
              </a:r>
            </a:p>
          </p:txBody>
        </p:sp>
        <p:sp>
          <p:nvSpPr>
            <p:cNvPr id="169" name="TextBox 168">
              <a:extLst>
                <a:ext uri="{FF2B5EF4-FFF2-40B4-BE49-F238E27FC236}">
                  <a16:creationId xmlns:a16="http://schemas.microsoft.com/office/drawing/2014/main" id="{A4788DFE-A38F-5083-DD8D-78039AB50AF7}"/>
                </a:ext>
              </a:extLst>
            </p:cNvPr>
            <p:cNvSpPr txBox="1"/>
            <p:nvPr/>
          </p:nvSpPr>
          <p:spPr>
            <a:xfrm>
              <a:off x="10246011" y="4653926"/>
              <a:ext cx="26692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lIns="0" rIns="0" rtlCol="0" anchor="ctr" anchorCtr="0">
              <a:spAutoFit/>
            </a:bodyPr>
            <a:lstStyle/>
            <a:p>
              <a:pPr algn="ctr"/>
              <a:r>
                <a:rPr lang="en-US" sz="800" b="1"/>
                <a:t>100</a:t>
              </a:r>
            </a:p>
          </p:txBody>
        </p:sp>
        <p:sp>
          <p:nvSpPr>
            <p:cNvPr id="170" name="TextBox 169">
              <a:extLst>
                <a:ext uri="{FF2B5EF4-FFF2-40B4-BE49-F238E27FC236}">
                  <a16:creationId xmlns:a16="http://schemas.microsoft.com/office/drawing/2014/main" id="{44547AC5-973A-909E-D7C2-8D8CDB170603}"/>
                </a:ext>
              </a:extLst>
            </p:cNvPr>
            <p:cNvSpPr txBox="1"/>
            <p:nvPr/>
          </p:nvSpPr>
          <p:spPr>
            <a:xfrm>
              <a:off x="10259970" y="4877289"/>
              <a:ext cx="26692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lIns="0" rIns="0" rtlCol="0" anchor="ctr" anchorCtr="0">
              <a:spAutoFit/>
            </a:bodyPr>
            <a:lstStyle/>
            <a:p>
              <a:pPr algn="ctr"/>
              <a:r>
                <a:rPr lang="en-US" sz="800" b="1"/>
                <a:t>90</a:t>
              </a:r>
            </a:p>
          </p:txBody>
        </p:sp>
        <p:sp>
          <p:nvSpPr>
            <p:cNvPr id="171" name="TextBox 170">
              <a:extLst>
                <a:ext uri="{FF2B5EF4-FFF2-40B4-BE49-F238E27FC236}">
                  <a16:creationId xmlns:a16="http://schemas.microsoft.com/office/drawing/2014/main" id="{DC8D83B2-E49D-25C6-0F00-81D7F9F8256E}"/>
                </a:ext>
              </a:extLst>
            </p:cNvPr>
            <p:cNvSpPr txBox="1"/>
            <p:nvPr/>
          </p:nvSpPr>
          <p:spPr>
            <a:xfrm>
              <a:off x="10265388" y="5095221"/>
              <a:ext cx="26692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lIns="0" rIns="0" rtlCol="0" anchor="ctr" anchorCtr="0">
              <a:spAutoFit/>
            </a:bodyPr>
            <a:lstStyle/>
            <a:p>
              <a:pPr algn="ctr"/>
              <a:r>
                <a:rPr lang="en-US" sz="800" b="1"/>
                <a:t>80</a:t>
              </a:r>
            </a:p>
          </p:txBody>
        </p:sp>
        <p:sp>
          <p:nvSpPr>
            <p:cNvPr id="172" name="TextBox 171">
              <a:extLst>
                <a:ext uri="{FF2B5EF4-FFF2-40B4-BE49-F238E27FC236}">
                  <a16:creationId xmlns:a16="http://schemas.microsoft.com/office/drawing/2014/main" id="{5388B659-8607-A522-232E-7C0B22164E84}"/>
                </a:ext>
              </a:extLst>
            </p:cNvPr>
            <p:cNvSpPr txBox="1"/>
            <p:nvPr/>
          </p:nvSpPr>
          <p:spPr>
            <a:xfrm>
              <a:off x="10265388" y="5316067"/>
              <a:ext cx="26692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lIns="0" rIns="0" rtlCol="0" anchor="ctr" anchorCtr="0">
              <a:spAutoFit/>
            </a:bodyPr>
            <a:lstStyle/>
            <a:p>
              <a:pPr algn="ctr"/>
              <a:r>
                <a:rPr lang="en-US" sz="800" b="1"/>
                <a:t>70</a:t>
              </a:r>
            </a:p>
          </p:txBody>
        </p:sp>
        <p:sp>
          <p:nvSpPr>
            <p:cNvPr id="173" name="TextBox 172">
              <a:extLst>
                <a:ext uri="{FF2B5EF4-FFF2-40B4-BE49-F238E27FC236}">
                  <a16:creationId xmlns:a16="http://schemas.microsoft.com/office/drawing/2014/main" id="{F70D8CF3-F56F-2FCC-F392-8A47650C9804}"/>
                </a:ext>
              </a:extLst>
            </p:cNvPr>
            <p:cNvSpPr txBox="1"/>
            <p:nvPr/>
          </p:nvSpPr>
          <p:spPr>
            <a:xfrm>
              <a:off x="10272204" y="5531055"/>
              <a:ext cx="26692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lIns="0" rIns="0" rtlCol="0" anchor="ctr" anchorCtr="0">
              <a:spAutoFit/>
            </a:bodyPr>
            <a:lstStyle/>
            <a:p>
              <a:pPr algn="ctr"/>
              <a:r>
                <a:rPr lang="en-US" sz="800" b="1"/>
                <a:t>60</a:t>
              </a:r>
            </a:p>
          </p:txBody>
        </p:sp>
        <p:pic>
          <p:nvPicPr>
            <p:cNvPr id="174" name="Picture 173">
              <a:extLst>
                <a:ext uri="{FF2B5EF4-FFF2-40B4-BE49-F238E27FC236}">
                  <a16:creationId xmlns:a16="http://schemas.microsoft.com/office/drawing/2014/main" id="{2A2FD168-9091-209F-8427-7FED377FC13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17851" t="17883" r="9722" b="12241"/>
            <a:stretch/>
          </p:blipFill>
          <p:spPr>
            <a:xfrm>
              <a:off x="8409711" y="6295202"/>
              <a:ext cx="1559111" cy="1054806"/>
            </a:xfrm>
            <a:prstGeom prst="rect">
              <a:avLst/>
            </a:prstGeom>
            <a:ln>
              <a:noFill/>
            </a:ln>
          </p:spPr>
        </p:pic>
        <p:sp>
          <p:nvSpPr>
            <p:cNvPr id="175" name="TextBox 174">
              <a:extLst>
                <a:ext uri="{FF2B5EF4-FFF2-40B4-BE49-F238E27FC236}">
                  <a16:creationId xmlns:a16="http://schemas.microsoft.com/office/drawing/2014/main" id="{D4DBA928-3D22-BFFC-F2AE-6E920A95EC0B}"/>
                </a:ext>
              </a:extLst>
            </p:cNvPr>
            <p:cNvSpPr txBox="1"/>
            <p:nvPr/>
          </p:nvSpPr>
          <p:spPr>
            <a:xfrm>
              <a:off x="8233726" y="7193062"/>
              <a:ext cx="26692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lIns="0" rIns="0" rtlCol="0" anchor="ctr" anchorCtr="0">
              <a:spAutoFit/>
            </a:bodyPr>
            <a:lstStyle/>
            <a:p>
              <a:pPr algn="ctr"/>
              <a:r>
                <a:rPr lang="en-US" sz="800" b="1"/>
                <a:t>0</a:t>
              </a:r>
            </a:p>
          </p:txBody>
        </p:sp>
        <p:sp>
          <p:nvSpPr>
            <p:cNvPr id="176" name="TextBox 175">
              <a:extLst>
                <a:ext uri="{FF2B5EF4-FFF2-40B4-BE49-F238E27FC236}">
                  <a16:creationId xmlns:a16="http://schemas.microsoft.com/office/drawing/2014/main" id="{1E1C56D4-48B8-8C67-EC5E-2BABB0486CA2}"/>
                </a:ext>
              </a:extLst>
            </p:cNvPr>
            <p:cNvSpPr txBox="1"/>
            <p:nvPr/>
          </p:nvSpPr>
          <p:spPr>
            <a:xfrm>
              <a:off x="8209150" y="6209862"/>
              <a:ext cx="26692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lIns="0" rIns="0" rtlCol="0" anchor="ctr" anchorCtr="0">
              <a:spAutoFit/>
            </a:bodyPr>
            <a:lstStyle/>
            <a:p>
              <a:pPr algn="ctr"/>
              <a:r>
                <a:rPr lang="en-US" sz="800" b="1"/>
                <a:t>40</a:t>
              </a:r>
            </a:p>
          </p:txBody>
        </p:sp>
        <p:sp>
          <p:nvSpPr>
            <p:cNvPr id="177" name="TextBox 176">
              <a:extLst>
                <a:ext uri="{FF2B5EF4-FFF2-40B4-BE49-F238E27FC236}">
                  <a16:creationId xmlns:a16="http://schemas.microsoft.com/office/drawing/2014/main" id="{0913916A-A496-50CA-989D-F1F3F909D26C}"/>
                </a:ext>
              </a:extLst>
            </p:cNvPr>
            <p:cNvSpPr txBox="1"/>
            <p:nvPr/>
          </p:nvSpPr>
          <p:spPr>
            <a:xfrm>
              <a:off x="8212325" y="6457515"/>
              <a:ext cx="26692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lIns="0" rIns="0" rtlCol="0" anchor="ctr" anchorCtr="0">
              <a:spAutoFit/>
            </a:bodyPr>
            <a:lstStyle/>
            <a:p>
              <a:pPr algn="ctr"/>
              <a:r>
                <a:rPr lang="en-US" sz="800" b="1"/>
                <a:t>30</a:t>
              </a:r>
            </a:p>
          </p:txBody>
        </p:sp>
        <p:sp>
          <p:nvSpPr>
            <p:cNvPr id="178" name="TextBox 177">
              <a:extLst>
                <a:ext uri="{FF2B5EF4-FFF2-40B4-BE49-F238E27FC236}">
                  <a16:creationId xmlns:a16="http://schemas.microsoft.com/office/drawing/2014/main" id="{57EB5D55-3F20-E2AB-1B9B-162BACDF9D4D}"/>
                </a:ext>
              </a:extLst>
            </p:cNvPr>
            <p:cNvSpPr txBox="1"/>
            <p:nvPr/>
          </p:nvSpPr>
          <p:spPr>
            <a:xfrm>
              <a:off x="8215499" y="6704848"/>
              <a:ext cx="26692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lIns="0" rIns="0" rtlCol="0" anchor="ctr" anchorCtr="0">
              <a:spAutoFit/>
            </a:bodyPr>
            <a:lstStyle/>
            <a:p>
              <a:pPr algn="ctr"/>
              <a:r>
                <a:rPr lang="en-US" sz="800" b="1"/>
                <a:t>20</a:t>
              </a:r>
            </a:p>
          </p:txBody>
        </p:sp>
        <p:sp>
          <p:nvSpPr>
            <p:cNvPr id="179" name="TextBox 178">
              <a:extLst>
                <a:ext uri="{FF2B5EF4-FFF2-40B4-BE49-F238E27FC236}">
                  <a16:creationId xmlns:a16="http://schemas.microsoft.com/office/drawing/2014/main" id="{33567E91-D705-3C70-9077-B7967FBF810A}"/>
                </a:ext>
              </a:extLst>
            </p:cNvPr>
            <p:cNvSpPr txBox="1"/>
            <p:nvPr/>
          </p:nvSpPr>
          <p:spPr>
            <a:xfrm>
              <a:off x="8212324" y="6952181"/>
              <a:ext cx="26692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lIns="0" rIns="0" rtlCol="0" anchor="ctr" anchorCtr="0">
              <a:spAutoFit/>
            </a:bodyPr>
            <a:lstStyle/>
            <a:p>
              <a:pPr algn="ctr"/>
              <a:r>
                <a:rPr lang="en-US" sz="800" b="1"/>
                <a:t>10</a:t>
              </a:r>
            </a:p>
          </p:txBody>
        </p:sp>
        <p:sp>
          <p:nvSpPr>
            <p:cNvPr id="180" name="TextBox 179">
              <a:extLst>
                <a:ext uri="{FF2B5EF4-FFF2-40B4-BE49-F238E27FC236}">
                  <a16:creationId xmlns:a16="http://schemas.microsoft.com/office/drawing/2014/main" id="{55400E20-9FA7-1F8D-60FF-E1B9F945057F}"/>
                </a:ext>
              </a:extLst>
            </p:cNvPr>
            <p:cNvSpPr txBox="1"/>
            <p:nvPr/>
          </p:nvSpPr>
          <p:spPr>
            <a:xfrm>
              <a:off x="8414763" y="7325849"/>
              <a:ext cx="166963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    PM (</a:t>
              </a:r>
              <a:r>
                <a:rPr lang="en-US" sz="800" i="1" dirty="0"/>
                <a:t>n</a:t>
              </a:r>
              <a:r>
                <a:rPr lang="en-US" sz="800" dirty="0"/>
                <a:t>=14)                MBM (</a:t>
              </a:r>
              <a:r>
                <a:rPr lang="en-US" sz="800" i="1" dirty="0"/>
                <a:t>n</a:t>
              </a:r>
              <a:r>
                <a:rPr lang="en-US" sz="800" dirty="0"/>
                <a:t>=6)</a:t>
              </a:r>
            </a:p>
          </p:txBody>
        </p:sp>
        <p:sp>
          <p:nvSpPr>
            <p:cNvPr id="181" name="TextBox 180">
              <a:extLst>
                <a:ext uri="{FF2B5EF4-FFF2-40B4-BE49-F238E27FC236}">
                  <a16:creationId xmlns:a16="http://schemas.microsoft.com/office/drawing/2014/main" id="{383E62AF-8830-9D26-2095-738F9911C539}"/>
                </a:ext>
              </a:extLst>
            </p:cNvPr>
            <p:cNvSpPr txBox="1"/>
            <p:nvPr/>
          </p:nvSpPr>
          <p:spPr>
            <a:xfrm>
              <a:off x="8393330" y="6013934"/>
              <a:ext cx="159291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/>
                <a:t>CD56 dim</a:t>
              </a:r>
            </a:p>
          </p:txBody>
        </p:sp>
        <p:sp>
          <p:nvSpPr>
            <p:cNvPr id="182" name="TextBox 181">
              <a:extLst>
                <a:ext uri="{FF2B5EF4-FFF2-40B4-BE49-F238E27FC236}">
                  <a16:creationId xmlns:a16="http://schemas.microsoft.com/office/drawing/2014/main" id="{5A1AD4D1-311F-3B8C-1719-45EF41A1F83C}"/>
                </a:ext>
              </a:extLst>
            </p:cNvPr>
            <p:cNvSpPr txBox="1"/>
            <p:nvPr/>
          </p:nvSpPr>
          <p:spPr>
            <a:xfrm rot="16200000">
              <a:off x="7462366" y="6654006"/>
              <a:ext cx="1388563" cy="33855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b="1"/>
              </a:lvl1pPr>
            </a:lstStyle>
            <a:p>
              <a:pPr algn="ctr"/>
              <a:r>
                <a:rPr lang="en-US" sz="800" b="0"/>
                <a:t>% of CD3-CD56 dim cells </a:t>
              </a:r>
            </a:p>
            <a:p>
              <a:pPr algn="ctr"/>
              <a:r>
                <a:rPr lang="en-US" sz="800" b="0"/>
                <a:t>(gated on CD3- CD56+ cells)</a:t>
              </a:r>
            </a:p>
          </p:txBody>
        </p:sp>
        <p:grpSp>
          <p:nvGrpSpPr>
            <p:cNvPr id="183" name="Group 182">
              <a:extLst>
                <a:ext uri="{FF2B5EF4-FFF2-40B4-BE49-F238E27FC236}">
                  <a16:creationId xmlns:a16="http://schemas.microsoft.com/office/drawing/2014/main" id="{A9B68FE1-4A9E-7B6D-0290-A24CC0A5A456}"/>
                </a:ext>
              </a:extLst>
            </p:cNvPr>
            <p:cNvGrpSpPr/>
            <p:nvPr/>
          </p:nvGrpSpPr>
          <p:grpSpPr>
            <a:xfrm>
              <a:off x="8871939" y="6178511"/>
              <a:ext cx="821565" cy="228660"/>
              <a:chOff x="873626" y="5798195"/>
              <a:chExt cx="838218" cy="228660"/>
            </a:xfrm>
          </p:grpSpPr>
          <p:cxnSp>
            <p:nvCxnSpPr>
              <p:cNvPr id="184" name="Straight Connector 183">
                <a:extLst>
                  <a:ext uri="{FF2B5EF4-FFF2-40B4-BE49-F238E27FC236}">
                    <a16:creationId xmlns:a16="http://schemas.microsoft.com/office/drawing/2014/main" id="{AF69F3ED-8B60-FDFF-7B5F-D18C61FF90E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74657" y="6000468"/>
                <a:ext cx="1359" cy="26387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5" name="Straight Connector 184">
                <a:extLst>
                  <a:ext uri="{FF2B5EF4-FFF2-40B4-BE49-F238E27FC236}">
                    <a16:creationId xmlns:a16="http://schemas.microsoft.com/office/drawing/2014/main" id="{52B0FAE2-02CB-033C-4B50-03DD9BC1A1A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74570" y="6006340"/>
                <a:ext cx="83716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6" name="TextBox 185">
                <a:extLst>
                  <a:ext uri="{FF2B5EF4-FFF2-40B4-BE49-F238E27FC236}">
                    <a16:creationId xmlns:a16="http://schemas.microsoft.com/office/drawing/2014/main" id="{DE0BC07A-E774-2547-0F2A-188EEC722D36}"/>
                  </a:ext>
                </a:extLst>
              </p:cNvPr>
              <p:cNvSpPr txBox="1"/>
              <p:nvPr/>
            </p:nvSpPr>
            <p:spPr>
              <a:xfrm>
                <a:off x="873626" y="5798195"/>
                <a:ext cx="83821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i="1"/>
                  <a:t>P </a:t>
                </a:r>
                <a:r>
                  <a:rPr lang="en-US" sz="800" b="1"/>
                  <a:t>= 0.01</a:t>
                </a:r>
              </a:p>
            </p:txBody>
          </p:sp>
          <p:cxnSp>
            <p:nvCxnSpPr>
              <p:cNvPr id="187" name="Straight Connector 186">
                <a:extLst>
                  <a:ext uri="{FF2B5EF4-FFF2-40B4-BE49-F238E27FC236}">
                    <a16:creationId xmlns:a16="http://schemas.microsoft.com/office/drawing/2014/main" id="{FCBFB130-7572-7684-64F5-3B6DF165C20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710485" y="6000468"/>
                <a:ext cx="1359" cy="26387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88" name="TextBox 187">
              <a:extLst>
                <a:ext uri="{FF2B5EF4-FFF2-40B4-BE49-F238E27FC236}">
                  <a16:creationId xmlns:a16="http://schemas.microsoft.com/office/drawing/2014/main" id="{7BEFD2BA-A076-F33B-B86F-BA9EA5516653}"/>
                </a:ext>
              </a:extLst>
            </p:cNvPr>
            <p:cNvSpPr txBox="1"/>
            <p:nvPr/>
          </p:nvSpPr>
          <p:spPr>
            <a:xfrm rot="16200000">
              <a:off x="2716252" y="2458362"/>
              <a:ext cx="1479908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MBM</a:t>
              </a:r>
            </a:p>
          </p:txBody>
        </p:sp>
        <p:sp>
          <p:nvSpPr>
            <p:cNvPr id="189" name="TextBox 188">
              <a:extLst>
                <a:ext uri="{FF2B5EF4-FFF2-40B4-BE49-F238E27FC236}">
                  <a16:creationId xmlns:a16="http://schemas.microsoft.com/office/drawing/2014/main" id="{BF0C02E4-EBC4-3A5A-95C3-390886268173}"/>
                </a:ext>
              </a:extLst>
            </p:cNvPr>
            <p:cNvSpPr txBox="1"/>
            <p:nvPr/>
          </p:nvSpPr>
          <p:spPr>
            <a:xfrm rot="16200000">
              <a:off x="2749829" y="964408"/>
              <a:ext cx="1412751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PM</a:t>
              </a:r>
            </a:p>
          </p:txBody>
        </p:sp>
        <p:sp>
          <p:nvSpPr>
            <p:cNvPr id="190" name="TextBox 189">
              <a:extLst>
                <a:ext uri="{FF2B5EF4-FFF2-40B4-BE49-F238E27FC236}">
                  <a16:creationId xmlns:a16="http://schemas.microsoft.com/office/drawing/2014/main" id="{0AF51E9C-B059-EC6B-A109-75A8C370BBAD}"/>
                </a:ext>
              </a:extLst>
            </p:cNvPr>
            <p:cNvSpPr txBox="1"/>
            <p:nvPr/>
          </p:nvSpPr>
          <p:spPr>
            <a:xfrm>
              <a:off x="3530517" y="3320106"/>
              <a:ext cx="1548932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/>
                <a:t>Morphology markers</a:t>
              </a:r>
            </a:p>
          </p:txBody>
        </p:sp>
        <p:sp>
          <p:nvSpPr>
            <p:cNvPr id="191" name="TextBox 190">
              <a:extLst>
                <a:ext uri="{FF2B5EF4-FFF2-40B4-BE49-F238E27FC236}">
                  <a16:creationId xmlns:a16="http://schemas.microsoft.com/office/drawing/2014/main" id="{CD32C471-12F2-0C4A-580B-8D03FD2DFB75}"/>
                </a:ext>
              </a:extLst>
            </p:cNvPr>
            <p:cNvSpPr txBox="1"/>
            <p:nvPr/>
          </p:nvSpPr>
          <p:spPr>
            <a:xfrm>
              <a:off x="5379485" y="3320106"/>
              <a:ext cx="2328414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/>
                <a:t>Enlarged Regions of Interest (ROIs)</a:t>
              </a:r>
            </a:p>
          </p:txBody>
        </p:sp>
        <p:sp>
          <p:nvSpPr>
            <p:cNvPr id="192" name="TextBox 191">
              <a:extLst>
                <a:ext uri="{FF2B5EF4-FFF2-40B4-BE49-F238E27FC236}">
                  <a16:creationId xmlns:a16="http://schemas.microsoft.com/office/drawing/2014/main" id="{D04C9E61-AAA6-4FFE-E18D-ABB607469DDC}"/>
                </a:ext>
              </a:extLst>
            </p:cNvPr>
            <p:cNvSpPr txBox="1"/>
            <p:nvPr/>
          </p:nvSpPr>
          <p:spPr>
            <a:xfrm>
              <a:off x="3550854" y="126699"/>
              <a:ext cx="1548932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rgbClr val="00B050"/>
                  </a:solidFill>
                </a:rPr>
                <a:t>S100-PMEL17   </a:t>
              </a:r>
              <a:r>
                <a:rPr lang="en-US" sz="800" b="1" dirty="0">
                  <a:solidFill>
                    <a:srgbClr val="F567CC"/>
                  </a:solidFill>
                </a:rPr>
                <a:t>CD45    </a:t>
              </a:r>
              <a:r>
                <a:rPr lang="en-US" sz="800" b="1" dirty="0">
                  <a:solidFill>
                    <a:srgbClr val="0070C0"/>
                  </a:solidFill>
                </a:rPr>
                <a:t>DNA</a:t>
              </a:r>
            </a:p>
          </p:txBody>
        </p:sp>
        <p:pic>
          <p:nvPicPr>
            <p:cNvPr id="193" name="Picture 192">
              <a:extLst>
                <a:ext uri="{FF2B5EF4-FFF2-40B4-BE49-F238E27FC236}">
                  <a16:creationId xmlns:a16="http://schemas.microsoft.com/office/drawing/2014/main" id="{30C038D6-6371-AAA9-8583-EB23590C76A1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3536847" y="336046"/>
              <a:ext cx="4204839" cy="3041572"/>
            </a:xfrm>
            <a:prstGeom prst="rect">
              <a:avLst/>
            </a:prstGeom>
          </p:spPr>
        </p:pic>
        <p:sp>
          <p:nvSpPr>
            <p:cNvPr id="194" name="TextBox 193">
              <a:extLst>
                <a:ext uri="{FF2B5EF4-FFF2-40B4-BE49-F238E27FC236}">
                  <a16:creationId xmlns:a16="http://schemas.microsoft.com/office/drawing/2014/main" id="{63160D9E-5E92-E218-1427-E8876C01303E}"/>
                </a:ext>
              </a:extLst>
            </p:cNvPr>
            <p:cNvSpPr txBox="1"/>
            <p:nvPr/>
          </p:nvSpPr>
          <p:spPr>
            <a:xfrm>
              <a:off x="5369206" y="126698"/>
              <a:ext cx="2328413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solidFill>
                    <a:srgbClr val="00B050"/>
                  </a:solidFill>
                </a:rPr>
                <a:t>S100-PMEL17   </a:t>
              </a:r>
              <a:r>
                <a:rPr lang="en-US" sz="800" b="1" dirty="0">
                  <a:solidFill>
                    <a:srgbClr val="F567CC"/>
                  </a:solidFill>
                </a:rPr>
                <a:t>CD45    </a:t>
              </a:r>
              <a:r>
                <a:rPr lang="en-US" sz="800" b="1" dirty="0">
                  <a:solidFill>
                    <a:srgbClr val="0070C0"/>
                  </a:solidFill>
                </a:rPr>
                <a:t>DNA</a:t>
              </a:r>
            </a:p>
          </p:txBody>
        </p:sp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D46BCF73-42D5-6F32-F733-3EC1B096D956}"/>
                </a:ext>
              </a:extLst>
            </p:cNvPr>
            <p:cNvSpPr/>
            <p:nvPr/>
          </p:nvSpPr>
          <p:spPr>
            <a:xfrm>
              <a:off x="9689617" y="330852"/>
              <a:ext cx="296632" cy="14067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53C335B9-80BB-A590-C52F-1EB1E835F38D}"/>
                </a:ext>
              </a:extLst>
            </p:cNvPr>
            <p:cNvSpPr/>
            <p:nvPr/>
          </p:nvSpPr>
          <p:spPr>
            <a:xfrm>
              <a:off x="11494785" y="1554348"/>
              <a:ext cx="296632" cy="14067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80428EE4-6EF3-BA5F-5995-915194F62523}"/>
                </a:ext>
              </a:extLst>
            </p:cNvPr>
            <p:cNvSpPr/>
            <p:nvPr/>
          </p:nvSpPr>
          <p:spPr>
            <a:xfrm>
              <a:off x="9664193" y="1962436"/>
              <a:ext cx="296632" cy="14067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id="{477D3BCD-A242-7CB0-C27D-A8B7F4733514}"/>
                </a:ext>
              </a:extLst>
            </p:cNvPr>
            <p:cNvSpPr/>
            <p:nvPr/>
          </p:nvSpPr>
          <p:spPr>
            <a:xfrm>
              <a:off x="9673610" y="3177230"/>
              <a:ext cx="296632" cy="14067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DA253477-3A7E-BA55-8463-42E879FA9ED6}"/>
                </a:ext>
              </a:extLst>
            </p:cNvPr>
            <p:cNvSpPr/>
            <p:nvPr/>
          </p:nvSpPr>
          <p:spPr>
            <a:xfrm>
              <a:off x="11497218" y="3217914"/>
              <a:ext cx="296632" cy="14067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6" name="Rectangle 45">
              <a:extLst>
                <a:ext uri="{FF2B5EF4-FFF2-40B4-BE49-F238E27FC236}">
                  <a16:creationId xmlns:a16="http://schemas.microsoft.com/office/drawing/2014/main" id="{6313F510-7E23-C438-31D9-C62BB1406E66}"/>
                </a:ext>
              </a:extLst>
            </p:cNvPr>
            <p:cNvSpPr/>
            <p:nvPr/>
          </p:nvSpPr>
          <p:spPr>
            <a:xfrm>
              <a:off x="10415197" y="3217914"/>
              <a:ext cx="296632" cy="14067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" name="Rectangle 47">
              <a:extLst>
                <a:ext uri="{FF2B5EF4-FFF2-40B4-BE49-F238E27FC236}">
                  <a16:creationId xmlns:a16="http://schemas.microsoft.com/office/drawing/2014/main" id="{FA85E17F-86E1-F4D5-283A-CE019BCB1BEC}"/>
                </a:ext>
              </a:extLst>
            </p:cNvPr>
            <p:cNvSpPr/>
            <p:nvPr/>
          </p:nvSpPr>
          <p:spPr>
            <a:xfrm>
              <a:off x="8601103" y="3258958"/>
              <a:ext cx="235716" cy="6214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" name="Rectangle 49">
              <a:extLst>
                <a:ext uri="{FF2B5EF4-FFF2-40B4-BE49-F238E27FC236}">
                  <a16:creationId xmlns:a16="http://schemas.microsoft.com/office/drawing/2014/main" id="{19C3989A-1377-D381-99BA-59954949A542}"/>
                </a:ext>
              </a:extLst>
            </p:cNvPr>
            <p:cNvSpPr/>
            <p:nvPr/>
          </p:nvSpPr>
          <p:spPr>
            <a:xfrm>
              <a:off x="8611315" y="1630095"/>
              <a:ext cx="235716" cy="6214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" name="Rectangle 50">
              <a:extLst>
                <a:ext uri="{FF2B5EF4-FFF2-40B4-BE49-F238E27FC236}">
                  <a16:creationId xmlns:a16="http://schemas.microsoft.com/office/drawing/2014/main" id="{7C56ABD9-B49B-4FAA-88E9-4745083178CA}"/>
                </a:ext>
              </a:extLst>
            </p:cNvPr>
            <p:cNvSpPr/>
            <p:nvPr/>
          </p:nvSpPr>
          <p:spPr>
            <a:xfrm>
              <a:off x="10416513" y="1634266"/>
              <a:ext cx="235716" cy="6214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56" name="Picture 55">
              <a:extLst>
                <a:ext uri="{FF2B5EF4-FFF2-40B4-BE49-F238E27FC236}">
                  <a16:creationId xmlns:a16="http://schemas.microsoft.com/office/drawing/2014/main" id="{31D12F4E-B21D-60B7-FC95-2FF29B7EC4D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r="5799"/>
            <a:stretch/>
          </p:blipFill>
          <p:spPr>
            <a:xfrm rot="5400000">
              <a:off x="1782911" y="502183"/>
              <a:ext cx="1342760" cy="1357527"/>
            </a:xfrm>
            <a:prstGeom prst="rect">
              <a:avLst/>
            </a:prstGeom>
          </p:spPr>
        </p:pic>
        <p:pic>
          <p:nvPicPr>
            <p:cNvPr id="57" name="Picture 56">
              <a:extLst>
                <a:ext uri="{FF2B5EF4-FFF2-40B4-BE49-F238E27FC236}">
                  <a16:creationId xmlns:a16="http://schemas.microsoft.com/office/drawing/2014/main" id="{F69BDAC9-D395-03F1-D4F8-CC53E1B4B51C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 rot="5400000">
              <a:off x="1781547" y="1902006"/>
              <a:ext cx="1342760" cy="1362456"/>
            </a:xfrm>
            <a:prstGeom prst="rect">
              <a:avLst/>
            </a:prstGeom>
          </p:spPr>
        </p:pic>
        <p:pic>
          <p:nvPicPr>
            <p:cNvPr id="61" name="Picture 60">
              <a:extLst>
                <a:ext uri="{FF2B5EF4-FFF2-40B4-BE49-F238E27FC236}">
                  <a16:creationId xmlns:a16="http://schemas.microsoft.com/office/drawing/2014/main" id="{ED3F6FE7-B14C-FAFE-2E9F-D9458837680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/>
            <a:srcRect l="32309" b="9476"/>
            <a:stretch/>
          </p:blipFill>
          <p:spPr>
            <a:xfrm>
              <a:off x="350647" y="1914949"/>
              <a:ext cx="1362456" cy="1339665"/>
            </a:xfrm>
            <a:prstGeom prst="rect">
              <a:avLst/>
            </a:prstGeom>
          </p:spPr>
        </p:pic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F4F70868-1084-364D-8A75-20164646E8C0}"/>
                </a:ext>
              </a:extLst>
            </p:cNvPr>
            <p:cNvSpPr txBox="1"/>
            <p:nvPr/>
          </p:nvSpPr>
          <p:spPr>
            <a:xfrm>
              <a:off x="40470" y="58277"/>
              <a:ext cx="2826721" cy="20082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just">
                <a:lnSpc>
                  <a:spcPts val="619"/>
                </a:lnSpc>
              </a:pPr>
              <a:r>
                <a:rPr lang="en-US" sz="1500" b="1" dirty="0"/>
                <a:t>Supplementary </a:t>
              </a:r>
              <a:r>
                <a:rPr lang="en-US" sz="1500" b="1"/>
                <a:t>Figure 1  </a:t>
              </a:r>
              <a:endParaRPr lang="en-US" sz="1500" dirty="0"/>
            </a:p>
          </p:txBody>
        </p:sp>
        <p:cxnSp>
          <p:nvCxnSpPr>
            <p:cNvPr id="66" name="Straight Arrow Connector 65">
              <a:extLst>
                <a:ext uri="{FF2B5EF4-FFF2-40B4-BE49-F238E27FC236}">
                  <a16:creationId xmlns:a16="http://schemas.microsoft.com/office/drawing/2014/main" id="{926DB50C-F787-8AAF-0235-47523E2684A6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6902695" y="4009225"/>
              <a:ext cx="136280" cy="136409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B18FFE72-7E14-42D4-6A7A-CD6F55BEA912}"/>
                </a:ext>
              </a:extLst>
            </p:cNvPr>
            <p:cNvSpPr txBox="1"/>
            <p:nvPr/>
          </p:nvSpPr>
          <p:spPr>
            <a:xfrm>
              <a:off x="6972905" y="4037912"/>
              <a:ext cx="46148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rgbClr val="FF5050"/>
                  </a:solidFill>
                </a:rPr>
                <a:t>Ki-67</a:t>
              </a:r>
            </a:p>
          </p:txBody>
        </p:sp>
        <p:cxnSp>
          <p:nvCxnSpPr>
            <p:cNvPr id="69" name="Straight Arrow Connector 68">
              <a:extLst>
                <a:ext uri="{FF2B5EF4-FFF2-40B4-BE49-F238E27FC236}">
                  <a16:creationId xmlns:a16="http://schemas.microsoft.com/office/drawing/2014/main" id="{C09BD84F-5BC8-2F87-C592-BCDDE943731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820604" y="5029666"/>
              <a:ext cx="36268" cy="198676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255F9EE3-7D3B-55A7-37D3-5D38841D03A1}"/>
                </a:ext>
              </a:extLst>
            </p:cNvPr>
            <p:cNvSpPr txBox="1"/>
            <p:nvPr/>
          </p:nvSpPr>
          <p:spPr>
            <a:xfrm>
              <a:off x="6432725" y="4841606"/>
              <a:ext cx="106913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rgbClr val="FF5050"/>
                  </a:solidFill>
                  <a:latin typeface="Symbol" panose="05050102010706020507" pitchFamily="18" charset="2"/>
                </a:rPr>
                <a:t>b</a:t>
              </a:r>
              <a:r>
                <a:rPr lang="en-US" sz="800" b="1" dirty="0">
                  <a:solidFill>
                    <a:srgbClr val="FF5050"/>
                  </a:solidFill>
                </a:rPr>
                <a:t>2-microglobulin</a:t>
              </a:r>
            </a:p>
          </p:txBody>
        </p:sp>
        <p:cxnSp>
          <p:nvCxnSpPr>
            <p:cNvPr id="72" name="Straight Arrow Connector 71">
              <a:extLst>
                <a:ext uri="{FF2B5EF4-FFF2-40B4-BE49-F238E27FC236}">
                  <a16:creationId xmlns:a16="http://schemas.microsoft.com/office/drawing/2014/main" id="{07AC770F-FE30-1633-9EA8-37332F2BFC40}"/>
                </a:ext>
              </a:extLst>
            </p:cNvPr>
            <p:cNvCxnSpPr>
              <a:cxnSpLocks/>
            </p:cNvCxnSpPr>
            <p:nvPr/>
          </p:nvCxnSpPr>
          <p:spPr>
            <a:xfrm>
              <a:off x="6530108" y="5520082"/>
              <a:ext cx="0" cy="177799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6208C340-ADAF-786D-0BC1-13CBA9003873}"/>
                </a:ext>
              </a:extLst>
            </p:cNvPr>
            <p:cNvSpPr txBox="1"/>
            <p:nvPr/>
          </p:nvSpPr>
          <p:spPr>
            <a:xfrm>
              <a:off x="6318095" y="5355707"/>
              <a:ext cx="4103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rgbClr val="FF5050"/>
                  </a:solidFill>
                </a:rPr>
                <a:t>CD39</a:t>
              </a:r>
            </a:p>
          </p:txBody>
        </p:sp>
        <p:cxnSp>
          <p:nvCxnSpPr>
            <p:cNvPr id="75" name="Straight Arrow Connector 74">
              <a:extLst>
                <a:ext uri="{FF2B5EF4-FFF2-40B4-BE49-F238E27FC236}">
                  <a16:creationId xmlns:a16="http://schemas.microsoft.com/office/drawing/2014/main" id="{59765263-E917-A37F-3C50-6DC274E7259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056805" y="5148093"/>
              <a:ext cx="122857" cy="152400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7" name="Straight Arrow Connector 76">
              <a:extLst>
                <a:ext uri="{FF2B5EF4-FFF2-40B4-BE49-F238E27FC236}">
                  <a16:creationId xmlns:a16="http://schemas.microsoft.com/office/drawing/2014/main" id="{7C142E8A-1450-79CB-F557-493781BB81F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005281" y="5377683"/>
              <a:ext cx="146895" cy="305962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9" name="Straight Arrow Connector 78">
              <a:extLst>
                <a:ext uri="{FF2B5EF4-FFF2-40B4-BE49-F238E27FC236}">
                  <a16:creationId xmlns:a16="http://schemas.microsoft.com/office/drawing/2014/main" id="{B7521503-3A1F-F79D-DE9F-94CB03A3965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128447" y="5495531"/>
              <a:ext cx="175224" cy="134695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1" name="Straight Arrow Connector 80">
              <a:extLst>
                <a:ext uri="{FF2B5EF4-FFF2-40B4-BE49-F238E27FC236}">
                  <a16:creationId xmlns:a16="http://schemas.microsoft.com/office/drawing/2014/main" id="{474B5CD3-B8DF-3308-B912-BF105B8013C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263147" y="5608981"/>
              <a:ext cx="185153" cy="137023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3" name="Straight Arrow Connector 82">
              <a:extLst>
                <a:ext uri="{FF2B5EF4-FFF2-40B4-BE49-F238E27FC236}">
                  <a16:creationId xmlns:a16="http://schemas.microsoft.com/office/drawing/2014/main" id="{06FE546E-389B-F15A-6890-5D892840E3FB}"/>
                </a:ext>
              </a:extLst>
            </p:cNvPr>
            <p:cNvCxnSpPr>
              <a:cxnSpLocks/>
            </p:cNvCxnSpPr>
            <p:nvPr/>
          </p:nvCxnSpPr>
          <p:spPr>
            <a:xfrm>
              <a:off x="4564051" y="4098845"/>
              <a:ext cx="195618" cy="158204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5" name="Straight Arrow Connector 84">
              <a:extLst>
                <a:ext uri="{FF2B5EF4-FFF2-40B4-BE49-F238E27FC236}">
                  <a16:creationId xmlns:a16="http://schemas.microsoft.com/office/drawing/2014/main" id="{85BFF7FD-FA9C-BF1E-085D-F9A648A8577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581870" y="4423748"/>
              <a:ext cx="253271" cy="176053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7" name="Straight Arrow Connector 86">
              <a:extLst>
                <a:ext uri="{FF2B5EF4-FFF2-40B4-BE49-F238E27FC236}">
                  <a16:creationId xmlns:a16="http://schemas.microsoft.com/office/drawing/2014/main" id="{8DCC07A2-2E49-D884-2713-18CDD889979C}"/>
                </a:ext>
              </a:extLst>
            </p:cNvPr>
            <p:cNvCxnSpPr>
              <a:cxnSpLocks/>
            </p:cNvCxnSpPr>
            <p:nvPr/>
          </p:nvCxnSpPr>
          <p:spPr>
            <a:xfrm>
              <a:off x="4673340" y="5027456"/>
              <a:ext cx="132255" cy="238482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9" name="Straight Arrow Connector 88">
              <a:extLst>
                <a:ext uri="{FF2B5EF4-FFF2-40B4-BE49-F238E27FC236}">
                  <a16:creationId xmlns:a16="http://schemas.microsoft.com/office/drawing/2014/main" id="{3E79516F-420E-59A2-393B-699D1907707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789423" y="5463429"/>
              <a:ext cx="19839" cy="130941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2" name="Straight Arrow Connector 91">
              <a:extLst>
                <a:ext uri="{FF2B5EF4-FFF2-40B4-BE49-F238E27FC236}">
                  <a16:creationId xmlns:a16="http://schemas.microsoft.com/office/drawing/2014/main" id="{503FAD63-10BE-338F-1BDD-B6864AD94A31}"/>
                </a:ext>
              </a:extLst>
            </p:cNvPr>
            <p:cNvCxnSpPr>
              <a:cxnSpLocks/>
            </p:cNvCxnSpPr>
            <p:nvPr/>
          </p:nvCxnSpPr>
          <p:spPr>
            <a:xfrm>
              <a:off x="4577591" y="5372543"/>
              <a:ext cx="126209" cy="215682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5" name="Straight Arrow Connector 94">
              <a:extLst>
                <a:ext uri="{FF2B5EF4-FFF2-40B4-BE49-F238E27FC236}">
                  <a16:creationId xmlns:a16="http://schemas.microsoft.com/office/drawing/2014/main" id="{21FB5F8F-683B-2B3E-A3B4-FF4A715B1B24}"/>
                </a:ext>
              </a:extLst>
            </p:cNvPr>
            <p:cNvCxnSpPr>
              <a:cxnSpLocks/>
            </p:cNvCxnSpPr>
            <p:nvPr/>
          </p:nvCxnSpPr>
          <p:spPr>
            <a:xfrm>
              <a:off x="4357985" y="5300493"/>
              <a:ext cx="159793" cy="283479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7" name="Straight Arrow Connector 96">
              <a:extLst>
                <a:ext uri="{FF2B5EF4-FFF2-40B4-BE49-F238E27FC236}">
                  <a16:creationId xmlns:a16="http://schemas.microsoft.com/office/drawing/2014/main" id="{063F14CB-D18B-86CD-99D9-D31FE4FB6BD5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606671" y="5718915"/>
              <a:ext cx="114151" cy="8579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5" name="Straight Arrow Connector 104">
              <a:extLst>
                <a:ext uri="{FF2B5EF4-FFF2-40B4-BE49-F238E27FC236}">
                  <a16:creationId xmlns:a16="http://schemas.microsoft.com/office/drawing/2014/main" id="{F4C37D38-8781-3E8A-C3BA-70645D62DDC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69602" y="5510830"/>
              <a:ext cx="8483" cy="183150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id="{6ADB841A-852E-3AF9-2684-A5CA4E77D506}"/>
                </a:ext>
              </a:extLst>
            </p:cNvPr>
            <p:cNvSpPr txBox="1"/>
            <p:nvPr/>
          </p:nvSpPr>
          <p:spPr>
            <a:xfrm>
              <a:off x="5391425" y="5504056"/>
              <a:ext cx="7445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PD-L2</a:t>
              </a:r>
            </a:p>
          </p:txBody>
        </p: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9272D969-46B6-3716-A789-A8A0D5682C6D}"/>
                </a:ext>
              </a:extLst>
            </p:cNvPr>
            <p:cNvSpPr txBox="1"/>
            <p:nvPr/>
          </p:nvSpPr>
          <p:spPr>
            <a:xfrm>
              <a:off x="5234295" y="5353043"/>
              <a:ext cx="7445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CTLA4</a:t>
              </a:r>
            </a:p>
          </p:txBody>
        </p: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C4E22AA1-B674-F59E-4099-3AEB74B7FB5A}"/>
                </a:ext>
              </a:extLst>
            </p:cNvPr>
            <p:cNvSpPr txBox="1"/>
            <p:nvPr/>
          </p:nvSpPr>
          <p:spPr>
            <a:xfrm>
              <a:off x="5083497" y="5225501"/>
              <a:ext cx="7445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LAG3</a:t>
              </a:r>
            </a:p>
          </p:txBody>
        </p: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5F3FDF87-61AE-2198-1E71-AE75D706D25D}"/>
                </a:ext>
              </a:extLst>
            </p:cNvPr>
            <p:cNvSpPr txBox="1"/>
            <p:nvPr/>
          </p:nvSpPr>
          <p:spPr>
            <a:xfrm>
              <a:off x="5078728" y="4983100"/>
              <a:ext cx="7445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GITR</a:t>
              </a:r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E4A77517-4AB2-38A0-5AD3-2DD67FEBE1D4}"/>
                </a:ext>
              </a:extLst>
            </p:cNvPr>
            <p:cNvSpPr txBox="1"/>
            <p:nvPr/>
          </p:nvSpPr>
          <p:spPr>
            <a:xfrm>
              <a:off x="4322423" y="3963581"/>
              <a:ext cx="31130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chemeClr val="accent5"/>
                  </a:solidFill>
                </a:rPr>
                <a:t>PR</a:t>
              </a:r>
            </a:p>
          </p:txBody>
        </p: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7B99F138-3AAD-BBB6-C93F-5DF7DDAC7421}"/>
                </a:ext>
              </a:extLst>
            </p:cNvPr>
            <p:cNvSpPr txBox="1"/>
            <p:nvPr/>
          </p:nvSpPr>
          <p:spPr>
            <a:xfrm>
              <a:off x="4219212" y="4506244"/>
              <a:ext cx="4868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1000" b="1">
                  <a:solidFill>
                    <a:srgbClr val="FF6600"/>
                  </a:solidFill>
                </a:defRPr>
              </a:lvl1pPr>
            </a:lstStyle>
            <a:p>
              <a:r>
                <a:rPr lang="en-US" sz="800" dirty="0">
                  <a:solidFill>
                    <a:schemeClr val="accent5"/>
                  </a:solidFill>
                </a:rPr>
                <a:t>Tim-3</a:t>
              </a: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D5D77958-83CB-4BCB-A8F9-1B9B9EB2F121}"/>
                </a:ext>
              </a:extLst>
            </p:cNvPr>
            <p:cNvSpPr txBox="1"/>
            <p:nvPr/>
          </p:nvSpPr>
          <p:spPr>
            <a:xfrm>
              <a:off x="4462244" y="4863800"/>
              <a:ext cx="41970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1100" b="1">
                  <a:solidFill>
                    <a:schemeClr val="accent5"/>
                  </a:solidFill>
                </a:defRPr>
              </a:lvl1pPr>
            </a:lstStyle>
            <a:p>
              <a:r>
                <a:rPr lang="en-US" sz="800" dirty="0"/>
                <a:t>CD80</a:t>
              </a:r>
            </a:p>
          </p:txBody>
        </p:sp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id="{6002FABF-727E-83B8-B97D-A30BAC706ED8}"/>
                </a:ext>
              </a:extLst>
            </p:cNvPr>
            <p:cNvSpPr txBox="1"/>
            <p:nvPr/>
          </p:nvSpPr>
          <p:spPr>
            <a:xfrm>
              <a:off x="4606363" y="5317216"/>
              <a:ext cx="40633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1100" b="1">
                  <a:solidFill>
                    <a:srgbClr val="FF5050"/>
                  </a:solidFill>
                </a:defRPr>
              </a:lvl1pPr>
            </a:lstStyle>
            <a:p>
              <a:r>
                <a:rPr lang="en-US" sz="800" dirty="0">
                  <a:solidFill>
                    <a:schemeClr val="accent5"/>
                  </a:solidFill>
                </a:rPr>
                <a:t>CD56</a:t>
              </a:r>
            </a:p>
          </p:txBody>
        </p: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780C5A6E-0593-9AB4-2DFE-5C4F67D572AC}"/>
                </a:ext>
              </a:extLst>
            </p:cNvPr>
            <p:cNvSpPr txBox="1"/>
            <p:nvPr/>
          </p:nvSpPr>
          <p:spPr>
            <a:xfrm>
              <a:off x="4380629" y="5207930"/>
              <a:ext cx="39650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1100" b="1">
                  <a:solidFill>
                    <a:srgbClr val="FF5050"/>
                  </a:solidFill>
                </a:defRPr>
              </a:lvl1pPr>
            </a:lstStyle>
            <a:p>
              <a:r>
                <a:rPr lang="en-US" sz="800" dirty="0">
                  <a:solidFill>
                    <a:schemeClr val="accent5"/>
                  </a:solidFill>
                </a:rPr>
                <a:t>ICOS</a:t>
              </a:r>
            </a:p>
          </p:txBody>
        </p: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ADC847D9-7CE2-FA3A-1C16-ED172FB2EAD3}"/>
                </a:ext>
              </a:extLst>
            </p:cNvPr>
            <p:cNvSpPr txBox="1"/>
            <p:nvPr/>
          </p:nvSpPr>
          <p:spPr>
            <a:xfrm>
              <a:off x="4088456" y="5111308"/>
              <a:ext cx="46687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1100" b="1">
                  <a:solidFill>
                    <a:schemeClr val="accent5"/>
                  </a:solidFill>
                </a:defRPr>
              </a:lvl1pPr>
            </a:lstStyle>
            <a:p>
              <a:r>
                <a:rPr lang="en-US" sz="800" dirty="0"/>
                <a:t>CD66b</a:t>
              </a:r>
            </a:p>
          </p:txBody>
        </p: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411A085C-A3AA-7F74-4B50-D014B473A758}"/>
                </a:ext>
              </a:extLst>
            </p:cNvPr>
            <p:cNvSpPr txBox="1"/>
            <p:nvPr/>
          </p:nvSpPr>
          <p:spPr>
            <a:xfrm>
              <a:off x="3996475" y="5319876"/>
              <a:ext cx="42717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chemeClr val="accent5"/>
                  </a:solidFill>
                </a:rPr>
                <a:t>CD34</a:t>
              </a:r>
            </a:p>
          </p:txBody>
        </p: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43D5D9DF-9FB1-53FD-10E7-42845C212F12}"/>
                </a:ext>
              </a:extLst>
            </p:cNvPr>
            <p:cNvSpPr txBox="1"/>
            <p:nvPr/>
          </p:nvSpPr>
          <p:spPr>
            <a:xfrm>
              <a:off x="4641178" y="5622981"/>
              <a:ext cx="45606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1100" b="1">
                  <a:solidFill>
                    <a:srgbClr val="FF5050"/>
                  </a:solidFill>
                </a:defRPr>
              </a:lvl1pPr>
            </a:lstStyle>
            <a:p>
              <a:r>
                <a:rPr lang="en-US" sz="800" dirty="0">
                  <a:solidFill>
                    <a:schemeClr val="accent5"/>
                  </a:solidFill>
                </a:rPr>
                <a:t>Bcl-2</a:t>
              </a:r>
            </a:p>
          </p:txBody>
        </p:sp>
        <p:sp>
          <p:nvSpPr>
            <p:cNvPr id="131" name="TextBox 130">
              <a:extLst>
                <a:ext uri="{FF2B5EF4-FFF2-40B4-BE49-F238E27FC236}">
                  <a16:creationId xmlns:a16="http://schemas.microsoft.com/office/drawing/2014/main" id="{FAB88A1E-41C4-D44B-44E0-6C9C34A222E0}"/>
                </a:ext>
              </a:extLst>
            </p:cNvPr>
            <p:cNvSpPr txBox="1"/>
            <p:nvPr/>
          </p:nvSpPr>
          <p:spPr>
            <a:xfrm>
              <a:off x="285505" y="280178"/>
              <a:ext cx="2826721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 H&amp;E                                                           CD45</a:t>
              </a:r>
            </a:p>
          </p:txBody>
        </p:sp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7D639B15-8268-37C0-C5C0-13A23C43C25C}"/>
                </a:ext>
              </a:extLst>
            </p:cNvPr>
            <p:cNvSpPr txBox="1"/>
            <p:nvPr/>
          </p:nvSpPr>
          <p:spPr>
            <a:xfrm>
              <a:off x="20761" y="171459"/>
              <a:ext cx="356219" cy="32316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500" b="1" dirty="0"/>
                <a:t>A</a:t>
              </a:r>
            </a:p>
          </p:txBody>
        </p:sp>
        <p:sp>
          <p:nvSpPr>
            <p:cNvPr id="137" name="TextBox 136">
              <a:extLst>
                <a:ext uri="{FF2B5EF4-FFF2-40B4-BE49-F238E27FC236}">
                  <a16:creationId xmlns:a16="http://schemas.microsoft.com/office/drawing/2014/main" id="{7AF421ED-3262-9246-9117-D428FE1D250E}"/>
                </a:ext>
              </a:extLst>
            </p:cNvPr>
            <p:cNvSpPr txBox="1"/>
            <p:nvPr/>
          </p:nvSpPr>
          <p:spPr>
            <a:xfrm>
              <a:off x="3249736" y="161934"/>
              <a:ext cx="356219" cy="32316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500" b="1" dirty="0"/>
                <a:t>B</a:t>
              </a:r>
            </a:p>
          </p:txBody>
        </p: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2B8E2653-0ADB-9326-5613-FDD580ACC35D}"/>
                </a:ext>
              </a:extLst>
            </p:cNvPr>
            <p:cNvSpPr txBox="1"/>
            <p:nvPr/>
          </p:nvSpPr>
          <p:spPr>
            <a:xfrm>
              <a:off x="8050336" y="171145"/>
              <a:ext cx="356219" cy="32316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500" b="1" dirty="0"/>
                <a:t>C</a:t>
              </a:r>
            </a:p>
          </p:txBody>
        </p:sp>
        <p:sp>
          <p:nvSpPr>
            <p:cNvPr id="141" name="TextBox 140">
              <a:extLst>
                <a:ext uri="{FF2B5EF4-FFF2-40B4-BE49-F238E27FC236}">
                  <a16:creationId xmlns:a16="http://schemas.microsoft.com/office/drawing/2014/main" id="{103BC343-EB27-34FB-C819-6E26E212A7F8}"/>
                </a:ext>
              </a:extLst>
            </p:cNvPr>
            <p:cNvSpPr txBox="1"/>
            <p:nvPr/>
          </p:nvSpPr>
          <p:spPr>
            <a:xfrm rot="16200000">
              <a:off x="-511160" y="2543229"/>
              <a:ext cx="1479908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MBM</a:t>
              </a:r>
            </a:p>
          </p:txBody>
        </p:sp>
        <p:sp>
          <p:nvSpPr>
            <p:cNvPr id="195" name="TextBox 194">
              <a:extLst>
                <a:ext uri="{FF2B5EF4-FFF2-40B4-BE49-F238E27FC236}">
                  <a16:creationId xmlns:a16="http://schemas.microsoft.com/office/drawing/2014/main" id="{E418586F-3004-F04E-2F8B-F448AC9B90BA}"/>
                </a:ext>
              </a:extLst>
            </p:cNvPr>
            <p:cNvSpPr txBox="1"/>
            <p:nvPr/>
          </p:nvSpPr>
          <p:spPr>
            <a:xfrm rot="16200000">
              <a:off x="-477583" y="1049275"/>
              <a:ext cx="1412751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PM</a:t>
              </a:r>
            </a:p>
          </p:txBody>
        </p:sp>
        <p:grpSp>
          <p:nvGrpSpPr>
            <p:cNvPr id="196" name="Group 195">
              <a:extLst>
                <a:ext uri="{FF2B5EF4-FFF2-40B4-BE49-F238E27FC236}">
                  <a16:creationId xmlns:a16="http://schemas.microsoft.com/office/drawing/2014/main" id="{68F29A1F-5BA9-7906-CDC8-F363B7DE64E3}"/>
                </a:ext>
              </a:extLst>
            </p:cNvPr>
            <p:cNvGrpSpPr/>
            <p:nvPr/>
          </p:nvGrpSpPr>
          <p:grpSpPr>
            <a:xfrm>
              <a:off x="1287134" y="4246664"/>
              <a:ext cx="920870" cy="222310"/>
              <a:chOff x="873626" y="5804545"/>
              <a:chExt cx="838218" cy="222310"/>
            </a:xfrm>
          </p:grpSpPr>
          <p:cxnSp>
            <p:nvCxnSpPr>
              <p:cNvPr id="197" name="Straight Connector 196">
                <a:extLst>
                  <a:ext uri="{FF2B5EF4-FFF2-40B4-BE49-F238E27FC236}">
                    <a16:creationId xmlns:a16="http://schemas.microsoft.com/office/drawing/2014/main" id="{0B062F5A-9898-E1B7-7C1A-1F5421E6840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74657" y="6000468"/>
                <a:ext cx="1359" cy="26387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8" name="Straight Connector 197">
                <a:extLst>
                  <a:ext uri="{FF2B5EF4-FFF2-40B4-BE49-F238E27FC236}">
                    <a16:creationId xmlns:a16="http://schemas.microsoft.com/office/drawing/2014/main" id="{D76781CE-66C1-1B73-036A-D8C79C3114A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74570" y="6006340"/>
                <a:ext cx="83716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9" name="TextBox 198">
                <a:extLst>
                  <a:ext uri="{FF2B5EF4-FFF2-40B4-BE49-F238E27FC236}">
                    <a16:creationId xmlns:a16="http://schemas.microsoft.com/office/drawing/2014/main" id="{5AA5856F-06C3-B5E8-3D8F-E631E521DB65}"/>
                  </a:ext>
                </a:extLst>
              </p:cNvPr>
              <p:cNvSpPr txBox="1"/>
              <p:nvPr/>
            </p:nvSpPr>
            <p:spPr>
              <a:xfrm>
                <a:off x="873626" y="5804545"/>
                <a:ext cx="83821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i="1" dirty="0"/>
                  <a:t>P </a:t>
                </a:r>
                <a:r>
                  <a:rPr lang="en-US" sz="800" b="1" dirty="0"/>
                  <a:t>= 0.205</a:t>
                </a:r>
              </a:p>
            </p:txBody>
          </p:sp>
          <p:cxnSp>
            <p:nvCxnSpPr>
              <p:cNvPr id="200" name="Straight Connector 199">
                <a:extLst>
                  <a:ext uri="{FF2B5EF4-FFF2-40B4-BE49-F238E27FC236}">
                    <a16:creationId xmlns:a16="http://schemas.microsoft.com/office/drawing/2014/main" id="{C0ACF196-82FE-398A-FF7F-C27C0999BF5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710485" y="6000468"/>
                <a:ext cx="1359" cy="26387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01" name="TextBox 200">
              <a:extLst>
                <a:ext uri="{FF2B5EF4-FFF2-40B4-BE49-F238E27FC236}">
                  <a16:creationId xmlns:a16="http://schemas.microsoft.com/office/drawing/2014/main" id="{1EA4DCDA-5BF2-EA4B-9984-7DFFC56E3E2C}"/>
                </a:ext>
              </a:extLst>
            </p:cNvPr>
            <p:cNvSpPr txBox="1"/>
            <p:nvPr/>
          </p:nvSpPr>
          <p:spPr>
            <a:xfrm rot="16200000">
              <a:off x="-424188" y="5177440"/>
              <a:ext cx="1528816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b="1"/>
              </a:lvl1pPr>
            </a:lstStyle>
            <a:p>
              <a:pPr algn="ctr"/>
              <a:r>
                <a:rPr lang="en-US" sz="800" b="0" dirty="0"/>
                <a:t>% of infiltrating cells</a:t>
              </a:r>
            </a:p>
          </p:txBody>
        </p:sp>
        <p:sp>
          <p:nvSpPr>
            <p:cNvPr id="202" name="TextBox 201">
              <a:extLst>
                <a:ext uri="{FF2B5EF4-FFF2-40B4-BE49-F238E27FC236}">
                  <a16:creationId xmlns:a16="http://schemas.microsoft.com/office/drawing/2014/main" id="{DE54FD22-0715-5042-4762-DDBCD44E59AD}"/>
                </a:ext>
              </a:extLst>
            </p:cNvPr>
            <p:cNvSpPr txBox="1"/>
            <p:nvPr/>
          </p:nvSpPr>
          <p:spPr>
            <a:xfrm>
              <a:off x="322757" y="4428831"/>
              <a:ext cx="387991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100</a:t>
              </a:r>
            </a:p>
          </p:txBody>
        </p:sp>
        <p:sp>
          <p:nvSpPr>
            <p:cNvPr id="211" name="TextBox 210">
              <a:extLst>
                <a:ext uri="{FF2B5EF4-FFF2-40B4-BE49-F238E27FC236}">
                  <a16:creationId xmlns:a16="http://schemas.microsoft.com/office/drawing/2014/main" id="{257C2E14-72A7-9D6C-AE52-EE5C504BC77A}"/>
                </a:ext>
              </a:extLst>
            </p:cNvPr>
            <p:cNvSpPr txBox="1"/>
            <p:nvPr/>
          </p:nvSpPr>
          <p:spPr>
            <a:xfrm>
              <a:off x="675222" y="5977930"/>
              <a:ext cx="2136696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              PM (</a:t>
              </a:r>
              <a:r>
                <a:rPr lang="en-US" sz="800" i="1" dirty="0"/>
                <a:t>n</a:t>
              </a:r>
              <a:r>
                <a:rPr lang="en-US" sz="800" dirty="0"/>
                <a:t>=7)                      MBM (</a:t>
              </a:r>
              <a:r>
                <a:rPr lang="en-US" sz="800" i="1" dirty="0"/>
                <a:t>n</a:t>
              </a:r>
              <a:r>
                <a:rPr lang="en-US" sz="800" dirty="0"/>
                <a:t>=13)</a:t>
              </a:r>
            </a:p>
          </p:txBody>
        </p:sp>
        <p:sp>
          <p:nvSpPr>
            <p:cNvPr id="212" name="TextBox 211">
              <a:extLst>
                <a:ext uri="{FF2B5EF4-FFF2-40B4-BE49-F238E27FC236}">
                  <a16:creationId xmlns:a16="http://schemas.microsoft.com/office/drawing/2014/main" id="{84A1F593-A85C-70C7-C9F3-FEFB39A0ABAA}"/>
                </a:ext>
              </a:extLst>
            </p:cNvPr>
            <p:cNvSpPr txBox="1"/>
            <p:nvPr/>
          </p:nvSpPr>
          <p:spPr>
            <a:xfrm>
              <a:off x="603806" y="4042784"/>
              <a:ext cx="2267168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/>
                <a:t>CD45</a:t>
              </a:r>
            </a:p>
          </p:txBody>
        </p:sp>
        <p:pic>
          <p:nvPicPr>
            <p:cNvPr id="47" name="Picture 46" descr="A close-up of a cell&#10;&#10;Description automatically generated">
              <a:extLst>
                <a:ext uri="{FF2B5EF4-FFF2-40B4-BE49-F238E27FC236}">
                  <a16:creationId xmlns:a16="http://schemas.microsoft.com/office/drawing/2014/main" id="{230EB767-C7BA-EBD4-5090-55C2F927F1B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926" t="23247" r="17650" b="17149"/>
            <a:stretch/>
          </p:blipFill>
          <p:spPr>
            <a:xfrm>
              <a:off x="355044" y="509565"/>
              <a:ext cx="1362456" cy="1345229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934B3CFD-A9EB-C016-7578-17F2D5B9375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/>
            <a:srcRect l="15510" t="10619" b="10762"/>
            <a:stretch/>
          </p:blipFill>
          <p:spPr>
            <a:xfrm>
              <a:off x="599093" y="4346036"/>
              <a:ext cx="2507758" cy="1646153"/>
            </a:xfrm>
            <a:prstGeom prst="rect">
              <a:avLst/>
            </a:prstGeom>
            <a:ln>
              <a:noFill/>
            </a:ln>
          </p:spPr>
        </p:pic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F50EB86C-9323-20E5-23B6-D7C36202C132}"/>
                </a:ext>
              </a:extLst>
            </p:cNvPr>
            <p:cNvSpPr txBox="1"/>
            <p:nvPr/>
          </p:nvSpPr>
          <p:spPr>
            <a:xfrm>
              <a:off x="389000" y="4895864"/>
              <a:ext cx="387991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10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01B80479-C5A9-F304-B304-2B33BD1EF067}"/>
                </a:ext>
              </a:extLst>
            </p:cNvPr>
            <p:cNvSpPr txBox="1"/>
            <p:nvPr/>
          </p:nvSpPr>
          <p:spPr>
            <a:xfrm>
              <a:off x="435840" y="5349529"/>
              <a:ext cx="387991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1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DC31A655-AF9C-1F61-93DB-130BC214E673}"/>
                </a:ext>
              </a:extLst>
            </p:cNvPr>
            <p:cNvSpPr txBox="1"/>
            <p:nvPr/>
          </p:nvSpPr>
          <p:spPr>
            <a:xfrm>
              <a:off x="362430" y="5807624"/>
              <a:ext cx="387991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0.1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0307391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cc8b63ee-64cf-4a99-8987-95f8e0e257c5">
      <Terms xmlns="http://schemas.microsoft.com/office/infopath/2007/PartnerControls"/>
    </lcf76f155ced4ddcb4097134ff3c332f>
    <TaxCatchAll xmlns="7f4c377c-6705-4b4f-8b07-648fa1217e5d" xsi:nil="true"/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948857253FD10B418DFFC8AF56E52813" ma:contentTypeVersion="15" ma:contentTypeDescription="Create a new document." ma:contentTypeScope="" ma:versionID="fd18f8ef797e431b951545bdf5cef5c4">
  <xsd:schema xmlns:xsd="http://www.w3.org/2001/XMLSchema" xmlns:xs="http://www.w3.org/2001/XMLSchema" xmlns:p="http://schemas.microsoft.com/office/2006/metadata/properties" xmlns:ns2="cc8b63ee-64cf-4a99-8987-95f8e0e257c5" xmlns:ns3="7f4c377c-6705-4b4f-8b07-648fa1217e5d" targetNamespace="http://schemas.microsoft.com/office/2006/metadata/properties" ma:root="true" ma:fieldsID="ac07ba9186dc7a755daa4e3822ed20dc" ns2:_="" ns3:_="">
    <xsd:import namespace="cc8b63ee-64cf-4a99-8987-95f8e0e257c5"/>
    <xsd:import namespace="7f4c377c-6705-4b4f-8b07-648fa1217e5d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lcf76f155ced4ddcb4097134ff3c332f" minOccurs="0"/>
                <xsd:element ref="ns3:TaxCatchAll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ServiceLocation" minOccurs="0"/>
                <xsd:element ref="ns2:MediaLengthInSeconds" minOccurs="0"/>
                <xsd:element ref="ns3:SharedWithUsers" minOccurs="0"/>
                <xsd:element ref="ns3:SharedWithDetails" minOccurs="0"/>
                <xsd:element ref="ns2:MediaServiceObjectDetectorVersion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c8b63ee-64cf-4a99-8987-95f8e0e257c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lcf76f155ced4ddcb4097134ff3c332f" ma:index="11" nillable="true" ma:taxonomy="true" ma:internalName="lcf76f155ced4ddcb4097134ff3c332f" ma:taxonomyFieldName="MediaServiceImageTags" ma:displayName="Image Tags" ma:readOnly="false" ma:fieldId="{5cf76f15-5ced-4ddc-b409-7134ff3c332f}" ma:taxonomyMulti="true" ma:sspId="d898b932-ec87-4f6e-a380-e59be69e9f7d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6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Location" ma:index="17" nillable="true" ma:displayName="Location" ma:indexed="true" ma:internalName="MediaServiceLocation" ma:readOnly="true">
      <xsd:simpleType>
        <xsd:restriction base="dms:Text"/>
      </xsd:simpleType>
    </xsd:element>
    <xsd:element name="MediaLengthInSeconds" ma:index="18" nillable="true" ma:displayName="MediaLengthInSeconds" ma:hidden="true" ma:internalName="MediaLengthInSeconds" ma:readOnly="true">
      <xsd:simpleType>
        <xsd:restriction base="dms:Unknown"/>
      </xsd:simpleType>
    </xsd:element>
    <xsd:element name="MediaServiceObjectDetectorVersions" ma:index="2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2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f4c377c-6705-4b4f-8b07-648fa1217e5d" elementFormDefault="qualified">
    <xsd:import namespace="http://schemas.microsoft.com/office/2006/documentManagement/types"/>
    <xsd:import namespace="http://schemas.microsoft.com/office/infopath/2007/PartnerControls"/>
    <xsd:element name="TaxCatchAll" ma:index="12" nillable="true" ma:displayName="Taxonomy Catch All Column" ma:hidden="true" ma:list="{ce3bf326-c720-4233-acef-1ee9483f63f2}" ma:internalName="TaxCatchAll" ma:showField="CatchAllData" ma:web="7f4c377c-6705-4b4f-8b07-648fa1217e5d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SharedWithUsers" ma:index="19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0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8A994AFA-DBE4-4A3D-9A20-2E1A8CB255AE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2DDE4D8C-AA86-4A95-A7B1-5723390573A0}">
  <ds:schemaRefs>
    <ds:schemaRef ds:uri="7f4c377c-6705-4b4f-8b07-648fa1217e5d"/>
    <ds:schemaRef ds:uri="cc8b63ee-64cf-4a99-8987-95f8e0e257c5"/>
    <ds:schemaRef ds:uri="http://schemas.microsoft.com/office/2006/metadata/properties"/>
    <ds:schemaRef ds:uri="http://schemas.microsoft.com/office/infopath/2007/PartnerControls"/>
  </ds:schemaRefs>
</ds:datastoreItem>
</file>

<file path=customXml/itemProps3.xml><?xml version="1.0" encoding="utf-8"?>
<ds:datastoreItem xmlns:ds="http://schemas.openxmlformats.org/officeDocument/2006/customXml" ds:itemID="{55A4F4D5-C6BE-42A6-8DEC-E88F57C82E80}">
  <ds:schemaRefs>
    <ds:schemaRef ds:uri="7f4c377c-6705-4b4f-8b07-648fa1217e5d"/>
    <ds:schemaRef ds:uri="cc8b63ee-64cf-4a99-8987-95f8e0e257c5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728</TotalTime>
  <Words>225</Words>
  <Application>Microsoft Office PowerPoint</Application>
  <PresentationFormat>Custom</PresentationFormat>
  <Paragraphs>9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ndoza Valderrey, Alberto</dc:creator>
  <cp:lastModifiedBy>Mendoza Valderrey, Alberto</cp:lastModifiedBy>
  <cp:revision>3</cp:revision>
  <dcterms:created xsi:type="dcterms:W3CDTF">2024-01-31T02:24:31Z</dcterms:created>
  <dcterms:modified xsi:type="dcterms:W3CDTF">2024-02-29T18:51:2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948857253FD10B418DFFC8AF56E52813</vt:lpwstr>
  </property>
  <property fmtid="{D5CDD505-2E9C-101B-9397-08002B2CF9AE}" pid="3" name="MediaServiceImageTags">
    <vt:lpwstr/>
  </property>
</Properties>
</file>